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83" r:id="rId2"/>
    <p:sldId id="281" r:id="rId3"/>
    <p:sldId id="280" r:id="rId4"/>
    <p:sldId id="262" r:id="rId5"/>
    <p:sldId id="270" r:id="rId6"/>
    <p:sldId id="271" r:id="rId7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  <a:srgbClr val="FFCCCC"/>
    <a:srgbClr val="FF9999"/>
    <a:srgbClr val="FF6699"/>
    <a:srgbClr val="CC99FF"/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009" autoAdjust="0"/>
  </p:normalViewPr>
  <p:slideViewPr>
    <p:cSldViewPr snapToGrid="0">
      <p:cViewPr>
        <p:scale>
          <a:sx n="125" d="100"/>
          <a:sy n="125" d="100"/>
        </p:scale>
        <p:origin x="678" y="-924"/>
      </p:cViewPr>
      <p:guideLst>
        <p:guide orient="horz" pos="2880"/>
        <p:guide pos="2160"/>
      </p:guideLst>
    </p:cSldViewPr>
  </p:slideViewPr>
  <p:outlineViewPr>
    <p:cViewPr>
      <p:scale>
        <a:sx n="75" d="100"/>
        <a:sy n="75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 snapToGrid="0">
      <p:cViewPr varScale="1">
        <p:scale>
          <a:sx n="57" d="100"/>
          <a:sy n="57" d="100"/>
        </p:scale>
        <p:origin x="2832" y="6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C65436-E03E-4BC4-B92F-8E56A7687541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66D520-9CFF-4C74-8C6A-69B76D9FB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9823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66D520-9CFF-4C74-8C6A-69B76D9FB3F8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63514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66D520-9CFF-4C74-8C6A-69B76D9FB3F8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26534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9319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3803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539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743561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0320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365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6251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3119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5050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74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884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0F288-AE8C-4898-93EF-96B12029F3D7}" type="datetimeFigureOut">
              <a:rPr lang="ko-KR" altLang="en-US" smtClean="0"/>
              <a:t>2019-09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F45E33-6847-4849-8C88-784E285F1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439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12.jpeg"/><Relationship Id="rId3" Type="http://schemas.openxmlformats.org/officeDocument/2006/relationships/image" Target="../media/image5.png"/><Relationship Id="rId7" Type="http://schemas.openxmlformats.org/officeDocument/2006/relationships/image" Target="../media/image7.png"/><Relationship Id="rId12" Type="http://schemas.openxmlformats.org/officeDocument/2006/relationships/image" Target="../media/image11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10.jpeg"/><Relationship Id="rId5" Type="http://schemas.openxmlformats.org/officeDocument/2006/relationships/image" Target="../media/image6.png"/><Relationship Id="rId15" Type="http://schemas.openxmlformats.org/officeDocument/2006/relationships/image" Target="../media/image14.jpe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9.png"/><Relationship Id="rId14" Type="http://schemas.openxmlformats.org/officeDocument/2006/relationships/image" Target="../media/image13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jpe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318750" y="313936"/>
            <a:ext cx="2365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 smtClean="0">
                <a:cs typeface="Times New Roman" panose="02020603050405020304" pitchFamily="18" charset="0"/>
              </a:rPr>
              <a:t>Supplementary figure </a:t>
            </a:r>
            <a:r>
              <a:rPr lang="en-US" altLang="ko-KR" i="1" dirty="0">
                <a:cs typeface="Times New Roman" panose="02020603050405020304" pitchFamily="18" charset="0"/>
              </a:rPr>
              <a:t>1</a:t>
            </a:r>
            <a:endParaRPr lang="ko-KR" altLang="en-US" i="1" dirty="0">
              <a:cs typeface="Times New Roman" panose="02020603050405020304" pitchFamily="18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85356" y="4807586"/>
            <a:ext cx="6398785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Transduction efficacy of vaccinia virus in B cells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cells were transduced with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ither</a:t>
            </a:r>
            <a:r>
              <a:rPr lang="ko-KR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ccinia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rus expressing GFP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GF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vaccinia virus expressing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AT6 (vacESAT6) for 24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a MOI of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To assess the expression of ESAT6, the transduce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e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ESAT6 Ab, an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rther stained with anti-mouse IgG (H+L), F(ab’)2 Fragment Ab fluorescently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jugated with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yLight</a:t>
            </a:r>
            <a:r>
              <a:rPr lang="en-US" altLang="ko-KR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M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405 (blue)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ls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counterstained with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pidium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odid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red)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nuclei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analyze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confocal microscopy to detect the expression of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 and ESAT6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cale bar = 20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ko-KR" altLang="ko-KR" sz="1200" dirty="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50598" y="2386779"/>
            <a:ext cx="1003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Vaccinia-GFP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85356" y="3509809"/>
            <a:ext cx="1133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Vaccinia-ESAT6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687805" y="1705797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N</a:t>
            </a:r>
            <a:r>
              <a:rPr lang="en-US" altLang="ko-KR" sz="1200" b="1" dirty="0" smtClean="0"/>
              <a:t>uclei</a:t>
            </a:r>
            <a:endParaRPr lang="en-US" altLang="ko-KR" sz="1200" b="1" dirty="0" smtClean="0"/>
          </a:p>
        </p:txBody>
      </p:sp>
      <p:sp>
        <p:nvSpPr>
          <p:cNvPr id="33" name="TextBox 32"/>
          <p:cNvSpPr txBox="1"/>
          <p:nvPr/>
        </p:nvSpPr>
        <p:spPr>
          <a:xfrm>
            <a:off x="2827147" y="1705797"/>
            <a:ext cx="565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ESAT6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019885" y="1705796"/>
            <a:ext cx="434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GFP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5061983" y="1705796"/>
            <a:ext cx="597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Merge</a:t>
            </a:r>
          </a:p>
        </p:txBody>
      </p:sp>
      <p:pic>
        <p:nvPicPr>
          <p:cNvPr id="9" name="그림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9193" y="1982795"/>
            <a:ext cx="4480948" cy="2213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18502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318750" y="313936"/>
            <a:ext cx="2365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 smtClean="0">
                <a:cs typeface="Times New Roman" panose="02020603050405020304" pitchFamily="18" charset="0"/>
              </a:rPr>
              <a:t>Supplementary figure </a:t>
            </a:r>
            <a:r>
              <a:rPr lang="en-US" altLang="ko-KR" i="1" dirty="0">
                <a:cs typeface="Times New Roman" panose="02020603050405020304" pitchFamily="18" charset="0"/>
              </a:rPr>
              <a:t>2</a:t>
            </a:r>
            <a:endParaRPr lang="ko-KR" altLang="en-US" i="1" dirty="0">
              <a:cs typeface="Times New Roman" panose="02020603050405020304" pitchFamily="18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7" name="직사각형 6"/>
              <p:cNvSpPr/>
              <p:nvPr/>
            </p:nvSpPr>
            <p:spPr>
              <a:xfrm>
                <a:off x="285356" y="6215842"/>
                <a:ext cx="6398785" cy="175432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>
                  <a:lnSpc>
                    <a:spcPct val="150000"/>
                  </a:lnSpc>
                </a:pPr>
                <a:r>
                  <a:rPr lang="en-US" altLang="ko-KR" sz="12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figure 2. Upregulation of CD86 on B cells by vaccinia virus infection. </a:t>
                </a:r>
                <a:r>
                  <a:rPr lang="en-US" altLang="ko-KR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220</a:t>
                </a:r>
                <a:r>
                  <a:rPr lang="en-US" altLang="ko-KR" sz="1200" baseline="30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US" altLang="ko-KR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 were isolated from splenocytes of naïve C57BL/6 mice. Isolated B220</a:t>
                </a:r>
                <a:r>
                  <a:rPr lang="en-US" altLang="ko-KR" sz="1200" baseline="30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US" altLang="ko-KR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 were transduced with </a:t>
                </a:r>
                <a:r>
                  <a:rPr lang="en-US" altLang="ko-KR" sz="12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cGFP</a:t>
                </a:r>
                <a:r>
                  <a:rPr lang="en-US" altLang="ko-KR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control virus) or vacESAT6 at a MOI of 1 and/or loaded with 1</a:t>
                </a:r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n-US" altLang="ko-KR" sz="1200">
                        <a:solidFill>
                          <a:schemeClr val="tx1"/>
                        </a:solidFill>
                        <a:latin typeface="Cambria Math" panose="02040503050406030204" pitchFamily="18" charset="0"/>
                      </a:rPr>
                      <m:t>μ</m:t>
                    </m:r>
                  </m:oMath>
                </a14:m>
                <a:r>
                  <a:rPr lang="en-US" altLang="ko-KR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/ml of αGC and then co-cultured with naïve splenocytes for 24 h. The expression levels of CD86 on B220</a:t>
                </a:r>
                <a:r>
                  <a:rPr lang="en-US" altLang="ko-KR" sz="1200" baseline="30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US" altLang="ko-KR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 were analyzed by flow cytometry and the mean fluorescence intensity (MFI) of CD86 expression was shown.</a:t>
                </a:r>
                <a:endParaRPr lang="ko-KR" altLang="ko-KR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굴림" panose="020B0600000101010101" pitchFamily="50" charset="-127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7" name="직사각형 6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85356" y="6215842"/>
                <a:ext cx="6398785" cy="1754326"/>
              </a:xfrm>
              <a:prstGeom prst="rect">
                <a:avLst/>
              </a:prstGeom>
              <a:blipFill rotWithShape="0">
                <a:blip r:embed="rId2"/>
                <a:stretch>
                  <a:fillRect l="-95" r="-95" b="-348"/>
                </a:stretch>
              </a:blipFill>
            </p:spPr>
            <p:txBody>
              <a:bodyPr/>
              <a:lstStyle/>
              <a:p>
                <a:r>
                  <a:rPr lang="ko-KR" alt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8" name="그림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2739" y="1555575"/>
            <a:ext cx="2106011" cy="25483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91380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238" y="1552914"/>
            <a:ext cx="1509621" cy="180000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9703" y="1552914"/>
            <a:ext cx="1509621" cy="1800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318750" y="313936"/>
            <a:ext cx="2365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 smtClean="0">
                <a:cs typeface="Times New Roman" panose="02020603050405020304" pitchFamily="18" charset="0"/>
              </a:rPr>
              <a:t>Supplementary figure 3</a:t>
            </a:r>
            <a:endParaRPr lang="ko-KR" altLang="en-US" i="1" dirty="0">
              <a:cs typeface="Times New Roman" panose="02020603050405020304" pitchFamily="18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285356" y="6215842"/>
            <a:ext cx="6398785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Immunization of mice with Bvac increased the percentages of NK cells and NKT cells after 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kansasii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ion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were immunized with Bvac by tail vein injection at day 0 and 7 (n=5 ~ 6 per group). At day 14, mice were challenged with 10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FU/mouse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kansasi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fter 14 days following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kansasi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ection, splenocytes were isolated from the mice of each group. The proportion of NK cells and NKT cells in splenocytes was analyzed by using flow cytometry. </a:t>
            </a:r>
            <a:endParaRPr lang="ko-KR" altLang="ko-KR" sz="1200" dirty="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514238" y="1359632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cs typeface="Times New Roman" panose="02020603050405020304" pitchFamily="18" charset="0"/>
              </a:rPr>
              <a:t>A</a:t>
            </a:r>
            <a:endParaRPr lang="ko-KR" altLang="en-US" sz="2000" b="1" dirty="0"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309002" y="1359632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cs typeface="Times New Roman" panose="02020603050405020304" pitchFamily="18" charset="0"/>
              </a:rPr>
              <a:t>B</a:t>
            </a:r>
            <a:endParaRPr lang="ko-KR" altLang="en-US" sz="2000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82012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그림 22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7124" y="1443314"/>
            <a:ext cx="1188000" cy="89014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5" name="그림 24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7450" y="1443314"/>
            <a:ext cx="1188000" cy="89014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" name="그림 28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7124" y="2515928"/>
            <a:ext cx="1188000" cy="89014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" name="그림 29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7450" y="2515928"/>
            <a:ext cx="1188000" cy="89014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" name="Rectangle 143"/>
          <p:cNvSpPr>
            <a:spLocks noChangeArrowheads="1"/>
          </p:cNvSpPr>
          <p:nvPr/>
        </p:nvSpPr>
        <p:spPr bwMode="auto">
          <a:xfrm>
            <a:off x="1139253" y="86211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sp>
        <p:nvSpPr>
          <p:cNvPr id="22" name="TextBox 21"/>
          <p:cNvSpPr txBox="1"/>
          <p:nvPr/>
        </p:nvSpPr>
        <p:spPr>
          <a:xfrm>
            <a:off x="4318750" y="313936"/>
            <a:ext cx="2365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 smtClean="0">
                <a:cs typeface="Times New Roman" panose="02020603050405020304" pitchFamily="18" charset="0"/>
              </a:rPr>
              <a:t>Supplementary figure </a:t>
            </a:r>
            <a:r>
              <a:rPr lang="en-US" altLang="ko-KR" i="1" dirty="0">
                <a:cs typeface="Times New Roman" panose="02020603050405020304" pitchFamily="18" charset="0"/>
              </a:rPr>
              <a:t>4</a:t>
            </a:r>
            <a:endParaRPr lang="ko-KR" altLang="en-US" i="1" dirty="0"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077757" y="1061091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cs typeface="Times New Roman" panose="02020603050405020304" pitchFamily="18" charset="0"/>
              </a:rPr>
              <a:t>A</a:t>
            </a:r>
            <a:endParaRPr lang="ko-KR" altLang="en-US" sz="2000" b="1" dirty="0"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402698" y="2306246"/>
            <a:ext cx="1317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BCG+</a:t>
            </a:r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altLang="ko-KR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kansasii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542812" y="1216144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Uninfected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540850" y="1216144"/>
            <a:ext cx="1149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line+M</a:t>
            </a:r>
            <a:r>
              <a:rPr lang="en-US" altLang="ko-KR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ansasii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573959" y="2296931"/>
            <a:ext cx="1085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vac+</a:t>
            </a:r>
            <a:r>
              <a:rPr lang="en-US" altLang="ko-KR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kansasii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921730" y="1061091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cs typeface="Times New Roman" panose="02020603050405020304" pitchFamily="18" charset="0"/>
              </a:rPr>
              <a:t>B</a:t>
            </a:r>
            <a:endParaRPr lang="ko-KR" altLang="en-US" sz="2000" b="1" dirty="0"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402698" y="4663320"/>
            <a:ext cx="1079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BCG+</a:t>
            </a:r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altLang="ko-KR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kansasii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542812" y="3587616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Uninfected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573959" y="4654005"/>
            <a:ext cx="1085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vac+</a:t>
            </a:r>
            <a:r>
              <a:rPr lang="en-US" altLang="ko-KR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kansasii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077757" y="3428862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cs typeface="Times New Roman" panose="02020603050405020304" pitchFamily="18" charset="0"/>
              </a:rPr>
              <a:t>C</a:t>
            </a:r>
            <a:endParaRPr lang="ko-KR" altLang="en-US" sz="2000" b="1" dirty="0"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927508" y="3428862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cs typeface="Times New Roman" panose="02020603050405020304" pitchFamily="18" charset="0"/>
              </a:rPr>
              <a:t>D</a:t>
            </a:r>
            <a:endParaRPr lang="ko-KR" altLang="en-US" sz="2000" b="1" dirty="0">
              <a:cs typeface="Times New Roman" panose="02020603050405020304" pitchFamily="18" charset="0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285356" y="6215842"/>
            <a:ext cx="6398785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굴림" panose="020B0600000101010101" pitchFamily="50" charset="-127"/>
              </a:rPr>
              <a:t>Supplementary figure 4. Immunization of Bvac showed comparable protection against </a:t>
            </a:r>
            <a:r>
              <a:rPr lang="en-US" altLang="ko-KR" sz="1200" b="1" i="1" dirty="0">
                <a:latin typeface="Times New Roman" panose="02020603050405020304" pitchFamily="18" charset="0"/>
                <a:cs typeface="굴림" panose="020B0600000101010101" pitchFamily="50" charset="-127"/>
              </a:rPr>
              <a:t>Mycobacterium kansasii</a:t>
            </a:r>
            <a:r>
              <a:rPr lang="en-US" altLang="ko-KR" sz="1200" b="1" dirty="0">
                <a:latin typeface="Times New Roman" panose="02020603050405020304" pitchFamily="18" charset="0"/>
                <a:cs typeface="굴림" panose="020B0600000101010101" pitchFamily="50" charset="-127"/>
              </a:rPr>
              <a:t> as compared to BCG. 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Mice were immunized with BCG by intramuscular injection at a 10</a:t>
            </a:r>
            <a:r>
              <a:rPr lang="en-US" altLang="ko-KR" sz="1200" baseline="30000" dirty="0">
                <a:latin typeface="Times New Roman" panose="02020603050405020304" pitchFamily="18" charset="0"/>
                <a:cs typeface="굴림" panose="020B0600000101010101" pitchFamily="50" charset="-127"/>
              </a:rPr>
              <a:t>5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FU/mouse or with Bvac by tail vein injection at day 0 and 7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5 for uninfected, n=6 for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line, BCG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Bvac group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day 14, mice were challenged with 10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FU/mouse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kansasi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fter 14 days following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altLang="ko-KR" sz="1200" i="1" dirty="0">
                <a:latin typeface="Times New Roman" panose="02020603050405020304" pitchFamily="18" charset="0"/>
                <a:cs typeface="굴림" panose="020B0600000101010101" pitchFamily="50" charset="-127"/>
              </a:rPr>
              <a:t>kansasii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 infection, histologic analysis as well as bacterial CFU of lung (A, B) and liver (C, D) were determined. (A) Representative H&amp;E images of lung  from each group of mice (scale bar = 50 </a:t>
            </a:r>
            <a:r>
              <a:rPr lang="el-GR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μ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m). (B) CFU of </a:t>
            </a:r>
            <a:r>
              <a:rPr lang="en-US" altLang="ko-KR" sz="1200" i="1" dirty="0">
                <a:latin typeface="Times New Roman" panose="02020603050405020304" pitchFamily="18" charset="0"/>
                <a:cs typeface="굴림" panose="020B0600000101010101" pitchFamily="50" charset="-127"/>
              </a:rPr>
              <a:t>M. kansasii 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from lung homogenates. (C) Representative H&amp;E images of liver from each group of mice (scale bar = 100 </a:t>
            </a:r>
            <a:r>
              <a:rPr lang="el-GR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μ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m). (D) CFU of </a:t>
            </a:r>
            <a:r>
              <a:rPr lang="en-US" altLang="ko-KR" sz="1200" i="1" dirty="0">
                <a:latin typeface="Times New Roman" panose="02020603050405020304" pitchFamily="18" charset="0"/>
                <a:cs typeface="굴림" panose="020B0600000101010101" pitchFamily="50" charset="-127"/>
              </a:rPr>
              <a:t>M. kansasii 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from liver homogenates.</a:t>
            </a:r>
            <a:endParaRPr lang="ko-KR" altLang="ko-KR" sz="1200" dirty="0"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  <a:p>
            <a:pPr algn="just">
              <a:lnSpc>
                <a:spcPct val="150000"/>
              </a:lnSpc>
            </a:pPr>
            <a:r>
              <a:rPr lang="en-US" altLang="ko-KR" sz="1200" dirty="0"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 </a:t>
            </a:r>
            <a:endParaRPr lang="ko-KR" altLang="ko-KR" sz="1200" dirty="0"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  <p:pic>
        <p:nvPicPr>
          <p:cNvPr id="10" name="그림 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8899" y="3784644"/>
            <a:ext cx="1186740" cy="889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3959" y="3784644"/>
            <a:ext cx="1186740" cy="889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8899" y="4871132"/>
            <a:ext cx="1186740" cy="889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7041" y="4871132"/>
            <a:ext cx="1186740" cy="889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TextBox 26"/>
          <p:cNvSpPr txBox="1"/>
          <p:nvPr/>
        </p:nvSpPr>
        <p:spPr>
          <a:xfrm>
            <a:off x="2573959" y="3581554"/>
            <a:ext cx="1149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line+M</a:t>
            </a:r>
            <a:r>
              <a:rPr lang="en-US" altLang="ko-KR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ansasii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879" y="1469401"/>
            <a:ext cx="1459701" cy="18000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879" y="3774286"/>
            <a:ext cx="1459701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39147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7324" y="1407996"/>
            <a:ext cx="1491815" cy="183960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664" y="1256796"/>
            <a:ext cx="1427228" cy="19908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318750" y="313936"/>
            <a:ext cx="2365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 smtClean="0">
                <a:cs typeface="Times New Roman" panose="02020603050405020304" pitchFamily="18" charset="0"/>
              </a:rPr>
              <a:t>Supplementary figure 5</a:t>
            </a:r>
            <a:endParaRPr lang="ko-KR" altLang="en-US" i="1" dirty="0"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296524" y="100788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cs typeface="Times New Roman" panose="02020603050405020304" pitchFamily="18" charset="0"/>
              </a:rPr>
              <a:t>A</a:t>
            </a:r>
            <a:endParaRPr lang="ko-KR" altLang="en-US" sz="2000" b="1" dirty="0"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76346" y="100788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cs typeface="Times New Roman" panose="02020603050405020304" pitchFamily="18" charset="0"/>
              </a:rPr>
              <a:t>B</a:t>
            </a:r>
            <a:endParaRPr lang="ko-KR" altLang="en-US" sz="2000" b="1" dirty="0">
              <a:cs typeface="Times New Roman" panose="02020603050405020304" pitchFamily="18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324344" y="4932068"/>
            <a:ext cx="6359797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굴림" panose="020B0600000101010101" pitchFamily="50" charset="-127"/>
              </a:rPr>
              <a:t>Supplementary figure 5. Therapeutic administration of Bvac ameliorated bacterial load in lung of mice infected with </a:t>
            </a:r>
            <a:r>
              <a:rPr lang="en-US" altLang="ko-KR" sz="1200" b="1" i="1" dirty="0">
                <a:latin typeface="Times New Roman" panose="02020603050405020304" pitchFamily="18" charset="0"/>
                <a:cs typeface="굴림" panose="020B0600000101010101" pitchFamily="50" charset="-127"/>
              </a:rPr>
              <a:t>Mycobacterium kansasii</a:t>
            </a:r>
            <a:r>
              <a:rPr lang="en-US" altLang="ko-KR" sz="1200" b="1" dirty="0">
                <a:latin typeface="Times New Roman" panose="02020603050405020304" pitchFamily="18" charset="0"/>
                <a:cs typeface="굴림" panose="020B0600000101010101" pitchFamily="50" charset="-127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To evaluate therapeutic efficacy of Bvac, mice were infected with 10</a:t>
            </a:r>
            <a:r>
              <a:rPr lang="en-US" altLang="ko-KR" sz="1200" baseline="30000" dirty="0">
                <a:latin typeface="Times New Roman" panose="02020603050405020304" pitchFamily="18" charset="0"/>
                <a:cs typeface="굴림" panose="020B0600000101010101" pitchFamily="50" charset="-127"/>
              </a:rPr>
              <a:t>7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 CFU of </a:t>
            </a:r>
            <a:r>
              <a:rPr lang="en-US" altLang="ko-KR" sz="1200" i="1" dirty="0">
                <a:latin typeface="Times New Roman" panose="02020603050405020304" pitchFamily="18" charset="0"/>
                <a:cs typeface="굴림" panose="020B0600000101010101" pitchFamily="50" charset="-127"/>
              </a:rPr>
              <a:t>M. kansasii 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per mouse, and were administrated BCG by intramuscular injection and Bvac by tail vein injection at 3 days post-infection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5 for uninfected, n=6 for saline, BCG and Bvac group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US" altLang="ko-KR" sz="1200" dirty="0" smtClean="0">
                <a:latin typeface="Times New Roman" panose="02020603050405020304" pitchFamily="18" charset="0"/>
                <a:cs typeface="굴림" panose="020B0600000101010101" pitchFamily="50" charset="-127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At 14 days following </a:t>
            </a:r>
            <a:r>
              <a:rPr lang="en-US" altLang="ko-KR" sz="1200" i="1" dirty="0">
                <a:latin typeface="Times New Roman" panose="02020603050405020304" pitchFamily="18" charset="0"/>
                <a:cs typeface="굴림" panose="020B0600000101010101" pitchFamily="50" charset="-127"/>
              </a:rPr>
              <a:t>M. kansasii</a:t>
            </a:r>
            <a:r>
              <a:rPr lang="en-US" altLang="ko-KR" sz="1200" dirty="0">
                <a:latin typeface="Times New Roman" panose="02020603050405020304" pitchFamily="18" charset="0"/>
                <a:cs typeface="굴림" panose="020B0600000101010101" pitchFamily="50" charset="-127"/>
              </a:rPr>
              <a:t> infection, bacterial CFU were determined from liver (A) and lung (B). </a:t>
            </a:r>
            <a:endParaRPr lang="ko-KR" altLang="ko-KR" sz="1200" dirty="0"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  <a:p>
            <a:pPr>
              <a:lnSpc>
                <a:spcPct val="150000"/>
              </a:lnSpc>
            </a:pPr>
            <a:r>
              <a:rPr lang="en-US" altLang="ko-KR" sz="1200" dirty="0">
                <a:latin typeface="굴림" panose="020B0600000101010101" pitchFamily="50" charset="-127"/>
                <a:ea typeface="굴림" panose="020B0600000101010101" pitchFamily="50" charset="-127"/>
                <a:cs typeface="굴림" panose="020B0600000101010101" pitchFamily="50" charset="-127"/>
              </a:rPr>
              <a:t> </a:t>
            </a:r>
            <a:endParaRPr lang="ko-KR" altLang="ko-KR" sz="1200" dirty="0"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9981230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Box 70"/>
          <p:cNvSpPr txBox="1"/>
          <p:nvPr/>
        </p:nvSpPr>
        <p:spPr>
          <a:xfrm>
            <a:off x="4318750" y="313936"/>
            <a:ext cx="2365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i="1" dirty="0" smtClean="0">
                <a:cs typeface="Times New Roman" panose="02020603050405020304" pitchFamily="18" charset="0"/>
              </a:rPr>
              <a:t>Supplementary figure 6</a:t>
            </a:r>
            <a:endParaRPr lang="ko-KR" altLang="en-US" i="1" dirty="0">
              <a:cs typeface="Times New Roman" panose="02020603050405020304" pitchFamily="18" charset="0"/>
            </a:endParaRPr>
          </a:p>
        </p:txBody>
      </p:sp>
      <p:sp>
        <p:nvSpPr>
          <p:cNvPr id="72" name="직사각형 71"/>
          <p:cNvSpPr/>
          <p:nvPr/>
        </p:nvSpPr>
        <p:spPr>
          <a:xfrm>
            <a:off x="229489" y="5916766"/>
            <a:ext cx="6359797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Mechanism of B cell-based vaccines through NKT cell activation.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ince antigen presentation induced by viral vectors, vaccinia virus expressing ESAT6 is MHC class I-dominant, an appropriate adjuvant is required to enhance the CD4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 response. αGC, which is loaded on the CD1d molecule of B cells, can act as an adjuvant for immunization. NKT cells activated by αGC up-regulate MHC class II molecules on B cells. Activated CD4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induce cytokine production for preventing or protecting against mycobacterial infection. In addition to the B cell-based vaccine, NKT cell activation using αGC induces stronger immune responses by activating NKT and CD4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 responses. As a result, the B cell-based vaccine could be a potent candidate that functions by activating CD4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 responses against mycobacterial infection. </a:t>
            </a:r>
            <a:endParaRPr lang="ko-KR" altLang="ko-KR" sz="1200" dirty="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69" name="자유형 68"/>
          <p:cNvSpPr/>
          <p:nvPr/>
        </p:nvSpPr>
        <p:spPr>
          <a:xfrm>
            <a:off x="2064896" y="3168373"/>
            <a:ext cx="123589" cy="398999"/>
          </a:xfrm>
          <a:custGeom>
            <a:avLst/>
            <a:gdLst>
              <a:gd name="connsiteX0" fmla="*/ 10062 w 221430"/>
              <a:gd name="connsiteY0" fmla="*/ 0 h 714874"/>
              <a:gd name="connsiteX1" fmla="*/ 537 w 221430"/>
              <a:gd name="connsiteY1" fmla="*/ 376237 h 714874"/>
              <a:gd name="connsiteX2" fmla="*/ 24349 w 221430"/>
              <a:gd name="connsiteY2" fmla="*/ 333375 h 714874"/>
              <a:gd name="connsiteX3" fmla="*/ 133887 w 221430"/>
              <a:gd name="connsiteY3" fmla="*/ 257175 h 714874"/>
              <a:gd name="connsiteX4" fmla="*/ 219612 w 221430"/>
              <a:gd name="connsiteY4" fmla="*/ 361950 h 714874"/>
              <a:gd name="connsiteX5" fmla="*/ 186274 w 221430"/>
              <a:gd name="connsiteY5" fmla="*/ 457200 h 714874"/>
              <a:gd name="connsiteX6" fmla="*/ 114837 w 221430"/>
              <a:gd name="connsiteY6" fmla="*/ 466725 h 714874"/>
              <a:gd name="connsiteX7" fmla="*/ 48162 w 221430"/>
              <a:gd name="connsiteY7" fmla="*/ 457200 h 714874"/>
              <a:gd name="connsiteX8" fmla="*/ 57687 w 221430"/>
              <a:gd name="connsiteY8" fmla="*/ 504825 h 714874"/>
              <a:gd name="connsiteX9" fmla="*/ 138649 w 221430"/>
              <a:gd name="connsiteY9" fmla="*/ 528637 h 714874"/>
              <a:gd name="connsiteX10" fmla="*/ 205324 w 221430"/>
              <a:gd name="connsiteY10" fmla="*/ 552450 h 714874"/>
              <a:gd name="connsiteX11" fmla="*/ 205324 w 221430"/>
              <a:gd name="connsiteY11" fmla="*/ 661987 h 714874"/>
              <a:gd name="connsiteX12" fmla="*/ 91024 w 221430"/>
              <a:gd name="connsiteY12" fmla="*/ 714375 h 714874"/>
              <a:gd name="connsiteX13" fmla="*/ 29112 w 221430"/>
              <a:gd name="connsiteY13" fmla="*/ 633412 h 714874"/>
              <a:gd name="connsiteX14" fmla="*/ 537 w 221430"/>
              <a:gd name="connsiteY14" fmla="*/ 552450 h 71487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221430" h="714874">
                <a:moveTo>
                  <a:pt x="10062" y="0"/>
                </a:moveTo>
                <a:cubicBezTo>
                  <a:pt x="4109" y="160337"/>
                  <a:pt x="-1844" y="320675"/>
                  <a:pt x="537" y="376237"/>
                </a:cubicBezTo>
                <a:cubicBezTo>
                  <a:pt x="2918" y="431799"/>
                  <a:pt x="2124" y="353219"/>
                  <a:pt x="24349" y="333375"/>
                </a:cubicBezTo>
                <a:cubicBezTo>
                  <a:pt x="46574" y="313531"/>
                  <a:pt x="101343" y="252413"/>
                  <a:pt x="133887" y="257175"/>
                </a:cubicBezTo>
                <a:cubicBezTo>
                  <a:pt x="166431" y="261937"/>
                  <a:pt x="210881" y="328613"/>
                  <a:pt x="219612" y="361950"/>
                </a:cubicBezTo>
                <a:cubicBezTo>
                  <a:pt x="228343" y="395287"/>
                  <a:pt x="203736" y="439738"/>
                  <a:pt x="186274" y="457200"/>
                </a:cubicBezTo>
                <a:cubicBezTo>
                  <a:pt x="168812" y="474662"/>
                  <a:pt x="137856" y="466725"/>
                  <a:pt x="114837" y="466725"/>
                </a:cubicBezTo>
                <a:cubicBezTo>
                  <a:pt x="91818" y="466725"/>
                  <a:pt x="57687" y="450850"/>
                  <a:pt x="48162" y="457200"/>
                </a:cubicBezTo>
                <a:cubicBezTo>
                  <a:pt x="38637" y="463550"/>
                  <a:pt x="42606" y="492919"/>
                  <a:pt x="57687" y="504825"/>
                </a:cubicBezTo>
                <a:cubicBezTo>
                  <a:pt x="72768" y="516731"/>
                  <a:pt x="114043" y="520700"/>
                  <a:pt x="138649" y="528637"/>
                </a:cubicBezTo>
                <a:cubicBezTo>
                  <a:pt x="163255" y="536574"/>
                  <a:pt x="194212" y="530225"/>
                  <a:pt x="205324" y="552450"/>
                </a:cubicBezTo>
                <a:cubicBezTo>
                  <a:pt x="216436" y="574675"/>
                  <a:pt x="224374" y="635000"/>
                  <a:pt x="205324" y="661987"/>
                </a:cubicBezTo>
                <a:cubicBezTo>
                  <a:pt x="186274" y="688974"/>
                  <a:pt x="120393" y="719137"/>
                  <a:pt x="91024" y="714375"/>
                </a:cubicBezTo>
                <a:cubicBezTo>
                  <a:pt x="61655" y="709613"/>
                  <a:pt x="44193" y="660399"/>
                  <a:pt x="29112" y="633412"/>
                </a:cubicBezTo>
                <a:cubicBezTo>
                  <a:pt x="14031" y="606425"/>
                  <a:pt x="7284" y="579437"/>
                  <a:pt x="537" y="552450"/>
                </a:cubicBezTo>
              </a:path>
            </a:pathLst>
          </a:cu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sp>
        <p:nvSpPr>
          <p:cNvPr id="146" name="자유형 145"/>
          <p:cNvSpPr/>
          <p:nvPr/>
        </p:nvSpPr>
        <p:spPr>
          <a:xfrm flipH="1">
            <a:off x="1906324" y="3168373"/>
            <a:ext cx="123589" cy="398999"/>
          </a:xfrm>
          <a:custGeom>
            <a:avLst/>
            <a:gdLst>
              <a:gd name="connsiteX0" fmla="*/ 10062 w 221430"/>
              <a:gd name="connsiteY0" fmla="*/ 0 h 714874"/>
              <a:gd name="connsiteX1" fmla="*/ 537 w 221430"/>
              <a:gd name="connsiteY1" fmla="*/ 376237 h 714874"/>
              <a:gd name="connsiteX2" fmla="*/ 24349 w 221430"/>
              <a:gd name="connsiteY2" fmla="*/ 333375 h 714874"/>
              <a:gd name="connsiteX3" fmla="*/ 133887 w 221430"/>
              <a:gd name="connsiteY3" fmla="*/ 257175 h 714874"/>
              <a:gd name="connsiteX4" fmla="*/ 219612 w 221430"/>
              <a:gd name="connsiteY4" fmla="*/ 361950 h 714874"/>
              <a:gd name="connsiteX5" fmla="*/ 186274 w 221430"/>
              <a:gd name="connsiteY5" fmla="*/ 457200 h 714874"/>
              <a:gd name="connsiteX6" fmla="*/ 114837 w 221430"/>
              <a:gd name="connsiteY6" fmla="*/ 466725 h 714874"/>
              <a:gd name="connsiteX7" fmla="*/ 48162 w 221430"/>
              <a:gd name="connsiteY7" fmla="*/ 457200 h 714874"/>
              <a:gd name="connsiteX8" fmla="*/ 57687 w 221430"/>
              <a:gd name="connsiteY8" fmla="*/ 504825 h 714874"/>
              <a:gd name="connsiteX9" fmla="*/ 138649 w 221430"/>
              <a:gd name="connsiteY9" fmla="*/ 528637 h 714874"/>
              <a:gd name="connsiteX10" fmla="*/ 205324 w 221430"/>
              <a:gd name="connsiteY10" fmla="*/ 552450 h 714874"/>
              <a:gd name="connsiteX11" fmla="*/ 205324 w 221430"/>
              <a:gd name="connsiteY11" fmla="*/ 661987 h 714874"/>
              <a:gd name="connsiteX12" fmla="*/ 91024 w 221430"/>
              <a:gd name="connsiteY12" fmla="*/ 714375 h 714874"/>
              <a:gd name="connsiteX13" fmla="*/ 29112 w 221430"/>
              <a:gd name="connsiteY13" fmla="*/ 633412 h 714874"/>
              <a:gd name="connsiteX14" fmla="*/ 537 w 221430"/>
              <a:gd name="connsiteY14" fmla="*/ 552450 h 71487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221430" h="714874">
                <a:moveTo>
                  <a:pt x="10062" y="0"/>
                </a:moveTo>
                <a:cubicBezTo>
                  <a:pt x="4109" y="160337"/>
                  <a:pt x="-1844" y="320675"/>
                  <a:pt x="537" y="376237"/>
                </a:cubicBezTo>
                <a:cubicBezTo>
                  <a:pt x="2918" y="431799"/>
                  <a:pt x="2124" y="353219"/>
                  <a:pt x="24349" y="333375"/>
                </a:cubicBezTo>
                <a:cubicBezTo>
                  <a:pt x="46574" y="313531"/>
                  <a:pt x="101343" y="252413"/>
                  <a:pt x="133887" y="257175"/>
                </a:cubicBezTo>
                <a:cubicBezTo>
                  <a:pt x="166431" y="261937"/>
                  <a:pt x="210881" y="328613"/>
                  <a:pt x="219612" y="361950"/>
                </a:cubicBezTo>
                <a:cubicBezTo>
                  <a:pt x="228343" y="395287"/>
                  <a:pt x="203736" y="439738"/>
                  <a:pt x="186274" y="457200"/>
                </a:cubicBezTo>
                <a:cubicBezTo>
                  <a:pt x="168812" y="474662"/>
                  <a:pt x="137856" y="466725"/>
                  <a:pt x="114837" y="466725"/>
                </a:cubicBezTo>
                <a:cubicBezTo>
                  <a:pt x="91818" y="466725"/>
                  <a:pt x="57687" y="450850"/>
                  <a:pt x="48162" y="457200"/>
                </a:cubicBezTo>
                <a:cubicBezTo>
                  <a:pt x="38637" y="463550"/>
                  <a:pt x="42606" y="492919"/>
                  <a:pt x="57687" y="504825"/>
                </a:cubicBezTo>
                <a:cubicBezTo>
                  <a:pt x="72768" y="516731"/>
                  <a:pt x="114043" y="520700"/>
                  <a:pt x="138649" y="528637"/>
                </a:cubicBezTo>
                <a:cubicBezTo>
                  <a:pt x="163255" y="536574"/>
                  <a:pt x="194212" y="530225"/>
                  <a:pt x="205324" y="552450"/>
                </a:cubicBezTo>
                <a:cubicBezTo>
                  <a:pt x="216436" y="574675"/>
                  <a:pt x="224374" y="635000"/>
                  <a:pt x="205324" y="661987"/>
                </a:cubicBezTo>
                <a:cubicBezTo>
                  <a:pt x="186274" y="688974"/>
                  <a:pt x="120393" y="719137"/>
                  <a:pt x="91024" y="714375"/>
                </a:cubicBezTo>
                <a:cubicBezTo>
                  <a:pt x="61655" y="709613"/>
                  <a:pt x="44193" y="660399"/>
                  <a:pt x="29112" y="633412"/>
                </a:cubicBezTo>
                <a:cubicBezTo>
                  <a:pt x="14031" y="606425"/>
                  <a:pt x="7284" y="579437"/>
                  <a:pt x="537" y="552450"/>
                </a:cubicBezTo>
              </a:path>
            </a:pathLst>
          </a:cu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grpSp>
        <p:nvGrpSpPr>
          <p:cNvPr id="62" name="그룹 61"/>
          <p:cNvGrpSpPr>
            <a:grpSpLocks noChangeAspect="1"/>
          </p:cNvGrpSpPr>
          <p:nvPr/>
        </p:nvGrpSpPr>
        <p:grpSpPr>
          <a:xfrm>
            <a:off x="1650009" y="1070317"/>
            <a:ext cx="704693" cy="649266"/>
            <a:chOff x="1814131" y="1070317"/>
            <a:chExt cx="763801" cy="703725"/>
          </a:xfrm>
        </p:grpSpPr>
        <p:sp>
          <p:nvSpPr>
            <p:cNvPr id="5" name="자유형 4"/>
            <p:cNvSpPr/>
            <p:nvPr/>
          </p:nvSpPr>
          <p:spPr bwMode="auto">
            <a:xfrm>
              <a:off x="1814131" y="1070317"/>
              <a:ext cx="763801" cy="703725"/>
            </a:xfrm>
            <a:custGeom>
              <a:avLst/>
              <a:gdLst>
                <a:gd name="connsiteX0" fmla="*/ 220723 w 566459"/>
                <a:gd name="connsiteY0" fmla="*/ 4656 h 520288"/>
                <a:gd name="connsiteX1" fmla="*/ 1648 w 566459"/>
                <a:gd name="connsiteY1" fmla="*/ 238019 h 520288"/>
                <a:gd name="connsiteX2" fmla="*/ 139760 w 566459"/>
                <a:gd name="connsiteY2" fmla="*/ 476144 h 520288"/>
                <a:gd name="connsiteX3" fmla="*/ 482660 w 566459"/>
                <a:gd name="connsiteY3" fmla="*/ 485669 h 520288"/>
                <a:gd name="connsiteX4" fmla="*/ 549335 w 566459"/>
                <a:gd name="connsiteY4" fmla="*/ 114194 h 520288"/>
                <a:gd name="connsiteX5" fmla="*/ 220723 w 566459"/>
                <a:gd name="connsiteY5" fmla="*/ 4656 h 5202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66459" h="520288">
                  <a:moveTo>
                    <a:pt x="220723" y="4656"/>
                  </a:moveTo>
                  <a:cubicBezTo>
                    <a:pt x="129442" y="25294"/>
                    <a:pt x="15142" y="159438"/>
                    <a:pt x="1648" y="238019"/>
                  </a:cubicBezTo>
                  <a:cubicBezTo>
                    <a:pt x="-11846" y="316600"/>
                    <a:pt x="59591" y="434869"/>
                    <a:pt x="139760" y="476144"/>
                  </a:cubicBezTo>
                  <a:cubicBezTo>
                    <a:pt x="219929" y="517419"/>
                    <a:pt x="414398" y="545994"/>
                    <a:pt x="482660" y="485669"/>
                  </a:cubicBezTo>
                  <a:cubicBezTo>
                    <a:pt x="550922" y="425344"/>
                    <a:pt x="591404" y="194363"/>
                    <a:pt x="549335" y="114194"/>
                  </a:cubicBezTo>
                  <a:cubicBezTo>
                    <a:pt x="507266" y="34025"/>
                    <a:pt x="312004" y="-15982"/>
                    <a:pt x="220723" y="4656"/>
                  </a:cubicBezTo>
                  <a:close/>
                </a:path>
              </a:pathLst>
            </a:custGeom>
            <a:solidFill>
              <a:schemeClr val="accent5">
                <a:lumMod val="20000"/>
                <a:lumOff val="80000"/>
              </a:schemeClr>
            </a:solidFill>
            <a:ln w="3175"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kumimoji="1" lang="ko-KR" altLang="en-US" sz="1200">
                <a:solidFill>
                  <a:prstClr val="white"/>
                </a:solidFill>
              </a:endParaRPr>
            </a:p>
          </p:txBody>
        </p:sp>
        <p:sp>
          <p:nvSpPr>
            <p:cNvPr id="6" name="자유형 5"/>
            <p:cNvSpPr/>
            <p:nvPr/>
          </p:nvSpPr>
          <p:spPr bwMode="auto">
            <a:xfrm rot="1392245">
              <a:off x="2046730" y="1307265"/>
              <a:ext cx="443076" cy="382349"/>
            </a:xfrm>
            <a:custGeom>
              <a:avLst/>
              <a:gdLst>
                <a:gd name="connsiteX0" fmla="*/ 69738 w 223419"/>
                <a:gd name="connsiteY0" fmla="*/ 29871 h 244358"/>
                <a:gd name="connsiteX1" fmla="*/ 3063 w 223419"/>
                <a:gd name="connsiteY1" fmla="*/ 172746 h 244358"/>
                <a:gd name="connsiteX2" fmla="*/ 174513 w 223419"/>
                <a:gd name="connsiteY2" fmla="*/ 239421 h 244358"/>
                <a:gd name="connsiteX3" fmla="*/ 222138 w 223419"/>
                <a:gd name="connsiteY3" fmla="*/ 44158 h 244358"/>
                <a:gd name="connsiteX4" fmla="*/ 136413 w 223419"/>
                <a:gd name="connsiteY4" fmla="*/ 1296 h 244358"/>
                <a:gd name="connsiteX5" fmla="*/ 69738 w 223419"/>
                <a:gd name="connsiteY5" fmla="*/ 29871 h 244358"/>
                <a:gd name="connsiteX0" fmla="*/ 16966 w 242109"/>
                <a:gd name="connsiteY0" fmla="*/ 9182 h 282599"/>
                <a:gd name="connsiteX1" fmla="*/ 21753 w 242109"/>
                <a:gd name="connsiteY1" fmla="*/ 210289 h 282599"/>
                <a:gd name="connsiteX2" fmla="*/ 193203 w 242109"/>
                <a:gd name="connsiteY2" fmla="*/ 276964 h 282599"/>
                <a:gd name="connsiteX3" fmla="*/ 240828 w 242109"/>
                <a:gd name="connsiteY3" fmla="*/ 81701 h 282599"/>
                <a:gd name="connsiteX4" fmla="*/ 155103 w 242109"/>
                <a:gd name="connsiteY4" fmla="*/ 38839 h 282599"/>
                <a:gd name="connsiteX5" fmla="*/ 16966 w 242109"/>
                <a:gd name="connsiteY5" fmla="*/ 9182 h 282599"/>
                <a:gd name="connsiteX0" fmla="*/ 19303 w 244446"/>
                <a:gd name="connsiteY0" fmla="*/ 88609 h 362026"/>
                <a:gd name="connsiteX1" fmla="*/ 24090 w 244446"/>
                <a:gd name="connsiteY1" fmla="*/ 289716 h 362026"/>
                <a:gd name="connsiteX2" fmla="*/ 195540 w 244446"/>
                <a:gd name="connsiteY2" fmla="*/ 356391 h 362026"/>
                <a:gd name="connsiteX3" fmla="*/ 243165 w 244446"/>
                <a:gd name="connsiteY3" fmla="*/ 161128 h 362026"/>
                <a:gd name="connsiteX4" fmla="*/ 193170 w 244446"/>
                <a:gd name="connsiteY4" fmla="*/ 1802 h 362026"/>
                <a:gd name="connsiteX5" fmla="*/ 19303 w 244446"/>
                <a:gd name="connsiteY5" fmla="*/ 88609 h 362026"/>
                <a:gd name="connsiteX0" fmla="*/ 19303 w 322115"/>
                <a:gd name="connsiteY0" fmla="*/ 89327 h 361750"/>
                <a:gd name="connsiteX1" fmla="*/ 24090 w 322115"/>
                <a:gd name="connsiteY1" fmla="*/ 290434 h 361750"/>
                <a:gd name="connsiteX2" fmla="*/ 195540 w 322115"/>
                <a:gd name="connsiteY2" fmla="*/ 357109 h 361750"/>
                <a:gd name="connsiteX3" fmla="*/ 321771 w 322115"/>
                <a:gd name="connsiteY3" fmla="*/ 178484 h 361750"/>
                <a:gd name="connsiteX4" fmla="*/ 193170 w 322115"/>
                <a:gd name="connsiteY4" fmla="*/ 2520 h 361750"/>
                <a:gd name="connsiteX5" fmla="*/ 19303 w 322115"/>
                <a:gd name="connsiteY5" fmla="*/ 89327 h 361750"/>
                <a:gd name="connsiteX0" fmla="*/ 20995 w 323970"/>
                <a:gd name="connsiteY0" fmla="*/ 89327 h 393526"/>
                <a:gd name="connsiteX1" fmla="*/ 25782 w 323970"/>
                <a:gd name="connsiteY1" fmla="*/ 290434 h 393526"/>
                <a:gd name="connsiteX2" fmla="*/ 225816 w 323970"/>
                <a:gd name="connsiteY2" fmla="*/ 390385 h 393526"/>
                <a:gd name="connsiteX3" fmla="*/ 323463 w 323970"/>
                <a:gd name="connsiteY3" fmla="*/ 178484 h 393526"/>
                <a:gd name="connsiteX4" fmla="*/ 194862 w 323970"/>
                <a:gd name="connsiteY4" fmla="*/ 2520 h 393526"/>
                <a:gd name="connsiteX5" fmla="*/ 20995 w 323970"/>
                <a:gd name="connsiteY5" fmla="*/ 89327 h 393526"/>
                <a:gd name="connsiteX0" fmla="*/ 83227 w 386337"/>
                <a:gd name="connsiteY0" fmla="*/ 89719 h 403775"/>
                <a:gd name="connsiteX1" fmla="*/ 9407 w 386337"/>
                <a:gd name="connsiteY1" fmla="*/ 349058 h 403775"/>
                <a:gd name="connsiteX2" fmla="*/ 288048 w 386337"/>
                <a:gd name="connsiteY2" fmla="*/ 390777 h 403775"/>
                <a:gd name="connsiteX3" fmla="*/ 385695 w 386337"/>
                <a:gd name="connsiteY3" fmla="*/ 178876 h 403775"/>
                <a:gd name="connsiteX4" fmla="*/ 257094 w 386337"/>
                <a:gd name="connsiteY4" fmla="*/ 2912 h 403775"/>
                <a:gd name="connsiteX5" fmla="*/ 83227 w 386337"/>
                <a:gd name="connsiteY5" fmla="*/ 89719 h 403775"/>
                <a:gd name="connsiteX0" fmla="*/ 34024 w 408594"/>
                <a:gd name="connsiteY0" fmla="*/ 61951 h 410458"/>
                <a:gd name="connsiteX1" fmla="*/ 31664 w 408594"/>
                <a:gd name="connsiteY1" fmla="*/ 354566 h 410458"/>
                <a:gd name="connsiteX2" fmla="*/ 310305 w 408594"/>
                <a:gd name="connsiteY2" fmla="*/ 396285 h 410458"/>
                <a:gd name="connsiteX3" fmla="*/ 407952 w 408594"/>
                <a:gd name="connsiteY3" fmla="*/ 184384 h 410458"/>
                <a:gd name="connsiteX4" fmla="*/ 279351 w 408594"/>
                <a:gd name="connsiteY4" fmla="*/ 8420 h 410458"/>
                <a:gd name="connsiteX5" fmla="*/ 34024 w 408594"/>
                <a:gd name="connsiteY5" fmla="*/ 61951 h 41045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408594" h="410458">
                  <a:moveTo>
                    <a:pt x="34024" y="61951"/>
                  </a:moveTo>
                  <a:cubicBezTo>
                    <a:pt x="-7257" y="119642"/>
                    <a:pt x="-14383" y="298844"/>
                    <a:pt x="31664" y="354566"/>
                  </a:cubicBezTo>
                  <a:cubicBezTo>
                    <a:pt x="77711" y="410288"/>
                    <a:pt x="247590" y="424649"/>
                    <a:pt x="310305" y="396285"/>
                  </a:cubicBezTo>
                  <a:cubicBezTo>
                    <a:pt x="373020" y="367921"/>
                    <a:pt x="414302" y="224071"/>
                    <a:pt x="407952" y="184384"/>
                  </a:cubicBezTo>
                  <a:cubicBezTo>
                    <a:pt x="401602" y="144697"/>
                    <a:pt x="341672" y="28826"/>
                    <a:pt x="279351" y="8420"/>
                  </a:cubicBezTo>
                  <a:cubicBezTo>
                    <a:pt x="217030" y="-11986"/>
                    <a:pt x="75305" y="4260"/>
                    <a:pt x="34024" y="61951"/>
                  </a:cubicBezTo>
                  <a:close/>
                </a:path>
              </a:pathLst>
            </a:custGeom>
            <a:gradFill flip="none" rotWithShape="1">
              <a:gsLst>
                <a:gs pos="0">
                  <a:schemeClr val="accent1">
                    <a:lumMod val="20000"/>
                    <a:lumOff val="80000"/>
                  </a:schemeClr>
                </a:gs>
                <a:gs pos="50000">
                  <a:schemeClr val="accent5">
                    <a:lumMod val="60000"/>
                    <a:lumOff val="40000"/>
                    <a:shade val="67500"/>
                    <a:satMod val="115000"/>
                  </a:schemeClr>
                </a:gs>
                <a:gs pos="100000">
                  <a:schemeClr val="accent5">
                    <a:lumMod val="60000"/>
                    <a:lumOff val="40000"/>
                    <a:shade val="100000"/>
                    <a:satMod val="115000"/>
                  </a:schemeClr>
                </a:gs>
              </a:gsLst>
              <a:lin ang="13500000" scaled="1"/>
              <a:tileRect/>
            </a:gradFill>
            <a:ln w="3175"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kumimoji="1" lang="ko-KR" altLang="en-US" sz="1200">
                <a:solidFill>
                  <a:prstClr val="white"/>
                </a:solidFill>
              </a:endParaRP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2384342" y="129363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 cell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cxnSp>
        <p:nvCxnSpPr>
          <p:cNvPr id="8" name="직선 화살표 연결선 7"/>
          <p:cNvCxnSpPr/>
          <p:nvPr/>
        </p:nvCxnSpPr>
        <p:spPr>
          <a:xfrm>
            <a:off x="2031909" y="1842008"/>
            <a:ext cx="0" cy="601579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885550" y="1578681"/>
            <a:ext cx="942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vacESAT6 </a:t>
            </a:r>
            <a:endParaRPr lang="ko-KR" altLang="en-US" sz="12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421386" y="1863037"/>
            <a:ext cx="5036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αGC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pSp>
        <p:nvGrpSpPr>
          <p:cNvPr id="64" name="그룹 63"/>
          <p:cNvGrpSpPr/>
          <p:nvPr/>
        </p:nvGrpSpPr>
        <p:grpSpPr>
          <a:xfrm>
            <a:off x="3315870" y="2507122"/>
            <a:ext cx="721529" cy="713354"/>
            <a:chOff x="3479992" y="2507122"/>
            <a:chExt cx="721529" cy="713354"/>
          </a:xfrm>
        </p:grpSpPr>
        <p:sp>
          <p:nvSpPr>
            <p:cNvPr id="30" name="자유형 29"/>
            <p:cNvSpPr/>
            <p:nvPr/>
          </p:nvSpPr>
          <p:spPr bwMode="auto">
            <a:xfrm rot="15979521">
              <a:off x="3484080" y="2503034"/>
              <a:ext cx="713354" cy="721529"/>
            </a:xfrm>
            <a:custGeom>
              <a:avLst/>
              <a:gdLst>
                <a:gd name="connsiteX0" fmla="*/ 184435 w 554963"/>
                <a:gd name="connsiteY0" fmla="*/ 39905 h 574227"/>
                <a:gd name="connsiteX1" fmla="*/ 17747 w 554963"/>
                <a:gd name="connsiteY1" fmla="*/ 178018 h 574227"/>
                <a:gd name="connsiteX2" fmla="*/ 22510 w 554963"/>
                <a:gd name="connsiteY2" fmla="*/ 406618 h 574227"/>
                <a:gd name="connsiteX3" fmla="*/ 174910 w 554963"/>
                <a:gd name="connsiteY3" fmla="*/ 568543 h 574227"/>
                <a:gd name="connsiteX4" fmla="*/ 436847 w 554963"/>
                <a:gd name="connsiteY4" fmla="*/ 511393 h 574227"/>
                <a:gd name="connsiteX5" fmla="*/ 551147 w 554963"/>
                <a:gd name="connsiteY5" fmla="*/ 263743 h 574227"/>
                <a:gd name="connsiteX6" fmla="*/ 308260 w 554963"/>
                <a:gd name="connsiteY6" fmla="*/ 16093 h 574227"/>
                <a:gd name="connsiteX7" fmla="*/ 184435 w 554963"/>
                <a:gd name="connsiteY7" fmla="*/ 39905 h 574227"/>
                <a:gd name="connsiteX0" fmla="*/ 184435 w 554309"/>
                <a:gd name="connsiteY0" fmla="*/ 25566 h 559888"/>
                <a:gd name="connsiteX1" fmla="*/ 17747 w 554309"/>
                <a:gd name="connsiteY1" fmla="*/ 163679 h 559888"/>
                <a:gd name="connsiteX2" fmla="*/ 22510 w 554309"/>
                <a:gd name="connsiteY2" fmla="*/ 392279 h 559888"/>
                <a:gd name="connsiteX3" fmla="*/ 174910 w 554309"/>
                <a:gd name="connsiteY3" fmla="*/ 554204 h 559888"/>
                <a:gd name="connsiteX4" fmla="*/ 436847 w 554309"/>
                <a:gd name="connsiteY4" fmla="*/ 497054 h 559888"/>
                <a:gd name="connsiteX5" fmla="*/ 551147 w 554309"/>
                <a:gd name="connsiteY5" fmla="*/ 249404 h 559888"/>
                <a:gd name="connsiteX6" fmla="*/ 432085 w 554309"/>
                <a:gd name="connsiteY6" fmla="*/ 49379 h 559888"/>
                <a:gd name="connsiteX7" fmla="*/ 308260 w 554309"/>
                <a:gd name="connsiteY7" fmla="*/ 1754 h 559888"/>
                <a:gd name="connsiteX8" fmla="*/ 184435 w 554309"/>
                <a:gd name="connsiteY8" fmla="*/ 25566 h 5598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54309" h="559888">
                  <a:moveTo>
                    <a:pt x="184435" y="25566"/>
                  </a:moveTo>
                  <a:cubicBezTo>
                    <a:pt x="136016" y="52554"/>
                    <a:pt x="44734" y="102560"/>
                    <a:pt x="17747" y="163679"/>
                  </a:cubicBezTo>
                  <a:cubicBezTo>
                    <a:pt x="-9240" y="224798"/>
                    <a:pt x="-3684" y="327192"/>
                    <a:pt x="22510" y="392279"/>
                  </a:cubicBezTo>
                  <a:cubicBezTo>
                    <a:pt x="48704" y="457366"/>
                    <a:pt x="105854" y="536742"/>
                    <a:pt x="174910" y="554204"/>
                  </a:cubicBezTo>
                  <a:cubicBezTo>
                    <a:pt x="243966" y="571666"/>
                    <a:pt x="374141" y="547854"/>
                    <a:pt x="436847" y="497054"/>
                  </a:cubicBezTo>
                  <a:cubicBezTo>
                    <a:pt x="499553" y="446254"/>
                    <a:pt x="570197" y="332748"/>
                    <a:pt x="551147" y="249404"/>
                  </a:cubicBezTo>
                  <a:cubicBezTo>
                    <a:pt x="532097" y="166060"/>
                    <a:pt x="472566" y="90654"/>
                    <a:pt x="432085" y="49379"/>
                  </a:cubicBezTo>
                  <a:cubicBezTo>
                    <a:pt x="391604" y="8104"/>
                    <a:pt x="349535" y="5723"/>
                    <a:pt x="308260" y="1754"/>
                  </a:cubicBezTo>
                  <a:cubicBezTo>
                    <a:pt x="266985" y="-2215"/>
                    <a:pt x="232854" y="-1422"/>
                    <a:pt x="184435" y="25566"/>
                  </a:cubicBezTo>
                  <a:close/>
                </a:path>
              </a:pathLst>
            </a:custGeom>
            <a:gradFill flip="none" rotWithShape="1">
              <a:gsLst>
                <a:gs pos="0">
                  <a:schemeClr val="accent2">
                    <a:lumMod val="40000"/>
                    <a:lumOff val="60000"/>
                  </a:schemeClr>
                </a:gs>
                <a:gs pos="23000">
                  <a:schemeClr val="accent2">
                    <a:lumMod val="20000"/>
                    <a:lumOff val="80000"/>
                  </a:schemeClr>
                </a:gs>
                <a:gs pos="100000">
                  <a:schemeClr val="bg1"/>
                </a:gs>
              </a:gsLst>
              <a:lin ang="13500000" scaled="1"/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kumimoji="1" lang="ko-KR" altLang="en-US" sz="1200">
                <a:solidFill>
                  <a:prstClr val="white"/>
                </a:solidFill>
              </a:endParaRPr>
            </a:p>
          </p:txBody>
        </p:sp>
        <p:sp>
          <p:nvSpPr>
            <p:cNvPr id="31" name="자유형 30"/>
            <p:cNvSpPr/>
            <p:nvPr/>
          </p:nvSpPr>
          <p:spPr bwMode="auto">
            <a:xfrm rot="15979521">
              <a:off x="3674863" y="2750919"/>
              <a:ext cx="363781" cy="422113"/>
            </a:xfrm>
            <a:custGeom>
              <a:avLst/>
              <a:gdLst>
                <a:gd name="connsiteX0" fmla="*/ 29112 w 350755"/>
                <a:gd name="connsiteY0" fmla="*/ 36326 h 315757"/>
                <a:gd name="connsiteX1" fmla="*/ 224374 w 350755"/>
                <a:gd name="connsiteY1" fmla="*/ 2988 h 315757"/>
                <a:gd name="connsiteX2" fmla="*/ 348199 w 350755"/>
                <a:gd name="connsiteY2" fmla="*/ 112526 h 315757"/>
                <a:gd name="connsiteX3" fmla="*/ 295812 w 350755"/>
                <a:gd name="connsiteY3" fmla="*/ 274451 h 315757"/>
                <a:gd name="connsiteX4" fmla="*/ 152937 w 350755"/>
                <a:gd name="connsiteY4" fmla="*/ 312551 h 315757"/>
                <a:gd name="connsiteX5" fmla="*/ 10062 w 350755"/>
                <a:gd name="connsiteY5" fmla="*/ 212538 h 315757"/>
                <a:gd name="connsiteX6" fmla="*/ 14824 w 350755"/>
                <a:gd name="connsiteY6" fmla="*/ 93476 h 315757"/>
                <a:gd name="connsiteX7" fmla="*/ 29112 w 350755"/>
                <a:gd name="connsiteY7" fmla="*/ 36326 h 315757"/>
                <a:gd name="connsiteX0" fmla="*/ 108090 w 353533"/>
                <a:gd name="connsiteY0" fmla="*/ 14981 h 322987"/>
                <a:gd name="connsiteX1" fmla="*/ 227152 w 353533"/>
                <a:gd name="connsiteY1" fmla="*/ 10218 h 322987"/>
                <a:gd name="connsiteX2" fmla="*/ 350977 w 353533"/>
                <a:gd name="connsiteY2" fmla="*/ 119756 h 322987"/>
                <a:gd name="connsiteX3" fmla="*/ 298590 w 353533"/>
                <a:gd name="connsiteY3" fmla="*/ 281681 h 322987"/>
                <a:gd name="connsiteX4" fmla="*/ 155715 w 353533"/>
                <a:gd name="connsiteY4" fmla="*/ 319781 h 322987"/>
                <a:gd name="connsiteX5" fmla="*/ 12840 w 353533"/>
                <a:gd name="connsiteY5" fmla="*/ 219768 h 322987"/>
                <a:gd name="connsiteX6" fmla="*/ 17602 w 353533"/>
                <a:gd name="connsiteY6" fmla="*/ 100706 h 322987"/>
                <a:gd name="connsiteX7" fmla="*/ 108090 w 353533"/>
                <a:gd name="connsiteY7" fmla="*/ 14981 h 3229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53533" h="322987">
                  <a:moveTo>
                    <a:pt x="108090" y="14981"/>
                  </a:moveTo>
                  <a:cubicBezTo>
                    <a:pt x="143015" y="-100"/>
                    <a:pt x="186671" y="-7244"/>
                    <a:pt x="227152" y="10218"/>
                  </a:cubicBezTo>
                  <a:cubicBezTo>
                    <a:pt x="267633" y="27680"/>
                    <a:pt x="339071" y="74512"/>
                    <a:pt x="350977" y="119756"/>
                  </a:cubicBezTo>
                  <a:cubicBezTo>
                    <a:pt x="362883" y="165000"/>
                    <a:pt x="331134" y="248344"/>
                    <a:pt x="298590" y="281681"/>
                  </a:cubicBezTo>
                  <a:cubicBezTo>
                    <a:pt x="266046" y="315019"/>
                    <a:pt x="203340" y="330100"/>
                    <a:pt x="155715" y="319781"/>
                  </a:cubicBezTo>
                  <a:cubicBezTo>
                    <a:pt x="108090" y="309462"/>
                    <a:pt x="35859" y="256280"/>
                    <a:pt x="12840" y="219768"/>
                  </a:cubicBezTo>
                  <a:cubicBezTo>
                    <a:pt x="-10179" y="183256"/>
                    <a:pt x="1727" y="134837"/>
                    <a:pt x="17602" y="100706"/>
                  </a:cubicBezTo>
                  <a:cubicBezTo>
                    <a:pt x="33477" y="66575"/>
                    <a:pt x="73165" y="30062"/>
                    <a:pt x="108090" y="14981"/>
                  </a:cubicBezTo>
                  <a:close/>
                </a:path>
              </a:pathLst>
            </a:custGeom>
            <a:gradFill flip="none" rotWithShape="1">
              <a:gsLst>
                <a:gs pos="0">
                  <a:srgbClr val="C00000"/>
                </a:gs>
                <a:gs pos="65000">
                  <a:srgbClr val="C00000">
                    <a:tint val="44500"/>
                    <a:satMod val="160000"/>
                  </a:srgbClr>
                </a:gs>
                <a:gs pos="100000">
                  <a:srgbClr val="C00000">
                    <a:tint val="23500"/>
                    <a:satMod val="160000"/>
                  </a:srgbClr>
                </a:gs>
              </a:gsLst>
              <a:lin ang="13500000" scaled="1"/>
              <a:tileRect/>
            </a:gradFill>
            <a:ln w="3175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kumimoji="1" lang="ko-KR" altLang="en-US" sz="1200">
                <a:solidFill>
                  <a:prstClr val="white"/>
                </a:solidFill>
              </a:endParaRP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1013073" y="2716813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B cell</a:t>
            </a:r>
            <a:endParaRPr lang="ko-KR" altLang="en-US" sz="12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044722" y="2733259"/>
            <a:ext cx="7621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NKT cell</a:t>
            </a:r>
            <a:endParaRPr lang="ko-KR" altLang="en-US" sz="12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7" name="자유형 36"/>
          <p:cNvSpPr/>
          <p:nvPr/>
        </p:nvSpPr>
        <p:spPr bwMode="auto">
          <a:xfrm rot="15979521">
            <a:off x="1714202" y="3915209"/>
            <a:ext cx="721126" cy="727993"/>
          </a:xfrm>
          <a:custGeom>
            <a:avLst/>
            <a:gdLst>
              <a:gd name="connsiteX0" fmla="*/ 184435 w 554963"/>
              <a:gd name="connsiteY0" fmla="*/ 39905 h 574227"/>
              <a:gd name="connsiteX1" fmla="*/ 17747 w 554963"/>
              <a:gd name="connsiteY1" fmla="*/ 178018 h 574227"/>
              <a:gd name="connsiteX2" fmla="*/ 22510 w 554963"/>
              <a:gd name="connsiteY2" fmla="*/ 406618 h 574227"/>
              <a:gd name="connsiteX3" fmla="*/ 174910 w 554963"/>
              <a:gd name="connsiteY3" fmla="*/ 568543 h 574227"/>
              <a:gd name="connsiteX4" fmla="*/ 436847 w 554963"/>
              <a:gd name="connsiteY4" fmla="*/ 511393 h 574227"/>
              <a:gd name="connsiteX5" fmla="*/ 551147 w 554963"/>
              <a:gd name="connsiteY5" fmla="*/ 263743 h 574227"/>
              <a:gd name="connsiteX6" fmla="*/ 308260 w 554963"/>
              <a:gd name="connsiteY6" fmla="*/ 16093 h 574227"/>
              <a:gd name="connsiteX7" fmla="*/ 184435 w 554963"/>
              <a:gd name="connsiteY7" fmla="*/ 39905 h 574227"/>
              <a:gd name="connsiteX0" fmla="*/ 184435 w 554309"/>
              <a:gd name="connsiteY0" fmla="*/ 25566 h 559888"/>
              <a:gd name="connsiteX1" fmla="*/ 17747 w 554309"/>
              <a:gd name="connsiteY1" fmla="*/ 163679 h 559888"/>
              <a:gd name="connsiteX2" fmla="*/ 22510 w 554309"/>
              <a:gd name="connsiteY2" fmla="*/ 392279 h 559888"/>
              <a:gd name="connsiteX3" fmla="*/ 174910 w 554309"/>
              <a:gd name="connsiteY3" fmla="*/ 554204 h 559888"/>
              <a:gd name="connsiteX4" fmla="*/ 436847 w 554309"/>
              <a:gd name="connsiteY4" fmla="*/ 497054 h 559888"/>
              <a:gd name="connsiteX5" fmla="*/ 551147 w 554309"/>
              <a:gd name="connsiteY5" fmla="*/ 249404 h 559888"/>
              <a:gd name="connsiteX6" fmla="*/ 432085 w 554309"/>
              <a:gd name="connsiteY6" fmla="*/ 49379 h 559888"/>
              <a:gd name="connsiteX7" fmla="*/ 308260 w 554309"/>
              <a:gd name="connsiteY7" fmla="*/ 1754 h 559888"/>
              <a:gd name="connsiteX8" fmla="*/ 184435 w 554309"/>
              <a:gd name="connsiteY8" fmla="*/ 25566 h 5598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54309" h="559888">
                <a:moveTo>
                  <a:pt x="184435" y="25566"/>
                </a:moveTo>
                <a:cubicBezTo>
                  <a:pt x="136016" y="52554"/>
                  <a:pt x="44734" y="102560"/>
                  <a:pt x="17747" y="163679"/>
                </a:cubicBezTo>
                <a:cubicBezTo>
                  <a:pt x="-9240" y="224798"/>
                  <a:pt x="-3684" y="327192"/>
                  <a:pt x="22510" y="392279"/>
                </a:cubicBezTo>
                <a:cubicBezTo>
                  <a:pt x="48704" y="457366"/>
                  <a:pt x="105854" y="536742"/>
                  <a:pt x="174910" y="554204"/>
                </a:cubicBezTo>
                <a:cubicBezTo>
                  <a:pt x="243966" y="571666"/>
                  <a:pt x="374141" y="547854"/>
                  <a:pt x="436847" y="497054"/>
                </a:cubicBezTo>
                <a:cubicBezTo>
                  <a:pt x="499553" y="446254"/>
                  <a:pt x="570197" y="332748"/>
                  <a:pt x="551147" y="249404"/>
                </a:cubicBezTo>
                <a:cubicBezTo>
                  <a:pt x="532097" y="166060"/>
                  <a:pt x="472566" y="90654"/>
                  <a:pt x="432085" y="49379"/>
                </a:cubicBezTo>
                <a:cubicBezTo>
                  <a:pt x="391604" y="8104"/>
                  <a:pt x="349535" y="5723"/>
                  <a:pt x="308260" y="1754"/>
                </a:cubicBezTo>
                <a:cubicBezTo>
                  <a:pt x="266985" y="-2215"/>
                  <a:pt x="232854" y="-1422"/>
                  <a:pt x="184435" y="25566"/>
                </a:cubicBezTo>
                <a:close/>
              </a:path>
            </a:pathLst>
          </a:custGeom>
          <a:gradFill flip="none" rotWithShape="1">
            <a:gsLst>
              <a:gs pos="0">
                <a:srgbClr val="CCFF66">
                  <a:tint val="66000"/>
                  <a:satMod val="160000"/>
                </a:srgbClr>
              </a:gs>
              <a:gs pos="50000">
                <a:srgbClr val="CCFF66">
                  <a:tint val="44500"/>
                  <a:satMod val="160000"/>
                </a:srgbClr>
              </a:gs>
              <a:gs pos="100000">
                <a:srgbClr val="CCFF66">
                  <a:tint val="23500"/>
                  <a:satMod val="160000"/>
                </a:srgbClr>
              </a:gs>
            </a:gsLst>
            <a:lin ang="13500000" scaled="1"/>
            <a:tileRect/>
          </a:gradFill>
          <a:ln w="3175"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ko-KR" altLang="en-US" sz="1200">
              <a:solidFill>
                <a:prstClr val="white"/>
              </a:solidFill>
            </a:endParaRPr>
          </a:p>
        </p:txBody>
      </p:sp>
      <p:sp>
        <p:nvSpPr>
          <p:cNvPr id="38" name="자유형 37"/>
          <p:cNvSpPr/>
          <p:nvPr/>
        </p:nvSpPr>
        <p:spPr bwMode="auto">
          <a:xfrm rot="15979521">
            <a:off x="1930362" y="4121475"/>
            <a:ext cx="406230" cy="456392"/>
          </a:xfrm>
          <a:custGeom>
            <a:avLst/>
            <a:gdLst>
              <a:gd name="connsiteX0" fmla="*/ 29112 w 350755"/>
              <a:gd name="connsiteY0" fmla="*/ 36326 h 315757"/>
              <a:gd name="connsiteX1" fmla="*/ 224374 w 350755"/>
              <a:gd name="connsiteY1" fmla="*/ 2988 h 315757"/>
              <a:gd name="connsiteX2" fmla="*/ 348199 w 350755"/>
              <a:gd name="connsiteY2" fmla="*/ 112526 h 315757"/>
              <a:gd name="connsiteX3" fmla="*/ 295812 w 350755"/>
              <a:gd name="connsiteY3" fmla="*/ 274451 h 315757"/>
              <a:gd name="connsiteX4" fmla="*/ 152937 w 350755"/>
              <a:gd name="connsiteY4" fmla="*/ 312551 h 315757"/>
              <a:gd name="connsiteX5" fmla="*/ 10062 w 350755"/>
              <a:gd name="connsiteY5" fmla="*/ 212538 h 315757"/>
              <a:gd name="connsiteX6" fmla="*/ 14824 w 350755"/>
              <a:gd name="connsiteY6" fmla="*/ 93476 h 315757"/>
              <a:gd name="connsiteX7" fmla="*/ 29112 w 350755"/>
              <a:gd name="connsiteY7" fmla="*/ 36326 h 315757"/>
              <a:gd name="connsiteX0" fmla="*/ 108090 w 353533"/>
              <a:gd name="connsiteY0" fmla="*/ 14981 h 322987"/>
              <a:gd name="connsiteX1" fmla="*/ 227152 w 353533"/>
              <a:gd name="connsiteY1" fmla="*/ 10218 h 322987"/>
              <a:gd name="connsiteX2" fmla="*/ 350977 w 353533"/>
              <a:gd name="connsiteY2" fmla="*/ 119756 h 322987"/>
              <a:gd name="connsiteX3" fmla="*/ 298590 w 353533"/>
              <a:gd name="connsiteY3" fmla="*/ 281681 h 322987"/>
              <a:gd name="connsiteX4" fmla="*/ 155715 w 353533"/>
              <a:gd name="connsiteY4" fmla="*/ 319781 h 322987"/>
              <a:gd name="connsiteX5" fmla="*/ 12840 w 353533"/>
              <a:gd name="connsiteY5" fmla="*/ 219768 h 322987"/>
              <a:gd name="connsiteX6" fmla="*/ 17602 w 353533"/>
              <a:gd name="connsiteY6" fmla="*/ 100706 h 322987"/>
              <a:gd name="connsiteX7" fmla="*/ 108090 w 353533"/>
              <a:gd name="connsiteY7" fmla="*/ 14981 h 322987"/>
              <a:gd name="connsiteX0" fmla="*/ 108090 w 573010"/>
              <a:gd name="connsiteY0" fmla="*/ 15666 h 323513"/>
              <a:gd name="connsiteX1" fmla="*/ 227152 w 573010"/>
              <a:gd name="connsiteY1" fmla="*/ 10903 h 323513"/>
              <a:gd name="connsiteX2" fmla="*/ 572538 w 573010"/>
              <a:gd name="connsiteY2" fmla="*/ 130023 h 323513"/>
              <a:gd name="connsiteX3" fmla="*/ 298590 w 573010"/>
              <a:gd name="connsiteY3" fmla="*/ 282366 h 323513"/>
              <a:gd name="connsiteX4" fmla="*/ 155715 w 573010"/>
              <a:gd name="connsiteY4" fmla="*/ 320466 h 323513"/>
              <a:gd name="connsiteX5" fmla="*/ 12840 w 573010"/>
              <a:gd name="connsiteY5" fmla="*/ 220453 h 323513"/>
              <a:gd name="connsiteX6" fmla="*/ 17602 w 573010"/>
              <a:gd name="connsiteY6" fmla="*/ 101391 h 323513"/>
              <a:gd name="connsiteX7" fmla="*/ 108090 w 573010"/>
              <a:gd name="connsiteY7" fmla="*/ 15666 h 323513"/>
              <a:gd name="connsiteX0" fmla="*/ 108090 w 575759"/>
              <a:gd name="connsiteY0" fmla="*/ 15666 h 384941"/>
              <a:gd name="connsiteX1" fmla="*/ 227152 w 575759"/>
              <a:gd name="connsiteY1" fmla="*/ 10903 h 384941"/>
              <a:gd name="connsiteX2" fmla="*/ 572538 w 575759"/>
              <a:gd name="connsiteY2" fmla="*/ 130023 h 384941"/>
              <a:gd name="connsiteX3" fmla="*/ 386064 w 575759"/>
              <a:gd name="connsiteY3" fmla="*/ 376042 h 384941"/>
              <a:gd name="connsiteX4" fmla="*/ 155715 w 575759"/>
              <a:gd name="connsiteY4" fmla="*/ 320466 h 384941"/>
              <a:gd name="connsiteX5" fmla="*/ 12840 w 575759"/>
              <a:gd name="connsiteY5" fmla="*/ 220453 h 384941"/>
              <a:gd name="connsiteX6" fmla="*/ 17602 w 575759"/>
              <a:gd name="connsiteY6" fmla="*/ 101391 h 384941"/>
              <a:gd name="connsiteX7" fmla="*/ 108090 w 575759"/>
              <a:gd name="connsiteY7" fmla="*/ 15666 h 384941"/>
              <a:gd name="connsiteX0" fmla="*/ 108090 w 572650"/>
              <a:gd name="connsiteY0" fmla="*/ 82131 h 451406"/>
              <a:gd name="connsiteX1" fmla="*/ 360293 w 572650"/>
              <a:gd name="connsiteY1" fmla="*/ 3223 h 451406"/>
              <a:gd name="connsiteX2" fmla="*/ 572538 w 572650"/>
              <a:gd name="connsiteY2" fmla="*/ 196488 h 451406"/>
              <a:gd name="connsiteX3" fmla="*/ 386064 w 572650"/>
              <a:gd name="connsiteY3" fmla="*/ 442507 h 451406"/>
              <a:gd name="connsiteX4" fmla="*/ 155715 w 572650"/>
              <a:gd name="connsiteY4" fmla="*/ 386931 h 451406"/>
              <a:gd name="connsiteX5" fmla="*/ 12840 w 572650"/>
              <a:gd name="connsiteY5" fmla="*/ 286918 h 451406"/>
              <a:gd name="connsiteX6" fmla="*/ 17602 w 572650"/>
              <a:gd name="connsiteY6" fmla="*/ 167856 h 451406"/>
              <a:gd name="connsiteX7" fmla="*/ 108090 w 572650"/>
              <a:gd name="connsiteY7" fmla="*/ 82131 h 451406"/>
              <a:gd name="connsiteX0" fmla="*/ 77919 w 571340"/>
              <a:gd name="connsiteY0" fmla="*/ 19313 h 474734"/>
              <a:gd name="connsiteX1" fmla="*/ 358985 w 571340"/>
              <a:gd name="connsiteY1" fmla="*/ 26551 h 474734"/>
              <a:gd name="connsiteX2" fmla="*/ 571230 w 571340"/>
              <a:gd name="connsiteY2" fmla="*/ 219816 h 474734"/>
              <a:gd name="connsiteX3" fmla="*/ 384756 w 571340"/>
              <a:gd name="connsiteY3" fmla="*/ 465835 h 474734"/>
              <a:gd name="connsiteX4" fmla="*/ 154407 w 571340"/>
              <a:gd name="connsiteY4" fmla="*/ 410259 h 474734"/>
              <a:gd name="connsiteX5" fmla="*/ 11532 w 571340"/>
              <a:gd name="connsiteY5" fmla="*/ 310246 h 474734"/>
              <a:gd name="connsiteX6" fmla="*/ 16294 w 571340"/>
              <a:gd name="connsiteY6" fmla="*/ 191184 h 474734"/>
              <a:gd name="connsiteX7" fmla="*/ 77919 w 571340"/>
              <a:gd name="connsiteY7" fmla="*/ 19313 h 474734"/>
              <a:gd name="connsiteX0" fmla="*/ 134564 w 627987"/>
              <a:gd name="connsiteY0" fmla="*/ 17473 h 472894"/>
              <a:gd name="connsiteX1" fmla="*/ 415630 w 627987"/>
              <a:gd name="connsiteY1" fmla="*/ 24711 h 472894"/>
              <a:gd name="connsiteX2" fmla="*/ 627875 w 627987"/>
              <a:gd name="connsiteY2" fmla="*/ 217976 h 472894"/>
              <a:gd name="connsiteX3" fmla="*/ 441401 w 627987"/>
              <a:gd name="connsiteY3" fmla="*/ 463995 h 472894"/>
              <a:gd name="connsiteX4" fmla="*/ 211052 w 627987"/>
              <a:gd name="connsiteY4" fmla="*/ 408419 h 472894"/>
              <a:gd name="connsiteX5" fmla="*/ 68177 w 627987"/>
              <a:gd name="connsiteY5" fmla="*/ 308406 h 472894"/>
              <a:gd name="connsiteX6" fmla="*/ 1457 w 627987"/>
              <a:gd name="connsiteY6" fmla="*/ 161282 h 472894"/>
              <a:gd name="connsiteX7" fmla="*/ 134564 w 627987"/>
              <a:gd name="connsiteY7" fmla="*/ 17473 h 472894"/>
              <a:gd name="connsiteX0" fmla="*/ 137829 w 631250"/>
              <a:gd name="connsiteY0" fmla="*/ 17473 h 472685"/>
              <a:gd name="connsiteX1" fmla="*/ 418895 w 631250"/>
              <a:gd name="connsiteY1" fmla="*/ 24711 h 472685"/>
              <a:gd name="connsiteX2" fmla="*/ 631140 w 631250"/>
              <a:gd name="connsiteY2" fmla="*/ 217976 h 472685"/>
              <a:gd name="connsiteX3" fmla="*/ 444666 w 631250"/>
              <a:gd name="connsiteY3" fmla="*/ 463995 h 472685"/>
              <a:gd name="connsiteX4" fmla="*/ 214317 w 631250"/>
              <a:gd name="connsiteY4" fmla="*/ 408419 h 472685"/>
              <a:gd name="connsiteX5" fmla="*/ 40477 w 631250"/>
              <a:gd name="connsiteY5" fmla="*/ 322048 h 472685"/>
              <a:gd name="connsiteX6" fmla="*/ 4722 w 631250"/>
              <a:gd name="connsiteY6" fmla="*/ 161282 h 472685"/>
              <a:gd name="connsiteX7" fmla="*/ 137829 w 631250"/>
              <a:gd name="connsiteY7" fmla="*/ 17473 h 472685"/>
              <a:gd name="connsiteX0" fmla="*/ 137829 w 631253"/>
              <a:gd name="connsiteY0" fmla="*/ 17473 h 477595"/>
              <a:gd name="connsiteX1" fmla="*/ 418895 w 631253"/>
              <a:gd name="connsiteY1" fmla="*/ 24711 h 477595"/>
              <a:gd name="connsiteX2" fmla="*/ 631140 w 631253"/>
              <a:gd name="connsiteY2" fmla="*/ 217976 h 477595"/>
              <a:gd name="connsiteX3" fmla="*/ 444666 w 631253"/>
              <a:gd name="connsiteY3" fmla="*/ 463995 h 477595"/>
              <a:gd name="connsiteX4" fmla="*/ 197174 w 631253"/>
              <a:gd name="connsiteY4" fmla="*/ 432648 h 477595"/>
              <a:gd name="connsiteX5" fmla="*/ 40477 w 631253"/>
              <a:gd name="connsiteY5" fmla="*/ 322048 h 477595"/>
              <a:gd name="connsiteX6" fmla="*/ 4722 w 631253"/>
              <a:gd name="connsiteY6" fmla="*/ 161282 h 477595"/>
              <a:gd name="connsiteX7" fmla="*/ 137829 w 631253"/>
              <a:gd name="connsiteY7" fmla="*/ 17473 h 47759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631253" h="477595">
                <a:moveTo>
                  <a:pt x="137829" y="17473"/>
                </a:moveTo>
                <a:cubicBezTo>
                  <a:pt x="206858" y="-5289"/>
                  <a:pt x="336676" y="-8706"/>
                  <a:pt x="418895" y="24711"/>
                </a:cubicBezTo>
                <a:cubicBezTo>
                  <a:pt x="501114" y="58128"/>
                  <a:pt x="626845" y="144762"/>
                  <a:pt x="631140" y="217976"/>
                </a:cubicBezTo>
                <a:cubicBezTo>
                  <a:pt x="635435" y="291190"/>
                  <a:pt x="516994" y="428216"/>
                  <a:pt x="444666" y="463995"/>
                </a:cubicBezTo>
                <a:cubicBezTo>
                  <a:pt x="372338" y="499774"/>
                  <a:pt x="264539" y="456306"/>
                  <a:pt x="197174" y="432648"/>
                </a:cubicBezTo>
                <a:cubicBezTo>
                  <a:pt x="129809" y="408990"/>
                  <a:pt x="63496" y="358560"/>
                  <a:pt x="40477" y="322048"/>
                </a:cubicBezTo>
                <a:cubicBezTo>
                  <a:pt x="17458" y="285536"/>
                  <a:pt x="-11503" y="212045"/>
                  <a:pt x="4722" y="161282"/>
                </a:cubicBezTo>
                <a:cubicBezTo>
                  <a:pt x="20947" y="110519"/>
                  <a:pt x="68800" y="40235"/>
                  <a:pt x="137829" y="17473"/>
                </a:cubicBezTo>
                <a:close/>
              </a:path>
            </a:pathLst>
          </a:custGeom>
          <a:gradFill flip="none" rotWithShape="1">
            <a:gsLst>
              <a:gs pos="0">
                <a:schemeClr val="accent3">
                  <a:lumMod val="50000"/>
                </a:schemeClr>
              </a:gs>
              <a:gs pos="54000">
                <a:srgbClr val="92D050">
                  <a:shade val="67500"/>
                  <a:satMod val="115000"/>
                </a:srgbClr>
              </a:gs>
              <a:gs pos="100000">
                <a:srgbClr val="92D050">
                  <a:shade val="100000"/>
                  <a:satMod val="115000"/>
                </a:srgbClr>
              </a:gs>
            </a:gsLst>
            <a:lin ang="10800000" scaled="1"/>
            <a:tileRect/>
          </a:gradFill>
          <a:ln w="3175"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ko-KR" altLang="en-US" sz="1200">
              <a:solidFill>
                <a:prstClr val="white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89866" y="4097638"/>
            <a:ext cx="5934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D4</a:t>
            </a:r>
            <a:r>
              <a:rPr lang="en-US" altLang="ko-KR" sz="1200" baseline="30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+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</a:p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 cell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814729" y="4668522"/>
            <a:ext cx="6158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FN-</a:t>
            </a:r>
            <a:r>
              <a:rPr lang="el-GR" altLang="ko-KR" sz="12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γ</a:t>
            </a:r>
            <a:endParaRPr lang="en-US" altLang="ko-KR" sz="1200" dirty="0" smtClean="0">
              <a:latin typeface="Times New Roman" panose="02020603050405020304" pitchFamily="18" charset="0"/>
              <a:ea typeface="Arial Unicode MS" panose="020B0604020202020204" pitchFamily="50" charset="-127"/>
              <a:cs typeface="Times New Roman" panose="02020603050405020304" pitchFamily="18" charset="0"/>
            </a:endParaRPr>
          </a:p>
          <a:p>
            <a:pPr algn="ctr"/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NF-</a:t>
            </a:r>
            <a:r>
              <a:rPr lang="el-GR" altLang="ko-KR" sz="12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α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pSp>
        <p:nvGrpSpPr>
          <p:cNvPr id="53" name="그룹 52"/>
          <p:cNvGrpSpPr>
            <a:grpSpLocks noChangeAspect="1"/>
          </p:cNvGrpSpPr>
          <p:nvPr/>
        </p:nvGrpSpPr>
        <p:grpSpPr>
          <a:xfrm rot="1881805">
            <a:off x="4063525" y="3212972"/>
            <a:ext cx="752910" cy="692550"/>
            <a:chOff x="5914073" y="3809414"/>
            <a:chExt cx="585554" cy="538610"/>
          </a:xfrm>
        </p:grpSpPr>
        <p:grpSp>
          <p:nvGrpSpPr>
            <p:cNvPr id="54" name="그룹 53"/>
            <p:cNvGrpSpPr>
              <a:grpSpLocks noChangeAspect="1"/>
            </p:cNvGrpSpPr>
            <p:nvPr/>
          </p:nvGrpSpPr>
          <p:grpSpPr>
            <a:xfrm rot="19389918">
              <a:off x="5914073" y="3809414"/>
              <a:ext cx="585554" cy="538610"/>
              <a:chOff x="532327" y="3944228"/>
              <a:chExt cx="1128716" cy="1038226"/>
            </a:xfrm>
          </p:grpSpPr>
          <p:sp>
            <p:nvSpPr>
              <p:cNvPr id="58" name="Freeform 46">
                <a:extLst>
                  <a:ext uri="{FF2B5EF4-FFF2-40B4-BE49-F238E27FC236}">
                    <a16:creationId xmlns:a16="http://schemas.microsoft.com/office/drawing/2014/main" xmlns="" id="{A7708044-0432-4F38-B714-CDA28DFCBA0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2327" y="3944228"/>
                <a:ext cx="1128716" cy="1038226"/>
              </a:xfrm>
              <a:custGeom>
                <a:avLst/>
                <a:gdLst>
                  <a:gd name="T0" fmla="*/ 296 w 379"/>
                  <a:gd name="T1" fmla="*/ 19 h 349"/>
                  <a:gd name="T2" fmla="*/ 319 w 379"/>
                  <a:gd name="T3" fmla="*/ 92 h 349"/>
                  <a:gd name="T4" fmla="*/ 340 w 379"/>
                  <a:gd name="T5" fmla="*/ 121 h 349"/>
                  <a:gd name="T6" fmla="*/ 358 w 379"/>
                  <a:gd name="T7" fmla="*/ 183 h 349"/>
                  <a:gd name="T8" fmla="*/ 312 w 379"/>
                  <a:gd name="T9" fmla="*/ 245 h 349"/>
                  <a:gd name="T10" fmla="*/ 296 w 379"/>
                  <a:gd name="T11" fmla="*/ 304 h 349"/>
                  <a:gd name="T12" fmla="*/ 231 w 379"/>
                  <a:gd name="T13" fmla="*/ 319 h 349"/>
                  <a:gd name="T14" fmla="*/ 144 w 379"/>
                  <a:gd name="T15" fmla="*/ 319 h 349"/>
                  <a:gd name="T16" fmla="*/ 75 w 379"/>
                  <a:gd name="T17" fmla="*/ 245 h 349"/>
                  <a:gd name="T18" fmla="*/ 0 w 379"/>
                  <a:gd name="T19" fmla="*/ 193 h 349"/>
                  <a:gd name="T20" fmla="*/ 54 w 379"/>
                  <a:gd name="T21" fmla="*/ 120 h 349"/>
                  <a:gd name="T22" fmla="*/ 58 w 379"/>
                  <a:gd name="T23" fmla="*/ 48 h 349"/>
                  <a:gd name="T24" fmla="*/ 141 w 379"/>
                  <a:gd name="T25" fmla="*/ 25 h 349"/>
                  <a:gd name="T26" fmla="*/ 180 w 379"/>
                  <a:gd name="T27" fmla="*/ 18 h 349"/>
                  <a:gd name="T28" fmla="*/ 221 w 379"/>
                  <a:gd name="T29" fmla="*/ 22 h 349"/>
                  <a:gd name="T30" fmla="*/ 296 w 379"/>
                  <a:gd name="T31" fmla="*/ 19 h 3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379" h="349">
                    <a:moveTo>
                      <a:pt x="296" y="19"/>
                    </a:moveTo>
                    <a:cubicBezTo>
                      <a:pt x="331" y="38"/>
                      <a:pt x="342" y="73"/>
                      <a:pt x="319" y="92"/>
                    </a:cubicBezTo>
                    <a:cubicBezTo>
                      <a:pt x="296" y="111"/>
                      <a:pt x="323" y="119"/>
                      <a:pt x="340" y="121"/>
                    </a:cubicBezTo>
                    <a:cubicBezTo>
                      <a:pt x="356" y="124"/>
                      <a:pt x="379" y="160"/>
                      <a:pt x="358" y="183"/>
                    </a:cubicBezTo>
                    <a:cubicBezTo>
                      <a:pt x="337" y="207"/>
                      <a:pt x="309" y="223"/>
                      <a:pt x="312" y="245"/>
                    </a:cubicBezTo>
                    <a:cubicBezTo>
                      <a:pt x="315" y="268"/>
                      <a:pt x="324" y="302"/>
                      <a:pt x="296" y="304"/>
                    </a:cubicBezTo>
                    <a:cubicBezTo>
                      <a:pt x="268" y="305"/>
                      <a:pt x="274" y="291"/>
                      <a:pt x="231" y="319"/>
                    </a:cubicBezTo>
                    <a:cubicBezTo>
                      <a:pt x="188" y="347"/>
                      <a:pt x="162" y="349"/>
                      <a:pt x="144" y="319"/>
                    </a:cubicBezTo>
                    <a:cubicBezTo>
                      <a:pt x="126" y="288"/>
                      <a:pt x="111" y="247"/>
                      <a:pt x="75" y="245"/>
                    </a:cubicBezTo>
                    <a:cubicBezTo>
                      <a:pt x="40" y="243"/>
                      <a:pt x="0" y="234"/>
                      <a:pt x="0" y="193"/>
                    </a:cubicBezTo>
                    <a:cubicBezTo>
                      <a:pt x="1" y="153"/>
                      <a:pt x="45" y="142"/>
                      <a:pt x="54" y="120"/>
                    </a:cubicBezTo>
                    <a:cubicBezTo>
                      <a:pt x="64" y="99"/>
                      <a:pt x="41" y="69"/>
                      <a:pt x="58" y="48"/>
                    </a:cubicBezTo>
                    <a:cubicBezTo>
                      <a:pt x="74" y="27"/>
                      <a:pt x="119" y="6"/>
                      <a:pt x="141" y="25"/>
                    </a:cubicBezTo>
                    <a:cubicBezTo>
                      <a:pt x="164" y="44"/>
                      <a:pt x="171" y="30"/>
                      <a:pt x="180" y="18"/>
                    </a:cubicBezTo>
                    <a:cubicBezTo>
                      <a:pt x="188" y="5"/>
                      <a:pt x="210" y="10"/>
                      <a:pt x="221" y="22"/>
                    </a:cubicBezTo>
                    <a:cubicBezTo>
                      <a:pt x="232" y="33"/>
                      <a:pt x="264" y="0"/>
                      <a:pt x="296" y="19"/>
                    </a:cubicBezTo>
                    <a:close/>
                  </a:path>
                </a:pathLst>
              </a:custGeom>
              <a:gradFill>
                <a:gsLst>
                  <a:gs pos="13000">
                    <a:schemeClr val="bg1"/>
                  </a:gs>
                  <a:gs pos="38000">
                    <a:schemeClr val="accent2">
                      <a:lumMod val="20000"/>
                      <a:lumOff val="80000"/>
                    </a:schemeClr>
                  </a:gs>
                  <a:gs pos="76000">
                    <a:schemeClr val="bg1"/>
                  </a:gs>
                </a:gsLst>
                <a:lin ang="5400000" scaled="1"/>
              </a:gradFill>
              <a:ln w="3175" cap="flat">
                <a:solidFill>
                  <a:schemeClr val="accent2">
                    <a:lumMod val="50000"/>
                  </a:schemeClr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sz="1200" dirty="0">
                  <a:solidFill>
                    <a:prstClr val="black"/>
                  </a:solidFill>
                  <a:ea typeface="굴림" panose="020B0600000101010101" pitchFamily="50" charset="-127"/>
                </a:endParaRPr>
              </a:p>
            </p:txBody>
          </p:sp>
          <p:sp>
            <p:nvSpPr>
              <p:cNvPr id="59" name="Freeform 49">
                <a:extLst>
                  <a:ext uri="{FF2B5EF4-FFF2-40B4-BE49-F238E27FC236}">
                    <a16:creationId xmlns:a16="http://schemas.microsoft.com/office/drawing/2014/main" xmlns="" id="{05988BA9-3FBD-4857-827B-CE356C7078C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>
                <a:off x="750495" y="4114858"/>
                <a:ext cx="463669" cy="471359"/>
              </a:xfrm>
              <a:custGeom>
                <a:avLst/>
                <a:gdLst>
                  <a:gd name="T0" fmla="*/ 77 w 225"/>
                  <a:gd name="T1" fmla="*/ 59 h 229"/>
                  <a:gd name="T2" fmla="*/ 214 w 225"/>
                  <a:gd name="T3" fmla="*/ 65 h 229"/>
                  <a:gd name="T4" fmla="*/ 171 w 225"/>
                  <a:gd name="T5" fmla="*/ 137 h 229"/>
                  <a:gd name="T6" fmla="*/ 96 w 225"/>
                  <a:gd name="T7" fmla="*/ 200 h 229"/>
                  <a:gd name="T8" fmla="*/ 77 w 225"/>
                  <a:gd name="T9" fmla="*/ 59 h 2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5" h="229">
                    <a:moveTo>
                      <a:pt x="77" y="59"/>
                    </a:moveTo>
                    <a:cubicBezTo>
                      <a:pt x="155" y="0"/>
                      <a:pt x="204" y="39"/>
                      <a:pt x="214" y="65"/>
                    </a:cubicBezTo>
                    <a:cubicBezTo>
                      <a:pt x="225" y="93"/>
                      <a:pt x="218" y="121"/>
                      <a:pt x="171" y="137"/>
                    </a:cubicBezTo>
                    <a:cubicBezTo>
                      <a:pt x="125" y="152"/>
                      <a:pt x="131" y="172"/>
                      <a:pt x="96" y="200"/>
                    </a:cubicBezTo>
                    <a:cubicBezTo>
                      <a:pt x="60" y="229"/>
                      <a:pt x="0" y="118"/>
                      <a:pt x="77" y="59"/>
                    </a:cubicBezTo>
                    <a:close/>
                  </a:path>
                </a:pathLst>
              </a:custGeom>
              <a:gradFill flip="none" rotWithShape="1">
                <a:gsLst>
                  <a:gs pos="13000">
                    <a:schemeClr val="accent2">
                      <a:lumMod val="50000"/>
                    </a:schemeClr>
                  </a:gs>
                  <a:gs pos="94000">
                    <a:schemeClr val="bg1"/>
                  </a:gs>
                </a:gsLst>
                <a:lin ang="13500000" scaled="1"/>
                <a:tileRect/>
              </a:gradFill>
              <a:ln w="3175" cap="flat">
                <a:solidFill>
                  <a:schemeClr val="accent2">
                    <a:lumMod val="50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sz="1200">
                  <a:solidFill>
                    <a:prstClr val="black"/>
                  </a:solidFill>
                  <a:ea typeface="굴림" panose="020B0600000101010101" pitchFamily="50" charset="-127"/>
                </a:endParaRPr>
              </a:p>
            </p:txBody>
          </p:sp>
        </p:grpSp>
        <p:sp>
          <p:nvSpPr>
            <p:cNvPr id="55" name="타원 54"/>
            <p:cNvSpPr>
              <a:spLocks noChangeAspect="1"/>
            </p:cNvSpPr>
            <p:nvPr/>
          </p:nvSpPr>
          <p:spPr>
            <a:xfrm>
              <a:off x="6206849" y="4078718"/>
              <a:ext cx="71438" cy="71438"/>
            </a:xfrm>
            <a:prstGeom prst="ellipse">
              <a:avLst/>
            </a:prstGeom>
            <a:gradFill>
              <a:gsLst>
                <a:gs pos="16000">
                  <a:srgbClr val="FDE6E2"/>
                </a:gs>
                <a:gs pos="57000">
                  <a:schemeClr val="accent2">
                    <a:lumMod val="75000"/>
                  </a:schemeClr>
                </a:gs>
                <a:gs pos="86000">
                  <a:schemeClr val="accent2">
                    <a:lumMod val="50000"/>
                  </a:schemeClr>
                </a:gs>
              </a:gsLst>
              <a:lin ang="27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kumimoji="1" lang="ko-KR" altLang="en-US" sz="1200">
                <a:solidFill>
                  <a:prstClr val="white"/>
                </a:solidFill>
              </a:endParaRPr>
            </a:p>
          </p:txBody>
        </p:sp>
        <p:sp>
          <p:nvSpPr>
            <p:cNvPr id="56" name="타원 55"/>
            <p:cNvSpPr>
              <a:spLocks noChangeAspect="1"/>
            </p:cNvSpPr>
            <p:nvPr/>
          </p:nvSpPr>
          <p:spPr>
            <a:xfrm>
              <a:off x="6209306" y="3927221"/>
              <a:ext cx="71438" cy="71438"/>
            </a:xfrm>
            <a:prstGeom prst="ellipse">
              <a:avLst/>
            </a:prstGeom>
            <a:gradFill>
              <a:gsLst>
                <a:gs pos="16000">
                  <a:srgbClr val="FDE6E2"/>
                </a:gs>
                <a:gs pos="57000">
                  <a:schemeClr val="accent2">
                    <a:lumMod val="75000"/>
                  </a:schemeClr>
                </a:gs>
                <a:gs pos="86000">
                  <a:schemeClr val="accent2">
                    <a:lumMod val="50000"/>
                  </a:schemeClr>
                </a:gs>
              </a:gsLst>
              <a:lin ang="27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kumimoji="1" lang="ko-KR" altLang="en-US" sz="1200">
                <a:solidFill>
                  <a:prstClr val="white"/>
                </a:solidFill>
              </a:endParaRPr>
            </a:p>
          </p:txBody>
        </p:sp>
        <p:sp>
          <p:nvSpPr>
            <p:cNvPr id="57" name="타원 56"/>
            <p:cNvSpPr>
              <a:spLocks noChangeAspect="1"/>
            </p:cNvSpPr>
            <p:nvPr/>
          </p:nvSpPr>
          <p:spPr>
            <a:xfrm>
              <a:off x="6277124" y="4010877"/>
              <a:ext cx="71438" cy="71438"/>
            </a:xfrm>
            <a:prstGeom prst="ellipse">
              <a:avLst/>
            </a:prstGeom>
            <a:gradFill>
              <a:gsLst>
                <a:gs pos="16000">
                  <a:srgbClr val="FDE6E2"/>
                </a:gs>
                <a:gs pos="57000">
                  <a:schemeClr val="accent2">
                    <a:lumMod val="75000"/>
                  </a:schemeClr>
                </a:gs>
                <a:gs pos="86000">
                  <a:schemeClr val="accent2">
                    <a:lumMod val="50000"/>
                  </a:schemeClr>
                </a:gs>
              </a:gsLst>
              <a:lin ang="27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kumimoji="1" lang="ko-KR" altLang="en-US" sz="1200">
                <a:solidFill>
                  <a:prstClr val="white"/>
                </a:solidFill>
              </a:endParaRPr>
            </a:p>
          </p:txBody>
        </p:sp>
      </p:grpSp>
      <p:sp>
        <p:nvSpPr>
          <p:cNvPr id="60" name="TextBox 59"/>
          <p:cNvSpPr txBox="1"/>
          <p:nvPr/>
        </p:nvSpPr>
        <p:spPr>
          <a:xfrm>
            <a:off x="3914912" y="3847424"/>
            <a:ext cx="10358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acrophage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1" name="자유형 60"/>
          <p:cNvSpPr>
            <a:spLocks noChangeAspect="1"/>
          </p:cNvSpPr>
          <p:nvPr/>
        </p:nvSpPr>
        <p:spPr bwMode="auto">
          <a:xfrm rot="2063228">
            <a:off x="4960016" y="3349705"/>
            <a:ext cx="262428" cy="279194"/>
          </a:xfrm>
          <a:custGeom>
            <a:avLst/>
            <a:gdLst>
              <a:gd name="connsiteX0" fmla="*/ 2632 w 529326"/>
              <a:gd name="connsiteY0" fmla="*/ 405469 h 509441"/>
              <a:gd name="connsiteX1" fmla="*/ 71643 w 529326"/>
              <a:gd name="connsiteY1" fmla="*/ 120797 h 509441"/>
              <a:gd name="connsiteX2" fmla="*/ 382194 w 529326"/>
              <a:gd name="connsiteY2" fmla="*/ 27 h 509441"/>
              <a:gd name="connsiteX3" fmla="*/ 528843 w 529326"/>
              <a:gd name="connsiteY3" fmla="*/ 129423 h 509441"/>
              <a:gd name="connsiteX4" fmla="*/ 425326 w 529326"/>
              <a:gd name="connsiteY4" fmla="*/ 241567 h 509441"/>
              <a:gd name="connsiteX5" fmla="*/ 313183 w 529326"/>
              <a:gd name="connsiteY5" fmla="*/ 258819 h 509441"/>
              <a:gd name="connsiteX6" fmla="*/ 261424 w 529326"/>
              <a:gd name="connsiteY6" fmla="*/ 414095 h 509441"/>
              <a:gd name="connsiteX7" fmla="*/ 166534 w 529326"/>
              <a:gd name="connsiteY7" fmla="*/ 508986 h 509441"/>
              <a:gd name="connsiteX8" fmla="*/ 28511 w 529326"/>
              <a:gd name="connsiteY8" fmla="*/ 448601 h 509441"/>
              <a:gd name="connsiteX9" fmla="*/ 2632 w 529326"/>
              <a:gd name="connsiteY9" fmla="*/ 405469 h 509441"/>
              <a:gd name="connsiteX0" fmla="*/ 17635 w 509823"/>
              <a:gd name="connsiteY0" fmla="*/ 284693 h 509714"/>
              <a:gd name="connsiteX1" fmla="*/ 52140 w 509823"/>
              <a:gd name="connsiteY1" fmla="*/ 120791 h 509714"/>
              <a:gd name="connsiteX2" fmla="*/ 362691 w 509823"/>
              <a:gd name="connsiteY2" fmla="*/ 21 h 509714"/>
              <a:gd name="connsiteX3" fmla="*/ 509340 w 509823"/>
              <a:gd name="connsiteY3" fmla="*/ 129417 h 509714"/>
              <a:gd name="connsiteX4" fmla="*/ 405823 w 509823"/>
              <a:gd name="connsiteY4" fmla="*/ 241561 h 509714"/>
              <a:gd name="connsiteX5" fmla="*/ 293680 w 509823"/>
              <a:gd name="connsiteY5" fmla="*/ 258813 h 509714"/>
              <a:gd name="connsiteX6" fmla="*/ 241921 w 509823"/>
              <a:gd name="connsiteY6" fmla="*/ 414089 h 509714"/>
              <a:gd name="connsiteX7" fmla="*/ 147031 w 509823"/>
              <a:gd name="connsiteY7" fmla="*/ 508980 h 509714"/>
              <a:gd name="connsiteX8" fmla="*/ 9008 w 509823"/>
              <a:gd name="connsiteY8" fmla="*/ 448595 h 509714"/>
              <a:gd name="connsiteX9" fmla="*/ 17635 w 509823"/>
              <a:gd name="connsiteY9" fmla="*/ 284693 h 509714"/>
              <a:gd name="connsiteX0" fmla="*/ 21983 w 514171"/>
              <a:gd name="connsiteY0" fmla="*/ 285100 h 510121"/>
              <a:gd name="connsiteX1" fmla="*/ 160005 w 514171"/>
              <a:gd name="connsiteY1" fmla="*/ 95319 h 510121"/>
              <a:gd name="connsiteX2" fmla="*/ 367039 w 514171"/>
              <a:gd name="connsiteY2" fmla="*/ 428 h 510121"/>
              <a:gd name="connsiteX3" fmla="*/ 513688 w 514171"/>
              <a:gd name="connsiteY3" fmla="*/ 129824 h 510121"/>
              <a:gd name="connsiteX4" fmla="*/ 410171 w 514171"/>
              <a:gd name="connsiteY4" fmla="*/ 241968 h 510121"/>
              <a:gd name="connsiteX5" fmla="*/ 298028 w 514171"/>
              <a:gd name="connsiteY5" fmla="*/ 259220 h 510121"/>
              <a:gd name="connsiteX6" fmla="*/ 246269 w 514171"/>
              <a:gd name="connsiteY6" fmla="*/ 414496 h 510121"/>
              <a:gd name="connsiteX7" fmla="*/ 151379 w 514171"/>
              <a:gd name="connsiteY7" fmla="*/ 509387 h 510121"/>
              <a:gd name="connsiteX8" fmla="*/ 13356 w 514171"/>
              <a:gd name="connsiteY8" fmla="*/ 449002 h 510121"/>
              <a:gd name="connsiteX9" fmla="*/ 21983 w 514171"/>
              <a:gd name="connsiteY9" fmla="*/ 285100 h 510121"/>
              <a:gd name="connsiteX0" fmla="*/ 21983 w 514171"/>
              <a:gd name="connsiteY0" fmla="*/ 285100 h 510121"/>
              <a:gd name="connsiteX1" fmla="*/ 160005 w 514171"/>
              <a:gd name="connsiteY1" fmla="*/ 95319 h 510121"/>
              <a:gd name="connsiteX2" fmla="*/ 367039 w 514171"/>
              <a:gd name="connsiteY2" fmla="*/ 428 h 510121"/>
              <a:gd name="connsiteX3" fmla="*/ 513688 w 514171"/>
              <a:gd name="connsiteY3" fmla="*/ 129824 h 510121"/>
              <a:gd name="connsiteX4" fmla="*/ 410171 w 514171"/>
              <a:gd name="connsiteY4" fmla="*/ 241968 h 510121"/>
              <a:gd name="connsiteX5" fmla="*/ 298028 w 514171"/>
              <a:gd name="connsiteY5" fmla="*/ 259220 h 510121"/>
              <a:gd name="connsiteX6" fmla="*/ 220390 w 514171"/>
              <a:gd name="connsiteY6" fmla="*/ 405869 h 510121"/>
              <a:gd name="connsiteX7" fmla="*/ 151379 w 514171"/>
              <a:gd name="connsiteY7" fmla="*/ 509387 h 510121"/>
              <a:gd name="connsiteX8" fmla="*/ 13356 w 514171"/>
              <a:gd name="connsiteY8" fmla="*/ 449002 h 510121"/>
              <a:gd name="connsiteX9" fmla="*/ 21983 w 514171"/>
              <a:gd name="connsiteY9" fmla="*/ 285100 h 510121"/>
              <a:gd name="connsiteX0" fmla="*/ 21983 w 514441"/>
              <a:gd name="connsiteY0" fmla="*/ 285100 h 510121"/>
              <a:gd name="connsiteX1" fmla="*/ 160005 w 514441"/>
              <a:gd name="connsiteY1" fmla="*/ 95319 h 510121"/>
              <a:gd name="connsiteX2" fmla="*/ 367039 w 514441"/>
              <a:gd name="connsiteY2" fmla="*/ 428 h 510121"/>
              <a:gd name="connsiteX3" fmla="*/ 513688 w 514441"/>
              <a:gd name="connsiteY3" fmla="*/ 129824 h 510121"/>
              <a:gd name="connsiteX4" fmla="*/ 418798 w 514441"/>
              <a:gd name="connsiteY4" fmla="*/ 207463 h 510121"/>
              <a:gd name="connsiteX5" fmla="*/ 298028 w 514441"/>
              <a:gd name="connsiteY5" fmla="*/ 259220 h 510121"/>
              <a:gd name="connsiteX6" fmla="*/ 220390 w 514441"/>
              <a:gd name="connsiteY6" fmla="*/ 405869 h 510121"/>
              <a:gd name="connsiteX7" fmla="*/ 151379 w 514441"/>
              <a:gd name="connsiteY7" fmla="*/ 509387 h 510121"/>
              <a:gd name="connsiteX8" fmla="*/ 13356 w 514441"/>
              <a:gd name="connsiteY8" fmla="*/ 449002 h 510121"/>
              <a:gd name="connsiteX9" fmla="*/ 21983 w 514441"/>
              <a:gd name="connsiteY9" fmla="*/ 285100 h 510121"/>
              <a:gd name="connsiteX0" fmla="*/ 21983 w 480405"/>
              <a:gd name="connsiteY0" fmla="*/ 285352 h 510373"/>
              <a:gd name="connsiteX1" fmla="*/ 160005 w 480405"/>
              <a:gd name="connsiteY1" fmla="*/ 95571 h 510373"/>
              <a:gd name="connsiteX2" fmla="*/ 367039 w 480405"/>
              <a:gd name="connsiteY2" fmla="*/ 680 h 510373"/>
              <a:gd name="connsiteX3" fmla="*/ 479183 w 480405"/>
              <a:gd name="connsiteY3" fmla="*/ 61065 h 510373"/>
              <a:gd name="connsiteX4" fmla="*/ 418798 w 480405"/>
              <a:gd name="connsiteY4" fmla="*/ 207715 h 510373"/>
              <a:gd name="connsiteX5" fmla="*/ 298028 w 480405"/>
              <a:gd name="connsiteY5" fmla="*/ 259472 h 510373"/>
              <a:gd name="connsiteX6" fmla="*/ 220390 w 480405"/>
              <a:gd name="connsiteY6" fmla="*/ 406121 h 510373"/>
              <a:gd name="connsiteX7" fmla="*/ 151379 w 480405"/>
              <a:gd name="connsiteY7" fmla="*/ 509639 h 510373"/>
              <a:gd name="connsiteX8" fmla="*/ 13356 w 480405"/>
              <a:gd name="connsiteY8" fmla="*/ 449254 h 510373"/>
              <a:gd name="connsiteX9" fmla="*/ 21983 w 480405"/>
              <a:gd name="connsiteY9" fmla="*/ 285352 h 510373"/>
              <a:gd name="connsiteX0" fmla="*/ 21983 w 479613"/>
              <a:gd name="connsiteY0" fmla="*/ 285264 h 510285"/>
              <a:gd name="connsiteX1" fmla="*/ 160005 w 479613"/>
              <a:gd name="connsiteY1" fmla="*/ 95483 h 510285"/>
              <a:gd name="connsiteX2" fmla="*/ 367039 w 479613"/>
              <a:gd name="connsiteY2" fmla="*/ 592 h 510285"/>
              <a:gd name="connsiteX3" fmla="*/ 479183 w 479613"/>
              <a:gd name="connsiteY3" fmla="*/ 60977 h 510285"/>
              <a:gd name="connsiteX4" fmla="*/ 401545 w 479613"/>
              <a:gd name="connsiteY4" fmla="*/ 173121 h 510285"/>
              <a:gd name="connsiteX5" fmla="*/ 298028 w 479613"/>
              <a:gd name="connsiteY5" fmla="*/ 259384 h 510285"/>
              <a:gd name="connsiteX6" fmla="*/ 220390 w 479613"/>
              <a:gd name="connsiteY6" fmla="*/ 406033 h 510285"/>
              <a:gd name="connsiteX7" fmla="*/ 151379 w 479613"/>
              <a:gd name="connsiteY7" fmla="*/ 509551 h 510285"/>
              <a:gd name="connsiteX8" fmla="*/ 13356 w 479613"/>
              <a:gd name="connsiteY8" fmla="*/ 449166 h 510285"/>
              <a:gd name="connsiteX9" fmla="*/ 21983 w 479613"/>
              <a:gd name="connsiteY9" fmla="*/ 285264 h 5102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479613" h="510285">
                <a:moveTo>
                  <a:pt x="21983" y="285264"/>
                </a:moveTo>
                <a:cubicBezTo>
                  <a:pt x="46424" y="226317"/>
                  <a:pt x="102496" y="142928"/>
                  <a:pt x="160005" y="95483"/>
                </a:cubicBezTo>
                <a:cubicBezTo>
                  <a:pt x="217514" y="48038"/>
                  <a:pt x="313843" y="6343"/>
                  <a:pt x="367039" y="592"/>
                </a:cubicBezTo>
                <a:cubicBezTo>
                  <a:pt x="420235" y="-5159"/>
                  <a:pt x="473432" y="32222"/>
                  <a:pt x="479183" y="60977"/>
                </a:cubicBezTo>
                <a:cubicBezTo>
                  <a:pt x="484934" y="89732"/>
                  <a:pt x="431737" y="140053"/>
                  <a:pt x="401545" y="173121"/>
                </a:cubicBezTo>
                <a:cubicBezTo>
                  <a:pt x="371353" y="206189"/>
                  <a:pt x="328220" y="220565"/>
                  <a:pt x="298028" y="259384"/>
                </a:cubicBezTo>
                <a:cubicBezTo>
                  <a:pt x="267836" y="298203"/>
                  <a:pt x="244831" y="364339"/>
                  <a:pt x="220390" y="406033"/>
                </a:cubicBezTo>
                <a:cubicBezTo>
                  <a:pt x="195949" y="447727"/>
                  <a:pt x="190198" y="503800"/>
                  <a:pt x="151379" y="509551"/>
                </a:cubicBezTo>
                <a:cubicBezTo>
                  <a:pt x="112560" y="515302"/>
                  <a:pt x="34922" y="486547"/>
                  <a:pt x="13356" y="449166"/>
                </a:cubicBezTo>
                <a:cubicBezTo>
                  <a:pt x="-8210" y="411785"/>
                  <a:pt x="-2458" y="344211"/>
                  <a:pt x="21983" y="285264"/>
                </a:cubicBezTo>
                <a:close/>
              </a:path>
            </a:pathLst>
          </a:custGeom>
          <a:gradFill flip="none" rotWithShape="1">
            <a:gsLst>
              <a:gs pos="0">
                <a:srgbClr val="FF0000"/>
              </a:gs>
              <a:gs pos="78000">
                <a:srgbClr val="F27350"/>
              </a:gs>
              <a:gs pos="100000">
                <a:schemeClr val="bg2">
                  <a:lumMod val="90000"/>
                </a:schemeClr>
              </a:gs>
            </a:gsLst>
            <a:path path="circle">
              <a:fillToRect l="100000" t="100000"/>
            </a:path>
            <a:tileRect r="-100000" b="-100000"/>
          </a:gradFill>
          <a:ln w="3175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ko-KR" altLang="en-US" sz="1200">
              <a:solidFill>
                <a:prstClr val="white"/>
              </a:solidFill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4763529" y="3621146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ycobacterium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6" name="자유형 65"/>
          <p:cNvSpPr>
            <a:spLocks noChangeAspect="1"/>
          </p:cNvSpPr>
          <p:nvPr/>
        </p:nvSpPr>
        <p:spPr bwMode="auto">
          <a:xfrm rot="2417608">
            <a:off x="5087265" y="3212326"/>
            <a:ext cx="284163" cy="161925"/>
          </a:xfrm>
          <a:custGeom>
            <a:avLst/>
            <a:gdLst>
              <a:gd name="connsiteX0" fmla="*/ 301479 w 482651"/>
              <a:gd name="connsiteY0" fmla="*/ 16274 h 277424"/>
              <a:gd name="connsiteX1" fmla="*/ 16808 w 482651"/>
              <a:gd name="connsiteY1" fmla="*/ 137043 h 277424"/>
              <a:gd name="connsiteX2" fmla="*/ 68566 w 482651"/>
              <a:gd name="connsiteY2" fmla="*/ 275066 h 277424"/>
              <a:gd name="connsiteX3" fmla="*/ 361864 w 482651"/>
              <a:gd name="connsiteY3" fmla="*/ 214681 h 277424"/>
              <a:gd name="connsiteX4" fmla="*/ 482634 w 482651"/>
              <a:gd name="connsiteY4" fmla="*/ 93911 h 277424"/>
              <a:gd name="connsiteX5" fmla="*/ 370491 w 482651"/>
              <a:gd name="connsiteY5" fmla="*/ 7647 h 277424"/>
              <a:gd name="connsiteX6" fmla="*/ 301479 w 482651"/>
              <a:gd name="connsiteY6" fmla="*/ 16274 h 277424"/>
              <a:gd name="connsiteX0" fmla="*/ 199639 w 475707"/>
              <a:gd name="connsiteY0" fmla="*/ 77665 h 269804"/>
              <a:gd name="connsiteX1" fmla="*/ 9859 w 475707"/>
              <a:gd name="connsiteY1" fmla="*/ 129423 h 269804"/>
              <a:gd name="connsiteX2" fmla="*/ 61617 w 475707"/>
              <a:gd name="connsiteY2" fmla="*/ 267446 h 269804"/>
              <a:gd name="connsiteX3" fmla="*/ 354915 w 475707"/>
              <a:gd name="connsiteY3" fmla="*/ 207061 h 269804"/>
              <a:gd name="connsiteX4" fmla="*/ 475685 w 475707"/>
              <a:gd name="connsiteY4" fmla="*/ 86291 h 269804"/>
              <a:gd name="connsiteX5" fmla="*/ 363542 w 475707"/>
              <a:gd name="connsiteY5" fmla="*/ 27 h 269804"/>
              <a:gd name="connsiteX6" fmla="*/ 199639 w 475707"/>
              <a:gd name="connsiteY6" fmla="*/ 77665 h 2698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75707" h="269804">
                <a:moveTo>
                  <a:pt x="199639" y="77665"/>
                </a:moveTo>
                <a:cubicBezTo>
                  <a:pt x="140692" y="99231"/>
                  <a:pt x="32863" y="97793"/>
                  <a:pt x="9859" y="129423"/>
                </a:cubicBezTo>
                <a:cubicBezTo>
                  <a:pt x="-13145" y="161053"/>
                  <a:pt x="4108" y="254506"/>
                  <a:pt x="61617" y="267446"/>
                </a:cubicBezTo>
                <a:cubicBezTo>
                  <a:pt x="119126" y="280386"/>
                  <a:pt x="285904" y="237253"/>
                  <a:pt x="354915" y="207061"/>
                </a:cubicBezTo>
                <a:cubicBezTo>
                  <a:pt x="423926" y="176869"/>
                  <a:pt x="474247" y="120797"/>
                  <a:pt x="475685" y="86291"/>
                </a:cubicBezTo>
                <a:cubicBezTo>
                  <a:pt x="477123" y="51785"/>
                  <a:pt x="409550" y="1465"/>
                  <a:pt x="363542" y="27"/>
                </a:cubicBezTo>
                <a:cubicBezTo>
                  <a:pt x="317534" y="-1411"/>
                  <a:pt x="258586" y="56099"/>
                  <a:pt x="199639" y="77665"/>
                </a:cubicBezTo>
                <a:close/>
              </a:path>
            </a:pathLst>
          </a:custGeom>
          <a:gradFill flip="none" rotWithShape="1">
            <a:gsLst>
              <a:gs pos="0">
                <a:srgbClr val="FF0000"/>
              </a:gs>
              <a:gs pos="33000">
                <a:srgbClr val="EB624B"/>
              </a:gs>
              <a:gs pos="100000">
                <a:schemeClr val="bg1"/>
              </a:gs>
            </a:gsLst>
            <a:lin ang="13500000" scaled="1"/>
            <a:tileRect/>
          </a:gradFill>
          <a:ln w="3175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ko-KR" altLang="en-US" sz="1200">
              <a:solidFill>
                <a:prstClr val="white"/>
              </a:solidFill>
            </a:endParaRPr>
          </a:p>
        </p:txBody>
      </p:sp>
      <p:sp>
        <p:nvSpPr>
          <p:cNvPr id="67" name="자유형 66"/>
          <p:cNvSpPr>
            <a:spLocks noChangeAspect="1"/>
          </p:cNvSpPr>
          <p:nvPr/>
        </p:nvSpPr>
        <p:spPr bwMode="auto">
          <a:xfrm rot="7212871">
            <a:off x="5377056" y="3344640"/>
            <a:ext cx="191874" cy="204132"/>
          </a:xfrm>
          <a:custGeom>
            <a:avLst/>
            <a:gdLst>
              <a:gd name="connsiteX0" fmla="*/ 2632 w 529326"/>
              <a:gd name="connsiteY0" fmla="*/ 405469 h 509441"/>
              <a:gd name="connsiteX1" fmla="*/ 71643 w 529326"/>
              <a:gd name="connsiteY1" fmla="*/ 120797 h 509441"/>
              <a:gd name="connsiteX2" fmla="*/ 382194 w 529326"/>
              <a:gd name="connsiteY2" fmla="*/ 27 h 509441"/>
              <a:gd name="connsiteX3" fmla="*/ 528843 w 529326"/>
              <a:gd name="connsiteY3" fmla="*/ 129423 h 509441"/>
              <a:gd name="connsiteX4" fmla="*/ 425326 w 529326"/>
              <a:gd name="connsiteY4" fmla="*/ 241567 h 509441"/>
              <a:gd name="connsiteX5" fmla="*/ 313183 w 529326"/>
              <a:gd name="connsiteY5" fmla="*/ 258819 h 509441"/>
              <a:gd name="connsiteX6" fmla="*/ 261424 w 529326"/>
              <a:gd name="connsiteY6" fmla="*/ 414095 h 509441"/>
              <a:gd name="connsiteX7" fmla="*/ 166534 w 529326"/>
              <a:gd name="connsiteY7" fmla="*/ 508986 h 509441"/>
              <a:gd name="connsiteX8" fmla="*/ 28511 w 529326"/>
              <a:gd name="connsiteY8" fmla="*/ 448601 h 509441"/>
              <a:gd name="connsiteX9" fmla="*/ 2632 w 529326"/>
              <a:gd name="connsiteY9" fmla="*/ 405469 h 509441"/>
              <a:gd name="connsiteX0" fmla="*/ 17635 w 509823"/>
              <a:gd name="connsiteY0" fmla="*/ 284693 h 509714"/>
              <a:gd name="connsiteX1" fmla="*/ 52140 w 509823"/>
              <a:gd name="connsiteY1" fmla="*/ 120791 h 509714"/>
              <a:gd name="connsiteX2" fmla="*/ 362691 w 509823"/>
              <a:gd name="connsiteY2" fmla="*/ 21 h 509714"/>
              <a:gd name="connsiteX3" fmla="*/ 509340 w 509823"/>
              <a:gd name="connsiteY3" fmla="*/ 129417 h 509714"/>
              <a:gd name="connsiteX4" fmla="*/ 405823 w 509823"/>
              <a:gd name="connsiteY4" fmla="*/ 241561 h 509714"/>
              <a:gd name="connsiteX5" fmla="*/ 293680 w 509823"/>
              <a:gd name="connsiteY5" fmla="*/ 258813 h 509714"/>
              <a:gd name="connsiteX6" fmla="*/ 241921 w 509823"/>
              <a:gd name="connsiteY6" fmla="*/ 414089 h 509714"/>
              <a:gd name="connsiteX7" fmla="*/ 147031 w 509823"/>
              <a:gd name="connsiteY7" fmla="*/ 508980 h 509714"/>
              <a:gd name="connsiteX8" fmla="*/ 9008 w 509823"/>
              <a:gd name="connsiteY8" fmla="*/ 448595 h 509714"/>
              <a:gd name="connsiteX9" fmla="*/ 17635 w 509823"/>
              <a:gd name="connsiteY9" fmla="*/ 284693 h 509714"/>
              <a:gd name="connsiteX0" fmla="*/ 21983 w 514171"/>
              <a:gd name="connsiteY0" fmla="*/ 285100 h 510121"/>
              <a:gd name="connsiteX1" fmla="*/ 160005 w 514171"/>
              <a:gd name="connsiteY1" fmla="*/ 95319 h 510121"/>
              <a:gd name="connsiteX2" fmla="*/ 367039 w 514171"/>
              <a:gd name="connsiteY2" fmla="*/ 428 h 510121"/>
              <a:gd name="connsiteX3" fmla="*/ 513688 w 514171"/>
              <a:gd name="connsiteY3" fmla="*/ 129824 h 510121"/>
              <a:gd name="connsiteX4" fmla="*/ 410171 w 514171"/>
              <a:gd name="connsiteY4" fmla="*/ 241968 h 510121"/>
              <a:gd name="connsiteX5" fmla="*/ 298028 w 514171"/>
              <a:gd name="connsiteY5" fmla="*/ 259220 h 510121"/>
              <a:gd name="connsiteX6" fmla="*/ 246269 w 514171"/>
              <a:gd name="connsiteY6" fmla="*/ 414496 h 510121"/>
              <a:gd name="connsiteX7" fmla="*/ 151379 w 514171"/>
              <a:gd name="connsiteY7" fmla="*/ 509387 h 510121"/>
              <a:gd name="connsiteX8" fmla="*/ 13356 w 514171"/>
              <a:gd name="connsiteY8" fmla="*/ 449002 h 510121"/>
              <a:gd name="connsiteX9" fmla="*/ 21983 w 514171"/>
              <a:gd name="connsiteY9" fmla="*/ 285100 h 510121"/>
              <a:gd name="connsiteX0" fmla="*/ 21983 w 514171"/>
              <a:gd name="connsiteY0" fmla="*/ 285100 h 510121"/>
              <a:gd name="connsiteX1" fmla="*/ 160005 w 514171"/>
              <a:gd name="connsiteY1" fmla="*/ 95319 h 510121"/>
              <a:gd name="connsiteX2" fmla="*/ 367039 w 514171"/>
              <a:gd name="connsiteY2" fmla="*/ 428 h 510121"/>
              <a:gd name="connsiteX3" fmla="*/ 513688 w 514171"/>
              <a:gd name="connsiteY3" fmla="*/ 129824 h 510121"/>
              <a:gd name="connsiteX4" fmla="*/ 410171 w 514171"/>
              <a:gd name="connsiteY4" fmla="*/ 241968 h 510121"/>
              <a:gd name="connsiteX5" fmla="*/ 298028 w 514171"/>
              <a:gd name="connsiteY5" fmla="*/ 259220 h 510121"/>
              <a:gd name="connsiteX6" fmla="*/ 220390 w 514171"/>
              <a:gd name="connsiteY6" fmla="*/ 405869 h 510121"/>
              <a:gd name="connsiteX7" fmla="*/ 151379 w 514171"/>
              <a:gd name="connsiteY7" fmla="*/ 509387 h 510121"/>
              <a:gd name="connsiteX8" fmla="*/ 13356 w 514171"/>
              <a:gd name="connsiteY8" fmla="*/ 449002 h 510121"/>
              <a:gd name="connsiteX9" fmla="*/ 21983 w 514171"/>
              <a:gd name="connsiteY9" fmla="*/ 285100 h 510121"/>
              <a:gd name="connsiteX0" fmla="*/ 21983 w 514441"/>
              <a:gd name="connsiteY0" fmla="*/ 285100 h 510121"/>
              <a:gd name="connsiteX1" fmla="*/ 160005 w 514441"/>
              <a:gd name="connsiteY1" fmla="*/ 95319 h 510121"/>
              <a:gd name="connsiteX2" fmla="*/ 367039 w 514441"/>
              <a:gd name="connsiteY2" fmla="*/ 428 h 510121"/>
              <a:gd name="connsiteX3" fmla="*/ 513688 w 514441"/>
              <a:gd name="connsiteY3" fmla="*/ 129824 h 510121"/>
              <a:gd name="connsiteX4" fmla="*/ 418798 w 514441"/>
              <a:gd name="connsiteY4" fmla="*/ 207463 h 510121"/>
              <a:gd name="connsiteX5" fmla="*/ 298028 w 514441"/>
              <a:gd name="connsiteY5" fmla="*/ 259220 h 510121"/>
              <a:gd name="connsiteX6" fmla="*/ 220390 w 514441"/>
              <a:gd name="connsiteY6" fmla="*/ 405869 h 510121"/>
              <a:gd name="connsiteX7" fmla="*/ 151379 w 514441"/>
              <a:gd name="connsiteY7" fmla="*/ 509387 h 510121"/>
              <a:gd name="connsiteX8" fmla="*/ 13356 w 514441"/>
              <a:gd name="connsiteY8" fmla="*/ 449002 h 510121"/>
              <a:gd name="connsiteX9" fmla="*/ 21983 w 514441"/>
              <a:gd name="connsiteY9" fmla="*/ 285100 h 510121"/>
              <a:gd name="connsiteX0" fmla="*/ 21983 w 480405"/>
              <a:gd name="connsiteY0" fmla="*/ 285352 h 510373"/>
              <a:gd name="connsiteX1" fmla="*/ 160005 w 480405"/>
              <a:gd name="connsiteY1" fmla="*/ 95571 h 510373"/>
              <a:gd name="connsiteX2" fmla="*/ 367039 w 480405"/>
              <a:gd name="connsiteY2" fmla="*/ 680 h 510373"/>
              <a:gd name="connsiteX3" fmla="*/ 479183 w 480405"/>
              <a:gd name="connsiteY3" fmla="*/ 61065 h 510373"/>
              <a:gd name="connsiteX4" fmla="*/ 418798 w 480405"/>
              <a:gd name="connsiteY4" fmla="*/ 207715 h 510373"/>
              <a:gd name="connsiteX5" fmla="*/ 298028 w 480405"/>
              <a:gd name="connsiteY5" fmla="*/ 259472 h 510373"/>
              <a:gd name="connsiteX6" fmla="*/ 220390 w 480405"/>
              <a:gd name="connsiteY6" fmla="*/ 406121 h 510373"/>
              <a:gd name="connsiteX7" fmla="*/ 151379 w 480405"/>
              <a:gd name="connsiteY7" fmla="*/ 509639 h 510373"/>
              <a:gd name="connsiteX8" fmla="*/ 13356 w 480405"/>
              <a:gd name="connsiteY8" fmla="*/ 449254 h 510373"/>
              <a:gd name="connsiteX9" fmla="*/ 21983 w 480405"/>
              <a:gd name="connsiteY9" fmla="*/ 285352 h 510373"/>
              <a:gd name="connsiteX0" fmla="*/ 21983 w 479613"/>
              <a:gd name="connsiteY0" fmla="*/ 285264 h 510285"/>
              <a:gd name="connsiteX1" fmla="*/ 160005 w 479613"/>
              <a:gd name="connsiteY1" fmla="*/ 95483 h 510285"/>
              <a:gd name="connsiteX2" fmla="*/ 367039 w 479613"/>
              <a:gd name="connsiteY2" fmla="*/ 592 h 510285"/>
              <a:gd name="connsiteX3" fmla="*/ 479183 w 479613"/>
              <a:gd name="connsiteY3" fmla="*/ 60977 h 510285"/>
              <a:gd name="connsiteX4" fmla="*/ 401545 w 479613"/>
              <a:gd name="connsiteY4" fmla="*/ 173121 h 510285"/>
              <a:gd name="connsiteX5" fmla="*/ 298028 w 479613"/>
              <a:gd name="connsiteY5" fmla="*/ 259384 h 510285"/>
              <a:gd name="connsiteX6" fmla="*/ 220390 w 479613"/>
              <a:gd name="connsiteY6" fmla="*/ 406033 h 510285"/>
              <a:gd name="connsiteX7" fmla="*/ 151379 w 479613"/>
              <a:gd name="connsiteY7" fmla="*/ 509551 h 510285"/>
              <a:gd name="connsiteX8" fmla="*/ 13356 w 479613"/>
              <a:gd name="connsiteY8" fmla="*/ 449166 h 510285"/>
              <a:gd name="connsiteX9" fmla="*/ 21983 w 479613"/>
              <a:gd name="connsiteY9" fmla="*/ 285264 h 5102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479613" h="510285">
                <a:moveTo>
                  <a:pt x="21983" y="285264"/>
                </a:moveTo>
                <a:cubicBezTo>
                  <a:pt x="46424" y="226317"/>
                  <a:pt x="102496" y="142928"/>
                  <a:pt x="160005" y="95483"/>
                </a:cubicBezTo>
                <a:cubicBezTo>
                  <a:pt x="217514" y="48038"/>
                  <a:pt x="313843" y="6343"/>
                  <a:pt x="367039" y="592"/>
                </a:cubicBezTo>
                <a:cubicBezTo>
                  <a:pt x="420235" y="-5159"/>
                  <a:pt x="473432" y="32222"/>
                  <a:pt x="479183" y="60977"/>
                </a:cubicBezTo>
                <a:cubicBezTo>
                  <a:pt x="484934" y="89732"/>
                  <a:pt x="431737" y="140053"/>
                  <a:pt x="401545" y="173121"/>
                </a:cubicBezTo>
                <a:cubicBezTo>
                  <a:pt x="371353" y="206189"/>
                  <a:pt x="328220" y="220565"/>
                  <a:pt x="298028" y="259384"/>
                </a:cubicBezTo>
                <a:cubicBezTo>
                  <a:pt x="267836" y="298203"/>
                  <a:pt x="244831" y="364339"/>
                  <a:pt x="220390" y="406033"/>
                </a:cubicBezTo>
                <a:cubicBezTo>
                  <a:pt x="195949" y="447727"/>
                  <a:pt x="190198" y="503800"/>
                  <a:pt x="151379" y="509551"/>
                </a:cubicBezTo>
                <a:cubicBezTo>
                  <a:pt x="112560" y="515302"/>
                  <a:pt x="34922" y="486547"/>
                  <a:pt x="13356" y="449166"/>
                </a:cubicBezTo>
                <a:cubicBezTo>
                  <a:pt x="-8210" y="411785"/>
                  <a:pt x="-2458" y="344211"/>
                  <a:pt x="21983" y="285264"/>
                </a:cubicBezTo>
                <a:close/>
              </a:path>
            </a:pathLst>
          </a:custGeom>
          <a:gradFill flip="none" rotWithShape="1">
            <a:gsLst>
              <a:gs pos="0">
                <a:srgbClr val="FF0000"/>
              </a:gs>
              <a:gs pos="78000">
                <a:srgbClr val="F27350"/>
              </a:gs>
              <a:gs pos="100000">
                <a:schemeClr val="bg2">
                  <a:lumMod val="90000"/>
                </a:schemeClr>
              </a:gs>
            </a:gsLst>
            <a:path path="circle">
              <a:fillToRect l="100000" t="100000"/>
            </a:path>
            <a:tileRect r="-100000" b="-100000"/>
          </a:gradFill>
          <a:ln w="3175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ko-KR" altLang="en-US" sz="1200">
              <a:solidFill>
                <a:prstClr val="white"/>
              </a:solidFill>
            </a:endParaRPr>
          </a:p>
        </p:txBody>
      </p:sp>
      <p:cxnSp>
        <p:nvCxnSpPr>
          <p:cNvPr id="70" name="직선 화살표 연결선 69"/>
          <p:cNvCxnSpPr/>
          <p:nvPr/>
        </p:nvCxnSpPr>
        <p:spPr>
          <a:xfrm flipH="1">
            <a:off x="2514208" y="3242864"/>
            <a:ext cx="884782" cy="765294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화살표 연결선 72"/>
          <p:cNvCxnSpPr/>
          <p:nvPr/>
        </p:nvCxnSpPr>
        <p:spPr>
          <a:xfrm>
            <a:off x="2508361" y="4374864"/>
            <a:ext cx="1812508" cy="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4" name="그룹 73"/>
          <p:cNvGrpSpPr>
            <a:grpSpLocks noChangeAspect="1"/>
          </p:cNvGrpSpPr>
          <p:nvPr/>
        </p:nvGrpSpPr>
        <p:grpSpPr>
          <a:xfrm rot="1881805">
            <a:off x="4027805" y="4746452"/>
            <a:ext cx="844543" cy="776837"/>
            <a:chOff x="5914073" y="3809414"/>
            <a:chExt cx="585554" cy="538610"/>
          </a:xfrm>
        </p:grpSpPr>
        <p:grpSp>
          <p:nvGrpSpPr>
            <p:cNvPr id="75" name="그룹 74"/>
            <p:cNvGrpSpPr>
              <a:grpSpLocks noChangeAspect="1"/>
            </p:cNvGrpSpPr>
            <p:nvPr/>
          </p:nvGrpSpPr>
          <p:grpSpPr>
            <a:xfrm rot="19389918">
              <a:off x="5914073" y="3809414"/>
              <a:ext cx="585554" cy="538610"/>
              <a:chOff x="532327" y="3944228"/>
              <a:chExt cx="1128716" cy="1038226"/>
            </a:xfrm>
          </p:grpSpPr>
          <p:sp>
            <p:nvSpPr>
              <p:cNvPr id="79" name="Freeform 46">
                <a:extLst>
                  <a:ext uri="{FF2B5EF4-FFF2-40B4-BE49-F238E27FC236}">
                    <a16:creationId xmlns:a16="http://schemas.microsoft.com/office/drawing/2014/main" xmlns="" id="{A7708044-0432-4F38-B714-CDA28DFCBA0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2327" y="3944228"/>
                <a:ext cx="1128716" cy="1038226"/>
              </a:xfrm>
              <a:custGeom>
                <a:avLst/>
                <a:gdLst>
                  <a:gd name="T0" fmla="*/ 296 w 379"/>
                  <a:gd name="T1" fmla="*/ 19 h 349"/>
                  <a:gd name="T2" fmla="*/ 319 w 379"/>
                  <a:gd name="T3" fmla="*/ 92 h 349"/>
                  <a:gd name="T4" fmla="*/ 340 w 379"/>
                  <a:gd name="T5" fmla="*/ 121 h 349"/>
                  <a:gd name="T6" fmla="*/ 358 w 379"/>
                  <a:gd name="T7" fmla="*/ 183 h 349"/>
                  <a:gd name="T8" fmla="*/ 312 w 379"/>
                  <a:gd name="T9" fmla="*/ 245 h 349"/>
                  <a:gd name="T10" fmla="*/ 296 w 379"/>
                  <a:gd name="T11" fmla="*/ 304 h 349"/>
                  <a:gd name="T12" fmla="*/ 231 w 379"/>
                  <a:gd name="T13" fmla="*/ 319 h 349"/>
                  <a:gd name="T14" fmla="*/ 144 w 379"/>
                  <a:gd name="T15" fmla="*/ 319 h 349"/>
                  <a:gd name="T16" fmla="*/ 75 w 379"/>
                  <a:gd name="T17" fmla="*/ 245 h 349"/>
                  <a:gd name="T18" fmla="*/ 0 w 379"/>
                  <a:gd name="T19" fmla="*/ 193 h 349"/>
                  <a:gd name="T20" fmla="*/ 54 w 379"/>
                  <a:gd name="T21" fmla="*/ 120 h 349"/>
                  <a:gd name="T22" fmla="*/ 58 w 379"/>
                  <a:gd name="T23" fmla="*/ 48 h 349"/>
                  <a:gd name="T24" fmla="*/ 141 w 379"/>
                  <a:gd name="T25" fmla="*/ 25 h 349"/>
                  <a:gd name="T26" fmla="*/ 180 w 379"/>
                  <a:gd name="T27" fmla="*/ 18 h 349"/>
                  <a:gd name="T28" fmla="*/ 221 w 379"/>
                  <a:gd name="T29" fmla="*/ 22 h 349"/>
                  <a:gd name="T30" fmla="*/ 296 w 379"/>
                  <a:gd name="T31" fmla="*/ 19 h 3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379" h="349">
                    <a:moveTo>
                      <a:pt x="296" y="19"/>
                    </a:moveTo>
                    <a:cubicBezTo>
                      <a:pt x="331" y="38"/>
                      <a:pt x="342" y="73"/>
                      <a:pt x="319" y="92"/>
                    </a:cubicBezTo>
                    <a:cubicBezTo>
                      <a:pt x="296" y="111"/>
                      <a:pt x="323" y="119"/>
                      <a:pt x="340" y="121"/>
                    </a:cubicBezTo>
                    <a:cubicBezTo>
                      <a:pt x="356" y="124"/>
                      <a:pt x="379" y="160"/>
                      <a:pt x="358" y="183"/>
                    </a:cubicBezTo>
                    <a:cubicBezTo>
                      <a:pt x="337" y="207"/>
                      <a:pt x="309" y="223"/>
                      <a:pt x="312" y="245"/>
                    </a:cubicBezTo>
                    <a:cubicBezTo>
                      <a:pt x="315" y="268"/>
                      <a:pt x="324" y="302"/>
                      <a:pt x="296" y="304"/>
                    </a:cubicBezTo>
                    <a:cubicBezTo>
                      <a:pt x="268" y="305"/>
                      <a:pt x="274" y="291"/>
                      <a:pt x="231" y="319"/>
                    </a:cubicBezTo>
                    <a:cubicBezTo>
                      <a:pt x="188" y="347"/>
                      <a:pt x="162" y="349"/>
                      <a:pt x="144" y="319"/>
                    </a:cubicBezTo>
                    <a:cubicBezTo>
                      <a:pt x="126" y="288"/>
                      <a:pt x="111" y="247"/>
                      <a:pt x="75" y="245"/>
                    </a:cubicBezTo>
                    <a:cubicBezTo>
                      <a:pt x="40" y="243"/>
                      <a:pt x="0" y="234"/>
                      <a:pt x="0" y="193"/>
                    </a:cubicBezTo>
                    <a:cubicBezTo>
                      <a:pt x="1" y="153"/>
                      <a:pt x="45" y="142"/>
                      <a:pt x="54" y="120"/>
                    </a:cubicBezTo>
                    <a:cubicBezTo>
                      <a:pt x="64" y="99"/>
                      <a:pt x="41" y="69"/>
                      <a:pt x="58" y="48"/>
                    </a:cubicBezTo>
                    <a:cubicBezTo>
                      <a:pt x="74" y="27"/>
                      <a:pt x="119" y="6"/>
                      <a:pt x="141" y="25"/>
                    </a:cubicBezTo>
                    <a:cubicBezTo>
                      <a:pt x="164" y="44"/>
                      <a:pt x="171" y="30"/>
                      <a:pt x="180" y="18"/>
                    </a:cubicBezTo>
                    <a:cubicBezTo>
                      <a:pt x="188" y="5"/>
                      <a:pt x="210" y="10"/>
                      <a:pt x="221" y="22"/>
                    </a:cubicBezTo>
                    <a:cubicBezTo>
                      <a:pt x="232" y="33"/>
                      <a:pt x="264" y="0"/>
                      <a:pt x="296" y="19"/>
                    </a:cubicBezTo>
                    <a:close/>
                  </a:path>
                </a:pathLst>
              </a:custGeom>
              <a:gradFill>
                <a:gsLst>
                  <a:gs pos="13000">
                    <a:schemeClr val="bg1"/>
                  </a:gs>
                  <a:gs pos="38000">
                    <a:schemeClr val="accent2">
                      <a:lumMod val="20000"/>
                      <a:lumOff val="80000"/>
                    </a:schemeClr>
                  </a:gs>
                  <a:gs pos="76000">
                    <a:schemeClr val="bg1"/>
                  </a:gs>
                </a:gsLst>
                <a:lin ang="5400000" scaled="1"/>
              </a:gradFill>
              <a:ln w="3175" cap="flat">
                <a:solidFill>
                  <a:schemeClr val="accent2">
                    <a:lumMod val="50000"/>
                  </a:schemeClr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sz="1200" dirty="0">
                  <a:solidFill>
                    <a:prstClr val="black"/>
                  </a:solidFill>
                  <a:ea typeface="굴림" panose="020B0600000101010101" pitchFamily="50" charset="-127"/>
                </a:endParaRPr>
              </a:p>
            </p:txBody>
          </p:sp>
          <p:sp>
            <p:nvSpPr>
              <p:cNvPr id="80" name="Freeform 49">
                <a:extLst>
                  <a:ext uri="{FF2B5EF4-FFF2-40B4-BE49-F238E27FC236}">
                    <a16:creationId xmlns:a16="http://schemas.microsoft.com/office/drawing/2014/main" xmlns="" id="{05988BA9-3FBD-4857-827B-CE356C7078C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>
                <a:off x="750495" y="4114858"/>
                <a:ext cx="463669" cy="471359"/>
              </a:xfrm>
              <a:custGeom>
                <a:avLst/>
                <a:gdLst>
                  <a:gd name="T0" fmla="*/ 77 w 225"/>
                  <a:gd name="T1" fmla="*/ 59 h 229"/>
                  <a:gd name="T2" fmla="*/ 214 w 225"/>
                  <a:gd name="T3" fmla="*/ 65 h 229"/>
                  <a:gd name="T4" fmla="*/ 171 w 225"/>
                  <a:gd name="T5" fmla="*/ 137 h 229"/>
                  <a:gd name="T6" fmla="*/ 96 w 225"/>
                  <a:gd name="T7" fmla="*/ 200 h 229"/>
                  <a:gd name="T8" fmla="*/ 77 w 225"/>
                  <a:gd name="T9" fmla="*/ 59 h 2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5" h="229">
                    <a:moveTo>
                      <a:pt x="77" y="59"/>
                    </a:moveTo>
                    <a:cubicBezTo>
                      <a:pt x="155" y="0"/>
                      <a:pt x="204" y="39"/>
                      <a:pt x="214" y="65"/>
                    </a:cubicBezTo>
                    <a:cubicBezTo>
                      <a:pt x="225" y="93"/>
                      <a:pt x="218" y="121"/>
                      <a:pt x="171" y="137"/>
                    </a:cubicBezTo>
                    <a:cubicBezTo>
                      <a:pt x="125" y="152"/>
                      <a:pt x="131" y="172"/>
                      <a:pt x="96" y="200"/>
                    </a:cubicBezTo>
                    <a:cubicBezTo>
                      <a:pt x="60" y="229"/>
                      <a:pt x="0" y="118"/>
                      <a:pt x="77" y="59"/>
                    </a:cubicBezTo>
                    <a:close/>
                  </a:path>
                </a:pathLst>
              </a:custGeom>
              <a:gradFill flip="none" rotWithShape="1">
                <a:gsLst>
                  <a:gs pos="13000">
                    <a:schemeClr val="accent2">
                      <a:lumMod val="50000"/>
                    </a:schemeClr>
                  </a:gs>
                  <a:gs pos="94000">
                    <a:schemeClr val="bg1"/>
                  </a:gs>
                </a:gsLst>
                <a:lin ang="13500000" scaled="1"/>
                <a:tileRect/>
              </a:gradFill>
              <a:ln w="3175" cap="flat">
                <a:solidFill>
                  <a:schemeClr val="accent2">
                    <a:lumMod val="50000"/>
                  </a:schemeClr>
                </a:solidFill>
                <a:prstDash val="solid"/>
                <a:miter lim="800000"/>
                <a:headEnd/>
                <a:tailEnd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kumimoji="1" lang="en-US" sz="1200">
                  <a:solidFill>
                    <a:prstClr val="black"/>
                  </a:solidFill>
                  <a:ea typeface="굴림" panose="020B0600000101010101" pitchFamily="50" charset="-127"/>
                </a:endParaRPr>
              </a:p>
            </p:txBody>
          </p:sp>
        </p:grpSp>
        <p:sp>
          <p:nvSpPr>
            <p:cNvPr id="76" name="타원 75"/>
            <p:cNvSpPr>
              <a:spLocks noChangeAspect="1"/>
            </p:cNvSpPr>
            <p:nvPr/>
          </p:nvSpPr>
          <p:spPr>
            <a:xfrm>
              <a:off x="6206849" y="4078718"/>
              <a:ext cx="71438" cy="71438"/>
            </a:xfrm>
            <a:prstGeom prst="ellipse">
              <a:avLst/>
            </a:prstGeom>
            <a:gradFill>
              <a:gsLst>
                <a:gs pos="16000">
                  <a:srgbClr val="FDE6E2"/>
                </a:gs>
                <a:gs pos="57000">
                  <a:schemeClr val="accent2">
                    <a:lumMod val="75000"/>
                  </a:schemeClr>
                </a:gs>
                <a:gs pos="86000">
                  <a:schemeClr val="accent2">
                    <a:lumMod val="50000"/>
                  </a:schemeClr>
                </a:gs>
              </a:gsLst>
              <a:lin ang="27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kumimoji="1" lang="ko-KR" altLang="en-US" sz="1200">
                <a:solidFill>
                  <a:prstClr val="white"/>
                </a:solidFill>
              </a:endParaRPr>
            </a:p>
          </p:txBody>
        </p:sp>
        <p:sp>
          <p:nvSpPr>
            <p:cNvPr id="77" name="타원 76"/>
            <p:cNvSpPr>
              <a:spLocks noChangeAspect="1"/>
            </p:cNvSpPr>
            <p:nvPr/>
          </p:nvSpPr>
          <p:spPr>
            <a:xfrm>
              <a:off x="6209306" y="3927221"/>
              <a:ext cx="71438" cy="71438"/>
            </a:xfrm>
            <a:prstGeom prst="ellipse">
              <a:avLst/>
            </a:prstGeom>
            <a:gradFill>
              <a:gsLst>
                <a:gs pos="16000">
                  <a:srgbClr val="FDE6E2"/>
                </a:gs>
                <a:gs pos="57000">
                  <a:schemeClr val="accent2">
                    <a:lumMod val="75000"/>
                  </a:schemeClr>
                </a:gs>
                <a:gs pos="86000">
                  <a:schemeClr val="accent2">
                    <a:lumMod val="50000"/>
                  </a:schemeClr>
                </a:gs>
              </a:gsLst>
              <a:lin ang="27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kumimoji="1" lang="ko-KR" altLang="en-US" sz="1200">
                <a:solidFill>
                  <a:prstClr val="white"/>
                </a:solidFill>
              </a:endParaRPr>
            </a:p>
          </p:txBody>
        </p:sp>
        <p:sp>
          <p:nvSpPr>
            <p:cNvPr id="78" name="타원 77"/>
            <p:cNvSpPr>
              <a:spLocks noChangeAspect="1"/>
            </p:cNvSpPr>
            <p:nvPr/>
          </p:nvSpPr>
          <p:spPr>
            <a:xfrm>
              <a:off x="6277124" y="4010877"/>
              <a:ext cx="71438" cy="71438"/>
            </a:xfrm>
            <a:prstGeom prst="ellipse">
              <a:avLst/>
            </a:prstGeom>
            <a:gradFill>
              <a:gsLst>
                <a:gs pos="16000">
                  <a:srgbClr val="FDE6E2"/>
                </a:gs>
                <a:gs pos="57000">
                  <a:schemeClr val="accent2">
                    <a:lumMod val="75000"/>
                  </a:schemeClr>
                </a:gs>
                <a:gs pos="86000">
                  <a:schemeClr val="accent2">
                    <a:lumMod val="50000"/>
                  </a:schemeClr>
                </a:gs>
              </a:gsLst>
              <a:lin ang="27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kumimoji="1" lang="ko-KR" altLang="en-US" sz="1200">
                <a:solidFill>
                  <a:prstClr val="white"/>
                </a:solidFill>
              </a:endParaRPr>
            </a:p>
          </p:txBody>
        </p:sp>
      </p:grpSp>
      <p:sp>
        <p:nvSpPr>
          <p:cNvPr id="81" name="자유형 80"/>
          <p:cNvSpPr>
            <a:spLocks noChangeAspect="1"/>
          </p:cNvSpPr>
          <p:nvPr/>
        </p:nvSpPr>
        <p:spPr bwMode="auto">
          <a:xfrm rot="2417608">
            <a:off x="4321328" y="5221977"/>
            <a:ext cx="284163" cy="161925"/>
          </a:xfrm>
          <a:custGeom>
            <a:avLst/>
            <a:gdLst>
              <a:gd name="connsiteX0" fmla="*/ 301479 w 482651"/>
              <a:gd name="connsiteY0" fmla="*/ 16274 h 277424"/>
              <a:gd name="connsiteX1" fmla="*/ 16808 w 482651"/>
              <a:gd name="connsiteY1" fmla="*/ 137043 h 277424"/>
              <a:gd name="connsiteX2" fmla="*/ 68566 w 482651"/>
              <a:gd name="connsiteY2" fmla="*/ 275066 h 277424"/>
              <a:gd name="connsiteX3" fmla="*/ 361864 w 482651"/>
              <a:gd name="connsiteY3" fmla="*/ 214681 h 277424"/>
              <a:gd name="connsiteX4" fmla="*/ 482634 w 482651"/>
              <a:gd name="connsiteY4" fmla="*/ 93911 h 277424"/>
              <a:gd name="connsiteX5" fmla="*/ 370491 w 482651"/>
              <a:gd name="connsiteY5" fmla="*/ 7647 h 277424"/>
              <a:gd name="connsiteX6" fmla="*/ 301479 w 482651"/>
              <a:gd name="connsiteY6" fmla="*/ 16274 h 277424"/>
              <a:gd name="connsiteX0" fmla="*/ 199639 w 475707"/>
              <a:gd name="connsiteY0" fmla="*/ 77665 h 269804"/>
              <a:gd name="connsiteX1" fmla="*/ 9859 w 475707"/>
              <a:gd name="connsiteY1" fmla="*/ 129423 h 269804"/>
              <a:gd name="connsiteX2" fmla="*/ 61617 w 475707"/>
              <a:gd name="connsiteY2" fmla="*/ 267446 h 269804"/>
              <a:gd name="connsiteX3" fmla="*/ 354915 w 475707"/>
              <a:gd name="connsiteY3" fmla="*/ 207061 h 269804"/>
              <a:gd name="connsiteX4" fmla="*/ 475685 w 475707"/>
              <a:gd name="connsiteY4" fmla="*/ 86291 h 269804"/>
              <a:gd name="connsiteX5" fmla="*/ 363542 w 475707"/>
              <a:gd name="connsiteY5" fmla="*/ 27 h 269804"/>
              <a:gd name="connsiteX6" fmla="*/ 199639 w 475707"/>
              <a:gd name="connsiteY6" fmla="*/ 77665 h 2698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75707" h="269804">
                <a:moveTo>
                  <a:pt x="199639" y="77665"/>
                </a:moveTo>
                <a:cubicBezTo>
                  <a:pt x="140692" y="99231"/>
                  <a:pt x="32863" y="97793"/>
                  <a:pt x="9859" y="129423"/>
                </a:cubicBezTo>
                <a:cubicBezTo>
                  <a:pt x="-13145" y="161053"/>
                  <a:pt x="4108" y="254506"/>
                  <a:pt x="61617" y="267446"/>
                </a:cubicBezTo>
                <a:cubicBezTo>
                  <a:pt x="119126" y="280386"/>
                  <a:pt x="285904" y="237253"/>
                  <a:pt x="354915" y="207061"/>
                </a:cubicBezTo>
                <a:cubicBezTo>
                  <a:pt x="423926" y="176869"/>
                  <a:pt x="474247" y="120797"/>
                  <a:pt x="475685" y="86291"/>
                </a:cubicBezTo>
                <a:cubicBezTo>
                  <a:pt x="477123" y="51785"/>
                  <a:pt x="409550" y="1465"/>
                  <a:pt x="363542" y="27"/>
                </a:cubicBezTo>
                <a:cubicBezTo>
                  <a:pt x="317534" y="-1411"/>
                  <a:pt x="258586" y="56099"/>
                  <a:pt x="199639" y="77665"/>
                </a:cubicBezTo>
                <a:close/>
              </a:path>
            </a:pathLst>
          </a:custGeom>
          <a:gradFill flip="none" rotWithShape="1">
            <a:gsLst>
              <a:gs pos="0">
                <a:schemeClr val="accent2">
                  <a:lumMod val="5000"/>
                  <a:lumOff val="95000"/>
                </a:schemeClr>
              </a:gs>
              <a:gs pos="74000">
                <a:schemeClr val="accent2">
                  <a:lumMod val="45000"/>
                  <a:lumOff val="55000"/>
                </a:schemeClr>
              </a:gs>
              <a:gs pos="83000">
                <a:schemeClr val="accent2">
                  <a:lumMod val="45000"/>
                  <a:lumOff val="55000"/>
                </a:schemeClr>
              </a:gs>
              <a:gs pos="100000">
                <a:schemeClr val="accent2">
                  <a:lumMod val="30000"/>
                  <a:lumOff val="70000"/>
                </a:schemeClr>
              </a:gs>
            </a:gsLst>
            <a:lin ang="5400000" scaled="1"/>
            <a:tileRect/>
          </a:gradFill>
          <a:ln w="31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ko-KR" altLang="en-US" sz="1200">
              <a:solidFill>
                <a:prstClr val="white"/>
              </a:solidFill>
            </a:endParaRPr>
          </a:p>
        </p:txBody>
      </p:sp>
      <p:sp>
        <p:nvSpPr>
          <p:cNvPr id="82" name="자유형 81"/>
          <p:cNvSpPr>
            <a:spLocks noChangeAspect="1"/>
          </p:cNvSpPr>
          <p:nvPr/>
        </p:nvSpPr>
        <p:spPr bwMode="auto">
          <a:xfrm rot="7212871">
            <a:off x="4485162" y="5108967"/>
            <a:ext cx="191874" cy="204132"/>
          </a:xfrm>
          <a:custGeom>
            <a:avLst/>
            <a:gdLst>
              <a:gd name="connsiteX0" fmla="*/ 2632 w 529326"/>
              <a:gd name="connsiteY0" fmla="*/ 405469 h 509441"/>
              <a:gd name="connsiteX1" fmla="*/ 71643 w 529326"/>
              <a:gd name="connsiteY1" fmla="*/ 120797 h 509441"/>
              <a:gd name="connsiteX2" fmla="*/ 382194 w 529326"/>
              <a:gd name="connsiteY2" fmla="*/ 27 h 509441"/>
              <a:gd name="connsiteX3" fmla="*/ 528843 w 529326"/>
              <a:gd name="connsiteY3" fmla="*/ 129423 h 509441"/>
              <a:gd name="connsiteX4" fmla="*/ 425326 w 529326"/>
              <a:gd name="connsiteY4" fmla="*/ 241567 h 509441"/>
              <a:gd name="connsiteX5" fmla="*/ 313183 w 529326"/>
              <a:gd name="connsiteY5" fmla="*/ 258819 h 509441"/>
              <a:gd name="connsiteX6" fmla="*/ 261424 w 529326"/>
              <a:gd name="connsiteY6" fmla="*/ 414095 h 509441"/>
              <a:gd name="connsiteX7" fmla="*/ 166534 w 529326"/>
              <a:gd name="connsiteY7" fmla="*/ 508986 h 509441"/>
              <a:gd name="connsiteX8" fmla="*/ 28511 w 529326"/>
              <a:gd name="connsiteY8" fmla="*/ 448601 h 509441"/>
              <a:gd name="connsiteX9" fmla="*/ 2632 w 529326"/>
              <a:gd name="connsiteY9" fmla="*/ 405469 h 509441"/>
              <a:gd name="connsiteX0" fmla="*/ 17635 w 509823"/>
              <a:gd name="connsiteY0" fmla="*/ 284693 h 509714"/>
              <a:gd name="connsiteX1" fmla="*/ 52140 w 509823"/>
              <a:gd name="connsiteY1" fmla="*/ 120791 h 509714"/>
              <a:gd name="connsiteX2" fmla="*/ 362691 w 509823"/>
              <a:gd name="connsiteY2" fmla="*/ 21 h 509714"/>
              <a:gd name="connsiteX3" fmla="*/ 509340 w 509823"/>
              <a:gd name="connsiteY3" fmla="*/ 129417 h 509714"/>
              <a:gd name="connsiteX4" fmla="*/ 405823 w 509823"/>
              <a:gd name="connsiteY4" fmla="*/ 241561 h 509714"/>
              <a:gd name="connsiteX5" fmla="*/ 293680 w 509823"/>
              <a:gd name="connsiteY5" fmla="*/ 258813 h 509714"/>
              <a:gd name="connsiteX6" fmla="*/ 241921 w 509823"/>
              <a:gd name="connsiteY6" fmla="*/ 414089 h 509714"/>
              <a:gd name="connsiteX7" fmla="*/ 147031 w 509823"/>
              <a:gd name="connsiteY7" fmla="*/ 508980 h 509714"/>
              <a:gd name="connsiteX8" fmla="*/ 9008 w 509823"/>
              <a:gd name="connsiteY8" fmla="*/ 448595 h 509714"/>
              <a:gd name="connsiteX9" fmla="*/ 17635 w 509823"/>
              <a:gd name="connsiteY9" fmla="*/ 284693 h 509714"/>
              <a:gd name="connsiteX0" fmla="*/ 21983 w 514171"/>
              <a:gd name="connsiteY0" fmla="*/ 285100 h 510121"/>
              <a:gd name="connsiteX1" fmla="*/ 160005 w 514171"/>
              <a:gd name="connsiteY1" fmla="*/ 95319 h 510121"/>
              <a:gd name="connsiteX2" fmla="*/ 367039 w 514171"/>
              <a:gd name="connsiteY2" fmla="*/ 428 h 510121"/>
              <a:gd name="connsiteX3" fmla="*/ 513688 w 514171"/>
              <a:gd name="connsiteY3" fmla="*/ 129824 h 510121"/>
              <a:gd name="connsiteX4" fmla="*/ 410171 w 514171"/>
              <a:gd name="connsiteY4" fmla="*/ 241968 h 510121"/>
              <a:gd name="connsiteX5" fmla="*/ 298028 w 514171"/>
              <a:gd name="connsiteY5" fmla="*/ 259220 h 510121"/>
              <a:gd name="connsiteX6" fmla="*/ 246269 w 514171"/>
              <a:gd name="connsiteY6" fmla="*/ 414496 h 510121"/>
              <a:gd name="connsiteX7" fmla="*/ 151379 w 514171"/>
              <a:gd name="connsiteY7" fmla="*/ 509387 h 510121"/>
              <a:gd name="connsiteX8" fmla="*/ 13356 w 514171"/>
              <a:gd name="connsiteY8" fmla="*/ 449002 h 510121"/>
              <a:gd name="connsiteX9" fmla="*/ 21983 w 514171"/>
              <a:gd name="connsiteY9" fmla="*/ 285100 h 510121"/>
              <a:gd name="connsiteX0" fmla="*/ 21983 w 514171"/>
              <a:gd name="connsiteY0" fmla="*/ 285100 h 510121"/>
              <a:gd name="connsiteX1" fmla="*/ 160005 w 514171"/>
              <a:gd name="connsiteY1" fmla="*/ 95319 h 510121"/>
              <a:gd name="connsiteX2" fmla="*/ 367039 w 514171"/>
              <a:gd name="connsiteY2" fmla="*/ 428 h 510121"/>
              <a:gd name="connsiteX3" fmla="*/ 513688 w 514171"/>
              <a:gd name="connsiteY3" fmla="*/ 129824 h 510121"/>
              <a:gd name="connsiteX4" fmla="*/ 410171 w 514171"/>
              <a:gd name="connsiteY4" fmla="*/ 241968 h 510121"/>
              <a:gd name="connsiteX5" fmla="*/ 298028 w 514171"/>
              <a:gd name="connsiteY5" fmla="*/ 259220 h 510121"/>
              <a:gd name="connsiteX6" fmla="*/ 220390 w 514171"/>
              <a:gd name="connsiteY6" fmla="*/ 405869 h 510121"/>
              <a:gd name="connsiteX7" fmla="*/ 151379 w 514171"/>
              <a:gd name="connsiteY7" fmla="*/ 509387 h 510121"/>
              <a:gd name="connsiteX8" fmla="*/ 13356 w 514171"/>
              <a:gd name="connsiteY8" fmla="*/ 449002 h 510121"/>
              <a:gd name="connsiteX9" fmla="*/ 21983 w 514171"/>
              <a:gd name="connsiteY9" fmla="*/ 285100 h 510121"/>
              <a:gd name="connsiteX0" fmla="*/ 21983 w 514441"/>
              <a:gd name="connsiteY0" fmla="*/ 285100 h 510121"/>
              <a:gd name="connsiteX1" fmla="*/ 160005 w 514441"/>
              <a:gd name="connsiteY1" fmla="*/ 95319 h 510121"/>
              <a:gd name="connsiteX2" fmla="*/ 367039 w 514441"/>
              <a:gd name="connsiteY2" fmla="*/ 428 h 510121"/>
              <a:gd name="connsiteX3" fmla="*/ 513688 w 514441"/>
              <a:gd name="connsiteY3" fmla="*/ 129824 h 510121"/>
              <a:gd name="connsiteX4" fmla="*/ 418798 w 514441"/>
              <a:gd name="connsiteY4" fmla="*/ 207463 h 510121"/>
              <a:gd name="connsiteX5" fmla="*/ 298028 w 514441"/>
              <a:gd name="connsiteY5" fmla="*/ 259220 h 510121"/>
              <a:gd name="connsiteX6" fmla="*/ 220390 w 514441"/>
              <a:gd name="connsiteY6" fmla="*/ 405869 h 510121"/>
              <a:gd name="connsiteX7" fmla="*/ 151379 w 514441"/>
              <a:gd name="connsiteY7" fmla="*/ 509387 h 510121"/>
              <a:gd name="connsiteX8" fmla="*/ 13356 w 514441"/>
              <a:gd name="connsiteY8" fmla="*/ 449002 h 510121"/>
              <a:gd name="connsiteX9" fmla="*/ 21983 w 514441"/>
              <a:gd name="connsiteY9" fmla="*/ 285100 h 510121"/>
              <a:gd name="connsiteX0" fmla="*/ 21983 w 480405"/>
              <a:gd name="connsiteY0" fmla="*/ 285352 h 510373"/>
              <a:gd name="connsiteX1" fmla="*/ 160005 w 480405"/>
              <a:gd name="connsiteY1" fmla="*/ 95571 h 510373"/>
              <a:gd name="connsiteX2" fmla="*/ 367039 w 480405"/>
              <a:gd name="connsiteY2" fmla="*/ 680 h 510373"/>
              <a:gd name="connsiteX3" fmla="*/ 479183 w 480405"/>
              <a:gd name="connsiteY3" fmla="*/ 61065 h 510373"/>
              <a:gd name="connsiteX4" fmla="*/ 418798 w 480405"/>
              <a:gd name="connsiteY4" fmla="*/ 207715 h 510373"/>
              <a:gd name="connsiteX5" fmla="*/ 298028 w 480405"/>
              <a:gd name="connsiteY5" fmla="*/ 259472 h 510373"/>
              <a:gd name="connsiteX6" fmla="*/ 220390 w 480405"/>
              <a:gd name="connsiteY6" fmla="*/ 406121 h 510373"/>
              <a:gd name="connsiteX7" fmla="*/ 151379 w 480405"/>
              <a:gd name="connsiteY7" fmla="*/ 509639 h 510373"/>
              <a:gd name="connsiteX8" fmla="*/ 13356 w 480405"/>
              <a:gd name="connsiteY8" fmla="*/ 449254 h 510373"/>
              <a:gd name="connsiteX9" fmla="*/ 21983 w 480405"/>
              <a:gd name="connsiteY9" fmla="*/ 285352 h 510373"/>
              <a:gd name="connsiteX0" fmla="*/ 21983 w 479613"/>
              <a:gd name="connsiteY0" fmla="*/ 285264 h 510285"/>
              <a:gd name="connsiteX1" fmla="*/ 160005 w 479613"/>
              <a:gd name="connsiteY1" fmla="*/ 95483 h 510285"/>
              <a:gd name="connsiteX2" fmla="*/ 367039 w 479613"/>
              <a:gd name="connsiteY2" fmla="*/ 592 h 510285"/>
              <a:gd name="connsiteX3" fmla="*/ 479183 w 479613"/>
              <a:gd name="connsiteY3" fmla="*/ 60977 h 510285"/>
              <a:gd name="connsiteX4" fmla="*/ 401545 w 479613"/>
              <a:gd name="connsiteY4" fmla="*/ 173121 h 510285"/>
              <a:gd name="connsiteX5" fmla="*/ 298028 w 479613"/>
              <a:gd name="connsiteY5" fmla="*/ 259384 h 510285"/>
              <a:gd name="connsiteX6" fmla="*/ 220390 w 479613"/>
              <a:gd name="connsiteY6" fmla="*/ 406033 h 510285"/>
              <a:gd name="connsiteX7" fmla="*/ 151379 w 479613"/>
              <a:gd name="connsiteY7" fmla="*/ 509551 h 510285"/>
              <a:gd name="connsiteX8" fmla="*/ 13356 w 479613"/>
              <a:gd name="connsiteY8" fmla="*/ 449166 h 510285"/>
              <a:gd name="connsiteX9" fmla="*/ 21983 w 479613"/>
              <a:gd name="connsiteY9" fmla="*/ 285264 h 5102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479613" h="510285">
                <a:moveTo>
                  <a:pt x="21983" y="285264"/>
                </a:moveTo>
                <a:cubicBezTo>
                  <a:pt x="46424" y="226317"/>
                  <a:pt x="102496" y="142928"/>
                  <a:pt x="160005" y="95483"/>
                </a:cubicBezTo>
                <a:cubicBezTo>
                  <a:pt x="217514" y="48038"/>
                  <a:pt x="313843" y="6343"/>
                  <a:pt x="367039" y="592"/>
                </a:cubicBezTo>
                <a:cubicBezTo>
                  <a:pt x="420235" y="-5159"/>
                  <a:pt x="473432" y="32222"/>
                  <a:pt x="479183" y="60977"/>
                </a:cubicBezTo>
                <a:cubicBezTo>
                  <a:pt x="484934" y="89732"/>
                  <a:pt x="431737" y="140053"/>
                  <a:pt x="401545" y="173121"/>
                </a:cubicBezTo>
                <a:cubicBezTo>
                  <a:pt x="371353" y="206189"/>
                  <a:pt x="328220" y="220565"/>
                  <a:pt x="298028" y="259384"/>
                </a:cubicBezTo>
                <a:cubicBezTo>
                  <a:pt x="267836" y="298203"/>
                  <a:pt x="244831" y="364339"/>
                  <a:pt x="220390" y="406033"/>
                </a:cubicBezTo>
                <a:cubicBezTo>
                  <a:pt x="195949" y="447727"/>
                  <a:pt x="190198" y="503800"/>
                  <a:pt x="151379" y="509551"/>
                </a:cubicBezTo>
                <a:cubicBezTo>
                  <a:pt x="112560" y="515302"/>
                  <a:pt x="34922" y="486547"/>
                  <a:pt x="13356" y="449166"/>
                </a:cubicBezTo>
                <a:cubicBezTo>
                  <a:pt x="-8210" y="411785"/>
                  <a:pt x="-2458" y="344211"/>
                  <a:pt x="21983" y="285264"/>
                </a:cubicBezTo>
                <a:close/>
              </a:path>
            </a:pathLst>
          </a:custGeom>
          <a:gradFill flip="none" rotWithShape="1">
            <a:gsLst>
              <a:gs pos="0">
                <a:schemeClr val="accent2">
                  <a:lumMod val="5000"/>
                  <a:lumOff val="95000"/>
                </a:schemeClr>
              </a:gs>
              <a:gs pos="74000">
                <a:schemeClr val="accent2">
                  <a:lumMod val="45000"/>
                  <a:lumOff val="55000"/>
                </a:schemeClr>
              </a:gs>
              <a:gs pos="83000">
                <a:schemeClr val="accent2">
                  <a:lumMod val="45000"/>
                  <a:lumOff val="55000"/>
                </a:schemeClr>
              </a:gs>
              <a:gs pos="100000">
                <a:schemeClr val="accent2">
                  <a:lumMod val="30000"/>
                  <a:lumOff val="70000"/>
                </a:schemeClr>
              </a:gs>
            </a:gsLst>
            <a:lin ang="5400000" scaled="1"/>
            <a:tileRect/>
          </a:gradFill>
          <a:ln w="317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ko-KR" altLang="en-US" sz="1200">
              <a:solidFill>
                <a:prstClr val="white"/>
              </a:solidFill>
            </a:endParaRPr>
          </a:p>
        </p:txBody>
      </p:sp>
      <p:cxnSp>
        <p:nvCxnSpPr>
          <p:cNvPr id="85" name="직선 화살표 연결선 84"/>
          <p:cNvCxnSpPr/>
          <p:nvPr/>
        </p:nvCxnSpPr>
        <p:spPr>
          <a:xfrm>
            <a:off x="4437457" y="4116644"/>
            <a:ext cx="0" cy="595996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36" name="그룹 1035"/>
          <p:cNvGrpSpPr/>
          <p:nvPr/>
        </p:nvGrpSpPr>
        <p:grpSpPr>
          <a:xfrm>
            <a:off x="953220" y="1886042"/>
            <a:ext cx="794175" cy="432844"/>
            <a:chOff x="953220" y="1886042"/>
            <a:chExt cx="794175" cy="432844"/>
          </a:xfrm>
        </p:grpSpPr>
        <p:sp>
          <p:nvSpPr>
            <p:cNvPr id="87" name="모서리가 둥근 직사각형 2"/>
            <p:cNvSpPr>
              <a:spLocks/>
            </p:cNvSpPr>
            <p:nvPr/>
          </p:nvSpPr>
          <p:spPr>
            <a:xfrm>
              <a:off x="973167" y="1916170"/>
              <a:ext cx="755065" cy="373752"/>
            </a:xfrm>
            <a:custGeom>
              <a:avLst/>
              <a:gdLst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31188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93181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163660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496514 w 2874936"/>
                <a:gd name="connsiteY5" fmla="*/ 138709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300931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308680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7749 w 2882685"/>
                <a:gd name="connsiteY0" fmla="*/ 300931 h 1394848"/>
                <a:gd name="connsiteX1" fmla="*/ 308679 w 2882685"/>
                <a:gd name="connsiteY1" fmla="*/ 1 h 1394848"/>
                <a:gd name="connsiteX2" fmla="*/ 2519761 w 2882685"/>
                <a:gd name="connsiteY2" fmla="*/ 0 h 1394848"/>
                <a:gd name="connsiteX3" fmla="*/ 2882685 w 2882685"/>
                <a:gd name="connsiteY3" fmla="*/ 262185 h 1394848"/>
                <a:gd name="connsiteX4" fmla="*/ 2874936 w 2882685"/>
                <a:gd name="connsiteY4" fmla="*/ 1078419 h 1394848"/>
                <a:gd name="connsiteX5" fmla="*/ 2558507 w 2882685"/>
                <a:gd name="connsiteY5" fmla="*/ 1394847 h 1394848"/>
                <a:gd name="connsiteX6" fmla="*/ 316429 w 2882685"/>
                <a:gd name="connsiteY6" fmla="*/ 1394848 h 1394848"/>
                <a:gd name="connsiteX7" fmla="*/ 0 w 2882685"/>
                <a:gd name="connsiteY7" fmla="*/ 1086168 h 1394848"/>
                <a:gd name="connsiteX8" fmla="*/ 7749 w 2882685"/>
                <a:gd name="connsiteY8" fmla="*/ 300931 h 13948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882685" h="1394848">
                  <a:moveTo>
                    <a:pt x="7749" y="300931"/>
                  </a:moveTo>
                  <a:cubicBezTo>
                    <a:pt x="7749" y="173249"/>
                    <a:pt x="180997" y="1"/>
                    <a:pt x="308679" y="1"/>
                  </a:cubicBezTo>
                  <a:lnTo>
                    <a:pt x="2519761" y="0"/>
                  </a:lnTo>
                  <a:cubicBezTo>
                    <a:pt x="2647443" y="0"/>
                    <a:pt x="2882685" y="134503"/>
                    <a:pt x="2882685" y="262185"/>
                  </a:cubicBezTo>
                  <a:lnTo>
                    <a:pt x="2874936" y="1078419"/>
                  </a:lnTo>
                  <a:cubicBezTo>
                    <a:pt x="2874936" y="1206101"/>
                    <a:pt x="2686189" y="1394847"/>
                    <a:pt x="2558507" y="1394847"/>
                  </a:cubicBezTo>
                  <a:lnTo>
                    <a:pt x="316429" y="1394848"/>
                  </a:lnTo>
                  <a:cubicBezTo>
                    <a:pt x="188747" y="1394848"/>
                    <a:pt x="0" y="1213850"/>
                    <a:pt x="0" y="1086168"/>
                  </a:cubicBezTo>
                  <a:lnTo>
                    <a:pt x="7749" y="300931"/>
                  </a:lnTo>
                  <a:close/>
                </a:path>
              </a:pathLst>
            </a:custGeom>
            <a:solidFill>
              <a:srgbClr val="FF7C8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93" name="모서리가 둥근 직사각형 2"/>
            <p:cNvSpPr>
              <a:spLocks/>
            </p:cNvSpPr>
            <p:nvPr/>
          </p:nvSpPr>
          <p:spPr>
            <a:xfrm>
              <a:off x="990327" y="1925600"/>
              <a:ext cx="720744" cy="354893"/>
            </a:xfrm>
            <a:custGeom>
              <a:avLst/>
              <a:gdLst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31188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93181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163660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496514 w 2874936"/>
                <a:gd name="connsiteY5" fmla="*/ 138709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300931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308680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7749 w 2882685"/>
                <a:gd name="connsiteY0" fmla="*/ 300931 h 1394848"/>
                <a:gd name="connsiteX1" fmla="*/ 308679 w 2882685"/>
                <a:gd name="connsiteY1" fmla="*/ 1 h 1394848"/>
                <a:gd name="connsiteX2" fmla="*/ 2519761 w 2882685"/>
                <a:gd name="connsiteY2" fmla="*/ 0 h 1394848"/>
                <a:gd name="connsiteX3" fmla="*/ 2882685 w 2882685"/>
                <a:gd name="connsiteY3" fmla="*/ 262185 h 1394848"/>
                <a:gd name="connsiteX4" fmla="*/ 2874936 w 2882685"/>
                <a:gd name="connsiteY4" fmla="*/ 1078419 h 1394848"/>
                <a:gd name="connsiteX5" fmla="*/ 2558507 w 2882685"/>
                <a:gd name="connsiteY5" fmla="*/ 1394847 h 1394848"/>
                <a:gd name="connsiteX6" fmla="*/ 316429 w 2882685"/>
                <a:gd name="connsiteY6" fmla="*/ 1394848 h 1394848"/>
                <a:gd name="connsiteX7" fmla="*/ 0 w 2882685"/>
                <a:gd name="connsiteY7" fmla="*/ 1086168 h 1394848"/>
                <a:gd name="connsiteX8" fmla="*/ 7749 w 2882685"/>
                <a:gd name="connsiteY8" fmla="*/ 300931 h 13948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882685" h="1394848">
                  <a:moveTo>
                    <a:pt x="7749" y="300931"/>
                  </a:moveTo>
                  <a:cubicBezTo>
                    <a:pt x="7749" y="173249"/>
                    <a:pt x="180997" y="1"/>
                    <a:pt x="308679" y="1"/>
                  </a:cubicBezTo>
                  <a:lnTo>
                    <a:pt x="2519761" y="0"/>
                  </a:lnTo>
                  <a:cubicBezTo>
                    <a:pt x="2647443" y="0"/>
                    <a:pt x="2882685" y="134503"/>
                    <a:pt x="2882685" y="262185"/>
                  </a:cubicBezTo>
                  <a:lnTo>
                    <a:pt x="2874936" y="1078419"/>
                  </a:lnTo>
                  <a:cubicBezTo>
                    <a:pt x="2874936" y="1206101"/>
                    <a:pt x="2686189" y="1394847"/>
                    <a:pt x="2558507" y="1394847"/>
                  </a:cubicBezTo>
                  <a:lnTo>
                    <a:pt x="316429" y="1394848"/>
                  </a:lnTo>
                  <a:cubicBezTo>
                    <a:pt x="188747" y="1394848"/>
                    <a:pt x="0" y="1213850"/>
                    <a:pt x="0" y="1086168"/>
                  </a:cubicBezTo>
                  <a:lnTo>
                    <a:pt x="7749" y="300931"/>
                  </a:lnTo>
                  <a:close/>
                </a:path>
              </a:pathLst>
            </a:custGeom>
            <a:solidFill>
              <a:srgbClr val="FF99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94" name="모서리가 둥근 직사각형 2"/>
            <p:cNvSpPr/>
            <p:nvPr/>
          </p:nvSpPr>
          <p:spPr>
            <a:xfrm>
              <a:off x="1007488" y="1936976"/>
              <a:ext cx="686423" cy="332140"/>
            </a:xfrm>
            <a:custGeom>
              <a:avLst/>
              <a:gdLst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31188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93181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163660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496514 w 2874936"/>
                <a:gd name="connsiteY5" fmla="*/ 138709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300931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308680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7749 w 2882685"/>
                <a:gd name="connsiteY0" fmla="*/ 300931 h 1394848"/>
                <a:gd name="connsiteX1" fmla="*/ 308679 w 2882685"/>
                <a:gd name="connsiteY1" fmla="*/ 1 h 1394848"/>
                <a:gd name="connsiteX2" fmla="*/ 2519761 w 2882685"/>
                <a:gd name="connsiteY2" fmla="*/ 0 h 1394848"/>
                <a:gd name="connsiteX3" fmla="*/ 2882685 w 2882685"/>
                <a:gd name="connsiteY3" fmla="*/ 262185 h 1394848"/>
                <a:gd name="connsiteX4" fmla="*/ 2874936 w 2882685"/>
                <a:gd name="connsiteY4" fmla="*/ 1078419 h 1394848"/>
                <a:gd name="connsiteX5" fmla="*/ 2558507 w 2882685"/>
                <a:gd name="connsiteY5" fmla="*/ 1394847 h 1394848"/>
                <a:gd name="connsiteX6" fmla="*/ 316429 w 2882685"/>
                <a:gd name="connsiteY6" fmla="*/ 1394848 h 1394848"/>
                <a:gd name="connsiteX7" fmla="*/ 0 w 2882685"/>
                <a:gd name="connsiteY7" fmla="*/ 1086168 h 1394848"/>
                <a:gd name="connsiteX8" fmla="*/ 7749 w 2882685"/>
                <a:gd name="connsiteY8" fmla="*/ 300931 h 13948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882685" h="1394848">
                  <a:moveTo>
                    <a:pt x="7749" y="300931"/>
                  </a:moveTo>
                  <a:cubicBezTo>
                    <a:pt x="7749" y="173249"/>
                    <a:pt x="180997" y="1"/>
                    <a:pt x="308679" y="1"/>
                  </a:cubicBezTo>
                  <a:lnTo>
                    <a:pt x="2519761" y="0"/>
                  </a:lnTo>
                  <a:cubicBezTo>
                    <a:pt x="2647443" y="0"/>
                    <a:pt x="2882685" y="134503"/>
                    <a:pt x="2882685" y="262185"/>
                  </a:cubicBezTo>
                  <a:lnTo>
                    <a:pt x="2874936" y="1078419"/>
                  </a:lnTo>
                  <a:cubicBezTo>
                    <a:pt x="2874936" y="1206101"/>
                    <a:pt x="2686189" y="1394847"/>
                    <a:pt x="2558507" y="1394847"/>
                  </a:cubicBezTo>
                  <a:lnTo>
                    <a:pt x="316429" y="1394848"/>
                  </a:lnTo>
                  <a:cubicBezTo>
                    <a:pt x="188747" y="1394848"/>
                    <a:pt x="0" y="1213850"/>
                    <a:pt x="0" y="1086168"/>
                  </a:cubicBezTo>
                  <a:lnTo>
                    <a:pt x="7749" y="300931"/>
                  </a:lnTo>
                  <a:close/>
                </a:path>
              </a:pathLst>
            </a:custGeom>
            <a:solidFill>
              <a:srgbClr val="FFCCC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95" name="자유형 94"/>
            <p:cNvSpPr/>
            <p:nvPr/>
          </p:nvSpPr>
          <p:spPr>
            <a:xfrm>
              <a:off x="1044267" y="1985490"/>
              <a:ext cx="607489" cy="231703"/>
            </a:xfrm>
            <a:custGeom>
              <a:avLst/>
              <a:gdLst>
                <a:gd name="connsiteX0" fmla="*/ 1523829 w 2573771"/>
                <a:gd name="connsiteY0" fmla="*/ 127016 h 958742"/>
                <a:gd name="connsiteX1" fmla="*/ 1275473 w 2573771"/>
                <a:gd name="connsiteY1" fmla="*/ 194749 h 958742"/>
                <a:gd name="connsiteX2" fmla="*/ 1060984 w 2573771"/>
                <a:gd name="connsiteY2" fmla="*/ 149593 h 958742"/>
                <a:gd name="connsiteX3" fmla="*/ 620718 w 2573771"/>
                <a:gd name="connsiteY3" fmla="*/ 2838 h 958742"/>
                <a:gd name="connsiteX4" fmla="*/ 112718 w 2573771"/>
                <a:gd name="connsiteY4" fmla="*/ 183460 h 958742"/>
                <a:gd name="connsiteX5" fmla="*/ 11118 w 2573771"/>
                <a:gd name="connsiteY5" fmla="*/ 623727 h 958742"/>
                <a:gd name="connsiteX6" fmla="*/ 293340 w 2573771"/>
                <a:gd name="connsiteY6" fmla="*/ 928527 h 958742"/>
                <a:gd name="connsiteX7" fmla="*/ 790051 w 2573771"/>
                <a:gd name="connsiteY7" fmla="*/ 928527 h 958742"/>
                <a:gd name="connsiteX8" fmla="*/ 1185162 w 2573771"/>
                <a:gd name="connsiteY8" fmla="*/ 759193 h 958742"/>
                <a:gd name="connsiteX9" fmla="*/ 1444806 w 2573771"/>
                <a:gd name="connsiteY9" fmla="*/ 759193 h 958742"/>
                <a:gd name="connsiteX10" fmla="*/ 1738318 w 2573771"/>
                <a:gd name="connsiteY10" fmla="*/ 928527 h 958742"/>
                <a:gd name="connsiteX11" fmla="*/ 2302762 w 2573771"/>
                <a:gd name="connsiteY11" fmla="*/ 883371 h 958742"/>
                <a:gd name="connsiteX12" fmla="*/ 2573695 w 2573771"/>
                <a:gd name="connsiteY12" fmla="*/ 454393 h 958742"/>
                <a:gd name="connsiteX13" fmla="*/ 2280184 w 2573771"/>
                <a:gd name="connsiteY13" fmla="*/ 47993 h 958742"/>
                <a:gd name="connsiteX14" fmla="*/ 1738318 w 2573771"/>
                <a:gd name="connsiteY14" fmla="*/ 14127 h 958742"/>
                <a:gd name="connsiteX15" fmla="*/ 1523829 w 2573771"/>
                <a:gd name="connsiteY15" fmla="*/ 127016 h 958742"/>
                <a:gd name="connsiteX0" fmla="*/ 1523829 w 2573771"/>
                <a:gd name="connsiteY0" fmla="*/ 141331 h 973057"/>
                <a:gd name="connsiteX1" fmla="*/ 1275473 w 2573771"/>
                <a:gd name="connsiteY1" fmla="*/ 209064 h 973057"/>
                <a:gd name="connsiteX2" fmla="*/ 1060984 w 2573771"/>
                <a:gd name="connsiteY2" fmla="*/ 163908 h 973057"/>
                <a:gd name="connsiteX3" fmla="*/ 620718 w 2573771"/>
                <a:gd name="connsiteY3" fmla="*/ 17153 h 973057"/>
                <a:gd name="connsiteX4" fmla="*/ 112718 w 2573771"/>
                <a:gd name="connsiteY4" fmla="*/ 197775 h 973057"/>
                <a:gd name="connsiteX5" fmla="*/ 11118 w 2573771"/>
                <a:gd name="connsiteY5" fmla="*/ 638042 h 973057"/>
                <a:gd name="connsiteX6" fmla="*/ 293340 w 2573771"/>
                <a:gd name="connsiteY6" fmla="*/ 942842 h 973057"/>
                <a:gd name="connsiteX7" fmla="*/ 790051 w 2573771"/>
                <a:gd name="connsiteY7" fmla="*/ 942842 h 973057"/>
                <a:gd name="connsiteX8" fmla="*/ 1185162 w 2573771"/>
                <a:gd name="connsiteY8" fmla="*/ 773508 h 973057"/>
                <a:gd name="connsiteX9" fmla="*/ 1444806 w 2573771"/>
                <a:gd name="connsiteY9" fmla="*/ 773508 h 973057"/>
                <a:gd name="connsiteX10" fmla="*/ 1738318 w 2573771"/>
                <a:gd name="connsiteY10" fmla="*/ 942842 h 973057"/>
                <a:gd name="connsiteX11" fmla="*/ 2302762 w 2573771"/>
                <a:gd name="connsiteY11" fmla="*/ 897686 h 973057"/>
                <a:gd name="connsiteX12" fmla="*/ 2573695 w 2573771"/>
                <a:gd name="connsiteY12" fmla="*/ 468708 h 973057"/>
                <a:gd name="connsiteX13" fmla="*/ 2280184 w 2573771"/>
                <a:gd name="connsiteY13" fmla="*/ 62308 h 973057"/>
                <a:gd name="connsiteX14" fmla="*/ 1885074 w 2573771"/>
                <a:gd name="connsiteY14" fmla="*/ 5864 h 973057"/>
                <a:gd name="connsiteX15" fmla="*/ 1523829 w 2573771"/>
                <a:gd name="connsiteY15" fmla="*/ 141331 h 973057"/>
                <a:gd name="connsiteX0" fmla="*/ 1523829 w 2573763"/>
                <a:gd name="connsiteY0" fmla="*/ 141331 h 973057"/>
                <a:gd name="connsiteX1" fmla="*/ 1275473 w 2573763"/>
                <a:gd name="connsiteY1" fmla="*/ 209064 h 973057"/>
                <a:gd name="connsiteX2" fmla="*/ 1060984 w 2573763"/>
                <a:gd name="connsiteY2" fmla="*/ 163908 h 973057"/>
                <a:gd name="connsiteX3" fmla="*/ 620718 w 2573763"/>
                <a:gd name="connsiteY3" fmla="*/ 17153 h 973057"/>
                <a:gd name="connsiteX4" fmla="*/ 112718 w 2573763"/>
                <a:gd name="connsiteY4" fmla="*/ 197775 h 973057"/>
                <a:gd name="connsiteX5" fmla="*/ 11118 w 2573763"/>
                <a:gd name="connsiteY5" fmla="*/ 638042 h 973057"/>
                <a:gd name="connsiteX6" fmla="*/ 293340 w 2573763"/>
                <a:gd name="connsiteY6" fmla="*/ 942842 h 973057"/>
                <a:gd name="connsiteX7" fmla="*/ 790051 w 2573763"/>
                <a:gd name="connsiteY7" fmla="*/ 942842 h 973057"/>
                <a:gd name="connsiteX8" fmla="*/ 1185162 w 2573763"/>
                <a:gd name="connsiteY8" fmla="*/ 773508 h 973057"/>
                <a:gd name="connsiteX9" fmla="*/ 1444806 w 2573763"/>
                <a:gd name="connsiteY9" fmla="*/ 773508 h 973057"/>
                <a:gd name="connsiteX10" fmla="*/ 1839918 w 2573763"/>
                <a:gd name="connsiteY10" fmla="*/ 942842 h 973057"/>
                <a:gd name="connsiteX11" fmla="*/ 2302762 w 2573763"/>
                <a:gd name="connsiteY11" fmla="*/ 897686 h 973057"/>
                <a:gd name="connsiteX12" fmla="*/ 2573695 w 2573763"/>
                <a:gd name="connsiteY12" fmla="*/ 468708 h 973057"/>
                <a:gd name="connsiteX13" fmla="*/ 2280184 w 2573763"/>
                <a:gd name="connsiteY13" fmla="*/ 62308 h 973057"/>
                <a:gd name="connsiteX14" fmla="*/ 1885074 w 2573763"/>
                <a:gd name="connsiteY14" fmla="*/ 5864 h 973057"/>
                <a:gd name="connsiteX15" fmla="*/ 1523829 w 2573763"/>
                <a:gd name="connsiteY15" fmla="*/ 141331 h 973057"/>
                <a:gd name="connsiteX0" fmla="*/ 1523829 w 2551194"/>
                <a:gd name="connsiteY0" fmla="*/ 141331 h 973057"/>
                <a:gd name="connsiteX1" fmla="*/ 1275473 w 2551194"/>
                <a:gd name="connsiteY1" fmla="*/ 209064 h 973057"/>
                <a:gd name="connsiteX2" fmla="*/ 1060984 w 2551194"/>
                <a:gd name="connsiteY2" fmla="*/ 163908 h 973057"/>
                <a:gd name="connsiteX3" fmla="*/ 620718 w 2551194"/>
                <a:gd name="connsiteY3" fmla="*/ 17153 h 973057"/>
                <a:gd name="connsiteX4" fmla="*/ 112718 w 2551194"/>
                <a:gd name="connsiteY4" fmla="*/ 197775 h 973057"/>
                <a:gd name="connsiteX5" fmla="*/ 11118 w 2551194"/>
                <a:gd name="connsiteY5" fmla="*/ 638042 h 973057"/>
                <a:gd name="connsiteX6" fmla="*/ 293340 w 2551194"/>
                <a:gd name="connsiteY6" fmla="*/ 942842 h 973057"/>
                <a:gd name="connsiteX7" fmla="*/ 790051 w 2551194"/>
                <a:gd name="connsiteY7" fmla="*/ 942842 h 973057"/>
                <a:gd name="connsiteX8" fmla="*/ 1185162 w 2551194"/>
                <a:gd name="connsiteY8" fmla="*/ 773508 h 973057"/>
                <a:gd name="connsiteX9" fmla="*/ 1444806 w 2551194"/>
                <a:gd name="connsiteY9" fmla="*/ 773508 h 973057"/>
                <a:gd name="connsiteX10" fmla="*/ 1839918 w 2551194"/>
                <a:gd name="connsiteY10" fmla="*/ 942842 h 973057"/>
                <a:gd name="connsiteX11" fmla="*/ 2302762 w 2551194"/>
                <a:gd name="connsiteY11" fmla="*/ 897686 h 973057"/>
                <a:gd name="connsiteX12" fmla="*/ 2551117 w 2551194"/>
                <a:gd name="connsiteY12" fmla="*/ 468708 h 973057"/>
                <a:gd name="connsiteX13" fmla="*/ 2280184 w 2551194"/>
                <a:gd name="connsiteY13" fmla="*/ 62308 h 973057"/>
                <a:gd name="connsiteX14" fmla="*/ 1885074 w 2551194"/>
                <a:gd name="connsiteY14" fmla="*/ 5864 h 973057"/>
                <a:gd name="connsiteX15" fmla="*/ 1523829 w 2551194"/>
                <a:gd name="connsiteY15" fmla="*/ 141331 h 97305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</a:cxnLst>
              <a:rect l="l" t="t" r="r" b="b"/>
              <a:pathLst>
                <a:path w="2551194" h="973057">
                  <a:moveTo>
                    <a:pt x="1523829" y="141331"/>
                  </a:moveTo>
                  <a:cubicBezTo>
                    <a:pt x="1422229" y="175198"/>
                    <a:pt x="1352614" y="205301"/>
                    <a:pt x="1275473" y="209064"/>
                  </a:cubicBezTo>
                  <a:cubicBezTo>
                    <a:pt x="1198332" y="212827"/>
                    <a:pt x="1170110" y="195893"/>
                    <a:pt x="1060984" y="163908"/>
                  </a:cubicBezTo>
                  <a:cubicBezTo>
                    <a:pt x="951858" y="131923"/>
                    <a:pt x="778762" y="11509"/>
                    <a:pt x="620718" y="17153"/>
                  </a:cubicBezTo>
                  <a:cubicBezTo>
                    <a:pt x="462674" y="22797"/>
                    <a:pt x="214318" y="94293"/>
                    <a:pt x="112718" y="197775"/>
                  </a:cubicBezTo>
                  <a:cubicBezTo>
                    <a:pt x="11118" y="301257"/>
                    <a:pt x="-18986" y="513864"/>
                    <a:pt x="11118" y="638042"/>
                  </a:cubicBezTo>
                  <a:cubicBezTo>
                    <a:pt x="41222" y="762220"/>
                    <a:pt x="163518" y="892042"/>
                    <a:pt x="293340" y="942842"/>
                  </a:cubicBezTo>
                  <a:cubicBezTo>
                    <a:pt x="423162" y="993642"/>
                    <a:pt x="641414" y="971064"/>
                    <a:pt x="790051" y="942842"/>
                  </a:cubicBezTo>
                  <a:cubicBezTo>
                    <a:pt x="938688" y="914620"/>
                    <a:pt x="1076036" y="801730"/>
                    <a:pt x="1185162" y="773508"/>
                  </a:cubicBezTo>
                  <a:cubicBezTo>
                    <a:pt x="1294288" y="745286"/>
                    <a:pt x="1335680" y="745286"/>
                    <a:pt x="1444806" y="773508"/>
                  </a:cubicBezTo>
                  <a:cubicBezTo>
                    <a:pt x="1553932" y="801730"/>
                    <a:pt x="1696925" y="922146"/>
                    <a:pt x="1839918" y="942842"/>
                  </a:cubicBezTo>
                  <a:cubicBezTo>
                    <a:pt x="1982911" y="963538"/>
                    <a:pt x="2184229" y="976708"/>
                    <a:pt x="2302762" y="897686"/>
                  </a:cubicBezTo>
                  <a:cubicBezTo>
                    <a:pt x="2421295" y="818664"/>
                    <a:pt x="2554880" y="607938"/>
                    <a:pt x="2551117" y="468708"/>
                  </a:cubicBezTo>
                  <a:cubicBezTo>
                    <a:pt x="2547354" y="329478"/>
                    <a:pt x="2419413" y="135686"/>
                    <a:pt x="2280184" y="62308"/>
                  </a:cubicBezTo>
                  <a:cubicBezTo>
                    <a:pt x="2140955" y="-11070"/>
                    <a:pt x="2011133" y="-3544"/>
                    <a:pt x="1885074" y="5864"/>
                  </a:cubicBezTo>
                  <a:cubicBezTo>
                    <a:pt x="1759015" y="15271"/>
                    <a:pt x="1625429" y="107464"/>
                    <a:pt x="1523829" y="141331"/>
                  </a:cubicBezTo>
                  <a:close/>
                </a:path>
              </a:pathLst>
            </a:custGeom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42000">
                  <a:srgbClr val="FF9999"/>
                </a:gs>
                <a:gs pos="92000">
                  <a:srgbClr val="FFCCCC"/>
                </a:gs>
              </a:gsLst>
              <a:path path="circle">
                <a:fillToRect r="100000" b="100000"/>
              </a:path>
              <a:tileRect l="-100000" t="-100000"/>
            </a:gradFill>
            <a:ln w="6350">
              <a:solidFill>
                <a:srgbClr val="FF7C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96" name="타원 95"/>
            <p:cNvSpPr/>
            <p:nvPr/>
          </p:nvSpPr>
          <p:spPr>
            <a:xfrm>
              <a:off x="1286185" y="1957265"/>
              <a:ext cx="123653" cy="60006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97" name="타원 96"/>
            <p:cNvSpPr/>
            <p:nvPr/>
          </p:nvSpPr>
          <p:spPr>
            <a:xfrm>
              <a:off x="1288873" y="2181361"/>
              <a:ext cx="123653" cy="60006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98" name="자유형 97"/>
            <p:cNvSpPr/>
            <p:nvPr/>
          </p:nvSpPr>
          <p:spPr>
            <a:xfrm>
              <a:off x="1105512" y="2009498"/>
              <a:ext cx="490373" cy="171863"/>
            </a:xfrm>
            <a:custGeom>
              <a:avLst/>
              <a:gdLst>
                <a:gd name="connsiteX0" fmla="*/ 10863 w 2059359"/>
                <a:gd name="connsiteY0" fmla="*/ 701193 h 721753"/>
                <a:gd name="connsiteX1" fmla="*/ 10863 w 2059359"/>
                <a:gd name="connsiteY1" fmla="*/ 339949 h 721753"/>
                <a:gd name="connsiteX2" fmla="*/ 123752 w 2059359"/>
                <a:gd name="connsiteY2" fmla="*/ 215771 h 721753"/>
                <a:gd name="connsiteX3" fmla="*/ 191485 w 2059359"/>
                <a:gd name="connsiteY3" fmla="*/ 328660 h 721753"/>
                <a:gd name="connsiteX4" fmla="*/ 112463 w 2059359"/>
                <a:gd name="connsiteY4" fmla="*/ 610882 h 721753"/>
                <a:gd name="connsiteX5" fmla="*/ 214063 w 2059359"/>
                <a:gd name="connsiteY5" fmla="*/ 689904 h 721753"/>
                <a:gd name="connsiteX6" fmla="*/ 270507 w 2059359"/>
                <a:gd name="connsiteY6" fmla="*/ 486704 h 721753"/>
                <a:gd name="connsiteX7" fmla="*/ 293085 w 2059359"/>
                <a:gd name="connsiteY7" fmla="*/ 80304 h 721753"/>
                <a:gd name="connsiteX8" fmla="*/ 372107 w 2059359"/>
                <a:gd name="connsiteY8" fmla="*/ 46438 h 721753"/>
                <a:gd name="connsiteX9" fmla="*/ 496285 w 2059359"/>
                <a:gd name="connsiteY9" fmla="*/ 125460 h 721753"/>
                <a:gd name="connsiteX10" fmla="*/ 405974 w 2059359"/>
                <a:gd name="connsiteY10" fmla="*/ 430260 h 721753"/>
                <a:gd name="connsiteX11" fmla="*/ 405974 w 2059359"/>
                <a:gd name="connsiteY11" fmla="*/ 610882 h 721753"/>
                <a:gd name="connsiteX12" fmla="*/ 484996 w 2059359"/>
                <a:gd name="connsiteY12" fmla="*/ 656038 h 721753"/>
                <a:gd name="connsiteX13" fmla="*/ 586596 w 2059359"/>
                <a:gd name="connsiteY13" fmla="*/ 418971 h 721753"/>
                <a:gd name="connsiteX14" fmla="*/ 597885 w 2059359"/>
                <a:gd name="connsiteY14" fmla="*/ 148038 h 721753"/>
                <a:gd name="connsiteX15" fmla="*/ 733352 w 2059359"/>
                <a:gd name="connsiteY15" fmla="*/ 227060 h 721753"/>
                <a:gd name="connsiteX16" fmla="*/ 665618 w 2059359"/>
                <a:gd name="connsiteY16" fmla="*/ 520571 h 721753"/>
                <a:gd name="connsiteX17" fmla="*/ 744641 w 2059359"/>
                <a:gd name="connsiteY17" fmla="*/ 622171 h 721753"/>
                <a:gd name="connsiteX18" fmla="*/ 812374 w 2059359"/>
                <a:gd name="connsiteY18" fmla="*/ 362527 h 721753"/>
                <a:gd name="connsiteX19" fmla="*/ 834952 w 2059359"/>
                <a:gd name="connsiteY19" fmla="*/ 181904 h 721753"/>
                <a:gd name="connsiteX20" fmla="*/ 913974 w 2059359"/>
                <a:gd name="connsiteY20" fmla="*/ 317371 h 721753"/>
                <a:gd name="connsiteX21" fmla="*/ 913974 w 2059359"/>
                <a:gd name="connsiteY21" fmla="*/ 554438 h 721753"/>
                <a:gd name="connsiteX22" fmla="*/ 981707 w 2059359"/>
                <a:gd name="connsiteY22" fmla="*/ 588304 h 721753"/>
                <a:gd name="connsiteX23" fmla="*/ 1026863 w 2059359"/>
                <a:gd name="connsiteY23" fmla="*/ 306082 h 721753"/>
                <a:gd name="connsiteX24" fmla="*/ 1151041 w 2059359"/>
                <a:gd name="connsiteY24" fmla="*/ 396393 h 721753"/>
                <a:gd name="connsiteX25" fmla="*/ 1151041 w 2059359"/>
                <a:gd name="connsiteY25" fmla="*/ 610882 h 721753"/>
                <a:gd name="connsiteX26" fmla="*/ 1320374 w 2059359"/>
                <a:gd name="connsiteY26" fmla="*/ 554438 h 721753"/>
                <a:gd name="connsiteX27" fmla="*/ 1320374 w 2059359"/>
                <a:gd name="connsiteY27" fmla="*/ 91593 h 721753"/>
                <a:gd name="connsiteX28" fmla="*/ 1421974 w 2059359"/>
                <a:gd name="connsiteY28" fmla="*/ 170616 h 721753"/>
                <a:gd name="connsiteX29" fmla="*/ 1410685 w 2059359"/>
                <a:gd name="connsiteY29" fmla="*/ 475416 h 721753"/>
                <a:gd name="connsiteX30" fmla="*/ 1444552 w 2059359"/>
                <a:gd name="connsiteY30" fmla="*/ 712482 h 721753"/>
                <a:gd name="connsiteX31" fmla="*/ 1534863 w 2059359"/>
                <a:gd name="connsiteY31" fmla="*/ 588304 h 721753"/>
                <a:gd name="connsiteX32" fmla="*/ 1489707 w 2059359"/>
                <a:gd name="connsiteY32" fmla="*/ 204482 h 721753"/>
                <a:gd name="connsiteX33" fmla="*/ 1546152 w 2059359"/>
                <a:gd name="connsiteY33" fmla="*/ 1282 h 721753"/>
                <a:gd name="connsiteX34" fmla="*/ 1659041 w 2059359"/>
                <a:gd name="connsiteY34" fmla="*/ 294793 h 721753"/>
                <a:gd name="connsiteX35" fmla="*/ 1659041 w 2059359"/>
                <a:gd name="connsiteY35" fmla="*/ 644749 h 721753"/>
                <a:gd name="connsiteX36" fmla="*/ 1817085 w 2059359"/>
                <a:gd name="connsiteY36" fmla="*/ 701193 h 721753"/>
                <a:gd name="connsiteX37" fmla="*/ 1783218 w 2059359"/>
                <a:gd name="connsiteY37" fmla="*/ 373816 h 721753"/>
                <a:gd name="connsiteX38" fmla="*/ 1771930 w 2059359"/>
                <a:gd name="connsiteY38" fmla="*/ 159327 h 721753"/>
                <a:gd name="connsiteX39" fmla="*/ 1850952 w 2059359"/>
                <a:gd name="connsiteY39" fmla="*/ 283504 h 721753"/>
                <a:gd name="connsiteX40" fmla="*/ 1941263 w 2059359"/>
                <a:gd name="connsiteY40" fmla="*/ 543149 h 721753"/>
                <a:gd name="connsiteX41" fmla="*/ 2054152 w 2059359"/>
                <a:gd name="connsiteY41" fmla="*/ 554438 h 721753"/>
                <a:gd name="connsiteX42" fmla="*/ 2031574 w 2059359"/>
                <a:gd name="connsiteY42" fmla="*/ 317371 h 721753"/>
                <a:gd name="connsiteX43" fmla="*/ 1952552 w 2059359"/>
                <a:gd name="connsiteY43" fmla="*/ 193193 h 7217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</a:cxnLst>
              <a:rect l="l" t="t" r="r" b="b"/>
              <a:pathLst>
                <a:path w="2059359" h="721753">
                  <a:moveTo>
                    <a:pt x="10863" y="701193"/>
                  </a:moveTo>
                  <a:cubicBezTo>
                    <a:pt x="1455" y="561023"/>
                    <a:pt x="-7952" y="420853"/>
                    <a:pt x="10863" y="339949"/>
                  </a:cubicBezTo>
                  <a:cubicBezTo>
                    <a:pt x="29678" y="259045"/>
                    <a:pt x="93648" y="217652"/>
                    <a:pt x="123752" y="215771"/>
                  </a:cubicBezTo>
                  <a:cubicBezTo>
                    <a:pt x="153856" y="213889"/>
                    <a:pt x="193366" y="262808"/>
                    <a:pt x="191485" y="328660"/>
                  </a:cubicBezTo>
                  <a:cubicBezTo>
                    <a:pt x="189604" y="394512"/>
                    <a:pt x="108700" y="550675"/>
                    <a:pt x="112463" y="610882"/>
                  </a:cubicBezTo>
                  <a:cubicBezTo>
                    <a:pt x="116226" y="671089"/>
                    <a:pt x="187722" y="710600"/>
                    <a:pt x="214063" y="689904"/>
                  </a:cubicBezTo>
                  <a:cubicBezTo>
                    <a:pt x="240404" y="669208"/>
                    <a:pt x="257337" y="588304"/>
                    <a:pt x="270507" y="486704"/>
                  </a:cubicBezTo>
                  <a:cubicBezTo>
                    <a:pt x="283677" y="385104"/>
                    <a:pt x="276152" y="153682"/>
                    <a:pt x="293085" y="80304"/>
                  </a:cubicBezTo>
                  <a:cubicBezTo>
                    <a:pt x="310018" y="6926"/>
                    <a:pt x="338240" y="38912"/>
                    <a:pt x="372107" y="46438"/>
                  </a:cubicBezTo>
                  <a:cubicBezTo>
                    <a:pt x="405974" y="53964"/>
                    <a:pt x="490641" y="61490"/>
                    <a:pt x="496285" y="125460"/>
                  </a:cubicBezTo>
                  <a:cubicBezTo>
                    <a:pt x="501930" y="189430"/>
                    <a:pt x="421026" y="349356"/>
                    <a:pt x="405974" y="430260"/>
                  </a:cubicBezTo>
                  <a:cubicBezTo>
                    <a:pt x="390922" y="511164"/>
                    <a:pt x="392804" y="573252"/>
                    <a:pt x="405974" y="610882"/>
                  </a:cubicBezTo>
                  <a:cubicBezTo>
                    <a:pt x="419144" y="648512"/>
                    <a:pt x="454892" y="688023"/>
                    <a:pt x="484996" y="656038"/>
                  </a:cubicBezTo>
                  <a:cubicBezTo>
                    <a:pt x="515100" y="624053"/>
                    <a:pt x="567781" y="503638"/>
                    <a:pt x="586596" y="418971"/>
                  </a:cubicBezTo>
                  <a:cubicBezTo>
                    <a:pt x="605411" y="334304"/>
                    <a:pt x="573426" y="180023"/>
                    <a:pt x="597885" y="148038"/>
                  </a:cubicBezTo>
                  <a:cubicBezTo>
                    <a:pt x="622344" y="116053"/>
                    <a:pt x="722063" y="164971"/>
                    <a:pt x="733352" y="227060"/>
                  </a:cubicBezTo>
                  <a:cubicBezTo>
                    <a:pt x="744641" y="289149"/>
                    <a:pt x="663737" y="454719"/>
                    <a:pt x="665618" y="520571"/>
                  </a:cubicBezTo>
                  <a:cubicBezTo>
                    <a:pt x="667499" y="586423"/>
                    <a:pt x="720182" y="648512"/>
                    <a:pt x="744641" y="622171"/>
                  </a:cubicBezTo>
                  <a:cubicBezTo>
                    <a:pt x="769100" y="595830"/>
                    <a:pt x="797322" y="435905"/>
                    <a:pt x="812374" y="362527"/>
                  </a:cubicBezTo>
                  <a:cubicBezTo>
                    <a:pt x="827426" y="289149"/>
                    <a:pt x="818019" y="189430"/>
                    <a:pt x="834952" y="181904"/>
                  </a:cubicBezTo>
                  <a:cubicBezTo>
                    <a:pt x="851885" y="174378"/>
                    <a:pt x="900804" y="255282"/>
                    <a:pt x="913974" y="317371"/>
                  </a:cubicBezTo>
                  <a:cubicBezTo>
                    <a:pt x="927144" y="379460"/>
                    <a:pt x="902685" y="509282"/>
                    <a:pt x="913974" y="554438"/>
                  </a:cubicBezTo>
                  <a:cubicBezTo>
                    <a:pt x="925263" y="599593"/>
                    <a:pt x="962892" y="629697"/>
                    <a:pt x="981707" y="588304"/>
                  </a:cubicBezTo>
                  <a:cubicBezTo>
                    <a:pt x="1000522" y="546911"/>
                    <a:pt x="998641" y="338067"/>
                    <a:pt x="1026863" y="306082"/>
                  </a:cubicBezTo>
                  <a:cubicBezTo>
                    <a:pt x="1055085" y="274097"/>
                    <a:pt x="1130345" y="345593"/>
                    <a:pt x="1151041" y="396393"/>
                  </a:cubicBezTo>
                  <a:cubicBezTo>
                    <a:pt x="1171737" y="447193"/>
                    <a:pt x="1122819" y="584541"/>
                    <a:pt x="1151041" y="610882"/>
                  </a:cubicBezTo>
                  <a:cubicBezTo>
                    <a:pt x="1179263" y="637223"/>
                    <a:pt x="1292152" y="640986"/>
                    <a:pt x="1320374" y="554438"/>
                  </a:cubicBezTo>
                  <a:cubicBezTo>
                    <a:pt x="1348596" y="467890"/>
                    <a:pt x="1303441" y="155563"/>
                    <a:pt x="1320374" y="91593"/>
                  </a:cubicBezTo>
                  <a:cubicBezTo>
                    <a:pt x="1337307" y="27623"/>
                    <a:pt x="1406922" y="106646"/>
                    <a:pt x="1421974" y="170616"/>
                  </a:cubicBezTo>
                  <a:cubicBezTo>
                    <a:pt x="1437026" y="234586"/>
                    <a:pt x="1406922" y="385105"/>
                    <a:pt x="1410685" y="475416"/>
                  </a:cubicBezTo>
                  <a:cubicBezTo>
                    <a:pt x="1414448" y="565727"/>
                    <a:pt x="1423856" y="693667"/>
                    <a:pt x="1444552" y="712482"/>
                  </a:cubicBezTo>
                  <a:cubicBezTo>
                    <a:pt x="1465248" y="731297"/>
                    <a:pt x="1527337" y="672971"/>
                    <a:pt x="1534863" y="588304"/>
                  </a:cubicBezTo>
                  <a:cubicBezTo>
                    <a:pt x="1542389" y="503637"/>
                    <a:pt x="1487826" y="302319"/>
                    <a:pt x="1489707" y="204482"/>
                  </a:cubicBezTo>
                  <a:cubicBezTo>
                    <a:pt x="1491589" y="106645"/>
                    <a:pt x="1517930" y="-13770"/>
                    <a:pt x="1546152" y="1282"/>
                  </a:cubicBezTo>
                  <a:cubicBezTo>
                    <a:pt x="1574374" y="16334"/>
                    <a:pt x="1640226" y="187548"/>
                    <a:pt x="1659041" y="294793"/>
                  </a:cubicBezTo>
                  <a:cubicBezTo>
                    <a:pt x="1677856" y="402037"/>
                    <a:pt x="1632700" y="577016"/>
                    <a:pt x="1659041" y="644749"/>
                  </a:cubicBezTo>
                  <a:cubicBezTo>
                    <a:pt x="1685382" y="712482"/>
                    <a:pt x="1796389" y="746348"/>
                    <a:pt x="1817085" y="701193"/>
                  </a:cubicBezTo>
                  <a:cubicBezTo>
                    <a:pt x="1837781" y="656038"/>
                    <a:pt x="1790744" y="464127"/>
                    <a:pt x="1783218" y="373816"/>
                  </a:cubicBezTo>
                  <a:cubicBezTo>
                    <a:pt x="1775692" y="283505"/>
                    <a:pt x="1760641" y="174379"/>
                    <a:pt x="1771930" y="159327"/>
                  </a:cubicBezTo>
                  <a:cubicBezTo>
                    <a:pt x="1783219" y="144275"/>
                    <a:pt x="1822730" y="219534"/>
                    <a:pt x="1850952" y="283504"/>
                  </a:cubicBezTo>
                  <a:cubicBezTo>
                    <a:pt x="1879174" y="347474"/>
                    <a:pt x="1907396" y="497993"/>
                    <a:pt x="1941263" y="543149"/>
                  </a:cubicBezTo>
                  <a:cubicBezTo>
                    <a:pt x="1975130" y="588305"/>
                    <a:pt x="2039100" y="592068"/>
                    <a:pt x="2054152" y="554438"/>
                  </a:cubicBezTo>
                  <a:cubicBezTo>
                    <a:pt x="2069204" y="516808"/>
                    <a:pt x="2048507" y="377578"/>
                    <a:pt x="2031574" y="317371"/>
                  </a:cubicBezTo>
                  <a:cubicBezTo>
                    <a:pt x="2014641" y="257164"/>
                    <a:pt x="1983596" y="225178"/>
                    <a:pt x="1952552" y="193193"/>
                  </a:cubicBezTo>
                </a:path>
              </a:pathLst>
            </a:custGeom>
            <a:noFill/>
            <a:ln w="12700">
              <a:solidFill>
                <a:srgbClr val="FF669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99" name="타원 98"/>
            <p:cNvSpPr/>
            <p:nvPr/>
          </p:nvSpPr>
          <p:spPr>
            <a:xfrm>
              <a:off x="1709741" y="2119510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00" name="타원 99"/>
            <p:cNvSpPr/>
            <p:nvPr/>
          </p:nvSpPr>
          <p:spPr>
            <a:xfrm>
              <a:off x="1710524" y="2170493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01" name="타원 100"/>
            <p:cNvSpPr/>
            <p:nvPr/>
          </p:nvSpPr>
          <p:spPr>
            <a:xfrm>
              <a:off x="1713201" y="2013097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02" name="타원 101"/>
            <p:cNvSpPr/>
            <p:nvPr/>
          </p:nvSpPr>
          <p:spPr>
            <a:xfrm>
              <a:off x="1713984" y="2064080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03" name="타원 102"/>
            <p:cNvSpPr/>
            <p:nvPr/>
          </p:nvSpPr>
          <p:spPr>
            <a:xfrm>
              <a:off x="954740" y="1980076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04" name="타원 103"/>
            <p:cNvSpPr/>
            <p:nvPr/>
          </p:nvSpPr>
          <p:spPr>
            <a:xfrm>
              <a:off x="955524" y="2031059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05" name="타원 104"/>
            <p:cNvSpPr/>
            <p:nvPr/>
          </p:nvSpPr>
          <p:spPr>
            <a:xfrm>
              <a:off x="954368" y="2087892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06" name="타원 105"/>
            <p:cNvSpPr/>
            <p:nvPr/>
          </p:nvSpPr>
          <p:spPr>
            <a:xfrm>
              <a:off x="955151" y="2138875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07" name="타원 106"/>
            <p:cNvSpPr/>
            <p:nvPr/>
          </p:nvSpPr>
          <p:spPr>
            <a:xfrm>
              <a:off x="953220" y="2199836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08" name="타원 107"/>
            <p:cNvSpPr/>
            <p:nvPr/>
          </p:nvSpPr>
          <p:spPr>
            <a:xfrm>
              <a:off x="990782" y="2249283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09" name="타원 108"/>
            <p:cNvSpPr/>
            <p:nvPr/>
          </p:nvSpPr>
          <p:spPr>
            <a:xfrm>
              <a:off x="1109541" y="2277831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10" name="타원 109"/>
            <p:cNvSpPr/>
            <p:nvPr/>
          </p:nvSpPr>
          <p:spPr>
            <a:xfrm>
              <a:off x="1041354" y="2277690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11" name="타원 110"/>
            <p:cNvSpPr/>
            <p:nvPr/>
          </p:nvSpPr>
          <p:spPr>
            <a:xfrm>
              <a:off x="1240748" y="2279379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12" name="타원 111"/>
            <p:cNvSpPr/>
            <p:nvPr/>
          </p:nvSpPr>
          <p:spPr>
            <a:xfrm>
              <a:off x="1172561" y="2279239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13" name="타원 112"/>
            <p:cNvSpPr/>
            <p:nvPr/>
          </p:nvSpPr>
          <p:spPr>
            <a:xfrm>
              <a:off x="1377739" y="2281413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14" name="타원 113"/>
            <p:cNvSpPr/>
            <p:nvPr/>
          </p:nvSpPr>
          <p:spPr>
            <a:xfrm>
              <a:off x="1309552" y="2281272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15" name="타원 114"/>
            <p:cNvSpPr/>
            <p:nvPr/>
          </p:nvSpPr>
          <p:spPr>
            <a:xfrm>
              <a:off x="1508946" y="2282961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16" name="타원 115"/>
            <p:cNvSpPr/>
            <p:nvPr/>
          </p:nvSpPr>
          <p:spPr>
            <a:xfrm>
              <a:off x="1440759" y="2282821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17" name="타원 116"/>
            <p:cNvSpPr/>
            <p:nvPr/>
          </p:nvSpPr>
          <p:spPr>
            <a:xfrm>
              <a:off x="1124255" y="1889505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18" name="타원 117"/>
            <p:cNvSpPr/>
            <p:nvPr/>
          </p:nvSpPr>
          <p:spPr>
            <a:xfrm>
              <a:off x="1056068" y="1889364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19" name="타원 118"/>
            <p:cNvSpPr/>
            <p:nvPr/>
          </p:nvSpPr>
          <p:spPr>
            <a:xfrm>
              <a:off x="1255462" y="1891054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20" name="타원 119"/>
            <p:cNvSpPr/>
            <p:nvPr/>
          </p:nvSpPr>
          <p:spPr>
            <a:xfrm>
              <a:off x="1187275" y="1890913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21" name="타원 120"/>
            <p:cNvSpPr/>
            <p:nvPr/>
          </p:nvSpPr>
          <p:spPr>
            <a:xfrm>
              <a:off x="1397201" y="1886183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22" name="타원 121"/>
            <p:cNvSpPr/>
            <p:nvPr/>
          </p:nvSpPr>
          <p:spPr>
            <a:xfrm>
              <a:off x="1329014" y="1886042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23" name="타원 122"/>
            <p:cNvSpPr/>
            <p:nvPr/>
          </p:nvSpPr>
          <p:spPr>
            <a:xfrm>
              <a:off x="1543833" y="1891560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24" name="타원 123"/>
            <p:cNvSpPr/>
            <p:nvPr/>
          </p:nvSpPr>
          <p:spPr>
            <a:xfrm>
              <a:off x="1460221" y="1887591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25" name="타원 124"/>
            <p:cNvSpPr/>
            <p:nvPr/>
          </p:nvSpPr>
          <p:spPr>
            <a:xfrm>
              <a:off x="1644705" y="2273904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26" name="타원 125"/>
            <p:cNvSpPr/>
            <p:nvPr/>
          </p:nvSpPr>
          <p:spPr>
            <a:xfrm>
              <a:off x="1585178" y="2282821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27" name="타원 126"/>
            <p:cNvSpPr/>
            <p:nvPr/>
          </p:nvSpPr>
          <p:spPr>
            <a:xfrm>
              <a:off x="989787" y="1915604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28" name="타원 127"/>
            <p:cNvSpPr/>
            <p:nvPr/>
          </p:nvSpPr>
          <p:spPr>
            <a:xfrm>
              <a:off x="1689717" y="2231321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29" name="타원 128"/>
            <p:cNvSpPr/>
            <p:nvPr/>
          </p:nvSpPr>
          <p:spPr>
            <a:xfrm>
              <a:off x="1698062" y="1936976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30" name="타원 129"/>
            <p:cNvSpPr/>
            <p:nvPr/>
          </p:nvSpPr>
          <p:spPr>
            <a:xfrm>
              <a:off x="1632664" y="1892891"/>
              <a:ext cx="33411" cy="35925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</p:grpSp>
      <p:pic>
        <p:nvPicPr>
          <p:cNvPr id="1028" name="Picture 4" descr="alpha galactosylceramideì ëí ì´ë¯¸ì§ ê²ìê²°ê³¼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9707" y="1835973"/>
            <a:ext cx="1806893" cy="5067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2" name="자유형 131"/>
          <p:cNvSpPr/>
          <p:nvPr/>
        </p:nvSpPr>
        <p:spPr bwMode="auto">
          <a:xfrm>
            <a:off x="1621646" y="2509310"/>
            <a:ext cx="763801" cy="703725"/>
          </a:xfrm>
          <a:custGeom>
            <a:avLst/>
            <a:gdLst>
              <a:gd name="connsiteX0" fmla="*/ 220723 w 566459"/>
              <a:gd name="connsiteY0" fmla="*/ 4656 h 520288"/>
              <a:gd name="connsiteX1" fmla="*/ 1648 w 566459"/>
              <a:gd name="connsiteY1" fmla="*/ 238019 h 520288"/>
              <a:gd name="connsiteX2" fmla="*/ 139760 w 566459"/>
              <a:gd name="connsiteY2" fmla="*/ 476144 h 520288"/>
              <a:gd name="connsiteX3" fmla="*/ 482660 w 566459"/>
              <a:gd name="connsiteY3" fmla="*/ 485669 h 520288"/>
              <a:gd name="connsiteX4" fmla="*/ 549335 w 566459"/>
              <a:gd name="connsiteY4" fmla="*/ 114194 h 520288"/>
              <a:gd name="connsiteX5" fmla="*/ 220723 w 566459"/>
              <a:gd name="connsiteY5" fmla="*/ 4656 h 520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566459" h="520288">
                <a:moveTo>
                  <a:pt x="220723" y="4656"/>
                </a:moveTo>
                <a:cubicBezTo>
                  <a:pt x="129442" y="25294"/>
                  <a:pt x="15142" y="159438"/>
                  <a:pt x="1648" y="238019"/>
                </a:cubicBezTo>
                <a:cubicBezTo>
                  <a:pt x="-11846" y="316600"/>
                  <a:pt x="59591" y="434869"/>
                  <a:pt x="139760" y="476144"/>
                </a:cubicBezTo>
                <a:cubicBezTo>
                  <a:pt x="219929" y="517419"/>
                  <a:pt x="414398" y="545994"/>
                  <a:pt x="482660" y="485669"/>
                </a:cubicBezTo>
                <a:cubicBezTo>
                  <a:pt x="550922" y="425344"/>
                  <a:pt x="591404" y="194363"/>
                  <a:pt x="549335" y="114194"/>
                </a:cubicBezTo>
                <a:cubicBezTo>
                  <a:pt x="507266" y="34025"/>
                  <a:pt x="312004" y="-15982"/>
                  <a:pt x="220723" y="4656"/>
                </a:cubicBezTo>
                <a:close/>
              </a:path>
            </a:pathLst>
          </a:custGeom>
          <a:gradFill>
            <a:gsLst>
              <a:gs pos="0">
                <a:schemeClr val="accent1">
                  <a:lumMod val="40000"/>
                  <a:lumOff val="60000"/>
                </a:schemeClr>
              </a:gs>
              <a:gs pos="17000">
                <a:schemeClr val="accent1">
                  <a:lumMod val="20000"/>
                  <a:lumOff val="80000"/>
                </a:schemeClr>
              </a:gs>
              <a:gs pos="100000">
                <a:sysClr val="window" lastClr="FFFFFF"/>
              </a:gs>
            </a:gsLst>
            <a:lin ang="13500000" scaled="1"/>
          </a:gradFill>
          <a:ln w="3175"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ko-KR" altLang="en-US" sz="1200">
              <a:solidFill>
                <a:prstClr val="white"/>
              </a:solidFill>
            </a:endParaRPr>
          </a:p>
        </p:txBody>
      </p:sp>
      <p:sp>
        <p:nvSpPr>
          <p:cNvPr id="133" name="자유형 132"/>
          <p:cNvSpPr>
            <a:spLocks noChangeAspect="1"/>
          </p:cNvSpPr>
          <p:nvPr/>
        </p:nvSpPr>
        <p:spPr bwMode="auto">
          <a:xfrm rot="21172636">
            <a:off x="1920831" y="2857128"/>
            <a:ext cx="354461" cy="305879"/>
          </a:xfrm>
          <a:custGeom>
            <a:avLst/>
            <a:gdLst>
              <a:gd name="connsiteX0" fmla="*/ 69738 w 223419"/>
              <a:gd name="connsiteY0" fmla="*/ 29871 h 244358"/>
              <a:gd name="connsiteX1" fmla="*/ 3063 w 223419"/>
              <a:gd name="connsiteY1" fmla="*/ 172746 h 244358"/>
              <a:gd name="connsiteX2" fmla="*/ 174513 w 223419"/>
              <a:gd name="connsiteY2" fmla="*/ 239421 h 244358"/>
              <a:gd name="connsiteX3" fmla="*/ 222138 w 223419"/>
              <a:gd name="connsiteY3" fmla="*/ 44158 h 244358"/>
              <a:gd name="connsiteX4" fmla="*/ 136413 w 223419"/>
              <a:gd name="connsiteY4" fmla="*/ 1296 h 244358"/>
              <a:gd name="connsiteX5" fmla="*/ 69738 w 223419"/>
              <a:gd name="connsiteY5" fmla="*/ 29871 h 244358"/>
              <a:gd name="connsiteX0" fmla="*/ 16966 w 242109"/>
              <a:gd name="connsiteY0" fmla="*/ 9182 h 282599"/>
              <a:gd name="connsiteX1" fmla="*/ 21753 w 242109"/>
              <a:gd name="connsiteY1" fmla="*/ 210289 h 282599"/>
              <a:gd name="connsiteX2" fmla="*/ 193203 w 242109"/>
              <a:gd name="connsiteY2" fmla="*/ 276964 h 282599"/>
              <a:gd name="connsiteX3" fmla="*/ 240828 w 242109"/>
              <a:gd name="connsiteY3" fmla="*/ 81701 h 282599"/>
              <a:gd name="connsiteX4" fmla="*/ 155103 w 242109"/>
              <a:gd name="connsiteY4" fmla="*/ 38839 h 282599"/>
              <a:gd name="connsiteX5" fmla="*/ 16966 w 242109"/>
              <a:gd name="connsiteY5" fmla="*/ 9182 h 282599"/>
              <a:gd name="connsiteX0" fmla="*/ 19303 w 244446"/>
              <a:gd name="connsiteY0" fmla="*/ 88609 h 362026"/>
              <a:gd name="connsiteX1" fmla="*/ 24090 w 244446"/>
              <a:gd name="connsiteY1" fmla="*/ 289716 h 362026"/>
              <a:gd name="connsiteX2" fmla="*/ 195540 w 244446"/>
              <a:gd name="connsiteY2" fmla="*/ 356391 h 362026"/>
              <a:gd name="connsiteX3" fmla="*/ 243165 w 244446"/>
              <a:gd name="connsiteY3" fmla="*/ 161128 h 362026"/>
              <a:gd name="connsiteX4" fmla="*/ 193170 w 244446"/>
              <a:gd name="connsiteY4" fmla="*/ 1802 h 362026"/>
              <a:gd name="connsiteX5" fmla="*/ 19303 w 244446"/>
              <a:gd name="connsiteY5" fmla="*/ 88609 h 362026"/>
              <a:gd name="connsiteX0" fmla="*/ 19303 w 322115"/>
              <a:gd name="connsiteY0" fmla="*/ 89327 h 361750"/>
              <a:gd name="connsiteX1" fmla="*/ 24090 w 322115"/>
              <a:gd name="connsiteY1" fmla="*/ 290434 h 361750"/>
              <a:gd name="connsiteX2" fmla="*/ 195540 w 322115"/>
              <a:gd name="connsiteY2" fmla="*/ 357109 h 361750"/>
              <a:gd name="connsiteX3" fmla="*/ 321771 w 322115"/>
              <a:gd name="connsiteY3" fmla="*/ 178484 h 361750"/>
              <a:gd name="connsiteX4" fmla="*/ 193170 w 322115"/>
              <a:gd name="connsiteY4" fmla="*/ 2520 h 361750"/>
              <a:gd name="connsiteX5" fmla="*/ 19303 w 322115"/>
              <a:gd name="connsiteY5" fmla="*/ 89327 h 361750"/>
              <a:gd name="connsiteX0" fmla="*/ 20995 w 323970"/>
              <a:gd name="connsiteY0" fmla="*/ 89327 h 393526"/>
              <a:gd name="connsiteX1" fmla="*/ 25782 w 323970"/>
              <a:gd name="connsiteY1" fmla="*/ 290434 h 393526"/>
              <a:gd name="connsiteX2" fmla="*/ 225816 w 323970"/>
              <a:gd name="connsiteY2" fmla="*/ 390385 h 393526"/>
              <a:gd name="connsiteX3" fmla="*/ 323463 w 323970"/>
              <a:gd name="connsiteY3" fmla="*/ 178484 h 393526"/>
              <a:gd name="connsiteX4" fmla="*/ 194862 w 323970"/>
              <a:gd name="connsiteY4" fmla="*/ 2520 h 393526"/>
              <a:gd name="connsiteX5" fmla="*/ 20995 w 323970"/>
              <a:gd name="connsiteY5" fmla="*/ 89327 h 393526"/>
              <a:gd name="connsiteX0" fmla="*/ 83227 w 386337"/>
              <a:gd name="connsiteY0" fmla="*/ 89719 h 403775"/>
              <a:gd name="connsiteX1" fmla="*/ 9407 w 386337"/>
              <a:gd name="connsiteY1" fmla="*/ 349058 h 403775"/>
              <a:gd name="connsiteX2" fmla="*/ 288048 w 386337"/>
              <a:gd name="connsiteY2" fmla="*/ 390777 h 403775"/>
              <a:gd name="connsiteX3" fmla="*/ 385695 w 386337"/>
              <a:gd name="connsiteY3" fmla="*/ 178876 h 403775"/>
              <a:gd name="connsiteX4" fmla="*/ 257094 w 386337"/>
              <a:gd name="connsiteY4" fmla="*/ 2912 h 403775"/>
              <a:gd name="connsiteX5" fmla="*/ 83227 w 386337"/>
              <a:gd name="connsiteY5" fmla="*/ 89719 h 403775"/>
              <a:gd name="connsiteX0" fmla="*/ 34024 w 408594"/>
              <a:gd name="connsiteY0" fmla="*/ 61951 h 410458"/>
              <a:gd name="connsiteX1" fmla="*/ 31664 w 408594"/>
              <a:gd name="connsiteY1" fmla="*/ 354566 h 410458"/>
              <a:gd name="connsiteX2" fmla="*/ 310305 w 408594"/>
              <a:gd name="connsiteY2" fmla="*/ 396285 h 410458"/>
              <a:gd name="connsiteX3" fmla="*/ 407952 w 408594"/>
              <a:gd name="connsiteY3" fmla="*/ 184384 h 410458"/>
              <a:gd name="connsiteX4" fmla="*/ 279351 w 408594"/>
              <a:gd name="connsiteY4" fmla="*/ 8420 h 410458"/>
              <a:gd name="connsiteX5" fmla="*/ 34024 w 408594"/>
              <a:gd name="connsiteY5" fmla="*/ 61951 h 4104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08594" h="410458">
                <a:moveTo>
                  <a:pt x="34024" y="61951"/>
                </a:moveTo>
                <a:cubicBezTo>
                  <a:pt x="-7257" y="119642"/>
                  <a:pt x="-14383" y="298844"/>
                  <a:pt x="31664" y="354566"/>
                </a:cubicBezTo>
                <a:cubicBezTo>
                  <a:pt x="77711" y="410288"/>
                  <a:pt x="247590" y="424649"/>
                  <a:pt x="310305" y="396285"/>
                </a:cubicBezTo>
                <a:cubicBezTo>
                  <a:pt x="373020" y="367921"/>
                  <a:pt x="414302" y="224071"/>
                  <a:pt x="407952" y="184384"/>
                </a:cubicBezTo>
                <a:cubicBezTo>
                  <a:pt x="401602" y="144697"/>
                  <a:pt x="341672" y="28826"/>
                  <a:pt x="279351" y="8420"/>
                </a:cubicBezTo>
                <a:cubicBezTo>
                  <a:pt x="217030" y="-11986"/>
                  <a:pt x="75305" y="4260"/>
                  <a:pt x="34024" y="61951"/>
                </a:cubicBezTo>
                <a:close/>
              </a:path>
            </a:pathLst>
          </a:custGeom>
          <a:gradFill flip="none" rotWithShape="1">
            <a:gsLst>
              <a:gs pos="0">
                <a:schemeClr val="accent1">
                  <a:lumMod val="20000"/>
                  <a:lumOff val="80000"/>
                </a:schemeClr>
              </a:gs>
              <a:gs pos="50000">
                <a:schemeClr val="accent5">
                  <a:lumMod val="60000"/>
                  <a:lumOff val="40000"/>
                  <a:shade val="67500"/>
                  <a:satMod val="115000"/>
                </a:schemeClr>
              </a:gs>
              <a:gs pos="100000">
                <a:schemeClr val="accent5">
                  <a:lumMod val="60000"/>
                  <a:lumOff val="40000"/>
                  <a:shade val="100000"/>
                  <a:satMod val="115000"/>
                </a:schemeClr>
              </a:gs>
            </a:gsLst>
            <a:lin ang="13500000" scaled="1"/>
            <a:tileRect/>
          </a:gradFill>
          <a:ln w="31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ko-KR" altLang="en-US" sz="1200">
              <a:solidFill>
                <a:prstClr val="white"/>
              </a:solidFill>
            </a:endParaRPr>
          </a:p>
        </p:txBody>
      </p:sp>
      <p:sp>
        <p:nvSpPr>
          <p:cNvPr id="143" name="타원 142"/>
          <p:cNvSpPr>
            <a:spLocks noChangeAspect="1"/>
          </p:cNvSpPr>
          <p:nvPr/>
        </p:nvSpPr>
        <p:spPr>
          <a:xfrm rot="15384778">
            <a:off x="1998614" y="3552932"/>
            <a:ext cx="98461" cy="114836"/>
          </a:xfrm>
          <a:prstGeom prst="ellipse">
            <a:avLst/>
          </a:prstGeom>
          <a:gradFill>
            <a:gsLst>
              <a:gs pos="0">
                <a:srgbClr val="FF6600"/>
              </a:gs>
              <a:gs pos="34000">
                <a:srgbClr val="F79646">
                  <a:lumMod val="75000"/>
                </a:srgbClr>
              </a:gs>
              <a:gs pos="100000">
                <a:sysClr val="window" lastClr="FFFFFF"/>
              </a:gs>
            </a:gsLst>
            <a:lin ang="13500000" scaled="1"/>
          </a:gradFill>
          <a:ln w="6350" cap="flat" cmpd="sng" algn="ctr">
            <a:solidFill>
              <a:srgbClr val="C0504D">
                <a:lumMod val="75000"/>
              </a:srgbClr>
            </a:solidFill>
            <a:prstDash val="solid"/>
          </a:ln>
          <a:effectLst/>
        </p:spPr>
        <p:txBody>
          <a:bodyPr rtlCol="0" anchor="ctr"/>
          <a:lstStyle/>
          <a:p>
            <a:pPr algn="ctr" defTabSz="685800" latinLnBrk="0">
              <a:defRPr/>
            </a:pPr>
            <a:endParaRPr lang="ko-KR" altLang="en-US" sz="1200" kern="0">
              <a:solidFill>
                <a:prstClr val="white"/>
              </a:solidFill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pSp>
        <p:nvGrpSpPr>
          <p:cNvPr id="149" name="그룹 148"/>
          <p:cNvGrpSpPr/>
          <p:nvPr/>
        </p:nvGrpSpPr>
        <p:grpSpPr>
          <a:xfrm rot="5489868">
            <a:off x="2424196" y="2620110"/>
            <a:ext cx="313025" cy="474025"/>
            <a:chOff x="5914735" y="119055"/>
            <a:chExt cx="2051021" cy="2895994"/>
          </a:xfrm>
        </p:grpSpPr>
        <p:sp>
          <p:nvSpPr>
            <p:cNvPr id="151" name="자유형 150"/>
            <p:cNvSpPr/>
            <p:nvPr/>
          </p:nvSpPr>
          <p:spPr>
            <a:xfrm>
              <a:off x="5914735" y="119055"/>
              <a:ext cx="1946604" cy="2895994"/>
            </a:xfrm>
            <a:custGeom>
              <a:avLst/>
              <a:gdLst>
                <a:gd name="connsiteX0" fmla="*/ 1624383 w 1964576"/>
                <a:gd name="connsiteY0" fmla="*/ 745918 h 2895994"/>
                <a:gd name="connsiteX1" fmla="*/ 1846805 w 1964576"/>
                <a:gd name="connsiteY1" fmla="*/ 688253 h 2895994"/>
                <a:gd name="connsiteX2" fmla="*/ 1953896 w 1964576"/>
                <a:gd name="connsiteY2" fmla="*/ 292837 h 2895994"/>
                <a:gd name="connsiteX3" fmla="*/ 1591432 w 1964576"/>
                <a:gd name="connsiteY3" fmla="*/ 4513 h 2895994"/>
                <a:gd name="connsiteX4" fmla="*/ 1196015 w 1964576"/>
                <a:gd name="connsiteY4" fmla="*/ 144556 h 2895994"/>
                <a:gd name="connsiteX5" fmla="*/ 1113637 w 1964576"/>
                <a:gd name="connsiteY5" fmla="*/ 507021 h 2895994"/>
                <a:gd name="connsiteX6" fmla="*/ 1023021 w 1964576"/>
                <a:gd name="connsiteY6" fmla="*/ 572923 h 2895994"/>
                <a:gd name="connsiteX7" fmla="*/ 874740 w 1964576"/>
                <a:gd name="connsiteY7" fmla="*/ 564686 h 2895994"/>
                <a:gd name="connsiteX8" fmla="*/ 775886 w 1964576"/>
                <a:gd name="connsiteY8" fmla="*/ 301075 h 2895994"/>
                <a:gd name="connsiteX9" fmla="*/ 709983 w 1964576"/>
                <a:gd name="connsiteY9" fmla="*/ 70415 h 2895994"/>
                <a:gd name="connsiteX10" fmla="*/ 314567 w 1964576"/>
                <a:gd name="connsiteY10" fmla="*/ 29226 h 2895994"/>
                <a:gd name="connsiteX11" fmla="*/ 100383 w 1964576"/>
                <a:gd name="connsiteY11" fmla="*/ 301075 h 2895994"/>
                <a:gd name="connsiteX12" fmla="*/ 18005 w 1964576"/>
                <a:gd name="connsiteY12" fmla="*/ 680015 h 2895994"/>
                <a:gd name="connsiteX13" fmla="*/ 438134 w 1964576"/>
                <a:gd name="connsiteY13" fmla="*/ 844772 h 2895994"/>
                <a:gd name="connsiteX14" fmla="*/ 718221 w 1964576"/>
                <a:gd name="connsiteY14" fmla="*/ 844772 h 2895994"/>
                <a:gd name="connsiteX15" fmla="*/ 759410 w 1964576"/>
                <a:gd name="connsiteY15" fmla="*/ 976577 h 2895994"/>
                <a:gd name="connsiteX16" fmla="*/ 726459 w 1964576"/>
                <a:gd name="connsiteY16" fmla="*/ 1075431 h 2895994"/>
                <a:gd name="connsiteX17" fmla="*/ 561702 w 1964576"/>
                <a:gd name="connsiteY17" fmla="*/ 1067194 h 2895994"/>
                <a:gd name="connsiteX18" fmla="*/ 421659 w 1964576"/>
                <a:gd name="connsiteY18" fmla="*/ 1017767 h 2895994"/>
                <a:gd name="connsiteX19" fmla="*/ 190999 w 1964576"/>
                <a:gd name="connsiteY19" fmla="*/ 1050718 h 2895994"/>
                <a:gd name="connsiteX20" fmla="*/ 34480 w 1964576"/>
                <a:gd name="connsiteY20" fmla="*/ 1297853 h 2895994"/>
                <a:gd name="connsiteX21" fmla="*/ 125096 w 1964576"/>
                <a:gd name="connsiteY21" fmla="*/ 1676794 h 2895994"/>
                <a:gd name="connsiteX22" fmla="*/ 413421 w 1964576"/>
                <a:gd name="connsiteY22" fmla="*/ 1899215 h 2895994"/>
                <a:gd name="connsiteX23" fmla="*/ 775886 w 1964576"/>
                <a:gd name="connsiteY23" fmla="*/ 1792123 h 2895994"/>
                <a:gd name="connsiteX24" fmla="*/ 948880 w 1964576"/>
                <a:gd name="connsiteY24" fmla="*/ 1569702 h 2895994"/>
                <a:gd name="connsiteX25" fmla="*/ 990069 w 1964576"/>
                <a:gd name="connsiteY25" fmla="*/ 1495561 h 2895994"/>
                <a:gd name="connsiteX26" fmla="*/ 981832 w 1964576"/>
                <a:gd name="connsiteY26" fmla="*/ 2895994 h 2895994"/>
                <a:gd name="connsiteX27" fmla="*/ 981832 w 1964576"/>
                <a:gd name="connsiteY27" fmla="*/ 2895994 h 2895994"/>
                <a:gd name="connsiteX0" fmla="*/ 1591770 w 1931963"/>
                <a:gd name="connsiteY0" fmla="*/ 745918 h 2895994"/>
                <a:gd name="connsiteX1" fmla="*/ 1814192 w 1931963"/>
                <a:gd name="connsiteY1" fmla="*/ 688253 h 2895994"/>
                <a:gd name="connsiteX2" fmla="*/ 1921283 w 1931963"/>
                <a:gd name="connsiteY2" fmla="*/ 292837 h 2895994"/>
                <a:gd name="connsiteX3" fmla="*/ 1558819 w 1931963"/>
                <a:gd name="connsiteY3" fmla="*/ 4513 h 2895994"/>
                <a:gd name="connsiteX4" fmla="*/ 1163402 w 1931963"/>
                <a:gd name="connsiteY4" fmla="*/ 144556 h 2895994"/>
                <a:gd name="connsiteX5" fmla="*/ 1081024 w 1931963"/>
                <a:gd name="connsiteY5" fmla="*/ 507021 h 2895994"/>
                <a:gd name="connsiteX6" fmla="*/ 990408 w 1931963"/>
                <a:gd name="connsiteY6" fmla="*/ 572923 h 2895994"/>
                <a:gd name="connsiteX7" fmla="*/ 842127 w 1931963"/>
                <a:gd name="connsiteY7" fmla="*/ 564686 h 2895994"/>
                <a:gd name="connsiteX8" fmla="*/ 743273 w 1931963"/>
                <a:gd name="connsiteY8" fmla="*/ 301075 h 2895994"/>
                <a:gd name="connsiteX9" fmla="*/ 677370 w 1931963"/>
                <a:gd name="connsiteY9" fmla="*/ 70415 h 2895994"/>
                <a:gd name="connsiteX10" fmla="*/ 281954 w 1931963"/>
                <a:gd name="connsiteY10" fmla="*/ 29226 h 2895994"/>
                <a:gd name="connsiteX11" fmla="*/ 67770 w 1931963"/>
                <a:gd name="connsiteY11" fmla="*/ 301075 h 2895994"/>
                <a:gd name="connsiteX12" fmla="*/ 67770 w 1931963"/>
                <a:gd name="connsiteY12" fmla="*/ 729442 h 2895994"/>
                <a:gd name="connsiteX13" fmla="*/ 405521 w 1931963"/>
                <a:gd name="connsiteY13" fmla="*/ 844772 h 2895994"/>
                <a:gd name="connsiteX14" fmla="*/ 685608 w 1931963"/>
                <a:gd name="connsiteY14" fmla="*/ 844772 h 2895994"/>
                <a:gd name="connsiteX15" fmla="*/ 726797 w 1931963"/>
                <a:gd name="connsiteY15" fmla="*/ 976577 h 2895994"/>
                <a:gd name="connsiteX16" fmla="*/ 693846 w 1931963"/>
                <a:gd name="connsiteY16" fmla="*/ 1075431 h 2895994"/>
                <a:gd name="connsiteX17" fmla="*/ 529089 w 1931963"/>
                <a:gd name="connsiteY17" fmla="*/ 1067194 h 2895994"/>
                <a:gd name="connsiteX18" fmla="*/ 389046 w 1931963"/>
                <a:gd name="connsiteY18" fmla="*/ 1017767 h 2895994"/>
                <a:gd name="connsiteX19" fmla="*/ 158386 w 1931963"/>
                <a:gd name="connsiteY19" fmla="*/ 1050718 h 2895994"/>
                <a:gd name="connsiteX20" fmla="*/ 1867 w 1931963"/>
                <a:gd name="connsiteY20" fmla="*/ 1297853 h 2895994"/>
                <a:gd name="connsiteX21" fmla="*/ 92483 w 1931963"/>
                <a:gd name="connsiteY21" fmla="*/ 1676794 h 2895994"/>
                <a:gd name="connsiteX22" fmla="*/ 380808 w 1931963"/>
                <a:gd name="connsiteY22" fmla="*/ 1899215 h 2895994"/>
                <a:gd name="connsiteX23" fmla="*/ 743273 w 1931963"/>
                <a:gd name="connsiteY23" fmla="*/ 1792123 h 2895994"/>
                <a:gd name="connsiteX24" fmla="*/ 916267 w 1931963"/>
                <a:gd name="connsiteY24" fmla="*/ 1569702 h 2895994"/>
                <a:gd name="connsiteX25" fmla="*/ 957456 w 1931963"/>
                <a:gd name="connsiteY25" fmla="*/ 1495561 h 2895994"/>
                <a:gd name="connsiteX26" fmla="*/ 949219 w 1931963"/>
                <a:gd name="connsiteY26" fmla="*/ 2895994 h 2895994"/>
                <a:gd name="connsiteX27" fmla="*/ 949219 w 1931963"/>
                <a:gd name="connsiteY27" fmla="*/ 2895994 h 2895994"/>
                <a:gd name="connsiteX0" fmla="*/ 1591770 w 1931963"/>
                <a:gd name="connsiteY0" fmla="*/ 745918 h 2895994"/>
                <a:gd name="connsiteX1" fmla="*/ 1814192 w 1931963"/>
                <a:gd name="connsiteY1" fmla="*/ 688253 h 2895994"/>
                <a:gd name="connsiteX2" fmla="*/ 1921283 w 1931963"/>
                <a:gd name="connsiteY2" fmla="*/ 292837 h 2895994"/>
                <a:gd name="connsiteX3" fmla="*/ 1558819 w 1931963"/>
                <a:gd name="connsiteY3" fmla="*/ 4513 h 2895994"/>
                <a:gd name="connsiteX4" fmla="*/ 1163402 w 1931963"/>
                <a:gd name="connsiteY4" fmla="*/ 144556 h 2895994"/>
                <a:gd name="connsiteX5" fmla="*/ 1081024 w 1931963"/>
                <a:gd name="connsiteY5" fmla="*/ 507021 h 2895994"/>
                <a:gd name="connsiteX6" fmla="*/ 990408 w 1931963"/>
                <a:gd name="connsiteY6" fmla="*/ 572923 h 2895994"/>
                <a:gd name="connsiteX7" fmla="*/ 842127 w 1931963"/>
                <a:gd name="connsiteY7" fmla="*/ 564686 h 2895994"/>
                <a:gd name="connsiteX8" fmla="*/ 743273 w 1931963"/>
                <a:gd name="connsiteY8" fmla="*/ 301075 h 2895994"/>
                <a:gd name="connsiteX9" fmla="*/ 677370 w 1931963"/>
                <a:gd name="connsiteY9" fmla="*/ 70415 h 2895994"/>
                <a:gd name="connsiteX10" fmla="*/ 281954 w 1931963"/>
                <a:gd name="connsiteY10" fmla="*/ 29226 h 2895994"/>
                <a:gd name="connsiteX11" fmla="*/ 18343 w 1931963"/>
                <a:gd name="connsiteY11" fmla="*/ 309313 h 2895994"/>
                <a:gd name="connsiteX12" fmla="*/ 67770 w 1931963"/>
                <a:gd name="connsiteY12" fmla="*/ 729442 h 2895994"/>
                <a:gd name="connsiteX13" fmla="*/ 405521 w 1931963"/>
                <a:gd name="connsiteY13" fmla="*/ 844772 h 2895994"/>
                <a:gd name="connsiteX14" fmla="*/ 685608 w 1931963"/>
                <a:gd name="connsiteY14" fmla="*/ 844772 h 2895994"/>
                <a:gd name="connsiteX15" fmla="*/ 726797 w 1931963"/>
                <a:gd name="connsiteY15" fmla="*/ 976577 h 2895994"/>
                <a:gd name="connsiteX16" fmla="*/ 693846 w 1931963"/>
                <a:gd name="connsiteY16" fmla="*/ 1075431 h 2895994"/>
                <a:gd name="connsiteX17" fmla="*/ 529089 w 1931963"/>
                <a:gd name="connsiteY17" fmla="*/ 1067194 h 2895994"/>
                <a:gd name="connsiteX18" fmla="*/ 389046 w 1931963"/>
                <a:gd name="connsiteY18" fmla="*/ 1017767 h 2895994"/>
                <a:gd name="connsiteX19" fmla="*/ 158386 w 1931963"/>
                <a:gd name="connsiteY19" fmla="*/ 1050718 h 2895994"/>
                <a:gd name="connsiteX20" fmla="*/ 1867 w 1931963"/>
                <a:gd name="connsiteY20" fmla="*/ 1297853 h 2895994"/>
                <a:gd name="connsiteX21" fmla="*/ 92483 w 1931963"/>
                <a:gd name="connsiteY21" fmla="*/ 1676794 h 2895994"/>
                <a:gd name="connsiteX22" fmla="*/ 380808 w 1931963"/>
                <a:gd name="connsiteY22" fmla="*/ 1899215 h 2895994"/>
                <a:gd name="connsiteX23" fmla="*/ 743273 w 1931963"/>
                <a:gd name="connsiteY23" fmla="*/ 1792123 h 2895994"/>
                <a:gd name="connsiteX24" fmla="*/ 916267 w 1931963"/>
                <a:gd name="connsiteY24" fmla="*/ 1569702 h 2895994"/>
                <a:gd name="connsiteX25" fmla="*/ 957456 w 1931963"/>
                <a:gd name="connsiteY25" fmla="*/ 1495561 h 2895994"/>
                <a:gd name="connsiteX26" fmla="*/ 949219 w 1931963"/>
                <a:gd name="connsiteY26" fmla="*/ 2895994 h 2895994"/>
                <a:gd name="connsiteX27" fmla="*/ 949219 w 1931963"/>
                <a:gd name="connsiteY27" fmla="*/ 2895994 h 2895994"/>
                <a:gd name="connsiteX0" fmla="*/ 1591770 w 1931963"/>
                <a:gd name="connsiteY0" fmla="*/ 745918 h 2895994"/>
                <a:gd name="connsiteX1" fmla="*/ 1814192 w 1931963"/>
                <a:gd name="connsiteY1" fmla="*/ 688253 h 2895994"/>
                <a:gd name="connsiteX2" fmla="*/ 1921283 w 1931963"/>
                <a:gd name="connsiteY2" fmla="*/ 292837 h 2895994"/>
                <a:gd name="connsiteX3" fmla="*/ 1558819 w 1931963"/>
                <a:gd name="connsiteY3" fmla="*/ 4513 h 2895994"/>
                <a:gd name="connsiteX4" fmla="*/ 1163402 w 1931963"/>
                <a:gd name="connsiteY4" fmla="*/ 144556 h 2895994"/>
                <a:gd name="connsiteX5" fmla="*/ 1081024 w 1931963"/>
                <a:gd name="connsiteY5" fmla="*/ 507021 h 2895994"/>
                <a:gd name="connsiteX6" fmla="*/ 990408 w 1931963"/>
                <a:gd name="connsiteY6" fmla="*/ 572923 h 2895994"/>
                <a:gd name="connsiteX7" fmla="*/ 842127 w 1931963"/>
                <a:gd name="connsiteY7" fmla="*/ 564686 h 2895994"/>
                <a:gd name="connsiteX8" fmla="*/ 743273 w 1931963"/>
                <a:gd name="connsiteY8" fmla="*/ 301075 h 2895994"/>
                <a:gd name="connsiteX9" fmla="*/ 677370 w 1931963"/>
                <a:gd name="connsiteY9" fmla="*/ 70415 h 2895994"/>
                <a:gd name="connsiteX10" fmla="*/ 281954 w 1931963"/>
                <a:gd name="connsiteY10" fmla="*/ 86891 h 2895994"/>
                <a:gd name="connsiteX11" fmla="*/ 18343 w 1931963"/>
                <a:gd name="connsiteY11" fmla="*/ 309313 h 2895994"/>
                <a:gd name="connsiteX12" fmla="*/ 67770 w 1931963"/>
                <a:gd name="connsiteY12" fmla="*/ 729442 h 2895994"/>
                <a:gd name="connsiteX13" fmla="*/ 405521 w 1931963"/>
                <a:gd name="connsiteY13" fmla="*/ 844772 h 2895994"/>
                <a:gd name="connsiteX14" fmla="*/ 685608 w 1931963"/>
                <a:gd name="connsiteY14" fmla="*/ 844772 h 2895994"/>
                <a:gd name="connsiteX15" fmla="*/ 726797 w 1931963"/>
                <a:gd name="connsiteY15" fmla="*/ 976577 h 2895994"/>
                <a:gd name="connsiteX16" fmla="*/ 693846 w 1931963"/>
                <a:gd name="connsiteY16" fmla="*/ 1075431 h 2895994"/>
                <a:gd name="connsiteX17" fmla="*/ 529089 w 1931963"/>
                <a:gd name="connsiteY17" fmla="*/ 1067194 h 2895994"/>
                <a:gd name="connsiteX18" fmla="*/ 389046 w 1931963"/>
                <a:gd name="connsiteY18" fmla="*/ 1017767 h 2895994"/>
                <a:gd name="connsiteX19" fmla="*/ 158386 w 1931963"/>
                <a:gd name="connsiteY19" fmla="*/ 1050718 h 2895994"/>
                <a:gd name="connsiteX20" fmla="*/ 1867 w 1931963"/>
                <a:gd name="connsiteY20" fmla="*/ 1297853 h 2895994"/>
                <a:gd name="connsiteX21" fmla="*/ 92483 w 1931963"/>
                <a:gd name="connsiteY21" fmla="*/ 1676794 h 2895994"/>
                <a:gd name="connsiteX22" fmla="*/ 380808 w 1931963"/>
                <a:gd name="connsiteY22" fmla="*/ 1899215 h 2895994"/>
                <a:gd name="connsiteX23" fmla="*/ 743273 w 1931963"/>
                <a:gd name="connsiteY23" fmla="*/ 1792123 h 2895994"/>
                <a:gd name="connsiteX24" fmla="*/ 916267 w 1931963"/>
                <a:gd name="connsiteY24" fmla="*/ 1569702 h 2895994"/>
                <a:gd name="connsiteX25" fmla="*/ 957456 w 1931963"/>
                <a:gd name="connsiteY25" fmla="*/ 1495561 h 2895994"/>
                <a:gd name="connsiteX26" fmla="*/ 949219 w 1931963"/>
                <a:gd name="connsiteY26" fmla="*/ 2895994 h 2895994"/>
                <a:gd name="connsiteX27" fmla="*/ 949219 w 1931963"/>
                <a:gd name="connsiteY27" fmla="*/ 2895994 h 2895994"/>
                <a:gd name="connsiteX0" fmla="*/ 1591770 w 1931963"/>
                <a:gd name="connsiteY0" fmla="*/ 745918 h 2895994"/>
                <a:gd name="connsiteX1" fmla="*/ 1814192 w 1931963"/>
                <a:gd name="connsiteY1" fmla="*/ 688253 h 2895994"/>
                <a:gd name="connsiteX2" fmla="*/ 1921283 w 1931963"/>
                <a:gd name="connsiteY2" fmla="*/ 292837 h 2895994"/>
                <a:gd name="connsiteX3" fmla="*/ 1558819 w 1931963"/>
                <a:gd name="connsiteY3" fmla="*/ 4513 h 2895994"/>
                <a:gd name="connsiteX4" fmla="*/ 1163402 w 1931963"/>
                <a:gd name="connsiteY4" fmla="*/ 144556 h 2895994"/>
                <a:gd name="connsiteX5" fmla="*/ 1081024 w 1931963"/>
                <a:gd name="connsiteY5" fmla="*/ 507021 h 2895994"/>
                <a:gd name="connsiteX6" fmla="*/ 990408 w 1931963"/>
                <a:gd name="connsiteY6" fmla="*/ 572923 h 2895994"/>
                <a:gd name="connsiteX7" fmla="*/ 842127 w 1931963"/>
                <a:gd name="connsiteY7" fmla="*/ 564686 h 2895994"/>
                <a:gd name="connsiteX8" fmla="*/ 743273 w 1931963"/>
                <a:gd name="connsiteY8" fmla="*/ 301075 h 2895994"/>
                <a:gd name="connsiteX9" fmla="*/ 562040 w 1931963"/>
                <a:gd name="connsiteY9" fmla="*/ 53940 h 2895994"/>
                <a:gd name="connsiteX10" fmla="*/ 281954 w 1931963"/>
                <a:gd name="connsiteY10" fmla="*/ 86891 h 2895994"/>
                <a:gd name="connsiteX11" fmla="*/ 18343 w 1931963"/>
                <a:gd name="connsiteY11" fmla="*/ 309313 h 2895994"/>
                <a:gd name="connsiteX12" fmla="*/ 67770 w 1931963"/>
                <a:gd name="connsiteY12" fmla="*/ 729442 h 2895994"/>
                <a:gd name="connsiteX13" fmla="*/ 405521 w 1931963"/>
                <a:gd name="connsiteY13" fmla="*/ 844772 h 2895994"/>
                <a:gd name="connsiteX14" fmla="*/ 685608 w 1931963"/>
                <a:gd name="connsiteY14" fmla="*/ 844772 h 2895994"/>
                <a:gd name="connsiteX15" fmla="*/ 726797 w 1931963"/>
                <a:gd name="connsiteY15" fmla="*/ 976577 h 2895994"/>
                <a:gd name="connsiteX16" fmla="*/ 693846 w 1931963"/>
                <a:gd name="connsiteY16" fmla="*/ 1075431 h 2895994"/>
                <a:gd name="connsiteX17" fmla="*/ 529089 w 1931963"/>
                <a:gd name="connsiteY17" fmla="*/ 1067194 h 2895994"/>
                <a:gd name="connsiteX18" fmla="*/ 389046 w 1931963"/>
                <a:gd name="connsiteY18" fmla="*/ 1017767 h 2895994"/>
                <a:gd name="connsiteX19" fmla="*/ 158386 w 1931963"/>
                <a:gd name="connsiteY19" fmla="*/ 1050718 h 2895994"/>
                <a:gd name="connsiteX20" fmla="*/ 1867 w 1931963"/>
                <a:gd name="connsiteY20" fmla="*/ 1297853 h 2895994"/>
                <a:gd name="connsiteX21" fmla="*/ 92483 w 1931963"/>
                <a:gd name="connsiteY21" fmla="*/ 1676794 h 2895994"/>
                <a:gd name="connsiteX22" fmla="*/ 380808 w 1931963"/>
                <a:gd name="connsiteY22" fmla="*/ 1899215 h 2895994"/>
                <a:gd name="connsiteX23" fmla="*/ 743273 w 1931963"/>
                <a:gd name="connsiteY23" fmla="*/ 1792123 h 2895994"/>
                <a:gd name="connsiteX24" fmla="*/ 916267 w 1931963"/>
                <a:gd name="connsiteY24" fmla="*/ 1569702 h 2895994"/>
                <a:gd name="connsiteX25" fmla="*/ 957456 w 1931963"/>
                <a:gd name="connsiteY25" fmla="*/ 1495561 h 2895994"/>
                <a:gd name="connsiteX26" fmla="*/ 949219 w 1931963"/>
                <a:gd name="connsiteY26" fmla="*/ 2895994 h 2895994"/>
                <a:gd name="connsiteX27" fmla="*/ 949219 w 1931963"/>
                <a:gd name="connsiteY27" fmla="*/ 2895994 h 2895994"/>
                <a:gd name="connsiteX0" fmla="*/ 1607845 w 1948038"/>
                <a:gd name="connsiteY0" fmla="*/ 745918 h 2895994"/>
                <a:gd name="connsiteX1" fmla="*/ 1830267 w 1948038"/>
                <a:gd name="connsiteY1" fmla="*/ 688253 h 2895994"/>
                <a:gd name="connsiteX2" fmla="*/ 1937358 w 1948038"/>
                <a:gd name="connsiteY2" fmla="*/ 292837 h 2895994"/>
                <a:gd name="connsiteX3" fmla="*/ 1574894 w 1948038"/>
                <a:gd name="connsiteY3" fmla="*/ 4513 h 2895994"/>
                <a:gd name="connsiteX4" fmla="*/ 1179477 w 1948038"/>
                <a:gd name="connsiteY4" fmla="*/ 144556 h 2895994"/>
                <a:gd name="connsiteX5" fmla="*/ 1097099 w 1948038"/>
                <a:gd name="connsiteY5" fmla="*/ 507021 h 2895994"/>
                <a:gd name="connsiteX6" fmla="*/ 1006483 w 1948038"/>
                <a:gd name="connsiteY6" fmla="*/ 572923 h 2895994"/>
                <a:gd name="connsiteX7" fmla="*/ 858202 w 1948038"/>
                <a:gd name="connsiteY7" fmla="*/ 564686 h 2895994"/>
                <a:gd name="connsiteX8" fmla="*/ 759348 w 1948038"/>
                <a:gd name="connsiteY8" fmla="*/ 301075 h 2895994"/>
                <a:gd name="connsiteX9" fmla="*/ 578115 w 1948038"/>
                <a:gd name="connsiteY9" fmla="*/ 53940 h 2895994"/>
                <a:gd name="connsiteX10" fmla="*/ 298029 w 1948038"/>
                <a:gd name="connsiteY10" fmla="*/ 86891 h 2895994"/>
                <a:gd name="connsiteX11" fmla="*/ 34418 w 1948038"/>
                <a:gd name="connsiteY11" fmla="*/ 309313 h 2895994"/>
                <a:gd name="connsiteX12" fmla="*/ 83845 w 1948038"/>
                <a:gd name="connsiteY12" fmla="*/ 729442 h 2895994"/>
                <a:gd name="connsiteX13" fmla="*/ 421596 w 1948038"/>
                <a:gd name="connsiteY13" fmla="*/ 844772 h 2895994"/>
                <a:gd name="connsiteX14" fmla="*/ 701683 w 1948038"/>
                <a:gd name="connsiteY14" fmla="*/ 844772 h 2895994"/>
                <a:gd name="connsiteX15" fmla="*/ 742872 w 1948038"/>
                <a:gd name="connsiteY15" fmla="*/ 976577 h 2895994"/>
                <a:gd name="connsiteX16" fmla="*/ 709921 w 1948038"/>
                <a:gd name="connsiteY16" fmla="*/ 1075431 h 2895994"/>
                <a:gd name="connsiteX17" fmla="*/ 545164 w 1948038"/>
                <a:gd name="connsiteY17" fmla="*/ 1067194 h 2895994"/>
                <a:gd name="connsiteX18" fmla="*/ 405121 w 1948038"/>
                <a:gd name="connsiteY18" fmla="*/ 1017767 h 2895994"/>
                <a:gd name="connsiteX19" fmla="*/ 174461 w 1948038"/>
                <a:gd name="connsiteY19" fmla="*/ 1050718 h 2895994"/>
                <a:gd name="connsiteX20" fmla="*/ 1467 w 1948038"/>
                <a:gd name="connsiteY20" fmla="*/ 1380231 h 2895994"/>
                <a:gd name="connsiteX21" fmla="*/ 108558 w 1948038"/>
                <a:gd name="connsiteY21" fmla="*/ 1676794 h 2895994"/>
                <a:gd name="connsiteX22" fmla="*/ 396883 w 1948038"/>
                <a:gd name="connsiteY22" fmla="*/ 1899215 h 2895994"/>
                <a:gd name="connsiteX23" fmla="*/ 759348 w 1948038"/>
                <a:gd name="connsiteY23" fmla="*/ 1792123 h 2895994"/>
                <a:gd name="connsiteX24" fmla="*/ 932342 w 1948038"/>
                <a:gd name="connsiteY24" fmla="*/ 1569702 h 2895994"/>
                <a:gd name="connsiteX25" fmla="*/ 973531 w 1948038"/>
                <a:gd name="connsiteY25" fmla="*/ 1495561 h 2895994"/>
                <a:gd name="connsiteX26" fmla="*/ 965294 w 1948038"/>
                <a:gd name="connsiteY26" fmla="*/ 2895994 h 2895994"/>
                <a:gd name="connsiteX27" fmla="*/ 965294 w 1948038"/>
                <a:gd name="connsiteY27" fmla="*/ 2895994 h 2895994"/>
                <a:gd name="connsiteX0" fmla="*/ 1606411 w 1946604"/>
                <a:gd name="connsiteY0" fmla="*/ 745918 h 2895994"/>
                <a:gd name="connsiteX1" fmla="*/ 1828833 w 1946604"/>
                <a:gd name="connsiteY1" fmla="*/ 688253 h 2895994"/>
                <a:gd name="connsiteX2" fmla="*/ 1935924 w 1946604"/>
                <a:gd name="connsiteY2" fmla="*/ 292837 h 2895994"/>
                <a:gd name="connsiteX3" fmla="*/ 1573460 w 1946604"/>
                <a:gd name="connsiteY3" fmla="*/ 4513 h 2895994"/>
                <a:gd name="connsiteX4" fmla="*/ 1178043 w 1946604"/>
                <a:gd name="connsiteY4" fmla="*/ 144556 h 2895994"/>
                <a:gd name="connsiteX5" fmla="*/ 1095665 w 1946604"/>
                <a:gd name="connsiteY5" fmla="*/ 507021 h 2895994"/>
                <a:gd name="connsiteX6" fmla="*/ 1005049 w 1946604"/>
                <a:gd name="connsiteY6" fmla="*/ 572923 h 2895994"/>
                <a:gd name="connsiteX7" fmla="*/ 856768 w 1946604"/>
                <a:gd name="connsiteY7" fmla="*/ 564686 h 2895994"/>
                <a:gd name="connsiteX8" fmla="*/ 757914 w 1946604"/>
                <a:gd name="connsiteY8" fmla="*/ 301075 h 2895994"/>
                <a:gd name="connsiteX9" fmla="*/ 576681 w 1946604"/>
                <a:gd name="connsiteY9" fmla="*/ 53940 h 2895994"/>
                <a:gd name="connsiteX10" fmla="*/ 296595 w 1946604"/>
                <a:gd name="connsiteY10" fmla="*/ 86891 h 2895994"/>
                <a:gd name="connsiteX11" fmla="*/ 32984 w 1946604"/>
                <a:gd name="connsiteY11" fmla="*/ 309313 h 2895994"/>
                <a:gd name="connsiteX12" fmla="*/ 82411 w 1946604"/>
                <a:gd name="connsiteY12" fmla="*/ 729442 h 2895994"/>
                <a:gd name="connsiteX13" fmla="*/ 420162 w 1946604"/>
                <a:gd name="connsiteY13" fmla="*/ 844772 h 2895994"/>
                <a:gd name="connsiteX14" fmla="*/ 700249 w 1946604"/>
                <a:gd name="connsiteY14" fmla="*/ 844772 h 2895994"/>
                <a:gd name="connsiteX15" fmla="*/ 741438 w 1946604"/>
                <a:gd name="connsiteY15" fmla="*/ 976577 h 2895994"/>
                <a:gd name="connsiteX16" fmla="*/ 708487 w 1946604"/>
                <a:gd name="connsiteY16" fmla="*/ 1075431 h 2895994"/>
                <a:gd name="connsiteX17" fmla="*/ 543730 w 1946604"/>
                <a:gd name="connsiteY17" fmla="*/ 1067194 h 2895994"/>
                <a:gd name="connsiteX18" fmla="*/ 403687 w 1946604"/>
                <a:gd name="connsiteY18" fmla="*/ 1017767 h 2895994"/>
                <a:gd name="connsiteX19" fmla="*/ 115362 w 1946604"/>
                <a:gd name="connsiteY19" fmla="*/ 1141334 h 2895994"/>
                <a:gd name="connsiteX20" fmla="*/ 33 w 1946604"/>
                <a:gd name="connsiteY20" fmla="*/ 1380231 h 2895994"/>
                <a:gd name="connsiteX21" fmla="*/ 107124 w 1946604"/>
                <a:gd name="connsiteY21" fmla="*/ 1676794 h 2895994"/>
                <a:gd name="connsiteX22" fmla="*/ 395449 w 1946604"/>
                <a:gd name="connsiteY22" fmla="*/ 1899215 h 2895994"/>
                <a:gd name="connsiteX23" fmla="*/ 757914 w 1946604"/>
                <a:gd name="connsiteY23" fmla="*/ 1792123 h 2895994"/>
                <a:gd name="connsiteX24" fmla="*/ 930908 w 1946604"/>
                <a:gd name="connsiteY24" fmla="*/ 1569702 h 2895994"/>
                <a:gd name="connsiteX25" fmla="*/ 972097 w 1946604"/>
                <a:gd name="connsiteY25" fmla="*/ 1495561 h 2895994"/>
                <a:gd name="connsiteX26" fmla="*/ 963860 w 1946604"/>
                <a:gd name="connsiteY26" fmla="*/ 2895994 h 2895994"/>
                <a:gd name="connsiteX27" fmla="*/ 963860 w 1946604"/>
                <a:gd name="connsiteY27" fmla="*/ 2895994 h 2895994"/>
                <a:gd name="connsiteX0" fmla="*/ 1606411 w 1946604"/>
                <a:gd name="connsiteY0" fmla="*/ 745918 h 2895994"/>
                <a:gd name="connsiteX1" fmla="*/ 1828833 w 1946604"/>
                <a:gd name="connsiteY1" fmla="*/ 688253 h 2895994"/>
                <a:gd name="connsiteX2" fmla="*/ 1935924 w 1946604"/>
                <a:gd name="connsiteY2" fmla="*/ 292837 h 2895994"/>
                <a:gd name="connsiteX3" fmla="*/ 1573460 w 1946604"/>
                <a:gd name="connsiteY3" fmla="*/ 4513 h 2895994"/>
                <a:gd name="connsiteX4" fmla="*/ 1178043 w 1946604"/>
                <a:gd name="connsiteY4" fmla="*/ 144556 h 2895994"/>
                <a:gd name="connsiteX5" fmla="*/ 1095665 w 1946604"/>
                <a:gd name="connsiteY5" fmla="*/ 507021 h 2895994"/>
                <a:gd name="connsiteX6" fmla="*/ 1005049 w 1946604"/>
                <a:gd name="connsiteY6" fmla="*/ 572923 h 2895994"/>
                <a:gd name="connsiteX7" fmla="*/ 856768 w 1946604"/>
                <a:gd name="connsiteY7" fmla="*/ 564686 h 2895994"/>
                <a:gd name="connsiteX8" fmla="*/ 757914 w 1946604"/>
                <a:gd name="connsiteY8" fmla="*/ 301075 h 2895994"/>
                <a:gd name="connsiteX9" fmla="*/ 576681 w 1946604"/>
                <a:gd name="connsiteY9" fmla="*/ 53940 h 2895994"/>
                <a:gd name="connsiteX10" fmla="*/ 296595 w 1946604"/>
                <a:gd name="connsiteY10" fmla="*/ 86891 h 2895994"/>
                <a:gd name="connsiteX11" fmla="*/ 32984 w 1946604"/>
                <a:gd name="connsiteY11" fmla="*/ 309313 h 2895994"/>
                <a:gd name="connsiteX12" fmla="*/ 82411 w 1946604"/>
                <a:gd name="connsiteY12" fmla="*/ 729442 h 2895994"/>
                <a:gd name="connsiteX13" fmla="*/ 420162 w 1946604"/>
                <a:gd name="connsiteY13" fmla="*/ 844772 h 2895994"/>
                <a:gd name="connsiteX14" fmla="*/ 700249 w 1946604"/>
                <a:gd name="connsiteY14" fmla="*/ 844772 h 2895994"/>
                <a:gd name="connsiteX15" fmla="*/ 741438 w 1946604"/>
                <a:gd name="connsiteY15" fmla="*/ 976577 h 2895994"/>
                <a:gd name="connsiteX16" fmla="*/ 708487 w 1946604"/>
                <a:gd name="connsiteY16" fmla="*/ 1075431 h 2895994"/>
                <a:gd name="connsiteX17" fmla="*/ 543730 w 1946604"/>
                <a:gd name="connsiteY17" fmla="*/ 1067194 h 2895994"/>
                <a:gd name="connsiteX18" fmla="*/ 263644 w 1946604"/>
                <a:gd name="connsiteY18" fmla="*/ 1026005 h 2895994"/>
                <a:gd name="connsiteX19" fmla="*/ 115362 w 1946604"/>
                <a:gd name="connsiteY19" fmla="*/ 1141334 h 2895994"/>
                <a:gd name="connsiteX20" fmla="*/ 33 w 1946604"/>
                <a:gd name="connsiteY20" fmla="*/ 1380231 h 2895994"/>
                <a:gd name="connsiteX21" fmla="*/ 107124 w 1946604"/>
                <a:gd name="connsiteY21" fmla="*/ 1676794 h 2895994"/>
                <a:gd name="connsiteX22" fmla="*/ 395449 w 1946604"/>
                <a:gd name="connsiteY22" fmla="*/ 1899215 h 2895994"/>
                <a:gd name="connsiteX23" fmla="*/ 757914 w 1946604"/>
                <a:gd name="connsiteY23" fmla="*/ 1792123 h 2895994"/>
                <a:gd name="connsiteX24" fmla="*/ 930908 w 1946604"/>
                <a:gd name="connsiteY24" fmla="*/ 1569702 h 2895994"/>
                <a:gd name="connsiteX25" fmla="*/ 972097 w 1946604"/>
                <a:gd name="connsiteY25" fmla="*/ 1495561 h 2895994"/>
                <a:gd name="connsiteX26" fmla="*/ 963860 w 1946604"/>
                <a:gd name="connsiteY26" fmla="*/ 2895994 h 2895994"/>
                <a:gd name="connsiteX27" fmla="*/ 963860 w 1946604"/>
                <a:gd name="connsiteY27" fmla="*/ 2895994 h 2895994"/>
                <a:gd name="connsiteX0" fmla="*/ 1606411 w 1946604"/>
                <a:gd name="connsiteY0" fmla="*/ 745918 h 2895994"/>
                <a:gd name="connsiteX1" fmla="*/ 1828833 w 1946604"/>
                <a:gd name="connsiteY1" fmla="*/ 688253 h 2895994"/>
                <a:gd name="connsiteX2" fmla="*/ 1935924 w 1946604"/>
                <a:gd name="connsiteY2" fmla="*/ 292837 h 2895994"/>
                <a:gd name="connsiteX3" fmla="*/ 1573460 w 1946604"/>
                <a:gd name="connsiteY3" fmla="*/ 4513 h 2895994"/>
                <a:gd name="connsiteX4" fmla="*/ 1178043 w 1946604"/>
                <a:gd name="connsiteY4" fmla="*/ 144556 h 2895994"/>
                <a:gd name="connsiteX5" fmla="*/ 1095665 w 1946604"/>
                <a:gd name="connsiteY5" fmla="*/ 507021 h 2895994"/>
                <a:gd name="connsiteX6" fmla="*/ 1005049 w 1946604"/>
                <a:gd name="connsiteY6" fmla="*/ 572923 h 2895994"/>
                <a:gd name="connsiteX7" fmla="*/ 856768 w 1946604"/>
                <a:gd name="connsiteY7" fmla="*/ 564686 h 2895994"/>
                <a:gd name="connsiteX8" fmla="*/ 757914 w 1946604"/>
                <a:gd name="connsiteY8" fmla="*/ 301075 h 2895994"/>
                <a:gd name="connsiteX9" fmla="*/ 576681 w 1946604"/>
                <a:gd name="connsiteY9" fmla="*/ 53940 h 2895994"/>
                <a:gd name="connsiteX10" fmla="*/ 296595 w 1946604"/>
                <a:gd name="connsiteY10" fmla="*/ 86891 h 2895994"/>
                <a:gd name="connsiteX11" fmla="*/ 32984 w 1946604"/>
                <a:gd name="connsiteY11" fmla="*/ 309313 h 2895994"/>
                <a:gd name="connsiteX12" fmla="*/ 82411 w 1946604"/>
                <a:gd name="connsiteY12" fmla="*/ 729442 h 2895994"/>
                <a:gd name="connsiteX13" fmla="*/ 420162 w 1946604"/>
                <a:gd name="connsiteY13" fmla="*/ 844772 h 2895994"/>
                <a:gd name="connsiteX14" fmla="*/ 700249 w 1946604"/>
                <a:gd name="connsiteY14" fmla="*/ 844772 h 2895994"/>
                <a:gd name="connsiteX15" fmla="*/ 741438 w 1946604"/>
                <a:gd name="connsiteY15" fmla="*/ 976577 h 2895994"/>
                <a:gd name="connsiteX16" fmla="*/ 708487 w 1946604"/>
                <a:gd name="connsiteY16" fmla="*/ 1075431 h 2895994"/>
                <a:gd name="connsiteX17" fmla="*/ 543730 w 1946604"/>
                <a:gd name="connsiteY17" fmla="*/ 1067194 h 2895994"/>
                <a:gd name="connsiteX18" fmla="*/ 263644 w 1946604"/>
                <a:gd name="connsiteY18" fmla="*/ 1026005 h 2895994"/>
                <a:gd name="connsiteX19" fmla="*/ 115362 w 1946604"/>
                <a:gd name="connsiteY19" fmla="*/ 1141334 h 2895994"/>
                <a:gd name="connsiteX20" fmla="*/ 33 w 1946604"/>
                <a:gd name="connsiteY20" fmla="*/ 1380231 h 2895994"/>
                <a:gd name="connsiteX21" fmla="*/ 107124 w 1946604"/>
                <a:gd name="connsiteY21" fmla="*/ 1676794 h 2895994"/>
                <a:gd name="connsiteX22" fmla="*/ 395449 w 1946604"/>
                <a:gd name="connsiteY22" fmla="*/ 1816836 h 2895994"/>
                <a:gd name="connsiteX23" fmla="*/ 757914 w 1946604"/>
                <a:gd name="connsiteY23" fmla="*/ 1792123 h 2895994"/>
                <a:gd name="connsiteX24" fmla="*/ 930908 w 1946604"/>
                <a:gd name="connsiteY24" fmla="*/ 1569702 h 2895994"/>
                <a:gd name="connsiteX25" fmla="*/ 972097 w 1946604"/>
                <a:gd name="connsiteY25" fmla="*/ 1495561 h 2895994"/>
                <a:gd name="connsiteX26" fmla="*/ 963860 w 1946604"/>
                <a:gd name="connsiteY26" fmla="*/ 2895994 h 2895994"/>
                <a:gd name="connsiteX27" fmla="*/ 963860 w 1946604"/>
                <a:gd name="connsiteY27" fmla="*/ 2895994 h 2895994"/>
                <a:gd name="connsiteX0" fmla="*/ 1606411 w 1946604"/>
                <a:gd name="connsiteY0" fmla="*/ 745918 h 2895994"/>
                <a:gd name="connsiteX1" fmla="*/ 1828833 w 1946604"/>
                <a:gd name="connsiteY1" fmla="*/ 688253 h 2895994"/>
                <a:gd name="connsiteX2" fmla="*/ 1935924 w 1946604"/>
                <a:gd name="connsiteY2" fmla="*/ 292837 h 2895994"/>
                <a:gd name="connsiteX3" fmla="*/ 1573460 w 1946604"/>
                <a:gd name="connsiteY3" fmla="*/ 4513 h 2895994"/>
                <a:gd name="connsiteX4" fmla="*/ 1178043 w 1946604"/>
                <a:gd name="connsiteY4" fmla="*/ 144556 h 2895994"/>
                <a:gd name="connsiteX5" fmla="*/ 1095665 w 1946604"/>
                <a:gd name="connsiteY5" fmla="*/ 507021 h 2895994"/>
                <a:gd name="connsiteX6" fmla="*/ 1005049 w 1946604"/>
                <a:gd name="connsiteY6" fmla="*/ 572923 h 2895994"/>
                <a:gd name="connsiteX7" fmla="*/ 856768 w 1946604"/>
                <a:gd name="connsiteY7" fmla="*/ 564686 h 2895994"/>
                <a:gd name="connsiteX8" fmla="*/ 757914 w 1946604"/>
                <a:gd name="connsiteY8" fmla="*/ 301075 h 2895994"/>
                <a:gd name="connsiteX9" fmla="*/ 576681 w 1946604"/>
                <a:gd name="connsiteY9" fmla="*/ 53940 h 2895994"/>
                <a:gd name="connsiteX10" fmla="*/ 296595 w 1946604"/>
                <a:gd name="connsiteY10" fmla="*/ 86891 h 2895994"/>
                <a:gd name="connsiteX11" fmla="*/ 32984 w 1946604"/>
                <a:gd name="connsiteY11" fmla="*/ 309313 h 2895994"/>
                <a:gd name="connsiteX12" fmla="*/ 82411 w 1946604"/>
                <a:gd name="connsiteY12" fmla="*/ 729442 h 2895994"/>
                <a:gd name="connsiteX13" fmla="*/ 420162 w 1946604"/>
                <a:gd name="connsiteY13" fmla="*/ 844772 h 2895994"/>
                <a:gd name="connsiteX14" fmla="*/ 700249 w 1946604"/>
                <a:gd name="connsiteY14" fmla="*/ 844772 h 2895994"/>
                <a:gd name="connsiteX15" fmla="*/ 741438 w 1946604"/>
                <a:gd name="connsiteY15" fmla="*/ 976577 h 2895994"/>
                <a:gd name="connsiteX16" fmla="*/ 708487 w 1946604"/>
                <a:gd name="connsiteY16" fmla="*/ 1075431 h 2895994"/>
                <a:gd name="connsiteX17" fmla="*/ 543730 w 1946604"/>
                <a:gd name="connsiteY17" fmla="*/ 1067194 h 2895994"/>
                <a:gd name="connsiteX18" fmla="*/ 263644 w 1946604"/>
                <a:gd name="connsiteY18" fmla="*/ 1026005 h 2895994"/>
                <a:gd name="connsiteX19" fmla="*/ 115362 w 1946604"/>
                <a:gd name="connsiteY19" fmla="*/ 1141334 h 2895994"/>
                <a:gd name="connsiteX20" fmla="*/ 33 w 1946604"/>
                <a:gd name="connsiteY20" fmla="*/ 1380231 h 2895994"/>
                <a:gd name="connsiteX21" fmla="*/ 107124 w 1946604"/>
                <a:gd name="connsiteY21" fmla="*/ 1676794 h 2895994"/>
                <a:gd name="connsiteX22" fmla="*/ 395449 w 1946604"/>
                <a:gd name="connsiteY22" fmla="*/ 1816836 h 2895994"/>
                <a:gd name="connsiteX23" fmla="*/ 708487 w 1946604"/>
                <a:gd name="connsiteY23" fmla="*/ 1726220 h 2895994"/>
                <a:gd name="connsiteX24" fmla="*/ 930908 w 1946604"/>
                <a:gd name="connsiteY24" fmla="*/ 1569702 h 2895994"/>
                <a:gd name="connsiteX25" fmla="*/ 972097 w 1946604"/>
                <a:gd name="connsiteY25" fmla="*/ 1495561 h 2895994"/>
                <a:gd name="connsiteX26" fmla="*/ 963860 w 1946604"/>
                <a:gd name="connsiteY26" fmla="*/ 2895994 h 2895994"/>
                <a:gd name="connsiteX27" fmla="*/ 963860 w 1946604"/>
                <a:gd name="connsiteY27" fmla="*/ 2895994 h 2895994"/>
                <a:gd name="connsiteX0" fmla="*/ 1606411 w 1946604"/>
                <a:gd name="connsiteY0" fmla="*/ 745918 h 2895994"/>
                <a:gd name="connsiteX1" fmla="*/ 1828833 w 1946604"/>
                <a:gd name="connsiteY1" fmla="*/ 688253 h 2895994"/>
                <a:gd name="connsiteX2" fmla="*/ 1935924 w 1946604"/>
                <a:gd name="connsiteY2" fmla="*/ 292837 h 2895994"/>
                <a:gd name="connsiteX3" fmla="*/ 1573460 w 1946604"/>
                <a:gd name="connsiteY3" fmla="*/ 4513 h 2895994"/>
                <a:gd name="connsiteX4" fmla="*/ 1178043 w 1946604"/>
                <a:gd name="connsiteY4" fmla="*/ 144556 h 2895994"/>
                <a:gd name="connsiteX5" fmla="*/ 1095665 w 1946604"/>
                <a:gd name="connsiteY5" fmla="*/ 507021 h 2895994"/>
                <a:gd name="connsiteX6" fmla="*/ 1005049 w 1946604"/>
                <a:gd name="connsiteY6" fmla="*/ 572923 h 2895994"/>
                <a:gd name="connsiteX7" fmla="*/ 856768 w 1946604"/>
                <a:gd name="connsiteY7" fmla="*/ 564686 h 2895994"/>
                <a:gd name="connsiteX8" fmla="*/ 757914 w 1946604"/>
                <a:gd name="connsiteY8" fmla="*/ 301075 h 2895994"/>
                <a:gd name="connsiteX9" fmla="*/ 576681 w 1946604"/>
                <a:gd name="connsiteY9" fmla="*/ 53940 h 2895994"/>
                <a:gd name="connsiteX10" fmla="*/ 296595 w 1946604"/>
                <a:gd name="connsiteY10" fmla="*/ 86891 h 2895994"/>
                <a:gd name="connsiteX11" fmla="*/ 32984 w 1946604"/>
                <a:gd name="connsiteY11" fmla="*/ 309313 h 2895994"/>
                <a:gd name="connsiteX12" fmla="*/ 82411 w 1946604"/>
                <a:gd name="connsiteY12" fmla="*/ 729442 h 2895994"/>
                <a:gd name="connsiteX13" fmla="*/ 420162 w 1946604"/>
                <a:gd name="connsiteY13" fmla="*/ 844772 h 2895994"/>
                <a:gd name="connsiteX14" fmla="*/ 700249 w 1946604"/>
                <a:gd name="connsiteY14" fmla="*/ 844772 h 2895994"/>
                <a:gd name="connsiteX15" fmla="*/ 741438 w 1946604"/>
                <a:gd name="connsiteY15" fmla="*/ 976577 h 2895994"/>
                <a:gd name="connsiteX16" fmla="*/ 708487 w 1946604"/>
                <a:gd name="connsiteY16" fmla="*/ 1075431 h 2895994"/>
                <a:gd name="connsiteX17" fmla="*/ 543730 w 1946604"/>
                <a:gd name="connsiteY17" fmla="*/ 1067194 h 2895994"/>
                <a:gd name="connsiteX18" fmla="*/ 263644 w 1946604"/>
                <a:gd name="connsiteY18" fmla="*/ 1026005 h 2895994"/>
                <a:gd name="connsiteX19" fmla="*/ 115362 w 1946604"/>
                <a:gd name="connsiteY19" fmla="*/ 1141334 h 2895994"/>
                <a:gd name="connsiteX20" fmla="*/ 33 w 1946604"/>
                <a:gd name="connsiteY20" fmla="*/ 1380231 h 2895994"/>
                <a:gd name="connsiteX21" fmla="*/ 107124 w 1946604"/>
                <a:gd name="connsiteY21" fmla="*/ 1676794 h 2895994"/>
                <a:gd name="connsiteX22" fmla="*/ 395449 w 1946604"/>
                <a:gd name="connsiteY22" fmla="*/ 1816836 h 2895994"/>
                <a:gd name="connsiteX23" fmla="*/ 708487 w 1946604"/>
                <a:gd name="connsiteY23" fmla="*/ 1726220 h 2895994"/>
                <a:gd name="connsiteX24" fmla="*/ 856768 w 1946604"/>
                <a:gd name="connsiteY24" fmla="*/ 1536750 h 2895994"/>
                <a:gd name="connsiteX25" fmla="*/ 972097 w 1946604"/>
                <a:gd name="connsiteY25" fmla="*/ 1495561 h 2895994"/>
                <a:gd name="connsiteX26" fmla="*/ 963860 w 1946604"/>
                <a:gd name="connsiteY26" fmla="*/ 2895994 h 2895994"/>
                <a:gd name="connsiteX27" fmla="*/ 963860 w 1946604"/>
                <a:gd name="connsiteY27" fmla="*/ 2895994 h 28959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1946604" h="2895994">
                  <a:moveTo>
                    <a:pt x="1606411" y="745918"/>
                  </a:moveTo>
                  <a:cubicBezTo>
                    <a:pt x="1690162" y="754842"/>
                    <a:pt x="1773914" y="763767"/>
                    <a:pt x="1828833" y="688253"/>
                  </a:cubicBezTo>
                  <a:cubicBezTo>
                    <a:pt x="1883752" y="612739"/>
                    <a:pt x="1978486" y="406794"/>
                    <a:pt x="1935924" y="292837"/>
                  </a:cubicBezTo>
                  <a:cubicBezTo>
                    <a:pt x="1893362" y="178880"/>
                    <a:pt x="1699773" y="29226"/>
                    <a:pt x="1573460" y="4513"/>
                  </a:cubicBezTo>
                  <a:cubicBezTo>
                    <a:pt x="1447147" y="-20200"/>
                    <a:pt x="1257675" y="60805"/>
                    <a:pt x="1178043" y="144556"/>
                  </a:cubicBezTo>
                  <a:cubicBezTo>
                    <a:pt x="1098411" y="228307"/>
                    <a:pt x="1124497" y="435626"/>
                    <a:pt x="1095665" y="507021"/>
                  </a:cubicBezTo>
                  <a:cubicBezTo>
                    <a:pt x="1066833" y="578415"/>
                    <a:pt x="1044865" y="563312"/>
                    <a:pt x="1005049" y="572923"/>
                  </a:cubicBezTo>
                  <a:cubicBezTo>
                    <a:pt x="965233" y="582534"/>
                    <a:pt x="897957" y="609994"/>
                    <a:pt x="856768" y="564686"/>
                  </a:cubicBezTo>
                  <a:cubicBezTo>
                    <a:pt x="815579" y="519378"/>
                    <a:pt x="804595" y="386199"/>
                    <a:pt x="757914" y="301075"/>
                  </a:cubicBezTo>
                  <a:cubicBezTo>
                    <a:pt x="711233" y="215951"/>
                    <a:pt x="653568" y="89637"/>
                    <a:pt x="576681" y="53940"/>
                  </a:cubicBezTo>
                  <a:cubicBezTo>
                    <a:pt x="499795" y="18243"/>
                    <a:pt x="387211" y="44329"/>
                    <a:pt x="296595" y="86891"/>
                  </a:cubicBezTo>
                  <a:cubicBezTo>
                    <a:pt x="205979" y="129453"/>
                    <a:pt x="68681" y="202221"/>
                    <a:pt x="32984" y="309313"/>
                  </a:cubicBezTo>
                  <a:cubicBezTo>
                    <a:pt x="-2713" y="416405"/>
                    <a:pt x="17881" y="640199"/>
                    <a:pt x="82411" y="729442"/>
                  </a:cubicBezTo>
                  <a:cubicBezTo>
                    <a:pt x="146941" y="818685"/>
                    <a:pt x="317189" y="825550"/>
                    <a:pt x="420162" y="844772"/>
                  </a:cubicBezTo>
                  <a:cubicBezTo>
                    <a:pt x="523135" y="863994"/>
                    <a:pt x="646703" y="822805"/>
                    <a:pt x="700249" y="844772"/>
                  </a:cubicBezTo>
                  <a:cubicBezTo>
                    <a:pt x="753795" y="866740"/>
                    <a:pt x="740065" y="938134"/>
                    <a:pt x="741438" y="976577"/>
                  </a:cubicBezTo>
                  <a:cubicBezTo>
                    <a:pt x="742811" y="1015020"/>
                    <a:pt x="741438" y="1060328"/>
                    <a:pt x="708487" y="1075431"/>
                  </a:cubicBezTo>
                  <a:cubicBezTo>
                    <a:pt x="675536" y="1090534"/>
                    <a:pt x="617871" y="1075432"/>
                    <a:pt x="543730" y="1067194"/>
                  </a:cubicBezTo>
                  <a:cubicBezTo>
                    <a:pt x="469590" y="1058956"/>
                    <a:pt x="335039" y="1013648"/>
                    <a:pt x="263644" y="1026005"/>
                  </a:cubicBezTo>
                  <a:cubicBezTo>
                    <a:pt x="192249" y="1038362"/>
                    <a:pt x="159297" y="1082296"/>
                    <a:pt x="115362" y="1141334"/>
                  </a:cubicBezTo>
                  <a:cubicBezTo>
                    <a:pt x="71427" y="1200372"/>
                    <a:pt x="1406" y="1290988"/>
                    <a:pt x="33" y="1380231"/>
                  </a:cubicBezTo>
                  <a:cubicBezTo>
                    <a:pt x="-1340" y="1469474"/>
                    <a:pt x="41222" y="1604027"/>
                    <a:pt x="107124" y="1676794"/>
                  </a:cubicBezTo>
                  <a:cubicBezTo>
                    <a:pt x="173026" y="1749561"/>
                    <a:pt x="295222" y="1808598"/>
                    <a:pt x="395449" y="1816836"/>
                  </a:cubicBezTo>
                  <a:cubicBezTo>
                    <a:pt x="495676" y="1825074"/>
                    <a:pt x="631601" y="1772901"/>
                    <a:pt x="708487" y="1726220"/>
                  </a:cubicBezTo>
                  <a:cubicBezTo>
                    <a:pt x="785373" y="1679539"/>
                    <a:pt x="812833" y="1575193"/>
                    <a:pt x="856768" y="1536750"/>
                  </a:cubicBezTo>
                  <a:cubicBezTo>
                    <a:pt x="900703" y="1498307"/>
                    <a:pt x="954248" y="1269020"/>
                    <a:pt x="972097" y="1495561"/>
                  </a:cubicBezTo>
                  <a:cubicBezTo>
                    <a:pt x="989946" y="1722102"/>
                    <a:pt x="963860" y="2895994"/>
                    <a:pt x="963860" y="2895994"/>
                  </a:cubicBezTo>
                  <a:lnTo>
                    <a:pt x="963860" y="2895994"/>
                  </a:lnTo>
                </a:path>
              </a:pathLst>
            </a:custGeom>
            <a:noFill/>
            <a:ln w="25400" cap="flat" cmpd="sng" algn="ctr">
              <a:solidFill>
                <a:srgbClr val="4F81BD">
                  <a:shade val="5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685800" latinLnBrk="0">
                <a:defRPr/>
              </a:pPr>
              <a:endParaRPr lang="ko-KR" altLang="en-US" sz="1200" kern="0">
                <a:solidFill>
                  <a:prstClr val="white"/>
                </a:solidFill>
                <a:latin typeface="맑은 고딕"/>
                <a:ea typeface="맑은 고딕" panose="020B0503020000020004" pitchFamily="50" charset="-127"/>
              </a:endParaRPr>
            </a:p>
          </p:txBody>
        </p:sp>
        <p:sp>
          <p:nvSpPr>
            <p:cNvPr id="152" name="자유형 151"/>
            <p:cNvSpPr/>
            <p:nvPr/>
          </p:nvSpPr>
          <p:spPr>
            <a:xfrm>
              <a:off x="7073932" y="1111391"/>
              <a:ext cx="891824" cy="1417866"/>
            </a:xfrm>
            <a:custGeom>
              <a:avLst/>
              <a:gdLst>
                <a:gd name="connsiteX0" fmla="*/ 370411 w 888143"/>
                <a:gd name="connsiteY0" fmla="*/ 92127 h 1410181"/>
                <a:gd name="connsiteX1" fmla="*/ 625784 w 888143"/>
                <a:gd name="connsiteY1" fmla="*/ 1511 h 1410181"/>
                <a:gd name="connsiteX2" fmla="*/ 831730 w 888143"/>
                <a:gd name="connsiteY2" fmla="*/ 158030 h 1410181"/>
                <a:gd name="connsiteX3" fmla="*/ 881157 w 888143"/>
                <a:gd name="connsiteY3" fmla="*/ 512257 h 1410181"/>
                <a:gd name="connsiteX4" fmla="*/ 708162 w 888143"/>
                <a:gd name="connsiteY4" fmla="*/ 767630 h 1410181"/>
                <a:gd name="connsiteX5" fmla="*/ 255081 w 888143"/>
                <a:gd name="connsiteY5" fmla="*/ 742916 h 1410181"/>
                <a:gd name="connsiteX6" fmla="*/ 16184 w 888143"/>
                <a:gd name="connsiteY6" fmla="*/ 396927 h 1410181"/>
                <a:gd name="connsiteX7" fmla="*/ 40897 w 888143"/>
                <a:gd name="connsiteY7" fmla="*/ 1410181 h 1410181"/>
                <a:gd name="connsiteX0" fmla="*/ 222130 w 888143"/>
                <a:gd name="connsiteY0" fmla="*/ 50385 h 1417866"/>
                <a:gd name="connsiteX1" fmla="*/ 625784 w 888143"/>
                <a:gd name="connsiteY1" fmla="*/ 9196 h 1417866"/>
                <a:gd name="connsiteX2" fmla="*/ 831730 w 888143"/>
                <a:gd name="connsiteY2" fmla="*/ 165715 h 1417866"/>
                <a:gd name="connsiteX3" fmla="*/ 881157 w 888143"/>
                <a:gd name="connsiteY3" fmla="*/ 519942 h 1417866"/>
                <a:gd name="connsiteX4" fmla="*/ 708162 w 888143"/>
                <a:gd name="connsiteY4" fmla="*/ 775315 h 1417866"/>
                <a:gd name="connsiteX5" fmla="*/ 255081 w 888143"/>
                <a:gd name="connsiteY5" fmla="*/ 750601 h 1417866"/>
                <a:gd name="connsiteX6" fmla="*/ 16184 w 888143"/>
                <a:gd name="connsiteY6" fmla="*/ 404612 h 1417866"/>
                <a:gd name="connsiteX7" fmla="*/ 40897 w 888143"/>
                <a:gd name="connsiteY7" fmla="*/ 1417866 h 1417866"/>
                <a:gd name="connsiteX0" fmla="*/ 223350 w 889363"/>
                <a:gd name="connsiteY0" fmla="*/ 50385 h 1417866"/>
                <a:gd name="connsiteX1" fmla="*/ 627004 w 889363"/>
                <a:gd name="connsiteY1" fmla="*/ 9196 h 1417866"/>
                <a:gd name="connsiteX2" fmla="*/ 832950 w 889363"/>
                <a:gd name="connsiteY2" fmla="*/ 165715 h 1417866"/>
                <a:gd name="connsiteX3" fmla="*/ 882377 w 889363"/>
                <a:gd name="connsiteY3" fmla="*/ 519942 h 1417866"/>
                <a:gd name="connsiteX4" fmla="*/ 709382 w 889363"/>
                <a:gd name="connsiteY4" fmla="*/ 775315 h 1417866"/>
                <a:gd name="connsiteX5" fmla="*/ 272776 w 889363"/>
                <a:gd name="connsiteY5" fmla="*/ 709412 h 1417866"/>
                <a:gd name="connsiteX6" fmla="*/ 17404 w 889363"/>
                <a:gd name="connsiteY6" fmla="*/ 404612 h 1417866"/>
                <a:gd name="connsiteX7" fmla="*/ 42117 w 889363"/>
                <a:gd name="connsiteY7" fmla="*/ 1417866 h 1417866"/>
                <a:gd name="connsiteX0" fmla="*/ 218890 w 884903"/>
                <a:gd name="connsiteY0" fmla="*/ 50385 h 1417866"/>
                <a:gd name="connsiteX1" fmla="*/ 622544 w 884903"/>
                <a:gd name="connsiteY1" fmla="*/ 9196 h 1417866"/>
                <a:gd name="connsiteX2" fmla="*/ 828490 w 884903"/>
                <a:gd name="connsiteY2" fmla="*/ 165715 h 1417866"/>
                <a:gd name="connsiteX3" fmla="*/ 877917 w 884903"/>
                <a:gd name="connsiteY3" fmla="*/ 519942 h 1417866"/>
                <a:gd name="connsiteX4" fmla="*/ 704922 w 884903"/>
                <a:gd name="connsiteY4" fmla="*/ 775315 h 1417866"/>
                <a:gd name="connsiteX5" fmla="*/ 268316 w 884903"/>
                <a:gd name="connsiteY5" fmla="*/ 709412 h 1417866"/>
                <a:gd name="connsiteX6" fmla="*/ 12944 w 884903"/>
                <a:gd name="connsiteY6" fmla="*/ 404612 h 1417866"/>
                <a:gd name="connsiteX7" fmla="*/ 37657 w 884903"/>
                <a:gd name="connsiteY7" fmla="*/ 874169 h 1417866"/>
                <a:gd name="connsiteX8" fmla="*/ 37657 w 884903"/>
                <a:gd name="connsiteY8" fmla="*/ 1417866 h 1417866"/>
                <a:gd name="connsiteX0" fmla="*/ 225811 w 891824"/>
                <a:gd name="connsiteY0" fmla="*/ 50385 h 1417866"/>
                <a:gd name="connsiteX1" fmla="*/ 629465 w 891824"/>
                <a:gd name="connsiteY1" fmla="*/ 9196 h 1417866"/>
                <a:gd name="connsiteX2" fmla="*/ 835411 w 891824"/>
                <a:gd name="connsiteY2" fmla="*/ 165715 h 1417866"/>
                <a:gd name="connsiteX3" fmla="*/ 884838 w 891824"/>
                <a:gd name="connsiteY3" fmla="*/ 519942 h 1417866"/>
                <a:gd name="connsiteX4" fmla="*/ 711843 w 891824"/>
                <a:gd name="connsiteY4" fmla="*/ 775315 h 1417866"/>
                <a:gd name="connsiteX5" fmla="*/ 275237 w 891824"/>
                <a:gd name="connsiteY5" fmla="*/ 709412 h 1417866"/>
                <a:gd name="connsiteX6" fmla="*/ 19865 w 891824"/>
                <a:gd name="connsiteY6" fmla="*/ 404612 h 1417866"/>
                <a:gd name="connsiteX7" fmla="*/ 19865 w 891824"/>
                <a:gd name="connsiteY7" fmla="*/ 874169 h 1417866"/>
                <a:gd name="connsiteX8" fmla="*/ 44578 w 891824"/>
                <a:gd name="connsiteY8" fmla="*/ 1417866 h 1417866"/>
                <a:gd name="connsiteX0" fmla="*/ 225811 w 891824"/>
                <a:gd name="connsiteY0" fmla="*/ 50385 h 1417866"/>
                <a:gd name="connsiteX1" fmla="*/ 629465 w 891824"/>
                <a:gd name="connsiteY1" fmla="*/ 9196 h 1417866"/>
                <a:gd name="connsiteX2" fmla="*/ 835411 w 891824"/>
                <a:gd name="connsiteY2" fmla="*/ 165715 h 1417866"/>
                <a:gd name="connsiteX3" fmla="*/ 884838 w 891824"/>
                <a:gd name="connsiteY3" fmla="*/ 519942 h 1417866"/>
                <a:gd name="connsiteX4" fmla="*/ 711843 w 891824"/>
                <a:gd name="connsiteY4" fmla="*/ 775315 h 1417866"/>
                <a:gd name="connsiteX5" fmla="*/ 275237 w 891824"/>
                <a:gd name="connsiteY5" fmla="*/ 709412 h 1417866"/>
                <a:gd name="connsiteX6" fmla="*/ 19865 w 891824"/>
                <a:gd name="connsiteY6" fmla="*/ 404612 h 1417866"/>
                <a:gd name="connsiteX7" fmla="*/ 19865 w 891824"/>
                <a:gd name="connsiteY7" fmla="*/ 874169 h 1417866"/>
                <a:gd name="connsiteX8" fmla="*/ 28103 w 891824"/>
                <a:gd name="connsiteY8" fmla="*/ 1417866 h 14178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891824" h="1417866">
                  <a:moveTo>
                    <a:pt x="225811" y="50385"/>
                  </a:moveTo>
                  <a:cubicBezTo>
                    <a:pt x="315054" y="-415"/>
                    <a:pt x="527865" y="-10026"/>
                    <a:pt x="629465" y="9196"/>
                  </a:cubicBezTo>
                  <a:cubicBezTo>
                    <a:pt x="731065" y="28418"/>
                    <a:pt x="792849" y="80591"/>
                    <a:pt x="835411" y="165715"/>
                  </a:cubicBezTo>
                  <a:cubicBezTo>
                    <a:pt x="877973" y="250839"/>
                    <a:pt x="905433" y="418342"/>
                    <a:pt x="884838" y="519942"/>
                  </a:cubicBezTo>
                  <a:cubicBezTo>
                    <a:pt x="864243" y="621542"/>
                    <a:pt x="813443" y="743737"/>
                    <a:pt x="711843" y="775315"/>
                  </a:cubicBezTo>
                  <a:cubicBezTo>
                    <a:pt x="610243" y="806893"/>
                    <a:pt x="390567" y="771196"/>
                    <a:pt x="275237" y="709412"/>
                  </a:cubicBezTo>
                  <a:cubicBezTo>
                    <a:pt x="159907" y="647628"/>
                    <a:pt x="62427" y="377153"/>
                    <a:pt x="19865" y="404612"/>
                  </a:cubicBezTo>
                  <a:cubicBezTo>
                    <a:pt x="-22697" y="432071"/>
                    <a:pt x="15746" y="705293"/>
                    <a:pt x="19865" y="874169"/>
                  </a:cubicBezTo>
                  <a:cubicBezTo>
                    <a:pt x="23984" y="1043045"/>
                    <a:pt x="23984" y="1327250"/>
                    <a:pt x="28103" y="1417866"/>
                  </a:cubicBezTo>
                </a:path>
              </a:pathLst>
            </a:custGeom>
            <a:noFill/>
            <a:ln w="25400" cap="flat" cmpd="sng" algn="ctr">
              <a:solidFill>
                <a:srgbClr val="4BACC6">
                  <a:lumMod val="75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685800" latinLnBrk="0">
                <a:defRPr/>
              </a:pPr>
              <a:endParaRPr lang="ko-KR" altLang="en-US" sz="1200" kern="0">
                <a:solidFill>
                  <a:prstClr val="white"/>
                </a:solidFill>
                <a:latin typeface="맑은 고딕"/>
                <a:ea typeface="맑은 고딕" panose="020B0503020000020004" pitchFamily="50" charset="-127"/>
              </a:endParaRPr>
            </a:p>
          </p:txBody>
        </p:sp>
      </p:grpSp>
      <p:grpSp>
        <p:nvGrpSpPr>
          <p:cNvPr id="153" name="그룹 152"/>
          <p:cNvGrpSpPr>
            <a:grpSpLocks noChangeAspect="1"/>
          </p:cNvGrpSpPr>
          <p:nvPr/>
        </p:nvGrpSpPr>
        <p:grpSpPr>
          <a:xfrm rot="16200000">
            <a:off x="3062085" y="2674305"/>
            <a:ext cx="336059" cy="398193"/>
            <a:chOff x="2092012" y="5697003"/>
            <a:chExt cx="495302" cy="586876"/>
          </a:xfrm>
          <a:gradFill>
            <a:gsLst>
              <a:gs pos="0">
                <a:srgbClr val="FF9999"/>
              </a:gs>
              <a:gs pos="23000">
                <a:srgbClr val="FFCCCC"/>
              </a:gs>
              <a:gs pos="97000">
                <a:schemeClr val="bg1"/>
              </a:gs>
            </a:gsLst>
            <a:path path="circle">
              <a:fillToRect l="50000" t="50000" r="50000" b="50000"/>
            </a:path>
          </a:gradFill>
        </p:grpSpPr>
        <p:sp>
          <p:nvSpPr>
            <p:cNvPr id="154" name="자유형 153"/>
            <p:cNvSpPr/>
            <p:nvPr/>
          </p:nvSpPr>
          <p:spPr>
            <a:xfrm rot="21384773" flipH="1">
              <a:off x="2092012" y="5697003"/>
              <a:ext cx="242234" cy="586876"/>
            </a:xfrm>
            <a:custGeom>
              <a:avLst/>
              <a:gdLst>
                <a:gd name="connsiteX0" fmla="*/ 93845 w 591932"/>
                <a:gd name="connsiteY0" fmla="*/ 0 h 1770602"/>
                <a:gd name="connsiteX1" fmla="*/ 479739 w 591932"/>
                <a:gd name="connsiteY1" fmla="*/ 83890 h 1770602"/>
                <a:gd name="connsiteX2" fmla="*/ 588796 w 591932"/>
                <a:gd name="connsiteY2" fmla="*/ 478173 h 1770602"/>
                <a:gd name="connsiteX3" fmla="*/ 387460 w 591932"/>
                <a:gd name="connsiteY3" fmla="*/ 746620 h 1770602"/>
                <a:gd name="connsiteX4" fmla="*/ 228069 w 591932"/>
                <a:gd name="connsiteY4" fmla="*/ 822121 h 1770602"/>
                <a:gd name="connsiteX5" fmla="*/ 228069 w 591932"/>
                <a:gd name="connsiteY5" fmla="*/ 1560352 h 1770602"/>
                <a:gd name="connsiteX6" fmla="*/ 43511 w 591932"/>
                <a:gd name="connsiteY6" fmla="*/ 1719743 h 1770602"/>
                <a:gd name="connsiteX7" fmla="*/ 1566 w 591932"/>
                <a:gd name="connsiteY7" fmla="*/ 788565 h 1770602"/>
                <a:gd name="connsiteX8" fmla="*/ 35122 w 591932"/>
                <a:gd name="connsiteY8" fmla="*/ 696286 h 1770602"/>
                <a:gd name="connsiteX9" fmla="*/ 261625 w 591932"/>
                <a:gd name="connsiteY9" fmla="*/ 553673 h 1770602"/>
                <a:gd name="connsiteX10" fmla="*/ 286792 w 591932"/>
                <a:gd name="connsiteY10" fmla="*/ 167780 h 1770602"/>
                <a:gd name="connsiteX11" fmla="*/ 169346 w 591932"/>
                <a:gd name="connsiteY11" fmla="*/ 25167 h 1770602"/>
                <a:gd name="connsiteX0" fmla="*/ 93845 w 591932"/>
                <a:gd name="connsiteY0" fmla="*/ 0 h 1770602"/>
                <a:gd name="connsiteX1" fmla="*/ 479739 w 591932"/>
                <a:gd name="connsiteY1" fmla="*/ 83890 h 1770602"/>
                <a:gd name="connsiteX2" fmla="*/ 588796 w 591932"/>
                <a:gd name="connsiteY2" fmla="*/ 478173 h 1770602"/>
                <a:gd name="connsiteX3" fmla="*/ 387460 w 591932"/>
                <a:gd name="connsiteY3" fmla="*/ 746620 h 1770602"/>
                <a:gd name="connsiteX4" fmla="*/ 228069 w 591932"/>
                <a:gd name="connsiteY4" fmla="*/ 822121 h 1770602"/>
                <a:gd name="connsiteX5" fmla="*/ 228069 w 591932"/>
                <a:gd name="connsiteY5" fmla="*/ 1560352 h 1770602"/>
                <a:gd name="connsiteX6" fmla="*/ 43511 w 591932"/>
                <a:gd name="connsiteY6" fmla="*/ 1719743 h 1770602"/>
                <a:gd name="connsiteX7" fmla="*/ 1566 w 591932"/>
                <a:gd name="connsiteY7" fmla="*/ 788565 h 1770602"/>
                <a:gd name="connsiteX8" fmla="*/ 35122 w 591932"/>
                <a:gd name="connsiteY8" fmla="*/ 696286 h 1770602"/>
                <a:gd name="connsiteX9" fmla="*/ 261625 w 591932"/>
                <a:gd name="connsiteY9" fmla="*/ 553673 h 1770602"/>
                <a:gd name="connsiteX10" fmla="*/ 286792 w 591932"/>
                <a:gd name="connsiteY10" fmla="*/ 167780 h 1770602"/>
                <a:gd name="connsiteX11" fmla="*/ 160957 w 591932"/>
                <a:gd name="connsiteY11" fmla="*/ 16778 h 1770602"/>
                <a:gd name="connsiteX0" fmla="*/ 101776 w 599863"/>
                <a:gd name="connsiteY0" fmla="*/ 0 h 1770602"/>
                <a:gd name="connsiteX1" fmla="*/ 487670 w 599863"/>
                <a:gd name="connsiteY1" fmla="*/ 83890 h 1770602"/>
                <a:gd name="connsiteX2" fmla="*/ 596727 w 599863"/>
                <a:gd name="connsiteY2" fmla="*/ 478173 h 1770602"/>
                <a:gd name="connsiteX3" fmla="*/ 395391 w 599863"/>
                <a:gd name="connsiteY3" fmla="*/ 746620 h 1770602"/>
                <a:gd name="connsiteX4" fmla="*/ 236000 w 599863"/>
                <a:gd name="connsiteY4" fmla="*/ 822121 h 1770602"/>
                <a:gd name="connsiteX5" fmla="*/ 236000 w 599863"/>
                <a:gd name="connsiteY5" fmla="*/ 1560352 h 1770602"/>
                <a:gd name="connsiteX6" fmla="*/ 51442 w 599863"/>
                <a:gd name="connsiteY6" fmla="*/ 1719743 h 1770602"/>
                <a:gd name="connsiteX7" fmla="*/ 9497 w 599863"/>
                <a:gd name="connsiteY7" fmla="*/ 788565 h 1770602"/>
                <a:gd name="connsiteX8" fmla="*/ 26275 w 599863"/>
                <a:gd name="connsiteY8" fmla="*/ 671119 h 1770602"/>
                <a:gd name="connsiteX9" fmla="*/ 269556 w 599863"/>
                <a:gd name="connsiteY9" fmla="*/ 553673 h 1770602"/>
                <a:gd name="connsiteX10" fmla="*/ 294723 w 599863"/>
                <a:gd name="connsiteY10" fmla="*/ 167780 h 1770602"/>
                <a:gd name="connsiteX11" fmla="*/ 168888 w 599863"/>
                <a:gd name="connsiteY11" fmla="*/ 16778 h 1770602"/>
                <a:gd name="connsiteX0" fmla="*/ 101776 w 596760"/>
                <a:gd name="connsiteY0" fmla="*/ 0 h 1770602"/>
                <a:gd name="connsiteX1" fmla="*/ 487670 w 596760"/>
                <a:gd name="connsiteY1" fmla="*/ 83890 h 1770602"/>
                <a:gd name="connsiteX2" fmla="*/ 596727 w 596760"/>
                <a:gd name="connsiteY2" fmla="*/ 478173 h 1770602"/>
                <a:gd name="connsiteX3" fmla="*/ 496059 w 596760"/>
                <a:gd name="connsiteY3" fmla="*/ 704675 h 1770602"/>
                <a:gd name="connsiteX4" fmla="*/ 236000 w 596760"/>
                <a:gd name="connsiteY4" fmla="*/ 822121 h 1770602"/>
                <a:gd name="connsiteX5" fmla="*/ 236000 w 596760"/>
                <a:gd name="connsiteY5" fmla="*/ 1560352 h 1770602"/>
                <a:gd name="connsiteX6" fmla="*/ 51442 w 596760"/>
                <a:gd name="connsiteY6" fmla="*/ 1719743 h 1770602"/>
                <a:gd name="connsiteX7" fmla="*/ 9497 w 596760"/>
                <a:gd name="connsiteY7" fmla="*/ 788565 h 1770602"/>
                <a:gd name="connsiteX8" fmla="*/ 26275 w 596760"/>
                <a:gd name="connsiteY8" fmla="*/ 671119 h 1770602"/>
                <a:gd name="connsiteX9" fmla="*/ 269556 w 596760"/>
                <a:gd name="connsiteY9" fmla="*/ 553673 h 1770602"/>
                <a:gd name="connsiteX10" fmla="*/ 294723 w 596760"/>
                <a:gd name="connsiteY10" fmla="*/ 167780 h 1770602"/>
                <a:gd name="connsiteX11" fmla="*/ 168888 w 596760"/>
                <a:gd name="connsiteY11" fmla="*/ 16778 h 1770602"/>
                <a:gd name="connsiteX0" fmla="*/ 99620 w 594604"/>
                <a:gd name="connsiteY0" fmla="*/ 0 h 1770602"/>
                <a:gd name="connsiteX1" fmla="*/ 485514 w 594604"/>
                <a:gd name="connsiteY1" fmla="*/ 83890 h 1770602"/>
                <a:gd name="connsiteX2" fmla="*/ 594571 w 594604"/>
                <a:gd name="connsiteY2" fmla="*/ 478173 h 1770602"/>
                <a:gd name="connsiteX3" fmla="*/ 493903 w 594604"/>
                <a:gd name="connsiteY3" fmla="*/ 704675 h 1770602"/>
                <a:gd name="connsiteX4" fmla="*/ 233844 w 594604"/>
                <a:gd name="connsiteY4" fmla="*/ 822121 h 1770602"/>
                <a:gd name="connsiteX5" fmla="*/ 233844 w 594604"/>
                <a:gd name="connsiteY5" fmla="*/ 1560352 h 1770602"/>
                <a:gd name="connsiteX6" fmla="*/ 49286 w 594604"/>
                <a:gd name="connsiteY6" fmla="*/ 1719743 h 1770602"/>
                <a:gd name="connsiteX7" fmla="*/ 7341 w 594604"/>
                <a:gd name="connsiteY7" fmla="*/ 788565 h 1770602"/>
                <a:gd name="connsiteX8" fmla="*/ 24119 w 594604"/>
                <a:gd name="connsiteY8" fmla="*/ 671119 h 1770602"/>
                <a:gd name="connsiteX9" fmla="*/ 233844 w 594604"/>
                <a:gd name="connsiteY9" fmla="*/ 486562 h 1770602"/>
                <a:gd name="connsiteX10" fmla="*/ 292567 w 594604"/>
                <a:gd name="connsiteY10" fmla="*/ 167780 h 1770602"/>
                <a:gd name="connsiteX11" fmla="*/ 166732 w 594604"/>
                <a:gd name="connsiteY11" fmla="*/ 16778 h 1770602"/>
                <a:gd name="connsiteX0" fmla="*/ 99620 w 611374"/>
                <a:gd name="connsiteY0" fmla="*/ 0 h 1770602"/>
                <a:gd name="connsiteX1" fmla="*/ 485514 w 611374"/>
                <a:gd name="connsiteY1" fmla="*/ 83890 h 1770602"/>
                <a:gd name="connsiteX2" fmla="*/ 611349 w 611374"/>
                <a:gd name="connsiteY2" fmla="*/ 343949 h 1770602"/>
                <a:gd name="connsiteX3" fmla="*/ 493903 w 611374"/>
                <a:gd name="connsiteY3" fmla="*/ 704675 h 1770602"/>
                <a:gd name="connsiteX4" fmla="*/ 233844 w 611374"/>
                <a:gd name="connsiteY4" fmla="*/ 822121 h 1770602"/>
                <a:gd name="connsiteX5" fmla="*/ 233844 w 611374"/>
                <a:gd name="connsiteY5" fmla="*/ 1560352 h 1770602"/>
                <a:gd name="connsiteX6" fmla="*/ 49286 w 611374"/>
                <a:gd name="connsiteY6" fmla="*/ 1719743 h 1770602"/>
                <a:gd name="connsiteX7" fmla="*/ 7341 w 611374"/>
                <a:gd name="connsiteY7" fmla="*/ 788565 h 1770602"/>
                <a:gd name="connsiteX8" fmla="*/ 24119 w 611374"/>
                <a:gd name="connsiteY8" fmla="*/ 671119 h 1770602"/>
                <a:gd name="connsiteX9" fmla="*/ 233844 w 611374"/>
                <a:gd name="connsiteY9" fmla="*/ 486562 h 1770602"/>
                <a:gd name="connsiteX10" fmla="*/ 292567 w 611374"/>
                <a:gd name="connsiteY10" fmla="*/ 167780 h 1770602"/>
                <a:gd name="connsiteX11" fmla="*/ 166732 w 611374"/>
                <a:gd name="connsiteY11" fmla="*/ 16778 h 1770602"/>
                <a:gd name="connsiteX0" fmla="*/ 99620 w 619760"/>
                <a:gd name="connsiteY0" fmla="*/ 0 h 1770602"/>
                <a:gd name="connsiteX1" fmla="*/ 485514 w 619760"/>
                <a:gd name="connsiteY1" fmla="*/ 83890 h 1770602"/>
                <a:gd name="connsiteX2" fmla="*/ 619738 w 619760"/>
                <a:gd name="connsiteY2" fmla="*/ 411061 h 1770602"/>
                <a:gd name="connsiteX3" fmla="*/ 493903 w 619760"/>
                <a:gd name="connsiteY3" fmla="*/ 704675 h 1770602"/>
                <a:gd name="connsiteX4" fmla="*/ 233844 w 619760"/>
                <a:gd name="connsiteY4" fmla="*/ 822121 h 1770602"/>
                <a:gd name="connsiteX5" fmla="*/ 233844 w 619760"/>
                <a:gd name="connsiteY5" fmla="*/ 1560352 h 1770602"/>
                <a:gd name="connsiteX6" fmla="*/ 49286 w 619760"/>
                <a:gd name="connsiteY6" fmla="*/ 1719743 h 1770602"/>
                <a:gd name="connsiteX7" fmla="*/ 7341 w 619760"/>
                <a:gd name="connsiteY7" fmla="*/ 788565 h 1770602"/>
                <a:gd name="connsiteX8" fmla="*/ 24119 w 619760"/>
                <a:gd name="connsiteY8" fmla="*/ 671119 h 1770602"/>
                <a:gd name="connsiteX9" fmla="*/ 233844 w 619760"/>
                <a:gd name="connsiteY9" fmla="*/ 486562 h 1770602"/>
                <a:gd name="connsiteX10" fmla="*/ 292567 w 619760"/>
                <a:gd name="connsiteY10" fmla="*/ 167780 h 1770602"/>
                <a:gd name="connsiteX11" fmla="*/ 166732 w 619760"/>
                <a:gd name="connsiteY11" fmla="*/ 16778 h 1770602"/>
                <a:gd name="connsiteX0" fmla="*/ 99620 w 619760"/>
                <a:gd name="connsiteY0" fmla="*/ 0 h 1770602"/>
                <a:gd name="connsiteX1" fmla="*/ 485514 w 619760"/>
                <a:gd name="connsiteY1" fmla="*/ 83890 h 1770602"/>
                <a:gd name="connsiteX2" fmla="*/ 619738 w 619760"/>
                <a:gd name="connsiteY2" fmla="*/ 411061 h 1770602"/>
                <a:gd name="connsiteX3" fmla="*/ 493903 w 619760"/>
                <a:gd name="connsiteY3" fmla="*/ 704675 h 1770602"/>
                <a:gd name="connsiteX4" fmla="*/ 233844 w 619760"/>
                <a:gd name="connsiteY4" fmla="*/ 822121 h 1770602"/>
                <a:gd name="connsiteX5" fmla="*/ 233844 w 619760"/>
                <a:gd name="connsiteY5" fmla="*/ 1560352 h 1770602"/>
                <a:gd name="connsiteX6" fmla="*/ 49286 w 619760"/>
                <a:gd name="connsiteY6" fmla="*/ 1719743 h 1770602"/>
                <a:gd name="connsiteX7" fmla="*/ 7341 w 619760"/>
                <a:gd name="connsiteY7" fmla="*/ 788565 h 1770602"/>
                <a:gd name="connsiteX8" fmla="*/ 24119 w 619760"/>
                <a:gd name="connsiteY8" fmla="*/ 671119 h 1770602"/>
                <a:gd name="connsiteX9" fmla="*/ 233844 w 619760"/>
                <a:gd name="connsiteY9" fmla="*/ 486562 h 1770602"/>
                <a:gd name="connsiteX10" fmla="*/ 292567 w 619760"/>
                <a:gd name="connsiteY10" fmla="*/ 167780 h 1770602"/>
                <a:gd name="connsiteX11" fmla="*/ 116398 w 619760"/>
                <a:gd name="connsiteY11" fmla="*/ 0 h 17706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619760" h="1770602">
                  <a:moveTo>
                    <a:pt x="99620" y="0"/>
                  </a:moveTo>
                  <a:cubicBezTo>
                    <a:pt x="251321" y="2097"/>
                    <a:pt x="398828" y="15380"/>
                    <a:pt x="485514" y="83890"/>
                  </a:cubicBezTo>
                  <a:cubicBezTo>
                    <a:pt x="572200" y="152400"/>
                    <a:pt x="618340" y="307597"/>
                    <a:pt x="619738" y="411061"/>
                  </a:cubicBezTo>
                  <a:cubicBezTo>
                    <a:pt x="621136" y="514525"/>
                    <a:pt x="558219" y="636165"/>
                    <a:pt x="493903" y="704675"/>
                  </a:cubicBezTo>
                  <a:cubicBezTo>
                    <a:pt x="429587" y="773185"/>
                    <a:pt x="277187" y="679508"/>
                    <a:pt x="233844" y="822121"/>
                  </a:cubicBezTo>
                  <a:cubicBezTo>
                    <a:pt x="190501" y="964734"/>
                    <a:pt x="264604" y="1410748"/>
                    <a:pt x="233844" y="1560352"/>
                  </a:cubicBezTo>
                  <a:cubicBezTo>
                    <a:pt x="203084" y="1709956"/>
                    <a:pt x="87036" y="1848374"/>
                    <a:pt x="49286" y="1719743"/>
                  </a:cubicBezTo>
                  <a:cubicBezTo>
                    <a:pt x="11536" y="1591112"/>
                    <a:pt x="11536" y="963336"/>
                    <a:pt x="7341" y="788565"/>
                  </a:cubicBezTo>
                  <a:cubicBezTo>
                    <a:pt x="3146" y="613794"/>
                    <a:pt x="-13632" y="721453"/>
                    <a:pt x="24119" y="671119"/>
                  </a:cubicBezTo>
                  <a:cubicBezTo>
                    <a:pt x="61870" y="620785"/>
                    <a:pt x="189103" y="570452"/>
                    <a:pt x="233844" y="486562"/>
                  </a:cubicBezTo>
                  <a:cubicBezTo>
                    <a:pt x="278585" y="402672"/>
                    <a:pt x="312141" y="248874"/>
                    <a:pt x="292567" y="167780"/>
                  </a:cubicBezTo>
                  <a:cubicBezTo>
                    <a:pt x="272993" y="86686"/>
                    <a:pt x="167431" y="27264"/>
                    <a:pt x="116398" y="0"/>
                  </a:cubicBezTo>
                </a:path>
              </a:pathLst>
            </a:custGeom>
            <a:grpFill/>
            <a:ln w="6350" cap="flat" cmpd="sng" algn="ctr">
              <a:solidFill>
                <a:srgbClr val="F79646">
                  <a:lumMod val="5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685800" latinLnBrk="0">
                <a:defRPr/>
              </a:pPr>
              <a:endParaRPr lang="ko-KR" altLang="en-US" sz="1200" kern="0">
                <a:solidFill>
                  <a:prstClr val="white"/>
                </a:solidFill>
                <a:latin typeface="맑은 고딕"/>
                <a:ea typeface="맑은 고딕" panose="020B0503020000020004" pitchFamily="50" charset="-127"/>
              </a:endParaRPr>
            </a:p>
          </p:txBody>
        </p:sp>
        <p:sp>
          <p:nvSpPr>
            <p:cNvPr id="155" name="자유형 154"/>
            <p:cNvSpPr/>
            <p:nvPr/>
          </p:nvSpPr>
          <p:spPr>
            <a:xfrm rot="215227">
              <a:off x="2345080" y="5697003"/>
              <a:ext cx="242234" cy="586876"/>
            </a:xfrm>
            <a:custGeom>
              <a:avLst/>
              <a:gdLst>
                <a:gd name="connsiteX0" fmla="*/ 93845 w 591932"/>
                <a:gd name="connsiteY0" fmla="*/ 0 h 1770602"/>
                <a:gd name="connsiteX1" fmla="*/ 479739 w 591932"/>
                <a:gd name="connsiteY1" fmla="*/ 83890 h 1770602"/>
                <a:gd name="connsiteX2" fmla="*/ 588796 w 591932"/>
                <a:gd name="connsiteY2" fmla="*/ 478173 h 1770602"/>
                <a:gd name="connsiteX3" fmla="*/ 387460 w 591932"/>
                <a:gd name="connsiteY3" fmla="*/ 746620 h 1770602"/>
                <a:gd name="connsiteX4" fmla="*/ 228069 w 591932"/>
                <a:gd name="connsiteY4" fmla="*/ 822121 h 1770602"/>
                <a:gd name="connsiteX5" fmla="*/ 228069 w 591932"/>
                <a:gd name="connsiteY5" fmla="*/ 1560352 h 1770602"/>
                <a:gd name="connsiteX6" fmla="*/ 43511 w 591932"/>
                <a:gd name="connsiteY6" fmla="*/ 1719743 h 1770602"/>
                <a:gd name="connsiteX7" fmla="*/ 1566 w 591932"/>
                <a:gd name="connsiteY7" fmla="*/ 788565 h 1770602"/>
                <a:gd name="connsiteX8" fmla="*/ 35122 w 591932"/>
                <a:gd name="connsiteY8" fmla="*/ 696286 h 1770602"/>
                <a:gd name="connsiteX9" fmla="*/ 261625 w 591932"/>
                <a:gd name="connsiteY9" fmla="*/ 553673 h 1770602"/>
                <a:gd name="connsiteX10" fmla="*/ 286792 w 591932"/>
                <a:gd name="connsiteY10" fmla="*/ 167780 h 1770602"/>
                <a:gd name="connsiteX11" fmla="*/ 169346 w 591932"/>
                <a:gd name="connsiteY11" fmla="*/ 25167 h 1770602"/>
                <a:gd name="connsiteX0" fmla="*/ 93845 w 591932"/>
                <a:gd name="connsiteY0" fmla="*/ 0 h 1770602"/>
                <a:gd name="connsiteX1" fmla="*/ 479739 w 591932"/>
                <a:gd name="connsiteY1" fmla="*/ 83890 h 1770602"/>
                <a:gd name="connsiteX2" fmla="*/ 588796 w 591932"/>
                <a:gd name="connsiteY2" fmla="*/ 478173 h 1770602"/>
                <a:gd name="connsiteX3" fmla="*/ 387460 w 591932"/>
                <a:gd name="connsiteY3" fmla="*/ 746620 h 1770602"/>
                <a:gd name="connsiteX4" fmla="*/ 228069 w 591932"/>
                <a:gd name="connsiteY4" fmla="*/ 822121 h 1770602"/>
                <a:gd name="connsiteX5" fmla="*/ 228069 w 591932"/>
                <a:gd name="connsiteY5" fmla="*/ 1560352 h 1770602"/>
                <a:gd name="connsiteX6" fmla="*/ 43511 w 591932"/>
                <a:gd name="connsiteY6" fmla="*/ 1719743 h 1770602"/>
                <a:gd name="connsiteX7" fmla="*/ 1566 w 591932"/>
                <a:gd name="connsiteY7" fmla="*/ 788565 h 1770602"/>
                <a:gd name="connsiteX8" fmla="*/ 35122 w 591932"/>
                <a:gd name="connsiteY8" fmla="*/ 696286 h 1770602"/>
                <a:gd name="connsiteX9" fmla="*/ 261625 w 591932"/>
                <a:gd name="connsiteY9" fmla="*/ 553673 h 1770602"/>
                <a:gd name="connsiteX10" fmla="*/ 286792 w 591932"/>
                <a:gd name="connsiteY10" fmla="*/ 167780 h 1770602"/>
                <a:gd name="connsiteX11" fmla="*/ 160957 w 591932"/>
                <a:gd name="connsiteY11" fmla="*/ 16778 h 1770602"/>
                <a:gd name="connsiteX0" fmla="*/ 101776 w 599863"/>
                <a:gd name="connsiteY0" fmla="*/ 0 h 1770602"/>
                <a:gd name="connsiteX1" fmla="*/ 487670 w 599863"/>
                <a:gd name="connsiteY1" fmla="*/ 83890 h 1770602"/>
                <a:gd name="connsiteX2" fmla="*/ 596727 w 599863"/>
                <a:gd name="connsiteY2" fmla="*/ 478173 h 1770602"/>
                <a:gd name="connsiteX3" fmla="*/ 395391 w 599863"/>
                <a:gd name="connsiteY3" fmla="*/ 746620 h 1770602"/>
                <a:gd name="connsiteX4" fmla="*/ 236000 w 599863"/>
                <a:gd name="connsiteY4" fmla="*/ 822121 h 1770602"/>
                <a:gd name="connsiteX5" fmla="*/ 236000 w 599863"/>
                <a:gd name="connsiteY5" fmla="*/ 1560352 h 1770602"/>
                <a:gd name="connsiteX6" fmla="*/ 51442 w 599863"/>
                <a:gd name="connsiteY6" fmla="*/ 1719743 h 1770602"/>
                <a:gd name="connsiteX7" fmla="*/ 9497 w 599863"/>
                <a:gd name="connsiteY7" fmla="*/ 788565 h 1770602"/>
                <a:gd name="connsiteX8" fmla="*/ 26275 w 599863"/>
                <a:gd name="connsiteY8" fmla="*/ 671119 h 1770602"/>
                <a:gd name="connsiteX9" fmla="*/ 269556 w 599863"/>
                <a:gd name="connsiteY9" fmla="*/ 553673 h 1770602"/>
                <a:gd name="connsiteX10" fmla="*/ 294723 w 599863"/>
                <a:gd name="connsiteY10" fmla="*/ 167780 h 1770602"/>
                <a:gd name="connsiteX11" fmla="*/ 168888 w 599863"/>
                <a:gd name="connsiteY11" fmla="*/ 16778 h 1770602"/>
                <a:gd name="connsiteX0" fmla="*/ 101776 w 596760"/>
                <a:gd name="connsiteY0" fmla="*/ 0 h 1770602"/>
                <a:gd name="connsiteX1" fmla="*/ 487670 w 596760"/>
                <a:gd name="connsiteY1" fmla="*/ 83890 h 1770602"/>
                <a:gd name="connsiteX2" fmla="*/ 596727 w 596760"/>
                <a:gd name="connsiteY2" fmla="*/ 478173 h 1770602"/>
                <a:gd name="connsiteX3" fmla="*/ 496059 w 596760"/>
                <a:gd name="connsiteY3" fmla="*/ 704675 h 1770602"/>
                <a:gd name="connsiteX4" fmla="*/ 236000 w 596760"/>
                <a:gd name="connsiteY4" fmla="*/ 822121 h 1770602"/>
                <a:gd name="connsiteX5" fmla="*/ 236000 w 596760"/>
                <a:gd name="connsiteY5" fmla="*/ 1560352 h 1770602"/>
                <a:gd name="connsiteX6" fmla="*/ 51442 w 596760"/>
                <a:gd name="connsiteY6" fmla="*/ 1719743 h 1770602"/>
                <a:gd name="connsiteX7" fmla="*/ 9497 w 596760"/>
                <a:gd name="connsiteY7" fmla="*/ 788565 h 1770602"/>
                <a:gd name="connsiteX8" fmla="*/ 26275 w 596760"/>
                <a:gd name="connsiteY8" fmla="*/ 671119 h 1770602"/>
                <a:gd name="connsiteX9" fmla="*/ 269556 w 596760"/>
                <a:gd name="connsiteY9" fmla="*/ 553673 h 1770602"/>
                <a:gd name="connsiteX10" fmla="*/ 294723 w 596760"/>
                <a:gd name="connsiteY10" fmla="*/ 167780 h 1770602"/>
                <a:gd name="connsiteX11" fmla="*/ 168888 w 596760"/>
                <a:gd name="connsiteY11" fmla="*/ 16778 h 1770602"/>
                <a:gd name="connsiteX0" fmla="*/ 99620 w 594604"/>
                <a:gd name="connsiteY0" fmla="*/ 0 h 1770602"/>
                <a:gd name="connsiteX1" fmla="*/ 485514 w 594604"/>
                <a:gd name="connsiteY1" fmla="*/ 83890 h 1770602"/>
                <a:gd name="connsiteX2" fmla="*/ 594571 w 594604"/>
                <a:gd name="connsiteY2" fmla="*/ 478173 h 1770602"/>
                <a:gd name="connsiteX3" fmla="*/ 493903 w 594604"/>
                <a:gd name="connsiteY3" fmla="*/ 704675 h 1770602"/>
                <a:gd name="connsiteX4" fmla="*/ 233844 w 594604"/>
                <a:gd name="connsiteY4" fmla="*/ 822121 h 1770602"/>
                <a:gd name="connsiteX5" fmla="*/ 233844 w 594604"/>
                <a:gd name="connsiteY5" fmla="*/ 1560352 h 1770602"/>
                <a:gd name="connsiteX6" fmla="*/ 49286 w 594604"/>
                <a:gd name="connsiteY6" fmla="*/ 1719743 h 1770602"/>
                <a:gd name="connsiteX7" fmla="*/ 7341 w 594604"/>
                <a:gd name="connsiteY7" fmla="*/ 788565 h 1770602"/>
                <a:gd name="connsiteX8" fmla="*/ 24119 w 594604"/>
                <a:gd name="connsiteY8" fmla="*/ 671119 h 1770602"/>
                <a:gd name="connsiteX9" fmla="*/ 233844 w 594604"/>
                <a:gd name="connsiteY9" fmla="*/ 486562 h 1770602"/>
                <a:gd name="connsiteX10" fmla="*/ 292567 w 594604"/>
                <a:gd name="connsiteY10" fmla="*/ 167780 h 1770602"/>
                <a:gd name="connsiteX11" fmla="*/ 166732 w 594604"/>
                <a:gd name="connsiteY11" fmla="*/ 16778 h 1770602"/>
                <a:gd name="connsiteX0" fmla="*/ 99620 w 611374"/>
                <a:gd name="connsiteY0" fmla="*/ 0 h 1770602"/>
                <a:gd name="connsiteX1" fmla="*/ 485514 w 611374"/>
                <a:gd name="connsiteY1" fmla="*/ 83890 h 1770602"/>
                <a:gd name="connsiteX2" fmla="*/ 611349 w 611374"/>
                <a:gd name="connsiteY2" fmla="*/ 343949 h 1770602"/>
                <a:gd name="connsiteX3" fmla="*/ 493903 w 611374"/>
                <a:gd name="connsiteY3" fmla="*/ 704675 h 1770602"/>
                <a:gd name="connsiteX4" fmla="*/ 233844 w 611374"/>
                <a:gd name="connsiteY4" fmla="*/ 822121 h 1770602"/>
                <a:gd name="connsiteX5" fmla="*/ 233844 w 611374"/>
                <a:gd name="connsiteY5" fmla="*/ 1560352 h 1770602"/>
                <a:gd name="connsiteX6" fmla="*/ 49286 w 611374"/>
                <a:gd name="connsiteY6" fmla="*/ 1719743 h 1770602"/>
                <a:gd name="connsiteX7" fmla="*/ 7341 w 611374"/>
                <a:gd name="connsiteY7" fmla="*/ 788565 h 1770602"/>
                <a:gd name="connsiteX8" fmla="*/ 24119 w 611374"/>
                <a:gd name="connsiteY8" fmla="*/ 671119 h 1770602"/>
                <a:gd name="connsiteX9" fmla="*/ 233844 w 611374"/>
                <a:gd name="connsiteY9" fmla="*/ 486562 h 1770602"/>
                <a:gd name="connsiteX10" fmla="*/ 292567 w 611374"/>
                <a:gd name="connsiteY10" fmla="*/ 167780 h 1770602"/>
                <a:gd name="connsiteX11" fmla="*/ 166732 w 611374"/>
                <a:gd name="connsiteY11" fmla="*/ 16778 h 1770602"/>
                <a:gd name="connsiteX0" fmla="*/ 99620 w 619760"/>
                <a:gd name="connsiteY0" fmla="*/ 0 h 1770602"/>
                <a:gd name="connsiteX1" fmla="*/ 485514 w 619760"/>
                <a:gd name="connsiteY1" fmla="*/ 83890 h 1770602"/>
                <a:gd name="connsiteX2" fmla="*/ 619738 w 619760"/>
                <a:gd name="connsiteY2" fmla="*/ 411061 h 1770602"/>
                <a:gd name="connsiteX3" fmla="*/ 493903 w 619760"/>
                <a:gd name="connsiteY3" fmla="*/ 704675 h 1770602"/>
                <a:gd name="connsiteX4" fmla="*/ 233844 w 619760"/>
                <a:gd name="connsiteY4" fmla="*/ 822121 h 1770602"/>
                <a:gd name="connsiteX5" fmla="*/ 233844 w 619760"/>
                <a:gd name="connsiteY5" fmla="*/ 1560352 h 1770602"/>
                <a:gd name="connsiteX6" fmla="*/ 49286 w 619760"/>
                <a:gd name="connsiteY6" fmla="*/ 1719743 h 1770602"/>
                <a:gd name="connsiteX7" fmla="*/ 7341 w 619760"/>
                <a:gd name="connsiteY7" fmla="*/ 788565 h 1770602"/>
                <a:gd name="connsiteX8" fmla="*/ 24119 w 619760"/>
                <a:gd name="connsiteY8" fmla="*/ 671119 h 1770602"/>
                <a:gd name="connsiteX9" fmla="*/ 233844 w 619760"/>
                <a:gd name="connsiteY9" fmla="*/ 486562 h 1770602"/>
                <a:gd name="connsiteX10" fmla="*/ 292567 w 619760"/>
                <a:gd name="connsiteY10" fmla="*/ 167780 h 1770602"/>
                <a:gd name="connsiteX11" fmla="*/ 166732 w 619760"/>
                <a:gd name="connsiteY11" fmla="*/ 16778 h 1770602"/>
                <a:gd name="connsiteX0" fmla="*/ 99620 w 619760"/>
                <a:gd name="connsiteY0" fmla="*/ 0 h 1770602"/>
                <a:gd name="connsiteX1" fmla="*/ 485514 w 619760"/>
                <a:gd name="connsiteY1" fmla="*/ 83890 h 1770602"/>
                <a:gd name="connsiteX2" fmla="*/ 619738 w 619760"/>
                <a:gd name="connsiteY2" fmla="*/ 411061 h 1770602"/>
                <a:gd name="connsiteX3" fmla="*/ 493903 w 619760"/>
                <a:gd name="connsiteY3" fmla="*/ 704675 h 1770602"/>
                <a:gd name="connsiteX4" fmla="*/ 233844 w 619760"/>
                <a:gd name="connsiteY4" fmla="*/ 822121 h 1770602"/>
                <a:gd name="connsiteX5" fmla="*/ 233844 w 619760"/>
                <a:gd name="connsiteY5" fmla="*/ 1560352 h 1770602"/>
                <a:gd name="connsiteX6" fmla="*/ 49286 w 619760"/>
                <a:gd name="connsiteY6" fmla="*/ 1719743 h 1770602"/>
                <a:gd name="connsiteX7" fmla="*/ 7341 w 619760"/>
                <a:gd name="connsiteY7" fmla="*/ 788565 h 1770602"/>
                <a:gd name="connsiteX8" fmla="*/ 24119 w 619760"/>
                <a:gd name="connsiteY8" fmla="*/ 671119 h 1770602"/>
                <a:gd name="connsiteX9" fmla="*/ 233844 w 619760"/>
                <a:gd name="connsiteY9" fmla="*/ 486562 h 1770602"/>
                <a:gd name="connsiteX10" fmla="*/ 292567 w 619760"/>
                <a:gd name="connsiteY10" fmla="*/ 167780 h 1770602"/>
                <a:gd name="connsiteX11" fmla="*/ 116398 w 619760"/>
                <a:gd name="connsiteY11" fmla="*/ 0 h 17706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619760" h="1770602">
                  <a:moveTo>
                    <a:pt x="99620" y="0"/>
                  </a:moveTo>
                  <a:cubicBezTo>
                    <a:pt x="251321" y="2097"/>
                    <a:pt x="398828" y="15380"/>
                    <a:pt x="485514" y="83890"/>
                  </a:cubicBezTo>
                  <a:cubicBezTo>
                    <a:pt x="572200" y="152400"/>
                    <a:pt x="618340" y="307597"/>
                    <a:pt x="619738" y="411061"/>
                  </a:cubicBezTo>
                  <a:cubicBezTo>
                    <a:pt x="621136" y="514525"/>
                    <a:pt x="558219" y="636165"/>
                    <a:pt x="493903" y="704675"/>
                  </a:cubicBezTo>
                  <a:cubicBezTo>
                    <a:pt x="429587" y="773185"/>
                    <a:pt x="277187" y="679508"/>
                    <a:pt x="233844" y="822121"/>
                  </a:cubicBezTo>
                  <a:cubicBezTo>
                    <a:pt x="190501" y="964734"/>
                    <a:pt x="264604" y="1410748"/>
                    <a:pt x="233844" y="1560352"/>
                  </a:cubicBezTo>
                  <a:cubicBezTo>
                    <a:pt x="203084" y="1709956"/>
                    <a:pt x="87036" y="1848374"/>
                    <a:pt x="49286" y="1719743"/>
                  </a:cubicBezTo>
                  <a:cubicBezTo>
                    <a:pt x="11536" y="1591112"/>
                    <a:pt x="11536" y="963336"/>
                    <a:pt x="7341" y="788565"/>
                  </a:cubicBezTo>
                  <a:cubicBezTo>
                    <a:pt x="3146" y="613794"/>
                    <a:pt x="-13632" y="721453"/>
                    <a:pt x="24119" y="671119"/>
                  </a:cubicBezTo>
                  <a:cubicBezTo>
                    <a:pt x="61870" y="620785"/>
                    <a:pt x="189103" y="570452"/>
                    <a:pt x="233844" y="486562"/>
                  </a:cubicBezTo>
                  <a:cubicBezTo>
                    <a:pt x="278585" y="402672"/>
                    <a:pt x="312141" y="248874"/>
                    <a:pt x="292567" y="167780"/>
                  </a:cubicBezTo>
                  <a:cubicBezTo>
                    <a:pt x="272993" y="86686"/>
                    <a:pt x="167431" y="27264"/>
                    <a:pt x="116398" y="0"/>
                  </a:cubicBezTo>
                </a:path>
              </a:pathLst>
            </a:custGeom>
            <a:grpFill/>
            <a:ln w="6350" cap="flat" cmpd="sng" algn="ctr">
              <a:solidFill>
                <a:srgbClr val="F79646">
                  <a:lumMod val="50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685800" latinLnBrk="0">
                <a:defRPr/>
              </a:pPr>
              <a:endParaRPr lang="ko-KR" altLang="en-US" sz="1200" kern="0">
                <a:solidFill>
                  <a:prstClr val="white"/>
                </a:solidFill>
                <a:latin typeface="맑은 고딕"/>
                <a:ea typeface="맑은 고딕" panose="020B0503020000020004" pitchFamily="50" charset="-127"/>
              </a:endParaRPr>
            </a:p>
          </p:txBody>
        </p:sp>
      </p:grpSp>
      <p:grpSp>
        <p:nvGrpSpPr>
          <p:cNvPr id="1027" name="그룹 1026"/>
          <p:cNvGrpSpPr/>
          <p:nvPr/>
        </p:nvGrpSpPr>
        <p:grpSpPr>
          <a:xfrm>
            <a:off x="2205457" y="1887434"/>
            <a:ext cx="234000" cy="391236"/>
            <a:chOff x="5319713" y="1842008"/>
            <a:chExt cx="234000" cy="391236"/>
          </a:xfrm>
        </p:grpSpPr>
        <p:sp>
          <p:nvSpPr>
            <p:cNvPr id="84" name="육각형 83"/>
            <p:cNvSpPr/>
            <p:nvPr/>
          </p:nvSpPr>
          <p:spPr>
            <a:xfrm>
              <a:off x="5319713" y="1842008"/>
              <a:ext cx="234000" cy="216000"/>
            </a:xfrm>
            <a:prstGeom prst="hexagon">
              <a:avLst/>
            </a:prstGeom>
            <a:gradFill flip="none" rotWithShape="1">
              <a:gsLst>
                <a:gs pos="0">
                  <a:srgbClr val="FFC000"/>
                </a:gs>
                <a:gs pos="59000">
                  <a:schemeClr val="accent4">
                    <a:lumMod val="40000"/>
                    <a:lumOff val="60000"/>
                  </a:schemeClr>
                </a:gs>
                <a:gs pos="97000">
                  <a:schemeClr val="bg1"/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solidFill>
                <a:srgbClr val="FF99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cxnSp>
          <p:nvCxnSpPr>
            <p:cNvPr id="1025" name="직선 연결선 1024"/>
            <p:cNvCxnSpPr/>
            <p:nvPr/>
          </p:nvCxnSpPr>
          <p:spPr>
            <a:xfrm>
              <a:off x="5378476" y="2053244"/>
              <a:ext cx="0" cy="180000"/>
            </a:xfrm>
            <a:prstGeom prst="line">
              <a:avLst/>
            </a:prstGeom>
            <a:ln w="12700">
              <a:solidFill>
                <a:srgbClr val="FF99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직선 연결선 158"/>
            <p:cNvCxnSpPr/>
            <p:nvPr/>
          </p:nvCxnSpPr>
          <p:spPr>
            <a:xfrm>
              <a:off x="5501445" y="2053244"/>
              <a:ext cx="0" cy="180000"/>
            </a:xfrm>
            <a:prstGeom prst="line">
              <a:avLst/>
            </a:prstGeom>
            <a:ln w="12700">
              <a:solidFill>
                <a:srgbClr val="FF99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1" name="그룹 160"/>
          <p:cNvGrpSpPr>
            <a:grpSpLocks noChangeAspect="1"/>
          </p:cNvGrpSpPr>
          <p:nvPr/>
        </p:nvGrpSpPr>
        <p:grpSpPr>
          <a:xfrm>
            <a:off x="2801122" y="2751316"/>
            <a:ext cx="207109" cy="346275"/>
            <a:chOff x="5319713" y="1842008"/>
            <a:chExt cx="234000" cy="391236"/>
          </a:xfrm>
        </p:grpSpPr>
        <p:sp>
          <p:nvSpPr>
            <p:cNvPr id="162" name="육각형 161"/>
            <p:cNvSpPr/>
            <p:nvPr/>
          </p:nvSpPr>
          <p:spPr>
            <a:xfrm>
              <a:off x="5319713" y="1842008"/>
              <a:ext cx="234000" cy="216000"/>
            </a:xfrm>
            <a:prstGeom prst="hexagon">
              <a:avLst/>
            </a:prstGeom>
            <a:gradFill flip="none" rotWithShape="1">
              <a:gsLst>
                <a:gs pos="0">
                  <a:srgbClr val="FFC000"/>
                </a:gs>
                <a:gs pos="59000">
                  <a:schemeClr val="accent4">
                    <a:lumMod val="40000"/>
                    <a:lumOff val="60000"/>
                  </a:schemeClr>
                </a:gs>
                <a:gs pos="97000">
                  <a:schemeClr val="bg1"/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solidFill>
                <a:srgbClr val="FF99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cxnSp>
          <p:nvCxnSpPr>
            <p:cNvPr id="163" name="직선 연결선 162"/>
            <p:cNvCxnSpPr/>
            <p:nvPr/>
          </p:nvCxnSpPr>
          <p:spPr>
            <a:xfrm>
              <a:off x="5378476" y="2053244"/>
              <a:ext cx="0" cy="180000"/>
            </a:xfrm>
            <a:prstGeom prst="line">
              <a:avLst/>
            </a:prstGeom>
            <a:ln w="12700">
              <a:solidFill>
                <a:srgbClr val="FF99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직선 연결선 163"/>
            <p:cNvCxnSpPr/>
            <p:nvPr/>
          </p:nvCxnSpPr>
          <p:spPr>
            <a:xfrm>
              <a:off x="5501445" y="2053244"/>
              <a:ext cx="0" cy="180000"/>
            </a:xfrm>
            <a:prstGeom prst="line">
              <a:avLst/>
            </a:prstGeom>
            <a:ln w="12700">
              <a:solidFill>
                <a:srgbClr val="FF99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8" name="그룹 137"/>
          <p:cNvGrpSpPr>
            <a:grpSpLocks noChangeAspect="1"/>
          </p:cNvGrpSpPr>
          <p:nvPr/>
        </p:nvGrpSpPr>
        <p:grpSpPr>
          <a:xfrm rot="21378757">
            <a:off x="1919189" y="3653507"/>
            <a:ext cx="292242" cy="346275"/>
            <a:chOff x="2092012" y="5697003"/>
            <a:chExt cx="495302" cy="586876"/>
          </a:xfrm>
          <a:gradFill flip="none" rotWithShape="1">
            <a:gsLst>
              <a:gs pos="35000">
                <a:schemeClr val="accent6">
                  <a:lumMod val="60000"/>
                  <a:lumOff val="40000"/>
                </a:schemeClr>
              </a:gs>
              <a:gs pos="67000">
                <a:schemeClr val="accent6">
                  <a:lumMod val="20000"/>
                  <a:lumOff val="80000"/>
                </a:schemeClr>
              </a:gs>
              <a:gs pos="97000">
                <a:schemeClr val="bg1"/>
              </a:gs>
            </a:gsLst>
            <a:path path="circle">
              <a:fillToRect l="100000" t="100000"/>
            </a:path>
            <a:tileRect r="-100000" b="-100000"/>
          </a:gradFill>
        </p:grpSpPr>
        <p:sp>
          <p:nvSpPr>
            <p:cNvPr id="140" name="자유형 139"/>
            <p:cNvSpPr/>
            <p:nvPr/>
          </p:nvSpPr>
          <p:spPr>
            <a:xfrm rot="21384773" flipH="1">
              <a:off x="2092012" y="5697003"/>
              <a:ext cx="242234" cy="586876"/>
            </a:xfrm>
            <a:custGeom>
              <a:avLst/>
              <a:gdLst>
                <a:gd name="connsiteX0" fmla="*/ 93845 w 591932"/>
                <a:gd name="connsiteY0" fmla="*/ 0 h 1770602"/>
                <a:gd name="connsiteX1" fmla="*/ 479739 w 591932"/>
                <a:gd name="connsiteY1" fmla="*/ 83890 h 1770602"/>
                <a:gd name="connsiteX2" fmla="*/ 588796 w 591932"/>
                <a:gd name="connsiteY2" fmla="*/ 478173 h 1770602"/>
                <a:gd name="connsiteX3" fmla="*/ 387460 w 591932"/>
                <a:gd name="connsiteY3" fmla="*/ 746620 h 1770602"/>
                <a:gd name="connsiteX4" fmla="*/ 228069 w 591932"/>
                <a:gd name="connsiteY4" fmla="*/ 822121 h 1770602"/>
                <a:gd name="connsiteX5" fmla="*/ 228069 w 591932"/>
                <a:gd name="connsiteY5" fmla="*/ 1560352 h 1770602"/>
                <a:gd name="connsiteX6" fmla="*/ 43511 w 591932"/>
                <a:gd name="connsiteY6" fmla="*/ 1719743 h 1770602"/>
                <a:gd name="connsiteX7" fmla="*/ 1566 w 591932"/>
                <a:gd name="connsiteY7" fmla="*/ 788565 h 1770602"/>
                <a:gd name="connsiteX8" fmla="*/ 35122 w 591932"/>
                <a:gd name="connsiteY8" fmla="*/ 696286 h 1770602"/>
                <a:gd name="connsiteX9" fmla="*/ 261625 w 591932"/>
                <a:gd name="connsiteY9" fmla="*/ 553673 h 1770602"/>
                <a:gd name="connsiteX10" fmla="*/ 286792 w 591932"/>
                <a:gd name="connsiteY10" fmla="*/ 167780 h 1770602"/>
                <a:gd name="connsiteX11" fmla="*/ 169346 w 591932"/>
                <a:gd name="connsiteY11" fmla="*/ 25167 h 1770602"/>
                <a:gd name="connsiteX0" fmla="*/ 93845 w 591932"/>
                <a:gd name="connsiteY0" fmla="*/ 0 h 1770602"/>
                <a:gd name="connsiteX1" fmla="*/ 479739 w 591932"/>
                <a:gd name="connsiteY1" fmla="*/ 83890 h 1770602"/>
                <a:gd name="connsiteX2" fmla="*/ 588796 w 591932"/>
                <a:gd name="connsiteY2" fmla="*/ 478173 h 1770602"/>
                <a:gd name="connsiteX3" fmla="*/ 387460 w 591932"/>
                <a:gd name="connsiteY3" fmla="*/ 746620 h 1770602"/>
                <a:gd name="connsiteX4" fmla="*/ 228069 w 591932"/>
                <a:gd name="connsiteY4" fmla="*/ 822121 h 1770602"/>
                <a:gd name="connsiteX5" fmla="*/ 228069 w 591932"/>
                <a:gd name="connsiteY5" fmla="*/ 1560352 h 1770602"/>
                <a:gd name="connsiteX6" fmla="*/ 43511 w 591932"/>
                <a:gd name="connsiteY6" fmla="*/ 1719743 h 1770602"/>
                <a:gd name="connsiteX7" fmla="*/ 1566 w 591932"/>
                <a:gd name="connsiteY7" fmla="*/ 788565 h 1770602"/>
                <a:gd name="connsiteX8" fmla="*/ 35122 w 591932"/>
                <a:gd name="connsiteY8" fmla="*/ 696286 h 1770602"/>
                <a:gd name="connsiteX9" fmla="*/ 261625 w 591932"/>
                <a:gd name="connsiteY9" fmla="*/ 553673 h 1770602"/>
                <a:gd name="connsiteX10" fmla="*/ 286792 w 591932"/>
                <a:gd name="connsiteY10" fmla="*/ 167780 h 1770602"/>
                <a:gd name="connsiteX11" fmla="*/ 160957 w 591932"/>
                <a:gd name="connsiteY11" fmla="*/ 16778 h 1770602"/>
                <a:gd name="connsiteX0" fmla="*/ 101776 w 599863"/>
                <a:gd name="connsiteY0" fmla="*/ 0 h 1770602"/>
                <a:gd name="connsiteX1" fmla="*/ 487670 w 599863"/>
                <a:gd name="connsiteY1" fmla="*/ 83890 h 1770602"/>
                <a:gd name="connsiteX2" fmla="*/ 596727 w 599863"/>
                <a:gd name="connsiteY2" fmla="*/ 478173 h 1770602"/>
                <a:gd name="connsiteX3" fmla="*/ 395391 w 599863"/>
                <a:gd name="connsiteY3" fmla="*/ 746620 h 1770602"/>
                <a:gd name="connsiteX4" fmla="*/ 236000 w 599863"/>
                <a:gd name="connsiteY4" fmla="*/ 822121 h 1770602"/>
                <a:gd name="connsiteX5" fmla="*/ 236000 w 599863"/>
                <a:gd name="connsiteY5" fmla="*/ 1560352 h 1770602"/>
                <a:gd name="connsiteX6" fmla="*/ 51442 w 599863"/>
                <a:gd name="connsiteY6" fmla="*/ 1719743 h 1770602"/>
                <a:gd name="connsiteX7" fmla="*/ 9497 w 599863"/>
                <a:gd name="connsiteY7" fmla="*/ 788565 h 1770602"/>
                <a:gd name="connsiteX8" fmla="*/ 26275 w 599863"/>
                <a:gd name="connsiteY8" fmla="*/ 671119 h 1770602"/>
                <a:gd name="connsiteX9" fmla="*/ 269556 w 599863"/>
                <a:gd name="connsiteY9" fmla="*/ 553673 h 1770602"/>
                <a:gd name="connsiteX10" fmla="*/ 294723 w 599863"/>
                <a:gd name="connsiteY10" fmla="*/ 167780 h 1770602"/>
                <a:gd name="connsiteX11" fmla="*/ 168888 w 599863"/>
                <a:gd name="connsiteY11" fmla="*/ 16778 h 1770602"/>
                <a:gd name="connsiteX0" fmla="*/ 101776 w 596760"/>
                <a:gd name="connsiteY0" fmla="*/ 0 h 1770602"/>
                <a:gd name="connsiteX1" fmla="*/ 487670 w 596760"/>
                <a:gd name="connsiteY1" fmla="*/ 83890 h 1770602"/>
                <a:gd name="connsiteX2" fmla="*/ 596727 w 596760"/>
                <a:gd name="connsiteY2" fmla="*/ 478173 h 1770602"/>
                <a:gd name="connsiteX3" fmla="*/ 496059 w 596760"/>
                <a:gd name="connsiteY3" fmla="*/ 704675 h 1770602"/>
                <a:gd name="connsiteX4" fmla="*/ 236000 w 596760"/>
                <a:gd name="connsiteY4" fmla="*/ 822121 h 1770602"/>
                <a:gd name="connsiteX5" fmla="*/ 236000 w 596760"/>
                <a:gd name="connsiteY5" fmla="*/ 1560352 h 1770602"/>
                <a:gd name="connsiteX6" fmla="*/ 51442 w 596760"/>
                <a:gd name="connsiteY6" fmla="*/ 1719743 h 1770602"/>
                <a:gd name="connsiteX7" fmla="*/ 9497 w 596760"/>
                <a:gd name="connsiteY7" fmla="*/ 788565 h 1770602"/>
                <a:gd name="connsiteX8" fmla="*/ 26275 w 596760"/>
                <a:gd name="connsiteY8" fmla="*/ 671119 h 1770602"/>
                <a:gd name="connsiteX9" fmla="*/ 269556 w 596760"/>
                <a:gd name="connsiteY9" fmla="*/ 553673 h 1770602"/>
                <a:gd name="connsiteX10" fmla="*/ 294723 w 596760"/>
                <a:gd name="connsiteY10" fmla="*/ 167780 h 1770602"/>
                <a:gd name="connsiteX11" fmla="*/ 168888 w 596760"/>
                <a:gd name="connsiteY11" fmla="*/ 16778 h 1770602"/>
                <a:gd name="connsiteX0" fmla="*/ 99620 w 594604"/>
                <a:gd name="connsiteY0" fmla="*/ 0 h 1770602"/>
                <a:gd name="connsiteX1" fmla="*/ 485514 w 594604"/>
                <a:gd name="connsiteY1" fmla="*/ 83890 h 1770602"/>
                <a:gd name="connsiteX2" fmla="*/ 594571 w 594604"/>
                <a:gd name="connsiteY2" fmla="*/ 478173 h 1770602"/>
                <a:gd name="connsiteX3" fmla="*/ 493903 w 594604"/>
                <a:gd name="connsiteY3" fmla="*/ 704675 h 1770602"/>
                <a:gd name="connsiteX4" fmla="*/ 233844 w 594604"/>
                <a:gd name="connsiteY4" fmla="*/ 822121 h 1770602"/>
                <a:gd name="connsiteX5" fmla="*/ 233844 w 594604"/>
                <a:gd name="connsiteY5" fmla="*/ 1560352 h 1770602"/>
                <a:gd name="connsiteX6" fmla="*/ 49286 w 594604"/>
                <a:gd name="connsiteY6" fmla="*/ 1719743 h 1770602"/>
                <a:gd name="connsiteX7" fmla="*/ 7341 w 594604"/>
                <a:gd name="connsiteY7" fmla="*/ 788565 h 1770602"/>
                <a:gd name="connsiteX8" fmla="*/ 24119 w 594604"/>
                <a:gd name="connsiteY8" fmla="*/ 671119 h 1770602"/>
                <a:gd name="connsiteX9" fmla="*/ 233844 w 594604"/>
                <a:gd name="connsiteY9" fmla="*/ 486562 h 1770602"/>
                <a:gd name="connsiteX10" fmla="*/ 292567 w 594604"/>
                <a:gd name="connsiteY10" fmla="*/ 167780 h 1770602"/>
                <a:gd name="connsiteX11" fmla="*/ 166732 w 594604"/>
                <a:gd name="connsiteY11" fmla="*/ 16778 h 1770602"/>
                <a:gd name="connsiteX0" fmla="*/ 99620 w 611374"/>
                <a:gd name="connsiteY0" fmla="*/ 0 h 1770602"/>
                <a:gd name="connsiteX1" fmla="*/ 485514 w 611374"/>
                <a:gd name="connsiteY1" fmla="*/ 83890 h 1770602"/>
                <a:gd name="connsiteX2" fmla="*/ 611349 w 611374"/>
                <a:gd name="connsiteY2" fmla="*/ 343949 h 1770602"/>
                <a:gd name="connsiteX3" fmla="*/ 493903 w 611374"/>
                <a:gd name="connsiteY3" fmla="*/ 704675 h 1770602"/>
                <a:gd name="connsiteX4" fmla="*/ 233844 w 611374"/>
                <a:gd name="connsiteY4" fmla="*/ 822121 h 1770602"/>
                <a:gd name="connsiteX5" fmla="*/ 233844 w 611374"/>
                <a:gd name="connsiteY5" fmla="*/ 1560352 h 1770602"/>
                <a:gd name="connsiteX6" fmla="*/ 49286 w 611374"/>
                <a:gd name="connsiteY6" fmla="*/ 1719743 h 1770602"/>
                <a:gd name="connsiteX7" fmla="*/ 7341 w 611374"/>
                <a:gd name="connsiteY7" fmla="*/ 788565 h 1770602"/>
                <a:gd name="connsiteX8" fmla="*/ 24119 w 611374"/>
                <a:gd name="connsiteY8" fmla="*/ 671119 h 1770602"/>
                <a:gd name="connsiteX9" fmla="*/ 233844 w 611374"/>
                <a:gd name="connsiteY9" fmla="*/ 486562 h 1770602"/>
                <a:gd name="connsiteX10" fmla="*/ 292567 w 611374"/>
                <a:gd name="connsiteY10" fmla="*/ 167780 h 1770602"/>
                <a:gd name="connsiteX11" fmla="*/ 166732 w 611374"/>
                <a:gd name="connsiteY11" fmla="*/ 16778 h 1770602"/>
                <a:gd name="connsiteX0" fmla="*/ 99620 w 619760"/>
                <a:gd name="connsiteY0" fmla="*/ 0 h 1770602"/>
                <a:gd name="connsiteX1" fmla="*/ 485514 w 619760"/>
                <a:gd name="connsiteY1" fmla="*/ 83890 h 1770602"/>
                <a:gd name="connsiteX2" fmla="*/ 619738 w 619760"/>
                <a:gd name="connsiteY2" fmla="*/ 411061 h 1770602"/>
                <a:gd name="connsiteX3" fmla="*/ 493903 w 619760"/>
                <a:gd name="connsiteY3" fmla="*/ 704675 h 1770602"/>
                <a:gd name="connsiteX4" fmla="*/ 233844 w 619760"/>
                <a:gd name="connsiteY4" fmla="*/ 822121 h 1770602"/>
                <a:gd name="connsiteX5" fmla="*/ 233844 w 619760"/>
                <a:gd name="connsiteY5" fmla="*/ 1560352 h 1770602"/>
                <a:gd name="connsiteX6" fmla="*/ 49286 w 619760"/>
                <a:gd name="connsiteY6" fmla="*/ 1719743 h 1770602"/>
                <a:gd name="connsiteX7" fmla="*/ 7341 w 619760"/>
                <a:gd name="connsiteY7" fmla="*/ 788565 h 1770602"/>
                <a:gd name="connsiteX8" fmla="*/ 24119 w 619760"/>
                <a:gd name="connsiteY8" fmla="*/ 671119 h 1770602"/>
                <a:gd name="connsiteX9" fmla="*/ 233844 w 619760"/>
                <a:gd name="connsiteY9" fmla="*/ 486562 h 1770602"/>
                <a:gd name="connsiteX10" fmla="*/ 292567 w 619760"/>
                <a:gd name="connsiteY10" fmla="*/ 167780 h 1770602"/>
                <a:gd name="connsiteX11" fmla="*/ 166732 w 619760"/>
                <a:gd name="connsiteY11" fmla="*/ 16778 h 1770602"/>
                <a:gd name="connsiteX0" fmla="*/ 99620 w 619760"/>
                <a:gd name="connsiteY0" fmla="*/ 0 h 1770602"/>
                <a:gd name="connsiteX1" fmla="*/ 485514 w 619760"/>
                <a:gd name="connsiteY1" fmla="*/ 83890 h 1770602"/>
                <a:gd name="connsiteX2" fmla="*/ 619738 w 619760"/>
                <a:gd name="connsiteY2" fmla="*/ 411061 h 1770602"/>
                <a:gd name="connsiteX3" fmla="*/ 493903 w 619760"/>
                <a:gd name="connsiteY3" fmla="*/ 704675 h 1770602"/>
                <a:gd name="connsiteX4" fmla="*/ 233844 w 619760"/>
                <a:gd name="connsiteY4" fmla="*/ 822121 h 1770602"/>
                <a:gd name="connsiteX5" fmla="*/ 233844 w 619760"/>
                <a:gd name="connsiteY5" fmla="*/ 1560352 h 1770602"/>
                <a:gd name="connsiteX6" fmla="*/ 49286 w 619760"/>
                <a:gd name="connsiteY6" fmla="*/ 1719743 h 1770602"/>
                <a:gd name="connsiteX7" fmla="*/ 7341 w 619760"/>
                <a:gd name="connsiteY7" fmla="*/ 788565 h 1770602"/>
                <a:gd name="connsiteX8" fmla="*/ 24119 w 619760"/>
                <a:gd name="connsiteY8" fmla="*/ 671119 h 1770602"/>
                <a:gd name="connsiteX9" fmla="*/ 233844 w 619760"/>
                <a:gd name="connsiteY9" fmla="*/ 486562 h 1770602"/>
                <a:gd name="connsiteX10" fmla="*/ 292567 w 619760"/>
                <a:gd name="connsiteY10" fmla="*/ 167780 h 1770602"/>
                <a:gd name="connsiteX11" fmla="*/ 116398 w 619760"/>
                <a:gd name="connsiteY11" fmla="*/ 0 h 17706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619760" h="1770602">
                  <a:moveTo>
                    <a:pt x="99620" y="0"/>
                  </a:moveTo>
                  <a:cubicBezTo>
                    <a:pt x="251321" y="2097"/>
                    <a:pt x="398828" y="15380"/>
                    <a:pt x="485514" y="83890"/>
                  </a:cubicBezTo>
                  <a:cubicBezTo>
                    <a:pt x="572200" y="152400"/>
                    <a:pt x="618340" y="307597"/>
                    <a:pt x="619738" y="411061"/>
                  </a:cubicBezTo>
                  <a:cubicBezTo>
                    <a:pt x="621136" y="514525"/>
                    <a:pt x="558219" y="636165"/>
                    <a:pt x="493903" y="704675"/>
                  </a:cubicBezTo>
                  <a:cubicBezTo>
                    <a:pt x="429587" y="773185"/>
                    <a:pt x="277187" y="679508"/>
                    <a:pt x="233844" y="822121"/>
                  </a:cubicBezTo>
                  <a:cubicBezTo>
                    <a:pt x="190501" y="964734"/>
                    <a:pt x="264604" y="1410748"/>
                    <a:pt x="233844" y="1560352"/>
                  </a:cubicBezTo>
                  <a:cubicBezTo>
                    <a:pt x="203084" y="1709956"/>
                    <a:pt x="87036" y="1848374"/>
                    <a:pt x="49286" y="1719743"/>
                  </a:cubicBezTo>
                  <a:cubicBezTo>
                    <a:pt x="11536" y="1591112"/>
                    <a:pt x="11536" y="963336"/>
                    <a:pt x="7341" y="788565"/>
                  </a:cubicBezTo>
                  <a:cubicBezTo>
                    <a:pt x="3146" y="613794"/>
                    <a:pt x="-13632" y="721453"/>
                    <a:pt x="24119" y="671119"/>
                  </a:cubicBezTo>
                  <a:cubicBezTo>
                    <a:pt x="61870" y="620785"/>
                    <a:pt x="189103" y="570452"/>
                    <a:pt x="233844" y="486562"/>
                  </a:cubicBezTo>
                  <a:cubicBezTo>
                    <a:pt x="278585" y="402672"/>
                    <a:pt x="312141" y="248874"/>
                    <a:pt x="292567" y="167780"/>
                  </a:cubicBezTo>
                  <a:cubicBezTo>
                    <a:pt x="272993" y="86686"/>
                    <a:pt x="167431" y="27264"/>
                    <a:pt x="116398" y="0"/>
                  </a:cubicBezTo>
                </a:path>
              </a:pathLst>
            </a:custGeom>
            <a:grpFill/>
            <a:ln w="6350" cap="flat" cmpd="sng" algn="ctr">
              <a:solidFill>
                <a:schemeClr val="accent6">
                  <a:lumMod val="75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685800" latinLnBrk="0">
                <a:defRPr/>
              </a:pPr>
              <a:endParaRPr lang="ko-KR" altLang="en-US" sz="1200" kern="0">
                <a:solidFill>
                  <a:prstClr val="white"/>
                </a:solidFill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41" name="자유형 140"/>
            <p:cNvSpPr/>
            <p:nvPr/>
          </p:nvSpPr>
          <p:spPr>
            <a:xfrm rot="215227">
              <a:off x="2345080" y="5697003"/>
              <a:ext cx="242234" cy="586876"/>
            </a:xfrm>
            <a:custGeom>
              <a:avLst/>
              <a:gdLst>
                <a:gd name="connsiteX0" fmla="*/ 93845 w 591932"/>
                <a:gd name="connsiteY0" fmla="*/ 0 h 1770602"/>
                <a:gd name="connsiteX1" fmla="*/ 479739 w 591932"/>
                <a:gd name="connsiteY1" fmla="*/ 83890 h 1770602"/>
                <a:gd name="connsiteX2" fmla="*/ 588796 w 591932"/>
                <a:gd name="connsiteY2" fmla="*/ 478173 h 1770602"/>
                <a:gd name="connsiteX3" fmla="*/ 387460 w 591932"/>
                <a:gd name="connsiteY3" fmla="*/ 746620 h 1770602"/>
                <a:gd name="connsiteX4" fmla="*/ 228069 w 591932"/>
                <a:gd name="connsiteY4" fmla="*/ 822121 h 1770602"/>
                <a:gd name="connsiteX5" fmla="*/ 228069 w 591932"/>
                <a:gd name="connsiteY5" fmla="*/ 1560352 h 1770602"/>
                <a:gd name="connsiteX6" fmla="*/ 43511 w 591932"/>
                <a:gd name="connsiteY6" fmla="*/ 1719743 h 1770602"/>
                <a:gd name="connsiteX7" fmla="*/ 1566 w 591932"/>
                <a:gd name="connsiteY7" fmla="*/ 788565 h 1770602"/>
                <a:gd name="connsiteX8" fmla="*/ 35122 w 591932"/>
                <a:gd name="connsiteY8" fmla="*/ 696286 h 1770602"/>
                <a:gd name="connsiteX9" fmla="*/ 261625 w 591932"/>
                <a:gd name="connsiteY9" fmla="*/ 553673 h 1770602"/>
                <a:gd name="connsiteX10" fmla="*/ 286792 w 591932"/>
                <a:gd name="connsiteY10" fmla="*/ 167780 h 1770602"/>
                <a:gd name="connsiteX11" fmla="*/ 169346 w 591932"/>
                <a:gd name="connsiteY11" fmla="*/ 25167 h 1770602"/>
                <a:gd name="connsiteX0" fmla="*/ 93845 w 591932"/>
                <a:gd name="connsiteY0" fmla="*/ 0 h 1770602"/>
                <a:gd name="connsiteX1" fmla="*/ 479739 w 591932"/>
                <a:gd name="connsiteY1" fmla="*/ 83890 h 1770602"/>
                <a:gd name="connsiteX2" fmla="*/ 588796 w 591932"/>
                <a:gd name="connsiteY2" fmla="*/ 478173 h 1770602"/>
                <a:gd name="connsiteX3" fmla="*/ 387460 w 591932"/>
                <a:gd name="connsiteY3" fmla="*/ 746620 h 1770602"/>
                <a:gd name="connsiteX4" fmla="*/ 228069 w 591932"/>
                <a:gd name="connsiteY4" fmla="*/ 822121 h 1770602"/>
                <a:gd name="connsiteX5" fmla="*/ 228069 w 591932"/>
                <a:gd name="connsiteY5" fmla="*/ 1560352 h 1770602"/>
                <a:gd name="connsiteX6" fmla="*/ 43511 w 591932"/>
                <a:gd name="connsiteY6" fmla="*/ 1719743 h 1770602"/>
                <a:gd name="connsiteX7" fmla="*/ 1566 w 591932"/>
                <a:gd name="connsiteY7" fmla="*/ 788565 h 1770602"/>
                <a:gd name="connsiteX8" fmla="*/ 35122 w 591932"/>
                <a:gd name="connsiteY8" fmla="*/ 696286 h 1770602"/>
                <a:gd name="connsiteX9" fmla="*/ 261625 w 591932"/>
                <a:gd name="connsiteY9" fmla="*/ 553673 h 1770602"/>
                <a:gd name="connsiteX10" fmla="*/ 286792 w 591932"/>
                <a:gd name="connsiteY10" fmla="*/ 167780 h 1770602"/>
                <a:gd name="connsiteX11" fmla="*/ 160957 w 591932"/>
                <a:gd name="connsiteY11" fmla="*/ 16778 h 1770602"/>
                <a:gd name="connsiteX0" fmla="*/ 101776 w 599863"/>
                <a:gd name="connsiteY0" fmla="*/ 0 h 1770602"/>
                <a:gd name="connsiteX1" fmla="*/ 487670 w 599863"/>
                <a:gd name="connsiteY1" fmla="*/ 83890 h 1770602"/>
                <a:gd name="connsiteX2" fmla="*/ 596727 w 599863"/>
                <a:gd name="connsiteY2" fmla="*/ 478173 h 1770602"/>
                <a:gd name="connsiteX3" fmla="*/ 395391 w 599863"/>
                <a:gd name="connsiteY3" fmla="*/ 746620 h 1770602"/>
                <a:gd name="connsiteX4" fmla="*/ 236000 w 599863"/>
                <a:gd name="connsiteY4" fmla="*/ 822121 h 1770602"/>
                <a:gd name="connsiteX5" fmla="*/ 236000 w 599863"/>
                <a:gd name="connsiteY5" fmla="*/ 1560352 h 1770602"/>
                <a:gd name="connsiteX6" fmla="*/ 51442 w 599863"/>
                <a:gd name="connsiteY6" fmla="*/ 1719743 h 1770602"/>
                <a:gd name="connsiteX7" fmla="*/ 9497 w 599863"/>
                <a:gd name="connsiteY7" fmla="*/ 788565 h 1770602"/>
                <a:gd name="connsiteX8" fmla="*/ 26275 w 599863"/>
                <a:gd name="connsiteY8" fmla="*/ 671119 h 1770602"/>
                <a:gd name="connsiteX9" fmla="*/ 269556 w 599863"/>
                <a:gd name="connsiteY9" fmla="*/ 553673 h 1770602"/>
                <a:gd name="connsiteX10" fmla="*/ 294723 w 599863"/>
                <a:gd name="connsiteY10" fmla="*/ 167780 h 1770602"/>
                <a:gd name="connsiteX11" fmla="*/ 168888 w 599863"/>
                <a:gd name="connsiteY11" fmla="*/ 16778 h 1770602"/>
                <a:gd name="connsiteX0" fmla="*/ 101776 w 596760"/>
                <a:gd name="connsiteY0" fmla="*/ 0 h 1770602"/>
                <a:gd name="connsiteX1" fmla="*/ 487670 w 596760"/>
                <a:gd name="connsiteY1" fmla="*/ 83890 h 1770602"/>
                <a:gd name="connsiteX2" fmla="*/ 596727 w 596760"/>
                <a:gd name="connsiteY2" fmla="*/ 478173 h 1770602"/>
                <a:gd name="connsiteX3" fmla="*/ 496059 w 596760"/>
                <a:gd name="connsiteY3" fmla="*/ 704675 h 1770602"/>
                <a:gd name="connsiteX4" fmla="*/ 236000 w 596760"/>
                <a:gd name="connsiteY4" fmla="*/ 822121 h 1770602"/>
                <a:gd name="connsiteX5" fmla="*/ 236000 w 596760"/>
                <a:gd name="connsiteY5" fmla="*/ 1560352 h 1770602"/>
                <a:gd name="connsiteX6" fmla="*/ 51442 w 596760"/>
                <a:gd name="connsiteY6" fmla="*/ 1719743 h 1770602"/>
                <a:gd name="connsiteX7" fmla="*/ 9497 w 596760"/>
                <a:gd name="connsiteY7" fmla="*/ 788565 h 1770602"/>
                <a:gd name="connsiteX8" fmla="*/ 26275 w 596760"/>
                <a:gd name="connsiteY8" fmla="*/ 671119 h 1770602"/>
                <a:gd name="connsiteX9" fmla="*/ 269556 w 596760"/>
                <a:gd name="connsiteY9" fmla="*/ 553673 h 1770602"/>
                <a:gd name="connsiteX10" fmla="*/ 294723 w 596760"/>
                <a:gd name="connsiteY10" fmla="*/ 167780 h 1770602"/>
                <a:gd name="connsiteX11" fmla="*/ 168888 w 596760"/>
                <a:gd name="connsiteY11" fmla="*/ 16778 h 1770602"/>
                <a:gd name="connsiteX0" fmla="*/ 99620 w 594604"/>
                <a:gd name="connsiteY0" fmla="*/ 0 h 1770602"/>
                <a:gd name="connsiteX1" fmla="*/ 485514 w 594604"/>
                <a:gd name="connsiteY1" fmla="*/ 83890 h 1770602"/>
                <a:gd name="connsiteX2" fmla="*/ 594571 w 594604"/>
                <a:gd name="connsiteY2" fmla="*/ 478173 h 1770602"/>
                <a:gd name="connsiteX3" fmla="*/ 493903 w 594604"/>
                <a:gd name="connsiteY3" fmla="*/ 704675 h 1770602"/>
                <a:gd name="connsiteX4" fmla="*/ 233844 w 594604"/>
                <a:gd name="connsiteY4" fmla="*/ 822121 h 1770602"/>
                <a:gd name="connsiteX5" fmla="*/ 233844 w 594604"/>
                <a:gd name="connsiteY5" fmla="*/ 1560352 h 1770602"/>
                <a:gd name="connsiteX6" fmla="*/ 49286 w 594604"/>
                <a:gd name="connsiteY6" fmla="*/ 1719743 h 1770602"/>
                <a:gd name="connsiteX7" fmla="*/ 7341 w 594604"/>
                <a:gd name="connsiteY7" fmla="*/ 788565 h 1770602"/>
                <a:gd name="connsiteX8" fmla="*/ 24119 w 594604"/>
                <a:gd name="connsiteY8" fmla="*/ 671119 h 1770602"/>
                <a:gd name="connsiteX9" fmla="*/ 233844 w 594604"/>
                <a:gd name="connsiteY9" fmla="*/ 486562 h 1770602"/>
                <a:gd name="connsiteX10" fmla="*/ 292567 w 594604"/>
                <a:gd name="connsiteY10" fmla="*/ 167780 h 1770602"/>
                <a:gd name="connsiteX11" fmla="*/ 166732 w 594604"/>
                <a:gd name="connsiteY11" fmla="*/ 16778 h 1770602"/>
                <a:gd name="connsiteX0" fmla="*/ 99620 w 611374"/>
                <a:gd name="connsiteY0" fmla="*/ 0 h 1770602"/>
                <a:gd name="connsiteX1" fmla="*/ 485514 w 611374"/>
                <a:gd name="connsiteY1" fmla="*/ 83890 h 1770602"/>
                <a:gd name="connsiteX2" fmla="*/ 611349 w 611374"/>
                <a:gd name="connsiteY2" fmla="*/ 343949 h 1770602"/>
                <a:gd name="connsiteX3" fmla="*/ 493903 w 611374"/>
                <a:gd name="connsiteY3" fmla="*/ 704675 h 1770602"/>
                <a:gd name="connsiteX4" fmla="*/ 233844 w 611374"/>
                <a:gd name="connsiteY4" fmla="*/ 822121 h 1770602"/>
                <a:gd name="connsiteX5" fmla="*/ 233844 w 611374"/>
                <a:gd name="connsiteY5" fmla="*/ 1560352 h 1770602"/>
                <a:gd name="connsiteX6" fmla="*/ 49286 w 611374"/>
                <a:gd name="connsiteY6" fmla="*/ 1719743 h 1770602"/>
                <a:gd name="connsiteX7" fmla="*/ 7341 w 611374"/>
                <a:gd name="connsiteY7" fmla="*/ 788565 h 1770602"/>
                <a:gd name="connsiteX8" fmla="*/ 24119 w 611374"/>
                <a:gd name="connsiteY8" fmla="*/ 671119 h 1770602"/>
                <a:gd name="connsiteX9" fmla="*/ 233844 w 611374"/>
                <a:gd name="connsiteY9" fmla="*/ 486562 h 1770602"/>
                <a:gd name="connsiteX10" fmla="*/ 292567 w 611374"/>
                <a:gd name="connsiteY10" fmla="*/ 167780 h 1770602"/>
                <a:gd name="connsiteX11" fmla="*/ 166732 w 611374"/>
                <a:gd name="connsiteY11" fmla="*/ 16778 h 1770602"/>
                <a:gd name="connsiteX0" fmla="*/ 99620 w 619760"/>
                <a:gd name="connsiteY0" fmla="*/ 0 h 1770602"/>
                <a:gd name="connsiteX1" fmla="*/ 485514 w 619760"/>
                <a:gd name="connsiteY1" fmla="*/ 83890 h 1770602"/>
                <a:gd name="connsiteX2" fmla="*/ 619738 w 619760"/>
                <a:gd name="connsiteY2" fmla="*/ 411061 h 1770602"/>
                <a:gd name="connsiteX3" fmla="*/ 493903 w 619760"/>
                <a:gd name="connsiteY3" fmla="*/ 704675 h 1770602"/>
                <a:gd name="connsiteX4" fmla="*/ 233844 w 619760"/>
                <a:gd name="connsiteY4" fmla="*/ 822121 h 1770602"/>
                <a:gd name="connsiteX5" fmla="*/ 233844 w 619760"/>
                <a:gd name="connsiteY5" fmla="*/ 1560352 h 1770602"/>
                <a:gd name="connsiteX6" fmla="*/ 49286 w 619760"/>
                <a:gd name="connsiteY6" fmla="*/ 1719743 h 1770602"/>
                <a:gd name="connsiteX7" fmla="*/ 7341 w 619760"/>
                <a:gd name="connsiteY7" fmla="*/ 788565 h 1770602"/>
                <a:gd name="connsiteX8" fmla="*/ 24119 w 619760"/>
                <a:gd name="connsiteY8" fmla="*/ 671119 h 1770602"/>
                <a:gd name="connsiteX9" fmla="*/ 233844 w 619760"/>
                <a:gd name="connsiteY9" fmla="*/ 486562 h 1770602"/>
                <a:gd name="connsiteX10" fmla="*/ 292567 w 619760"/>
                <a:gd name="connsiteY10" fmla="*/ 167780 h 1770602"/>
                <a:gd name="connsiteX11" fmla="*/ 166732 w 619760"/>
                <a:gd name="connsiteY11" fmla="*/ 16778 h 1770602"/>
                <a:gd name="connsiteX0" fmla="*/ 99620 w 619760"/>
                <a:gd name="connsiteY0" fmla="*/ 0 h 1770602"/>
                <a:gd name="connsiteX1" fmla="*/ 485514 w 619760"/>
                <a:gd name="connsiteY1" fmla="*/ 83890 h 1770602"/>
                <a:gd name="connsiteX2" fmla="*/ 619738 w 619760"/>
                <a:gd name="connsiteY2" fmla="*/ 411061 h 1770602"/>
                <a:gd name="connsiteX3" fmla="*/ 493903 w 619760"/>
                <a:gd name="connsiteY3" fmla="*/ 704675 h 1770602"/>
                <a:gd name="connsiteX4" fmla="*/ 233844 w 619760"/>
                <a:gd name="connsiteY4" fmla="*/ 822121 h 1770602"/>
                <a:gd name="connsiteX5" fmla="*/ 233844 w 619760"/>
                <a:gd name="connsiteY5" fmla="*/ 1560352 h 1770602"/>
                <a:gd name="connsiteX6" fmla="*/ 49286 w 619760"/>
                <a:gd name="connsiteY6" fmla="*/ 1719743 h 1770602"/>
                <a:gd name="connsiteX7" fmla="*/ 7341 w 619760"/>
                <a:gd name="connsiteY7" fmla="*/ 788565 h 1770602"/>
                <a:gd name="connsiteX8" fmla="*/ 24119 w 619760"/>
                <a:gd name="connsiteY8" fmla="*/ 671119 h 1770602"/>
                <a:gd name="connsiteX9" fmla="*/ 233844 w 619760"/>
                <a:gd name="connsiteY9" fmla="*/ 486562 h 1770602"/>
                <a:gd name="connsiteX10" fmla="*/ 292567 w 619760"/>
                <a:gd name="connsiteY10" fmla="*/ 167780 h 1770602"/>
                <a:gd name="connsiteX11" fmla="*/ 116398 w 619760"/>
                <a:gd name="connsiteY11" fmla="*/ 0 h 17706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619760" h="1770602">
                  <a:moveTo>
                    <a:pt x="99620" y="0"/>
                  </a:moveTo>
                  <a:cubicBezTo>
                    <a:pt x="251321" y="2097"/>
                    <a:pt x="398828" y="15380"/>
                    <a:pt x="485514" y="83890"/>
                  </a:cubicBezTo>
                  <a:cubicBezTo>
                    <a:pt x="572200" y="152400"/>
                    <a:pt x="618340" y="307597"/>
                    <a:pt x="619738" y="411061"/>
                  </a:cubicBezTo>
                  <a:cubicBezTo>
                    <a:pt x="621136" y="514525"/>
                    <a:pt x="558219" y="636165"/>
                    <a:pt x="493903" y="704675"/>
                  </a:cubicBezTo>
                  <a:cubicBezTo>
                    <a:pt x="429587" y="773185"/>
                    <a:pt x="277187" y="679508"/>
                    <a:pt x="233844" y="822121"/>
                  </a:cubicBezTo>
                  <a:cubicBezTo>
                    <a:pt x="190501" y="964734"/>
                    <a:pt x="264604" y="1410748"/>
                    <a:pt x="233844" y="1560352"/>
                  </a:cubicBezTo>
                  <a:cubicBezTo>
                    <a:pt x="203084" y="1709956"/>
                    <a:pt x="87036" y="1848374"/>
                    <a:pt x="49286" y="1719743"/>
                  </a:cubicBezTo>
                  <a:cubicBezTo>
                    <a:pt x="11536" y="1591112"/>
                    <a:pt x="11536" y="963336"/>
                    <a:pt x="7341" y="788565"/>
                  </a:cubicBezTo>
                  <a:cubicBezTo>
                    <a:pt x="3146" y="613794"/>
                    <a:pt x="-13632" y="721453"/>
                    <a:pt x="24119" y="671119"/>
                  </a:cubicBezTo>
                  <a:cubicBezTo>
                    <a:pt x="61870" y="620785"/>
                    <a:pt x="189103" y="570452"/>
                    <a:pt x="233844" y="486562"/>
                  </a:cubicBezTo>
                  <a:cubicBezTo>
                    <a:pt x="278585" y="402672"/>
                    <a:pt x="312141" y="248874"/>
                    <a:pt x="292567" y="167780"/>
                  </a:cubicBezTo>
                  <a:cubicBezTo>
                    <a:pt x="272993" y="86686"/>
                    <a:pt x="167431" y="27264"/>
                    <a:pt x="116398" y="0"/>
                  </a:cubicBezTo>
                </a:path>
              </a:pathLst>
            </a:custGeom>
            <a:grpFill/>
            <a:ln w="6350" cap="flat" cmpd="sng" algn="ctr">
              <a:solidFill>
                <a:schemeClr val="accent6">
                  <a:lumMod val="75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685800" latinLnBrk="0">
                <a:defRPr/>
              </a:pPr>
              <a:endParaRPr lang="ko-KR" altLang="en-US" sz="1200" kern="0">
                <a:solidFill>
                  <a:prstClr val="white"/>
                </a:solidFill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</p:grpSp>
      <p:grpSp>
        <p:nvGrpSpPr>
          <p:cNvPr id="1035" name="그룹 1034"/>
          <p:cNvGrpSpPr/>
          <p:nvPr/>
        </p:nvGrpSpPr>
        <p:grpSpPr>
          <a:xfrm>
            <a:off x="1755594" y="2574756"/>
            <a:ext cx="402961" cy="316791"/>
            <a:chOff x="1755594" y="2574756"/>
            <a:chExt cx="402961" cy="316791"/>
          </a:xfrm>
        </p:grpSpPr>
        <p:sp>
          <p:nvSpPr>
            <p:cNvPr id="167" name="모서리가 둥근 직사각형 2"/>
            <p:cNvSpPr>
              <a:spLocks/>
            </p:cNvSpPr>
            <p:nvPr/>
          </p:nvSpPr>
          <p:spPr>
            <a:xfrm rot="20109066">
              <a:off x="1769315" y="2640254"/>
              <a:ext cx="377532" cy="186876"/>
            </a:xfrm>
            <a:custGeom>
              <a:avLst/>
              <a:gdLst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31188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93181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163660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496514 w 2874936"/>
                <a:gd name="connsiteY5" fmla="*/ 138709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300931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308680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7749 w 2882685"/>
                <a:gd name="connsiteY0" fmla="*/ 300931 h 1394848"/>
                <a:gd name="connsiteX1" fmla="*/ 308679 w 2882685"/>
                <a:gd name="connsiteY1" fmla="*/ 1 h 1394848"/>
                <a:gd name="connsiteX2" fmla="*/ 2519761 w 2882685"/>
                <a:gd name="connsiteY2" fmla="*/ 0 h 1394848"/>
                <a:gd name="connsiteX3" fmla="*/ 2882685 w 2882685"/>
                <a:gd name="connsiteY3" fmla="*/ 262185 h 1394848"/>
                <a:gd name="connsiteX4" fmla="*/ 2874936 w 2882685"/>
                <a:gd name="connsiteY4" fmla="*/ 1078419 h 1394848"/>
                <a:gd name="connsiteX5" fmla="*/ 2558507 w 2882685"/>
                <a:gd name="connsiteY5" fmla="*/ 1394847 h 1394848"/>
                <a:gd name="connsiteX6" fmla="*/ 316429 w 2882685"/>
                <a:gd name="connsiteY6" fmla="*/ 1394848 h 1394848"/>
                <a:gd name="connsiteX7" fmla="*/ 0 w 2882685"/>
                <a:gd name="connsiteY7" fmla="*/ 1086168 h 1394848"/>
                <a:gd name="connsiteX8" fmla="*/ 7749 w 2882685"/>
                <a:gd name="connsiteY8" fmla="*/ 300931 h 13948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882685" h="1394848">
                  <a:moveTo>
                    <a:pt x="7749" y="300931"/>
                  </a:moveTo>
                  <a:cubicBezTo>
                    <a:pt x="7749" y="173249"/>
                    <a:pt x="180997" y="1"/>
                    <a:pt x="308679" y="1"/>
                  </a:cubicBezTo>
                  <a:lnTo>
                    <a:pt x="2519761" y="0"/>
                  </a:lnTo>
                  <a:cubicBezTo>
                    <a:pt x="2647443" y="0"/>
                    <a:pt x="2882685" y="134503"/>
                    <a:pt x="2882685" y="262185"/>
                  </a:cubicBezTo>
                  <a:lnTo>
                    <a:pt x="2874936" y="1078419"/>
                  </a:lnTo>
                  <a:cubicBezTo>
                    <a:pt x="2874936" y="1206101"/>
                    <a:pt x="2686189" y="1394847"/>
                    <a:pt x="2558507" y="1394847"/>
                  </a:cubicBezTo>
                  <a:lnTo>
                    <a:pt x="316429" y="1394848"/>
                  </a:lnTo>
                  <a:cubicBezTo>
                    <a:pt x="188747" y="1394848"/>
                    <a:pt x="0" y="1213850"/>
                    <a:pt x="0" y="1086168"/>
                  </a:cubicBezTo>
                  <a:lnTo>
                    <a:pt x="7749" y="300931"/>
                  </a:lnTo>
                  <a:close/>
                </a:path>
              </a:pathLst>
            </a:custGeom>
            <a:solidFill>
              <a:srgbClr val="FF7C8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68" name="모서리가 둥근 직사각형 2"/>
            <p:cNvSpPr>
              <a:spLocks/>
            </p:cNvSpPr>
            <p:nvPr/>
          </p:nvSpPr>
          <p:spPr>
            <a:xfrm rot="20109066">
              <a:off x="1777896" y="2644969"/>
              <a:ext cx="360372" cy="177446"/>
            </a:xfrm>
            <a:custGeom>
              <a:avLst/>
              <a:gdLst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31188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93181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163660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496514 w 2874936"/>
                <a:gd name="connsiteY5" fmla="*/ 138709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300931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308680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7749 w 2882685"/>
                <a:gd name="connsiteY0" fmla="*/ 300931 h 1394848"/>
                <a:gd name="connsiteX1" fmla="*/ 308679 w 2882685"/>
                <a:gd name="connsiteY1" fmla="*/ 1 h 1394848"/>
                <a:gd name="connsiteX2" fmla="*/ 2519761 w 2882685"/>
                <a:gd name="connsiteY2" fmla="*/ 0 h 1394848"/>
                <a:gd name="connsiteX3" fmla="*/ 2882685 w 2882685"/>
                <a:gd name="connsiteY3" fmla="*/ 262185 h 1394848"/>
                <a:gd name="connsiteX4" fmla="*/ 2874936 w 2882685"/>
                <a:gd name="connsiteY4" fmla="*/ 1078419 h 1394848"/>
                <a:gd name="connsiteX5" fmla="*/ 2558507 w 2882685"/>
                <a:gd name="connsiteY5" fmla="*/ 1394847 h 1394848"/>
                <a:gd name="connsiteX6" fmla="*/ 316429 w 2882685"/>
                <a:gd name="connsiteY6" fmla="*/ 1394848 h 1394848"/>
                <a:gd name="connsiteX7" fmla="*/ 0 w 2882685"/>
                <a:gd name="connsiteY7" fmla="*/ 1086168 h 1394848"/>
                <a:gd name="connsiteX8" fmla="*/ 7749 w 2882685"/>
                <a:gd name="connsiteY8" fmla="*/ 300931 h 13948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882685" h="1394848">
                  <a:moveTo>
                    <a:pt x="7749" y="300931"/>
                  </a:moveTo>
                  <a:cubicBezTo>
                    <a:pt x="7749" y="173249"/>
                    <a:pt x="180997" y="1"/>
                    <a:pt x="308679" y="1"/>
                  </a:cubicBezTo>
                  <a:lnTo>
                    <a:pt x="2519761" y="0"/>
                  </a:lnTo>
                  <a:cubicBezTo>
                    <a:pt x="2647443" y="0"/>
                    <a:pt x="2882685" y="134503"/>
                    <a:pt x="2882685" y="262185"/>
                  </a:cubicBezTo>
                  <a:lnTo>
                    <a:pt x="2874936" y="1078419"/>
                  </a:lnTo>
                  <a:cubicBezTo>
                    <a:pt x="2874936" y="1206101"/>
                    <a:pt x="2686189" y="1394847"/>
                    <a:pt x="2558507" y="1394847"/>
                  </a:cubicBezTo>
                  <a:lnTo>
                    <a:pt x="316429" y="1394848"/>
                  </a:lnTo>
                  <a:cubicBezTo>
                    <a:pt x="188747" y="1394848"/>
                    <a:pt x="0" y="1213850"/>
                    <a:pt x="0" y="1086168"/>
                  </a:cubicBezTo>
                  <a:lnTo>
                    <a:pt x="7749" y="300931"/>
                  </a:lnTo>
                  <a:close/>
                </a:path>
              </a:pathLst>
            </a:custGeom>
            <a:solidFill>
              <a:srgbClr val="FF99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69" name="모서리가 둥근 직사각형 2"/>
            <p:cNvSpPr/>
            <p:nvPr/>
          </p:nvSpPr>
          <p:spPr>
            <a:xfrm rot="20109066">
              <a:off x="1786476" y="2650657"/>
              <a:ext cx="343211" cy="166070"/>
            </a:xfrm>
            <a:custGeom>
              <a:avLst/>
              <a:gdLst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31188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1188 h 1387098"/>
                <a:gd name="connsiteX1" fmla="*/ 231188 w 2874936"/>
                <a:gd name="connsiteY1" fmla="*/ 0 h 1387098"/>
                <a:gd name="connsiteX2" fmla="*/ 2643748 w 2874936"/>
                <a:gd name="connsiteY2" fmla="*/ 0 h 1387098"/>
                <a:gd name="connsiteX3" fmla="*/ 2874936 w 2874936"/>
                <a:gd name="connsiteY3" fmla="*/ 293181 h 1387098"/>
                <a:gd name="connsiteX4" fmla="*/ 2874936 w 2874936"/>
                <a:gd name="connsiteY4" fmla="*/ 1155910 h 1387098"/>
                <a:gd name="connsiteX5" fmla="*/ 2643748 w 2874936"/>
                <a:gd name="connsiteY5" fmla="*/ 1387098 h 1387098"/>
                <a:gd name="connsiteX6" fmla="*/ 231188 w 2874936"/>
                <a:gd name="connsiteY6" fmla="*/ 1387098 h 1387098"/>
                <a:gd name="connsiteX7" fmla="*/ 0 w 2874936"/>
                <a:gd name="connsiteY7" fmla="*/ 1155910 h 1387098"/>
                <a:gd name="connsiteX8" fmla="*/ 0 w 2874936"/>
                <a:gd name="connsiteY8" fmla="*/ 231188 h 138709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163660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643748 w 2874936"/>
                <a:gd name="connsiteY5" fmla="*/ 139484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496514 w 2874936"/>
                <a:gd name="connsiteY5" fmla="*/ 1387098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74936 w 2874936"/>
                <a:gd name="connsiteY4" fmla="*/ 1055172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300931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238938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238938 h 1394848"/>
                <a:gd name="connsiteX0" fmla="*/ 0 w 2874936"/>
                <a:gd name="connsiteY0" fmla="*/ 300931 h 1394848"/>
                <a:gd name="connsiteX1" fmla="*/ 231188 w 2874936"/>
                <a:gd name="connsiteY1" fmla="*/ 7750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231188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0 w 2874936"/>
                <a:gd name="connsiteY0" fmla="*/ 300931 h 1394848"/>
                <a:gd name="connsiteX1" fmla="*/ 300930 w 2874936"/>
                <a:gd name="connsiteY1" fmla="*/ 1 h 1394848"/>
                <a:gd name="connsiteX2" fmla="*/ 2512012 w 2874936"/>
                <a:gd name="connsiteY2" fmla="*/ 0 h 1394848"/>
                <a:gd name="connsiteX3" fmla="*/ 2874936 w 2874936"/>
                <a:gd name="connsiteY3" fmla="*/ 262185 h 1394848"/>
                <a:gd name="connsiteX4" fmla="*/ 2867187 w 2874936"/>
                <a:gd name="connsiteY4" fmla="*/ 1078419 h 1394848"/>
                <a:gd name="connsiteX5" fmla="*/ 2550758 w 2874936"/>
                <a:gd name="connsiteY5" fmla="*/ 1394847 h 1394848"/>
                <a:gd name="connsiteX6" fmla="*/ 308680 w 2874936"/>
                <a:gd name="connsiteY6" fmla="*/ 1394848 h 1394848"/>
                <a:gd name="connsiteX7" fmla="*/ 0 w 2874936"/>
                <a:gd name="connsiteY7" fmla="*/ 1163660 h 1394848"/>
                <a:gd name="connsiteX8" fmla="*/ 0 w 2874936"/>
                <a:gd name="connsiteY8" fmla="*/ 300931 h 1394848"/>
                <a:gd name="connsiteX0" fmla="*/ 7749 w 2882685"/>
                <a:gd name="connsiteY0" fmla="*/ 300931 h 1394848"/>
                <a:gd name="connsiteX1" fmla="*/ 308679 w 2882685"/>
                <a:gd name="connsiteY1" fmla="*/ 1 h 1394848"/>
                <a:gd name="connsiteX2" fmla="*/ 2519761 w 2882685"/>
                <a:gd name="connsiteY2" fmla="*/ 0 h 1394848"/>
                <a:gd name="connsiteX3" fmla="*/ 2882685 w 2882685"/>
                <a:gd name="connsiteY3" fmla="*/ 262185 h 1394848"/>
                <a:gd name="connsiteX4" fmla="*/ 2874936 w 2882685"/>
                <a:gd name="connsiteY4" fmla="*/ 1078419 h 1394848"/>
                <a:gd name="connsiteX5" fmla="*/ 2558507 w 2882685"/>
                <a:gd name="connsiteY5" fmla="*/ 1394847 h 1394848"/>
                <a:gd name="connsiteX6" fmla="*/ 316429 w 2882685"/>
                <a:gd name="connsiteY6" fmla="*/ 1394848 h 1394848"/>
                <a:gd name="connsiteX7" fmla="*/ 0 w 2882685"/>
                <a:gd name="connsiteY7" fmla="*/ 1086168 h 1394848"/>
                <a:gd name="connsiteX8" fmla="*/ 7749 w 2882685"/>
                <a:gd name="connsiteY8" fmla="*/ 300931 h 13948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882685" h="1394848">
                  <a:moveTo>
                    <a:pt x="7749" y="300931"/>
                  </a:moveTo>
                  <a:cubicBezTo>
                    <a:pt x="7749" y="173249"/>
                    <a:pt x="180997" y="1"/>
                    <a:pt x="308679" y="1"/>
                  </a:cubicBezTo>
                  <a:lnTo>
                    <a:pt x="2519761" y="0"/>
                  </a:lnTo>
                  <a:cubicBezTo>
                    <a:pt x="2647443" y="0"/>
                    <a:pt x="2882685" y="134503"/>
                    <a:pt x="2882685" y="262185"/>
                  </a:cubicBezTo>
                  <a:lnTo>
                    <a:pt x="2874936" y="1078419"/>
                  </a:lnTo>
                  <a:cubicBezTo>
                    <a:pt x="2874936" y="1206101"/>
                    <a:pt x="2686189" y="1394847"/>
                    <a:pt x="2558507" y="1394847"/>
                  </a:cubicBezTo>
                  <a:lnTo>
                    <a:pt x="316429" y="1394848"/>
                  </a:lnTo>
                  <a:cubicBezTo>
                    <a:pt x="188747" y="1394848"/>
                    <a:pt x="0" y="1213850"/>
                    <a:pt x="0" y="1086168"/>
                  </a:cubicBezTo>
                  <a:lnTo>
                    <a:pt x="7749" y="300931"/>
                  </a:lnTo>
                  <a:close/>
                </a:path>
              </a:pathLst>
            </a:custGeom>
            <a:solidFill>
              <a:srgbClr val="FFCCC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70" name="자유형 169"/>
            <p:cNvSpPr/>
            <p:nvPr/>
          </p:nvSpPr>
          <p:spPr>
            <a:xfrm rot="20109066">
              <a:off x="1804632" y="2675557"/>
              <a:ext cx="303744" cy="115852"/>
            </a:xfrm>
            <a:custGeom>
              <a:avLst/>
              <a:gdLst>
                <a:gd name="connsiteX0" fmla="*/ 1523829 w 2573771"/>
                <a:gd name="connsiteY0" fmla="*/ 127016 h 958742"/>
                <a:gd name="connsiteX1" fmla="*/ 1275473 w 2573771"/>
                <a:gd name="connsiteY1" fmla="*/ 194749 h 958742"/>
                <a:gd name="connsiteX2" fmla="*/ 1060984 w 2573771"/>
                <a:gd name="connsiteY2" fmla="*/ 149593 h 958742"/>
                <a:gd name="connsiteX3" fmla="*/ 620718 w 2573771"/>
                <a:gd name="connsiteY3" fmla="*/ 2838 h 958742"/>
                <a:gd name="connsiteX4" fmla="*/ 112718 w 2573771"/>
                <a:gd name="connsiteY4" fmla="*/ 183460 h 958742"/>
                <a:gd name="connsiteX5" fmla="*/ 11118 w 2573771"/>
                <a:gd name="connsiteY5" fmla="*/ 623727 h 958742"/>
                <a:gd name="connsiteX6" fmla="*/ 293340 w 2573771"/>
                <a:gd name="connsiteY6" fmla="*/ 928527 h 958742"/>
                <a:gd name="connsiteX7" fmla="*/ 790051 w 2573771"/>
                <a:gd name="connsiteY7" fmla="*/ 928527 h 958742"/>
                <a:gd name="connsiteX8" fmla="*/ 1185162 w 2573771"/>
                <a:gd name="connsiteY8" fmla="*/ 759193 h 958742"/>
                <a:gd name="connsiteX9" fmla="*/ 1444806 w 2573771"/>
                <a:gd name="connsiteY9" fmla="*/ 759193 h 958742"/>
                <a:gd name="connsiteX10" fmla="*/ 1738318 w 2573771"/>
                <a:gd name="connsiteY10" fmla="*/ 928527 h 958742"/>
                <a:gd name="connsiteX11" fmla="*/ 2302762 w 2573771"/>
                <a:gd name="connsiteY11" fmla="*/ 883371 h 958742"/>
                <a:gd name="connsiteX12" fmla="*/ 2573695 w 2573771"/>
                <a:gd name="connsiteY12" fmla="*/ 454393 h 958742"/>
                <a:gd name="connsiteX13" fmla="*/ 2280184 w 2573771"/>
                <a:gd name="connsiteY13" fmla="*/ 47993 h 958742"/>
                <a:gd name="connsiteX14" fmla="*/ 1738318 w 2573771"/>
                <a:gd name="connsiteY14" fmla="*/ 14127 h 958742"/>
                <a:gd name="connsiteX15" fmla="*/ 1523829 w 2573771"/>
                <a:gd name="connsiteY15" fmla="*/ 127016 h 958742"/>
                <a:gd name="connsiteX0" fmla="*/ 1523829 w 2573771"/>
                <a:gd name="connsiteY0" fmla="*/ 141331 h 973057"/>
                <a:gd name="connsiteX1" fmla="*/ 1275473 w 2573771"/>
                <a:gd name="connsiteY1" fmla="*/ 209064 h 973057"/>
                <a:gd name="connsiteX2" fmla="*/ 1060984 w 2573771"/>
                <a:gd name="connsiteY2" fmla="*/ 163908 h 973057"/>
                <a:gd name="connsiteX3" fmla="*/ 620718 w 2573771"/>
                <a:gd name="connsiteY3" fmla="*/ 17153 h 973057"/>
                <a:gd name="connsiteX4" fmla="*/ 112718 w 2573771"/>
                <a:gd name="connsiteY4" fmla="*/ 197775 h 973057"/>
                <a:gd name="connsiteX5" fmla="*/ 11118 w 2573771"/>
                <a:gd name="connsiteY5" fmla="*/ 638042 h 973057"/>
                <a:gd name="connsiteX6" fmla="*/ 293340 w 2573771"/>
                <a:gd name="connsiteY6" fmla="*/ 942842 h 973057"/>
                <a:gd name="connsiteX7" fmla="*/ 790051 w 2573771"/>
                <a:gd name="connsiteY7" fmla="*/ 942842 h 973057"/>
                <a:gd name="connsiteX8" fmla="*/ 1185162 w 2573771"/>
                <a:gd name="connsiteY8" fmla="*/ 773508 h 973057"/>
                <a:gd name="connsiteX9" fmla="*/ 1444806 w 2573771"/>
                <a:gd name="connsiteY9" fmla="*/ 773508 h 973057"/>
                <a:gd name="connsiteX10" fmla="*/ 1738318 w 2573771"/>
                <a:gd name="connsiteY10" fmla="*/ 942842 h 973057"/>
                <a:gd name="connsiteX11" fmla="*/ 2302762 w 2573771"/>
                <a:gd name="connsiteY11" fmla="*/ 897686 h 973057"/>
                <a:gd name="connsiteX12" fmla="*/ 2573695 w 2573771"/>
                <a:gd name="connsiteY12" fmla="*/ 468708 h 973057"/>
                <a:gd name="connsiteX13" fmla="*/ 2280184 w 2573771"/>
                <a:gd name="connsiteY13" fmla="*/ 62308 h 973057"/>
                <a:gd name="connsiteX14" fmla="*/ 1885074 w 2573771"/>
                <a:gd name="connsiteY14" fmla="*/ 5864 h 973057"/>
                <a:gd name="connsiteX15" fmla="*/ 1523829 w 2573771"/>
                <a:gd name="connsiteY15" fmla="*/ 141331 h 973057"/>
                <a:gd name="connsiteX0" fmla="*/ 1523829 w 2573763"/>
                <a:gd name="connsiteY0" fmla="*/ 141331 h 973057"/>
                <a:gd name="connsiteX1" fmla="*/ 1275473 w 2573763"/>
                <a:gd name="connsiteY1" fmla="*/ 209064 h 973057"/>
                <a:gd name="connsiteX2" fmla="*/ 1060984 w 2573763"/>
                <a:gd name="connsiteY2" fmla="*/ 163908 h 973057"/>
                <a:gd name="connsiteX3" fmla="*/ 620718 w 2573763"/>
                <a:gd name="connsiteY3" fmla="*/ 17153 h 973057"/>
                <a:gd name="connsiteX4" fmla="*/ 112718 w 2573763"/>
                <a:gd name="connsiteY4" fmla="*/ 197775 h 973057"/>
                <a:gd name="connsiteX5" fmla="*/ 11118 w 2573763"/>
                <a:gd name="connsiteY5" fmla="*/ 638042 h 973057"/>
                <a:gd name="connsiteX6" fmla="*/ 293340 w 2573763"/>
                <a:gd name="connsiteY6" fmla="*/ 942842 h 973057"/>
                <a:gd name="connsiteX7" fmla="*/ 790051 w 2573763"/>
                <a:gd name="connsiteY7" fmla="*/ 942842 h 973057"/>
                <a:gd name="connsiteX8" fmla="*/ 1185162 w 2573763"/>
                <a:gd name="connsiteY8" fmla="*/ 773508 h 973057"/>
                <a:gd name="connsiteX9" fmla="*/ 1444806 w 2573763"/>
                <a:gd name="connsiteY9" fmla="*/ 773508 h 973057"/>
                <a:gd name="connsiteX10" fmla="*/ 1839918 w 2573763"/>
                <a:gd name="connsiteY10" fmla="*/ 942842 h 973057"/>
                <a:gd name="connsiteX11" fmla="*/ 2302762 w 2573763"/>
                <a:gd name="connsiteY11" fmla="*/ 897686 h 973057"/>
                <a:gd name="connsiteX12" fmla="*/ 2573695 w 2573763"/>
                <a:gd name="connsiteY12" fmla="*/ 468708 h 973057"/>
                <a:gd name="connsiteX13" fmla="*/ 2280184 w 2573763"/>
                <a:gd name="connsiteY13" fmla="*/ 62308 h 973057"/>
                <a:gd name="connsiteX14" fmla="*/ 1885074 w 2573763"/>
                <a:gd name="connsiteY14" fmla="*/ 5864 h 973057"/>
                <a:gd name="connsiteX15" fmla="*/ 1523829 w 2573763"/>
                <a:gd name="connsiteY15" fmla="*/ 141331 h 973057"/>
                <a:gd name="connsiteX0" fmla="*/ 1523829 w 2551194"/>
                <a:gd name="connsiteY0" fmla="*/ 141331 h 973057"/>
                <a:gd name="connsiteX1" fmla="*/ 1275473 w 2551194"/>
                <a:gd name="connsiteY1" fmla="*/ 209064 h 973057"/>
                <a:gd name="connsiteX2" fmla="*/ 1060984 w 2551194"/>
                <a:gd name="connsiteY2" fmla="*/ 163908 h 973057"/>
                <a:gd name="connsiteX3" fmla="*/ 620718 w 2551194"/>
                <a:gd name="connsiteY3" fmla="*/ 17153 h 973057"/>
                <a:gd name="connsiteX4" fmla="*/ 112718 w 2551194"/>
                <a:gd name="connsiteY4" fmla="*/ 197775 h 973057"/>
                <a:gd name="connsiteX5" fmla="*/ 11118 w 2551194"/>
                <a:gd name="connsiteY5" fmla="*/ 638042 h 973057"/>
                <a:gd name="connsiteX6" fmla="*/ 293340 w 2551194"/>
                <a:gd name="connsiteY6" fmla="*/ 942842 h 973057"/>
                <a:gd name="connsiteX7" fmla="*/ 790051 w 2551194"/>
                <a:gd name="connsiteY7" fmla="*/ 942842 h 973057"/>
                <a:gd name="connsiteX8" fmla="*/ 1185162 w 2551194"/>
                <a:gd name="connsiteY8" fmla="*/ 773508 h 973057"/>
                <a:gd name="connsiteX9" fmla="*/ 1444806 w 2551194"/>
                <a:gd name="connsiteY9" fmla="*/ 773508 h 973057"/>
                <a:gd name="connsiteX10" fmla="*/ 1839918 w 2551194"/>
                <a:gd name="connsiteY10" fmla="*/ 942842 h 973057"/>
                <a:gd name="connsiteX11" fmla="*/ 2302762 w 2551194"/>
                <a:gd name="connsiteY11" fmla="*/ 897686 h 973057"/>
                <a:gd name="connsiteX12" fmla="*/ 2551117 w 2551194"/>
                <a:gd name="connsiteY12" fmla="*/ 468708 h 973057"/>
                <a:gd name="connsiteX13" fmla="*/ 2280184 w 2551194"/>
                <a:gd name="connsiteY13" fmla="*/ 62308 h 973057"/>
                <a:gd name="connsiteX14" fmla="*/ 1885074 w 2551194"/>
                <a:gd name="connsiteY14" fmla="*/ 5864 h 973057"/>
                <a:gd name="connsiteX15" fmla="*/ 1523829 w 2551194"/>
                <a:gd name="connsiteY15" fmla="*/ 141331 h 97305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</a:cxnLst>
              <a:rect l="l" t="t" r="r" b="b"/>
              <a:pathLst>
                <a:path w="2551194" h="973057">
                  <a:moveTo>
                    <a:pt x="1523829" y="141331"/>
                  </a:moveTo>
                  <a:cubicBezTo>
                    <a:pt x="1422229" y="175198"/>
                    <a:pt x="1352614" y="205301"/>
                    <a:pt x="1275473" y="209064"/>
                  </a:cubicBezTo>
                  <a:cubicBezTo>
                    <a:pt x="1198332" y="212827"/>
                    <a:pt x="1170110" y="195893"/>
                    <a:pt x="1060984" y="163908"/>
                  </a:cubicBezTo>
                  <a:cubicBezTo>
                    <a:pt x="951858" y="131923"/>
                    <a:pt x="778762" y="11509"/>
                    <a:pt x="620718" y="17153"/>
                  </a:cubicBezTo>
                  <a:cubicBezTo>
                    <a:pt x="462674" y="22797"/>
                    <a:pt x="214318" y="94293"/>
                    <a:pt x="112718" y="197775"/>
                  </a:cubicBezTo>
                  <a:cubicBezTo>
                    <a:pt x="11118" y="301257"/>
                    <a:pt x="-18986" y="513864"/>
                    <a:pt x="11118" y="638042"/>
                  </a:cubicBezTo>
                  <a:cubicBezTo>
                    <a:pt x="41222" y="762220"/>
                    <a:pt x="163518" y="892042"/>
                    <a:pt x="293340" y="942842"/>
                  </a:cubicBezTo>
                  <a:cubicBezTo>
                    <a:pt x="423162" y="993642"/>
                    <a:pt x="641414" y="971064"/>
                    <a:pt x="790051" y="942842"/>
                  </a:cubicBezTo>
                  <a:cubicBezTo>
                    <a:pt x="938688" y="914620"/>
                    <a:pt x="1076036" y="801730"/>
                    <a:pt x="1185162" y="773508"/>
                  </a:cubicBezTo>
                  <a:cubicBezTo>
                    <a:pt x="1294288" y="745286"/>
                    <a:pt x="1335680" y="745286"/>
                    <a:pt x="1444806" y="773508"/>
                  </a:cubicBezTo>
                  <a:cubicBezTo>
                    <a:pt x="1553932" y="801730"/>
                    <a:pt x="1696925" y="922146"/>
                    <a:pt x="1839918" y="942842"/>
                  </a:cubicBezTo>
                  <a:cubicBezTo>
                    <a:pt x="1982911" y="963538"/>
                    <a:pt x="2184229" y="976708"/>
                    <a:pt x="2302762" y="897686"/>
                  </a:cubicBezTo>
                  <a:cubicBezTo>
                    <a:pt x="2421295" y="818664"/>
                    <a:pt x="2554880" y="607938"/>
                    <a:pt x="2551117" y="468708"/>
                  </a:cubicBezTo>
                  <a:cubicBezTo>
                    <a:pt x="2547354" y="329478"/>
                    <a:pt x="2419413" y="135686"/>
                    <a:pt x="2280184" y="62308"/>
                  </a:cubicBezTo>
                  <a:cubicBezTo>
                    <a:pt x="2140955" y="-11070"/>
                    <a:pt x="2011133" y="-3544"/>
                    <a:pt x="1885074" y="5864"/>
                  </a:cubicBezTo>
                  <a:cubicBezTo>
                    <a:pt x="1759015" y="15271"/>
                    <a:pt x="1625429" y="107464"/>
                    <a:pt x="1523829" y="141331"/>
                  </a:cubicBezTo>
                  <a:close/>
                </a:path>
              </a:pathLst>
            </a:custGeom>
            <a:gradFill flip="none" rotWithShape="1">
              <a:gsLst>
                <a:gs pos="0">
                  <a:schemeClr val="accent1">
                    <a:lumMod val="5000"/>
                    <a:lumOff val="95000"/>
                  </a:schemeClr>
                </a:gs>
                <a:gs pos="42000">
                  <a:srgbClr val="FF9999"/>
                </a:gs>
                <a:gs pos="92000">
                  <a:srgbClr val="FFCCCC"/>
                </a:gs>
              </a:gsLst>
              <a:path path="circle">
                <a:fillToRect r="100000" b="100000"/>
              </a:path>
              <a:tileRect l="-100000" t="-100000"/>
            </a:gradFill>
            <a:ln w="6350">
              <a:solidFill>
                <a:srgbClr val="FF7C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71" name="타원 170"/>
            <p:cNvSpPr/>
            <p:nvPr/>
          </p:nvSpPr>
          <p:spPr>
            <a:xfrm rot="20109066">
              <a:off x="1901622" y="2666725"/>
              <a:ext cx="61826" cy="30003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72" name="타원 171"/>
            <p:cNvSpPr/>
            <p:nvPr/>
          </p:nvSpPr>
          <p:spPr>
            <a:xfrm rot="20109066">
              <a:off x="1949927" y="2767835"/>
              <a:ext cx="61826" cy="30003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73" name="자유형 172"/>
            <p:cNvSpPr/>
            <p:nvPr/>
          </p:nvSpPr>
          <p:spPr>
            <a:xfrm rot="20109066">
              <a:off x="1833888" y="2687270"/>
              <a:ext cx="245186" cy="85932"/>
            </a:xfrm>
            <a:custGeom>
              <a:avLst/>
              <a:gdLst>
                <a:gd name="connsiteX0" fmla="*/ 10863 w 2059359"/>
                <a:gd name="connsiteY0" fmla="*/ 701193 h 721753"/>
                <a:gd name="connsiteX1" fmla="*/ 10863 w 2059359"/>
                <a:gd name="connsiteY1" fmla="*/ 339949 h 721753"/>
                <a:gd name="connsiteX2" fmla="*/ 123752 w 2059359"/>
                <a:gd name="connsiteY2" fmla="*/ 215771 h 721753"/>
                <a:gd name="connsiteX3" fmla="*/ 191485 w 2059359"/>
                <a:gd name="connsiteY3" fmla="*/ 328660 h 721753"/>
                <a:gd name="connsiteX4" fmla="*/ 112463 w 2059359"/>
                <a:gd name="connsiteY4" fmla="*/ 610882 h 721753"/>
                <a:gd name="connsiteX5" fmla="*/ 214063 w 2059359"/>
                <a:gd name="connsiteY5" fmla="*/ 689904 h 721753"/>
                <a:gd name="connsiteX6" fmla="*/ 270507 w 2059359"/>
                <a:gd name="connsiteY6" fmla="*/ 486704 h 721753"/>
                <a:gd name="connsiteX7" fmla="*/ 293085 w 2059359"/>
                <a:gd name="connsiteY7" fmla="*/ 80304 h 721753"/>
                <a:gd name="connsiteX8" fmla="*/ 372107 w 2059359"/>
                <a:gd name="connsiteY8" fmla="*/ 46438 h 721753"/>
                <a:gd name="connsiteX9" fmla="*/ 496285 w 2059359"/>
                <a:gd name="connsiteY9" fmla="*/ 125460 h 721753"/>
                <a:gd name="connsiteX10" fmla="*/ 405974 w 2059359"/>
                <a:gd name="connsiteY10" fmla="*/ 430260 h 721753"/>
                <a:gd name="connsiteX11" fmla="*/ 405974 w 2059359"/>
                <a:gd name="connsiteY11" fmla="*/ 610882 h 721753"/>
                <a:gd name="connsiteX12" fmla="*/ 484996 w 2059359"/>
                <a:gd name="connsiteY12" fmla="*/ 656038 h 721753"/>
                <a:gd name="connsiteX13" fmla="*/ 586596 w 2059359"/>
                <a:gd name="connsiteY13" fmla="*/ 418971 h 721753"/>
                <a:gd name="connsiteX14" fmla="*/ 597885 w 2059359"/>
                <a:gd name="connsiteY14" fmla="*/ 148038 h 721753"/>
                <a:gd name="connsiteX15" fmla="*/ 733352 w 2059359"/>
                <a:gd name="connsiteY15" fmla="*/ 227060 h 721753"/>
                <a:gd name="connsiteX16" fmla="*/ 665618 w 2059359"/>
                <a:gd name="connsiteY16" fmla="*/ 520571 h 721753"/>
                <a:gd name="connsiteX17" fmla="*/ 744641 w 2059359"/>
                <a:gd name="connsiteY17" fmla="*/ 622171 h 721753"/>
                <a:gd name="connsiteX18" fmla="*/ 812374 w 2059359"/>
                <a:gd name="connsiteY18" fmla="*/ 362527 h 721753"/>
                <a:gd name="connsiteX19" fmla="*/ 834952 w 2059359"/>
                <a:gd name="connsiteY19" fmla="*/ 181904 h 721753"/>
                <a:gd name="connsiteX20" fmla="*/ 913974 w 2059359"/>
                <a:gd name="connsiteY20" fmla="*/ 317371 h 721753"/>
                <a:gd name="connsiteX21" fmla="*/ 913974 w 2059359"/>
                <a:gd name="connsiteY21" fmla="*/ 554438 h 721753"/>
                <a:gd name="connsiteX22" fmla="*/ 981707 w 2059359"/>
                <a:gd name="connsiteY22" fmla="*/ 588304 h 721753"/>
                <a:gd name="connsiteX23" fmla="*/ 1026863 w 2059359"/>
                <a:gd name="connsiteY23" fmla="*/ 306082 h 721753"/>
                <a:gd name="connsiteX24" fmla="*/ 1151041 w 2059359"/>
                <a:gd name="connsiteY24" fmla="*/ 396393 h 721753"/>
                <a:gd name="connsiteX25" fmla="*/ 1151041 w 2059359"/>
                <a:gd name="connsiteY25" fmla="*/ 610882 h 721753"/>
                <a:gd name="connsiteX26" fmla="*/ 1320374 w 2059359"/>
                <a:gd name="connsiteY26" fmla="*/ 554438 h 721753"/>
                <a:gd name="connsiteX27" fmla="*/ 1320374 w 2059359"/>
                <a:gd name="connsiteY27" fmla="*/ 91593 h 721753"/>
                <a:gd name="connsiteX28" fmla="*/ 1421974 w 2059359"/>
                <a:gd name="connsiteY28" fmla="*/ 170616 h 721753"/>
                <a:gd name="connsiteX29" fmla="*/ 1410685 w 2059359"/>
                <a:gd name="connsiteY29" fmla="*/ 475416 h 721753"/>
                <a:gd name="connsiteX30" fmla="*/ 1444552 w 2059359"/>
                <a:gd name="connsiteY30" fmla="*/ 712482 h 721753"/>
                <a:gd name="connsiteX31" fmla="*/ 1534863 w 2059359"/>
                <a:gd name="connsiteY31" fmla="*/ 588304 h 721753"/>
                <a:gd name="connsiteX32" fmla="*/ 1489707 w 2059359"/>
                <a:gd name="connsiteY32" fmla="*/ 204482 h 721753"/>
                <a:gd name="connsiteX33" fmla="*/ 1546152 w 2059359"/>
                <a:gd name="connsiteY33" fmla="*/ 1282 h 721753"/>
                <a:gd name="connsiteX34" fmla="*/ 1659041 w 2059359"/>
                <a:gd name="connsiteY34" fmla="*/ 294793 h 721753"/>
                <a:gd name="connsiteX35" fmla="*/ 1659041 w 2059359"/>
                <a:gd name="connsiteY35" fmla="*/ 644749 h 721753"/>
                <a:gd name="connsiteX36" fmla="*/ 1817085 w 2059359"/>
                <a:gd name="connsiteY36" fmla="*/ 701193 h 721753"/>
                <a:gd name="connsiteX37" fmla="*/ 1783218 w 2059359"/>
                <a:gd name="connsiteY37" fmla="*/ 373816 h 721753"/>
                <a:gd name="connsiteX38" fmla="*/ 1771930 w 2059359"/>
                <a:gd name="connsiteY38" fmla="*/ 159327 h 721753"/>
                <a:gd name="connsiteX39" fmla="*/ 1850952 w 2059359"/>
                <a:gd name="connsiteY39" fmla="*/ 283504 h 721753"/>
                <a:gd name="connsiteX40" fmla="*/ 1941263 w 2059359"/>
                <a:gd name="connsiteY40" fmla="*/ 543149 h 721753"/>
                <a:gd name="connsiteX41" fmla="*/ 2054152 w 2059359"/>
                <a:gd name="connsiteY41" fmla="*/ 554438 h 721753"/>
                <a:gd name="connsiteX42" fmla="*/ 2031574 w 2059359"/>
                <a:gd name="connsiteY42" fmla="*/ 317371 h 721753"/>
                <a:gd name="connsiteX43" fmla="*/ 1952552 w 2059359"/>
                <a:gd name="connsiteY43" fmla="*/ 193193 h 7217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</a:cxnLst>
              <a:rect l="l" t="t" r="r" b="b"/>
              <a:pathLst>
                <a:path w="2059359" h="721753">
                  <a:moveTo>
                    <a:pt x="10863" y="701193"/>
                  </a:moveTo>
                  <a:cubicBezTo>
                    <a:pt x="1455" y="561023"/>
                    <a:pt x="-7952" y="420853"/>
                    <a:pt x="10863" y="339949"/>
                  </a:cubicBezTo>
                  <a:cubicBezTo>
                    <a:pt x="29678" y="259045"/>
                    <a:pt x="93648" y="217652"/>
                    <a:pt x="123752" y="215771"/>
                  </a:cubicBezTo>
                  <a:cubicBezTo>
                    <a:pt x="153856" y="213889"/>
                    <a:pt x="193366" y="262808"/>
                    <a:pt x="191485" y="328660"/>
                  </a:cubicBezTo>
                  <a:cubicBezTo>
                    <a:pt x="189604" y="394512"/>
                    <a:pt x="108700" y="550675"/>
                    <a:pt x="112463" y="610882"/>
                  </a:cubicBezTo>
                  <a:cubicBezTo>
                    <a:pt x="116226" y="671089"/>
                    <a:pt x="187722" y="710600"/>
                    <a:pt x="214063" y="689904"/>
                  </a:cubicBezTo>
                  <a:cubicBezTo>
                    <a:pt x="240404" y="669208"/>
                    <a:pt x="257337" y="588304"/>
                    <a:pt x="270507" y="486704"/>
                  </a:cubicBezTo>
                  <a:cubicBezTo>
                    <a:pt x="283677" y="385104"/>
                    <a:pt x="276152" y="153682"/>
                    <a:pt x="293085" y="80304"/>
                  </a:cubicBezTo>
                  <a:cubicBezTo>
                    <a:pt x="310018" y="6926"/>
                    <a:pt x="338240" y="38912"/>
                    <a:pt x="372107" y="46438"/>
                  </a:cubicBezTo>
                  <a:cubicBezTo>
                    <a:pt x="405974" y="53964"/>
                    <a:pt x="490641" y="61490"/>
                    <a:pt x="496285" y="125460"/>
                  </a:cubicBezTo>
                  <a:cubicBezTo>
                    <a:pt x="501930" y="189430"/>
                    <a:pt x="421026" y="349356"/>
                    <a:pt x="405974" y="430260"/>
                  </a:cubicBezTo>
                  <a:cubicBezTo>
                    <a:pt x="390922" y="511164"/>
                    <a:pt x="392804" y="573252"/>
                    <a:pt x="405974" y="610882"/>
                  </a:cubicBezTo>
                  <a:cubicBezTo>
                    <a:pt x="419144" y="648512"/>
                    <a:pt x="454892" y="688023"/>
                    <a:pt x="484996" y="656038"/>
                  </a:cubicBezTo>
                  <a:cubicBezTo>
                    <a:pt x="515100" y="624053"/>
                    <a:pt x="567781" y="503638"/>
                    <a:pt x="586596" y="418971"/>
                  </a:cubicBezTo>
                  <a:cubicBezTo>
                    <a:pt x="605411" y="334304"/>
                    <a:pt x="573426" y="180023"/>
                    <a:pt x="597885" y="148038"/>
                  </a:cubicBezTo>
                  <a:cubicBezTo>
                    <a:pt x="622344" y="116053"/>
                    <a:pt x="722063" y="164971"/>
                    <a:pt x="733352" y="227060"/>
                  </a:cubicBezTo>
                  <a:cubicBezTo>
                    <a:pt x="744641" y="289149"/>
                    <a:pt x="663737" y="454719"/>
                    <a:pt x="665618" y="520571"/>
                  </a:cubicBezTo>
                  <a:cubicBezTo>
                    <a:pt x="667499" y="586423"/>
                    <a:pt x="720182" y="648512"/>
                    <a:pt x="744641" y="622171"/>
                  </a:cubicBezTo>
                  <a:cubicBezTo>
                    <a:pt x="769100" y="595830"/>
                    <a:pt x="797322" y="435905"/>
                    <a:pt x="812374" y="362527"/>
                  </a:cubicBezTo>
                  <a:cubicBezTo>
                    <a:pt x="827426" y="289149"/>
                    <a:pt x="818019" y="189430"/>
                    <a:pt x="834952" y="181904"/>
                  </a:cubicBezTo>
                  <a:cubicBezTo>
                    <a:pt x="851885" y="174378"/>
                    <a:pt x="900804" y="255282"/>
                    <a:pt x="913974" y="317371"/>
                  </a:cubicBezTo>
                  <a:cubicBezTo>
                    <a:pt x="927144" y="379460"/>
                    <a:pt x="902685" y="509282"/>
                    <a:pt x="913974" y="554438"/>
                  </a:cubicBezTo>
                  <a:cubicBezTo>
                    <a:pt x="925263" y="599593"/>
                    <a:pt x="962892" y="629697"/>
                    <a:pt x="981707" y="588304"/>
                  </a:cubicBezTo>
                  <a:cubicBezTo>
                    <a:pt x="1000522" y="546911"/>
                    <a:pt x="998641" y="338067"/>
                    <a:pt x="1026863" y="306082"/>
                  </a:cubicBezTo>
                  <a:cubicBezTo>
                    <a:pt x="1055085" y="274097"/>
                    <a:pt x="1130345" y="345593"/>
                    <a:pt x="1151041" y="396393"/>
                  </a:cubicBezTo>
                  <a:cubicBezTo>
                    <a:pt x="1171737" y="447193"/>
                    <a:pt x="1122819" y="584541"/>
                    <a:pt x="1151041" y="610882"/>
                  </a:cubicBezTo>
                  <a:cubicBezTo>
                    <a:pt x="1179263" y="637223"/>
                    <a:pt x="1292152" y="640986"/>
                    <a:pt x="1320374" y="554438"/>
                  </a:cubicBezTo>
                  <a:cubicBezTo>
                    <a:pt x="1348596" y="467890"/>
                    <a:pt x="1303441" y="155563"/>
                    <a:pt x="1320374" y="91593"/>
                  </a:cubicBezTo>
                  <a:cubicBezTo>
                    <a:pt x="1337307" y="27623"/>
                    <a:pt x="1406922" y="106646"/>
                    <a:pt x="1421974" y="170616"/>
                  </a:cubicBezTo>
                  <a:cubicBezTo>
                    <a:pt x="1437026" y="234586"/>
                    <a:pt x="1406922" y="385105"/>
                    <a:pt x="1410685" y="475416"/>
                  </a:cubicBezTo>
                  <a:cubicBezTo>
                    <a:pt x="1414448" y="565727"/>
                    <a:pt x="1423856" y="693667"/>
                    <a:pt x="1444552" y="712482"/>
                  </a:cubicBezTo>
                  <a:cubicBezTo>
                    <a:pt x="1465248" y="731297"/>
                    <a:pt x="1527337" y="672971"/>
                    <a:pt x="1534863" y="588304"/>
                  </a:cubicBezTo>
                  <a:cubicBezTo>
                    <a:pt x="1542389" y="503637"/>
                    <a:pt x="1487826" y="302319"/>
                    <a:pt x="1489707" y="204482"/>
                  </a:cubicBezTo>
                  <a:cubicBezTo>
                    <a:pt x="1491589" y="106645"/>
                    <a:pt x="1517930" y="-13770"/>
                    <a:pt x="1546152" y="1282"/>
                  </a:cubicBezTo>
                  <a:cubicBezTo>
                    <a:pt x="1574374" y="16334"/>
                    <a:pt x="1640226" y="187548"/>
                    <a:pt x="1659041" y="294793"/>
                  </a:cubicBezTo>
                  <a:cubicBezTo>
                    <a:pt x="1677856" y="402037"/>
                    <a:pt x="1632700" y="577016"/>
                    <a:pt x="1659041" y="644749"/>
                  </a:cubicBezTo>
                  <a:cubicBezTo>
                    <a:pt x="1685382" y="712482"/>
                    <a:pt x="1796389" y="746348"/>
                    <a:pt x="1817085" y="701193"/>
                  </a:cubicBezTo>
                  <a:cubicBezTo>
                    <a:pt x="1837781" y="656038"/>
                    <a:pt x="1790744" y="464127"/>
                    <a:pt x="1783218" y="373816"/>
                  </a:cubicBezTo>
                  <a:cubicBezTo>
                    <a:pt x="1775692" y="283505"/>
                    <a:pt x="1760641" y="174379"/>
                    <a:pt x="1771930" y="159327"/>
                  </a:cubicBezTo>
                  <a:cubicBezTo>
                    <a:pt x="1783219" y="144275"/>
                    <a:pt x="1822730" y="219534"/>
                    <a:pt x="1850952" y="283504"/>
                  </a:cubicBezTo>
                  <a:cubicBezTo>
                    <a:pt x="1879174" y="347474"/>
                    <a:pt x="1907396" y="497993"/>
                    <a:pt x="1941263" y="543149"/>
                  </a:cubicBezTo>
                  <a:cubicBezTo>
                    <a:pt x="1975130" y="588305"/>
                    <a:pt x="2039100" y="592068"/>
                    <a:pt x="2054152" y="554438"/>
                  </a:cubicBezTo>
                  <a:cubicBezTo>
                    <a:pt x="2069204" y="516808"/>
                    <a:pt x="2048507" y="377578"/>
                    <a:pt x="2031574" y="317371"/>
                  </a:cubicBezTo>
                  <a:cubicBezTo>
                    <a:pt x="2014641" y="257164"/>
                    <a:pt x="1983596" y="225178"/>
                    <a:pt x="1952552" y="193193"/>
                  </a:cubicBezTo>
                </a:path>
              </a:pathLst>
            </a:custGeom>
            <a:noFill/>
            <a:ln w="12700">
              <a:solidFill>
                <a:srgbClr val="FF669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74" name="타원 173"/>
            <p:cNvSpPr/>
            <p:nvPr/>
          </p:nvSpPr>
          <p:spPr>
            <a:xfrm rot="20109066">
              <a:off x="2127442" y="2661381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75" name="타원 174"/>
            <p:cNvSpPr/>
            <p:nvPr/>
          </p:nvSpPr>
          <p:spPr>
            <a:xfrm rot="20109066">
              <a:off x="2138510" y="2684348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76" name="타원 175"/>
            <p:cNvSpPr/>
            <p:nvPr/>
          </p:nvSpPr>
          <p:spPr>
            <a:xfrm rot="20109066">
              <a:off x="2106653" y="2612373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77" name="타원 176"/>
            <p:cNvSpPr/>
            <p:nvPr/>
          </p:nvSpPr>
          <p:spPr>
            <a:xfrm rot="20109066">
              <a:off x="2117721" y="2635340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78" name="타원 177"/>
            <p:cNvSpPr/>
            <p:nvPr/>
          </p:nvSpPr>
          <p:spPr>
            <a:xfrm rot="20109066">
              <a:off x="1755594" y="2756754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79" name="타원 178"/>
            <p:cNvSpPr/>
            <p:nvPr/>
          </p:nvSpPr>
          <p:spPr>
            <a:xfrm rot="20109066">
              <a:off x="1766662" y="2779721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80" name="타원 179"/>
            <p:cNvSpPr/>
            <p:nvPr/>
          </p:nvSpPr>
          <p:spPr>
            <a:xfrm rot="20109066">
              <a:off x="1778079" y="2805749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81" name="타원 180"/>
            <p:cNvSpPr/>
            <p:nvPr/>
          </p:nvSpPr>
          <p:spPr>
            <a:xfrm rot="20109066">
              <a:off x="1789147" y="2828716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82" name="타원 181"/>
            <p:cNvSpPr/>
            <p:nvPr/>
          </p:nvSpPr>
          <p:spPr>
            <a:xfrm rot="20109066">
              <a:off x="1801079" y="2856780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83" name="타원 182"/>
            <p:cNvSpPr/>
            <p:nvPr/>
          </p:nvSpPr>
          <p:spPr>
            <a:xfrm rot="20109066">
              <a:off x="1828511" y="2871323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84" name="타원 183"/>
            <p:cNvSpPr/>
            <p:nvPr/>
          </p:nvSpPr>
          <p:spPr>
            <a:xfrm rot="20109066">
              <a:off x="1888391" y="2859322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85" name="타원 184"/>
            <p:cNvSpPr/>
            <p:nvPr/>
          </p:nvSpPr>
          <p:spPr>
            <a:xfrm rot="20109066">
              <a:off x="1857425" y="2873585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86" name="타원 185"/>
            <p:cNvSpPr/>
            <p:nvPr/>
          </p:nvSpPr>
          <p:spPr>
            <a:xfrm rot="20109066">
              <a:off x="1948247" y="2832457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87" name="타원 186"/>
            <p:cNvSpPr/>
            <p:nvPr/>
          </p:nvSpPr>
          <p:spPr>
            <a:xfrm rot="20109066">
              <a:off x="1917280" y="2846720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88" name="타원 187"/>
            <p:cNvSpPr/>
            <p:nvPr/>
          </p:nvSpPr>
          <p:spPr>
            <a:xfrm rot="20109066">
              <a:off x="2010828" y="2804596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89" name="타원 188"/>
            <p:cNvSpPr/>
            <p:nvPr/>
          </p:nvSpPr>
          <p:spPr>
            <a:xfrm rot="20109066">
              <a:off x="1979861" y="2818859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90" name="타원 189"/>
            <p:cNvSpPr/>
            <p:nvPr/>
          </p:nvSpPr>
          <p:spPr>
            <a:xfrm rot="20109066">
              <a:off x="2070683" y="2777730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91" name="타원 190"/>
            <p:cNvSpPr/>
            <p:nvPr/>
          </p:nvSpPr>
          <p:spPr>
            <a:xfrm rot="20109066">
              <a:off x="2039716" y="2791993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92" name="타원 191"/>
            <p:cNvSpPr/>
            <p:nvPr/>
          </p:nvSpPr>
          <p:spPr>
            <a:xfrm rot="20109066">
              <a:off x="1813475" y="2680044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93" name="타원 192"/>
            <p:cNvSpPr/>
            <p:nvPr/>
          </p:nvSpPr>
          <p:spPr>
            <a:xfrm rot="20109066">
              <a:off x="1782508" y="2694307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94" name="타원 193"/>
            <p:cNvSpPr/>
            <p:nvPr/>
          </p:nvSpPr>
          <p:spPr>
            <a:xfrm rot="20109066">
              <a:off x="1873330" y="2653178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95" name="타원 194"/>
            <p:cNvSpPr/>
            <p:nvPr/>
          </p:nvSpPr>
          <p:spPr>
            <a:xfrm rot="20109066">
              <a:off x="1842363" y="2667441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96" name="타원 195"/>
            <p:cNvSpPr/>
            <p:nvPr/>
          </p:nvSpPr>
          <p:spPr>
            <a:xfrm rot="20109066">
              <a:off x="1936615" y="2621187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97" name="타원 196"/>
            <p:cNvSpPr/>
            <p:nvPr/>
          </p:nvSpPr>
          <p:spPr>
            <a:xfrm rot="20109066">
              <a:off x="1905648" y="2635450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98" name="타원 197"/>
            <p:cNvSpPr/>
            <p:nvPr/>
          </p:nvSpPr>
          <p:spPr>
            <a:xfrm rot="20109066">
              <a:off x="2004273" y="2592817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199" name="타원 198"/>
            <p:cNvSpPr/>
            <p:nvPr/>
          </p:nvSpPr>
          <p:spPr>
            <a:xfrm rot="20109066">
              <a:off x="1965503" y="2608584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200" name="타원 199"/>
            <p:cNvSpPr/>
            <p:nvPr/>
          </p:nvSpPr>
          <p:spPr>
            <a:xfrm rot="20109066">
              <a:off x="2130375" y="2745096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201" name="타원 200"/>
            <p:cNvSpPr/>
            <p:nvPr/>
          </p:nvSpPr>
          <p:spPr>
            <a:xfrm rot="20109066">
              <a:off x="2105241" y="2761649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202" name="타원 201"/>
            <p:cNvSpPr/>
            <p:nvPr/>
          </p:nvSpPr>
          <p:spPr>
            <a:xfrm rot="20109066">
              <a:off x="1757949" y="2720139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203" name="타원 202"/>
            <p:cNvSpPr/>
            <p:nvPr/>
          </p:nvSpPr>
          <p:spPr>
            <a:xfrm rot="20109066">
              <a:off x="2141850" y="2716318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204" name="타원 203"/>
            <p:cNvSpPr/>
            <p:nvPr/>
          </p:nvSpPr>
          <p:spPr>
            <a:xfrm rot="20109066">
              <a:off x="2083791" y="2581017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sp>
          <p:nvSpPr>
            <p:cNvPr id="205" name="타원 204"/>
            <p:cNvSpPr/>
            <p:nvPr/>
          </p:nvSpPr>
          <p:spPr>
            <a:xfrm rot="20109066">
              <a:off x="2044856" y="2574756"/>
              <a:ext cx="16705" cy="17962"/>
            </a:xfrm>
            <a:prstGeom prst="ellipse">
              <a:avLst/>
            </a:prstGeom>
            <a:gradFill flip="none" rotWithShape="1">
              <a:gsLst>
                <a:gs pos="0">
                  <a:srgbClr val="CC99FF">
                    <a:shade val="30000"/>
                    <a:satMod val="115000"/>
                  </a:srgbClr>
                </a:gs>
                <a:gs pos="55000">
                  <a:srgbClr val="CC99FF">
                    <a:shade val="67500"/>
                    <a:satMod val="115000"/>
                  </a:srgbClr>
                </a:gs>
                <a:gs pos="100000">
                  <a:srgbClr val="CC99FF">
                    <a:shade val="100000"/>
                    <a:satMod val="115000"/>
                  </a:srgbClr>
                </a:gs>
              </a:gsLst>
              <a:lin ang="13500000" scaled="1"/>
              <a:tileRect/>
            </a:gradFill>
            <a:ln w="31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</p:grpSp>
      <p:sp>
        <p:nvSpPr>
          <p:cNvPr id="206" name="TextBox 205"/>
          <p:cNvSpPr txBox="1"/>
          <p:nvPr/>
        </p:nvSpPr>
        <p:spPr>
          <a:xfrm>
            <a:off x="1132579" y="3452497"/>
            <a:ext cx="7038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ESAT6 </a:t>
            </a:r>
            <a:endParaRPr lang="ko-KR" altLang="en-US" sz="12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1031" name="직선 연결선 1030"/>
          <p:cNvCxnSpPr/>
          <p:nvPr/>
        </p:nvCxnSpPr>
        <p:spPr>
          <a:xfrm>
            <a:off x="1750594" y="3606386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TextBox 208"/>
          <p:cNvSpPr txBox="1"/>
          <p:nvPr/>
        </p:nvSpPr>
        <p:spPr>
          <a:xfrm>
            <a:off x="2656132" y="2331546"/>
            <a:ext cx="5036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αGC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cxnSp>
        <p:nvCxnSpPr>
          <p:cNvPr id="1033" name="직선 연결선 1032"/>
          <p:cNvCxnSpPr/>
          <p:nvPr/>
        </p:nvCxnSpPr>
        <p:spPr>
          <a:xfrm flipH="1">
            <a:off x="2904676" y="2579840"/>
            <a:ext cx="0" cy="14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2" name="TextBox 211"/>
          <p:cNvSpPr txBox="1"/>
          <p:nvPr/>
        </p:nvSpPr>
        <p:spPr>
          <a:xfrm>
            <a:off x="2316218" y="3005799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D1d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2950541" y="3018216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CR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2142496" y="3604937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CR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15" name="TextBox 214"/>
          <p:cNvSpPr txBox="1"/>
          <p:nvPr/>
        </p:nvSpPr>
        <p:spPr>
          <a:xfrm>
            <a:off x="2152946" y="3275925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HCII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16" name="TextBox 215"/>
          <p:cNvSpPr txBox="1"/>
          <p:nvPr/>
        </p:nvSpPr>
        <p:spPr>
          <a:xfrm>
            <a:off x="4850238" y="4915486"/>
            <a:ext cx="11721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Enhanced </a:t>
            </a:r>
          </a:p>
          <a:p>
            <a:pPr algn="ctr"/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acteria killing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2569910" y="4382157"/>
            <a:ext cx="17267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acrophage activation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4405453" y="4266951"/>
            <a:ext cx="10967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hagocytosis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651995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17</TotalTime>
  <Words>796</Words>
  <Application>Microsoft Office PowerPoint</Application>
  <PresentationFormat>화면 슬라이드 쇼(4:3)</PresentationFormat>
  <Paragraphs>59</Paragraphs>
  <Slides>6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8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5" baseType="lpstr">
      <vt:lpstr>Arial Unicode MS</vt:lpstr>
      <vt:lpstr>굴림</vt:lpstr>
      <vt:lpstr>맑은 고딕</vt:lpstr>
      <vt:lpstr>Arial</vt:lpstr>
      <vt:lpstr>Calibri</vt:lpstr>
      <vt:lpstr>Calibri Light</vt:lpstr>
      <vt:lpstr>Cambria Math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-vac figure</dc:title>
  <dc:creator>권보은</dc:creator>
  <cp:lastModifiedBy>권 보은</cp:lastModifiedBy>
  <cp:revision>447</cp:revision>
  <cp:lastPrinted>2019-09-19T07:24:33Z</cp:lastPrinted>
  <dcterms:created xsi:type="dcterms:W3CDTF">2018-07-27T01:31:05Z</dcterms:created>
  <dcterms:modified xsi:type="dcterms:W3CDTF">2019-09-30T02:02:51Z</dcterms:modified>
</cp:coreProperties>
</file>